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480175" cy="3600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1212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211" d="100"/>
          <a:sy n="211" d="100"/>
        </p:scale>
        <p:origin x="480" y="5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10022" y="589241"/>
            <a:ext cx="4860131" cy="1253490"/>
          </a:xfrm>
        </p:spPr>
        <p:txBody>
          <a:bodyPr anchor="b"/>
          <a:lstStyle>
            <a:lvl1pPr algn="ctr">
              <a:defRPr sz="31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1891070"/>
            <a:ext cx="4860131" cy="869275"/>
          </a:xfrm>
        </p:spPr>
        <p:txBody>
          <a:bodyPr/>
          <a:lstStyle>
            <a:lvl1pPr marL="0" indent="0" algn="ctr">
              <a:buNone/>
              <a:defRPr sz="1260"/>
            </a:lvl1pPr>
            <a:lvl2pPr marL="240030" indent="0" algn="ctr">
              <a:buNone/>
              <a:defRPr sz="1050"/>
            </a:lvl2pPr>
            <a:lvl3pPr marL="480060" indent="0" algn="ctr">
              <a:buNone/>
              <a:defRPr sz="945"/>
            </a:lvl3pPr>
            <a:lvl4pPr marL="720090" indent="0" algn="ctr">
              <a:buNone/>
              <a:defRPr sz="840"/>
            </a:lvl4pPr>
            <a:lvl5pPr marL="960120" indent="0" algn="ctr">
              <a:buNone/>
              <a:defRPr sz="840"/>
            </a:lvl5pPr>
            <a:lvl6pPr marL="1200150" indent="0" algn="ctr">
              <a:buNone/>
              <a:defRPr sz="840"/>
            </a:lvl6pPr>
            <a:lvl7pPr marL="1440180" indent="0" algn="ctr">
              <a:buNone/>
              <a:defRPr sz="840"/>
            </a:lvl7pPr>
            <a:lvl8pPr marL="1680210" indent="0" algn="ctr">
              <a:buNone/>
              <a:defRPr sz="840"/>
            </a:lvl8pPr>
            <a:lvl9pPr marL="1920240" indent="0" algn="ctr">
              <a:buNone/>
              <a:defRPr sz="8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327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145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191691"/>
            <a:ext cx="1397288" cy="30512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191691"/>
            <a:ext cx="4110861" cy="30512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745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475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897613"/>
            <a:ext cx="5589151" cy="1497687"/>
          </a:xfrm>
        </p:spPr>
        <p:txBody>
          <a:bodyPr anchor="b"/>
          <a:lstStyle>
            <a:lvl1pPr>
              <a:defRPr sz="31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2409468"/>
            <a:ext cx="5589151" cy="787598"/>
          </a:xfrm>
        </p:spPr>
        <p:txBody>
          <a:bodyPr/>
          <a:lstStyle>
            <a:lvl1pPr marL="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1pPr>
            <a:lvl2pPr marL="24003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2pPr>
            <a:lvl3pPr marL="480060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3pPr>
            <a:lvl4pPr marL="72009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4pPr>
            <a:lvl5pPr marL="96012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5pPr>
            <a:lvl6pPr marL="120015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6pPr>
            <a:lvl7pPr marL="144018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7pPr>
            <a:lvl8pPr marL="168021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8pPr>
            <a:lvl9pPr marL="192024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848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958453"/>
            <a:ext cx="2754074" cy="22844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958453"/>
            <a:ext cx="2754074" cy="22844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199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191691"/>
            <a:ext cx="5589151" cy="69592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6" y="882610"/>
            <a:ext cx="2741418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6" y="1315164"/>
            <a:ext cx="2741418" cy="19344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882610"/>
            <a:ext cx="2754918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1315164"/>
            <a:ext cx="2754918" cy="19344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2793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319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953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40030"/>
            <a:ext cx="2090025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518398"/>
            <a:ext cx="3280589" cy="2558653"/>
          </a:xfrm>
        </p:spPr>
        <p:txBody>
          <a:bodyPr/>
          <a:lstStyle>
            <a:lvl1pPr>
              <a:defRPr sz="1680"/>
            </a:lvl1pPr>
            <a:lvl2pPr>
              <a:defRPr sz="1470"/>
            </a:lvl2pPr>
            <a:lvl3pPr>
              <a:defRPr sz="1260"/>
            </a:lvl3pPr>
            <a:lvl4pPr>
              <a:defRPr sz="1050"/>
            </a:lvl4pPr>
            <a:lvl5pPr>
              <a:defRPr sz="1050"/>
            </a:lvl5pPr>
            <a:lvl6pPr>
              <a:defRPr sz="1050"/>
            </a:lvl6pPr>
            <a:lvl7pPr>
              <a:defRPr sz="1050"/>
            </a:lvl7pPr>
            <a:lvl8pPr>
              <a:defRPr sz="1050"/>
            </a:lvl8pPr>
            <a:lvl9pPr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080135"/>
            <a:ext cx="2090025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94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40030"/>
            <a:ext cx="2090025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518398"/>
            <a:ext cx="3280589" cy="2558653"/>
          </a:xfrm>
        </p:spPr>
        <p:txBody>
          <a:bodyPr anchor="t"/>
          <a:lstStyle>
            <a:lvl1pPr marL="0" indent="0">
              <a:buNone/>
              <a:defRPr sz="1680"/>
            </a:lvl1pPr>
            <a:lvl2pPr marL="240030" indent="0">
              <a:buNone/>
              <a:defRPr sz="1470"/>
            </a:lvl2pPr>
            <a:lvl3pPr marL="480060" indent="0">
              <a:buNone/>
              <a:defRPr sz="1260"/>
            </a:lvl3pPr>
            <a:lvl4pPr marL="720090" indent="0">
              <a:buNone/>
              <a:defRPr sz="1050"/>
            </a:lvl4pPr>
            <a:lvl5pPr marL="960120" indent="0">
              <a:buNone/>
              <a:defRPr sz="1050"/>
            </a:lvl5pPr>
            <a:lvl6pPr marL="1200150" indent="0">
              <a:buNone/>
              <a:defRPr sz="1050"/>
            </a:lvl6pPr>
            <a:lvl7pPr marL="1440180" indent="0">
              <a:buNone/>
              <a:defRPr sz="1050"/>
            </a:lvl7pPr>
            <a:lvl8pPr marL="1680210" indent="0">
              <a:buNone/>
              <a:defRPr sz="1050"/>
            </a:lvl8pPr>
            <a:lvl9pPr marL="1920240" indent="0">
              <a:buNone/>
              <a:defRPr sz="10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080135"/>
            <a:ext cx="2090025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902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191691"/>
            <a:ext cx="5589151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958453"/>
            <a:ext cx="5589151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3337084"/>
            <a:ext cx="1458039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2675F3-C41C-4B2A-B7C9-69F8F6DCA9C6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3337084"/>
            <a:ext cx="2187059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3337084"/>
            <a:ext cx="1458039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62F49A-A681-4AD3-AFD0-3BDB63AD1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26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80060" rtl="0" eaLnBrk="1" latinLnBrk="0" hangingPunct="1">
        <a:lnSpc>
          <a:spcPct val="90000"/>
        </a:lnSpc>
        <a:spcBef>
          <a:spcPct val="0"/>
        </a:spcBef>
        <a:buNone/>
        <a:defRPr sz="23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0015" indent="-120015" algn="l" defTabSz="48006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470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0007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050" kern="1200">
          <a:solidFill>
            <a:schemeClr val="tx1"/>
          </a:solidFill>
          <a:latin typeface="+mn-lt"/>
          <a:ea typeface="+mn-ea"/>
          <a:cs typeface="+mn-cs"/>
        </a:defRPr>
      </a:lvl3pPr>
      <a:lvl4pPr marL="84010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108013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32016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56019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204025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1pPr>
      <a:lvl2pPr marL="24003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2pPr>
      <a:lvl3pPr marL="48006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2009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96012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20015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44018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68021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192024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26" Type="http://schemas.openxmlformats.org/officeDocument/2006/relationships/tags" Target="../tags/tag26.xml"/><Relationship Id="rId39" Type="http://schemas.openxmlformats.org/officeDocument/2006/relationships/image" Target="../media/image7.png"/><Relationship Id="rId3" Type="http://schemas.openxmlformats.org/officeDocument/2006/relationships/tags" Target="../tags/tag3.xml"/><Relationship Id="rId21" Type="http://schemas.openxmlformats.org/officeDocument/2006/relationships/tags" Target="../tags/tag21.xml"/><Relationship Id="rId34" Type="http://schemas.openxmlformats.org/officeDocument/2006/relationships/image" Target="../media/image3.emf"/><Relationship Id="rId42" Type="http://schemas.openxmlformats.org/officeDocument/2006/relationships/image" Target="../media/image4.png"/><Relationship Id="rId47" Type="http://schemas.openxmlformats.org/officeDocument/2006/relationships/image" Target="../media/image10.png"/><Relationship Id="rId50" Type="http://schemas.openxmlformats.org/officeDocument/2006/relationships/image" Target="../media/image13.png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tags" Target="../tags/tag25.xml"/><Relationship Id="rId33" Type="http://schemas.openxmlformats.org/officeDocument/2006/relationships/image" Target="../media/image2.png"/><Relationship Id="rId46" Type="http://schemas.openxmlformats.org/officeDocument/2006/relationships/image" Target="../media/image9.png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20" Type="http://schemas.openxmlformats.org/officeDocument/2006/relationships/tags" Target="../tags/tag20.xml"/><Relationship Id="rId29" Type="http://schemas.openxmlformats.org/officeDocument/2006/relationships/tags" Target="../tags/tag29.xml"/><Relationship Id="rId41" Type="http://schemas.openxmlformats.org/officeDocument/2006/relationships/image" Target="../media/image16.png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tags" Target="../tags/tag24.xml"/><Relationship Id="rId32" Type="http://schemas.openxmlformats.org/officeDocument/2006/relationships/image" Target="../media/image1.png"/><Relationship Id="rId40" Type="http://schemas.openxmlformats.org/officeDocument/2006/relationships/image" Target="../media/image40.png"/><Relationship Id="rId45" Type="http://schemas.openxmlformats.org/officeDocument/2006/relationships/image" Target="../media/image8.png"/><Relationship Id="rId53" Type="http://schemas.openxmlformats.org/officeDocument/2006/relationships/image" Target="../media/image17.png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23" Type="http://schemas.openxmlformats.org/officeDocument/2006/relationships/tags" Target="../tags/tag23.xml"/><Relationship Id="rId28" Type="http://schemas.openxmlformats.org/officeDocument/2006/relationships/tags" Target="../tags/tag28.xml"/><Relationship Id="rId49" Type="http://schemas.openxmlformats.org/officeDocument/2006/relationships/image" Target="../media/image12.emf"/><Relationship Id="rId10" Type="http://schemas.openxmlformats.org/officeDocument/2006/relationships/tags" Target="../tags/tag10.xml"/><Relationship Id="rId19" Type="http://schemas.openxmlformats.org/officeDocument/2006/relationships/tags" Target="../tags/tag19.xml"/><Relationship Id="rId31" Type="http://schemas.openxmlformats.org/officeDocument/2006/relationships/slideLayout" Target="../slideLayouts/slideLayout1.xml"/><Relationship Id="rId44" Type="http://schemas.openxmlformats.org/officeDocument/2006/relationships/image" Target="../media/image6.png"/><Relationship Id="rId52" Type="http://schemas.openxmlformats.org/officeDocument/2006/relationships/image" Target="../media/image15.png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Relationship Id="rId22" Type="http://schemas.openxmlformats.org/officeDocument/2006/relationships/tags" Target="../tags/tag22.xml"/><Relationship Id="rId27" Type="http://schemas.openxmlformats.org/officeDocument/2006/relationships/tags" Target="../tags/tag27.xml"/><Relationship Id="rId30" Type="http://schemas.openxmlformats.org/officeDocument/2006/relationships/tags" Target="../tags/tag30.xml"/><Relationship Id="rId43" Type="http://schemas.openxmlformats.org/officeDocument/2006/relationships/image" Target="../media/image5.png"/><Relationship Id="rId48" Type="http://schemas.openxmlformats.org/officeDocument/2006/relationships/image" Target="../media/image11.png"/><Relationship Id="rId8" Type="http://schemas.openxmlformats.org/officeDocument/2006/relationships/tags" Target="../tags/tag8.xml"/><Relationship Id="rId51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408119A5-AD5C-8E45-0E69-1A531CBC731F}"/>
              </a:ext>
            </a:extLst>
          </p:cNvPr>
          <p:cNvGrpSpPr/>
          <p:nvPr/>
        </p:nvGrpSpPr>
        <p:grpSpPr>
          <a:xfrm>
            <a:off x="35578" y="-125551"/>
            <a:ext cx="6283012" cy="3764555"/>
            <a:chOff x="35578" y="-125551"/>
            <a:chExt cx="6283012" cy="3764555"/>
          </a:xfrm>
        </p:grpSpPr>
        <p:grpSp>
          <p:nvGrpSpPr>
            <p:cNvPr id="143" name="Group 142">
              <a:extLst>
                <a:ext uri="{FF2B5EF4-FFF2-40B4-BE49-F238E27FC236}">
                  <a16:creationId xmlns:a16="http://schemas.microsoft.com/office/drawing/2014/main" id="{1B54CC32-92E5-AFAC-B330-F0029AC6F6C8}"/>
                </a:ext>
              </a:extLst>
            </p:cNvPr>
            <p:cNvGrpSpPr/>
            <p:nvPr/>
          </p:nvGrpSpPr>
          <p:grpSpPr>
            <a:xfrm>
              <a:off x="5059722" y="2426613"/>
              <a:ext cx="1258125" cy="1212391"/>
              <a:chOff x="5073990" y="2436595"/>
              <a:chExt cx="1210516" cy="1166512"/>
            </a:xfrm>
          </p:grpSpPr>
          <p:pic>
            <p:nvPicPr>
              <p:cNvPr id="153" name="Picture 152">
                <a:extLst>
                  <a:ext uri="{FF2B5EF4-FFF2-40B4-BE49-F238E27FC236}">
                    <a16:creationId xmlns:a16="http://schemas.microsoft.com/office/drawing/2014/main" id="{32FF803C-20C7-88A7-CE1A-D8E92595FBE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426" t="20076" r="9499" b="6592"/>
              <a:stretch/>
            </p:blipFill>
            <p:spPr>
              <a:xfrm>
                <a:off x="5121075" y="2436595"/>
                <a:ext cx="1163431" cy="1052340"/>
              </a:xfrm>
              <a:prstGeom prst="rect">
                <a:avLst/>
              </a:prstGeom>
            </p:spPr>
          </p:pic>
          <p:sp>
            <p:nvSpPr>
              <p:cNvPr id="157" name="Rectangle 156">
                <a:extLst>
                  <a:ext uri="{FF2B5EF4-FFF2-40B4-BE49-F238E27FC236}">
                    <a16:creationId xmlns:a16="http://schemas.microsoft.com/office/drawing/2014/main" id="{B7E8552B-58F7-D6B3-78AE-B118A5F084E2}"/>
                  </a:ext>
                </a:extLst>
              </p:cNvPr>
              <p:cNvSpPr/>
              <p:nvPr/>
            </p:nvSpPr>
            <p:spPr>
              <a:xfrm>
                <a:off x="5073990" y="3188499"/>
                <a:ext cx="995561" cy="414608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7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ost-processed</a:t>
                </a:r>
              </a:p>
            </p:txBody>
          </p:sp>
        </p:grp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839ABF84-A5D1-6B22-E740-C9193C1EE262}"/>
                </a:ext>
              </a:extLst>
            </p:cNvPr>
            <p:cNvSpPr/>
            <p:nvPr/>
          </p:nvSpPr>
          <p:spPr>
            <a:xfrm>
              <a:off x="3252444" y="2744162"/>
              <a:ext cx="1202024" cy="598454"/>
            </a:xfrm>
            <a:prstGeom prst="rect">
              <a:avLst/>
            </a:prstGeom>
            <a:solidFill>
              <a:srgbClr val="00B050">
                <a:alpha val="50000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2FE0DA9-6CC0-F574-F190-4D991DAAA20F}"/>
                </a:ext>
              </a:extLst>
            </p:cNvPr>
            <p:cNvSpPr txBox="1"/>
            <p:nvPr/>
          </p:nvSpPr>
          <p:spPr>
            <a:xfrm>
              <a:off x="35578" y="937120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F497440-B7D8-CD53-BEA3-29D25194D14D}"/>
                </a:ext>
              </a:extLst>
            </p:cNvPr>
            <p:cNvSpPr txBox="1"/>
            <p:nvPr/>
          </p:nvSpPr>
          <p:spPr>
            <a:xfrm>
              <a:off x="4883586" y="12143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183" name="Group 182" descr="\documentclass{article}&#10;\usepackage{amsmath}&#10;\pagestyle{empty}&#10;\begin{document}&#10;&#10;$\ell_{\text{F}}(f,\hat{f})$&#10;&#10;\end{document}" title="IguanaTex Vector Display">
              <a:extLst>
                <a:ext uri="{FF2B5EF4-FFF2-40B4-BE49-F238E27FC236}">
                  <a16:creationId xmlns:a16="http://schemas.microsoft.com/office/drawing/2014/main" id="{004CD1BC-3E69-6B90-8316-79D1E20484F5}"/>
                </a:ext>
              </a:extLst>
            </p:cNvPr>
            <p:cNvGrpSpPr>
              <a:grpSpLocks noChangeAspect="1"/>
            </p:cNvGrpSpPr>
            <p:nvPr>
              <p:custDataLst>
                <p:tags r:id="rId1"/>
              </p:custDataLst>
            </p:nvPr>
          </p:nvGrpSpPr>
          <p:grpSpPr>
            <a:xfrm>
              <a:off x="4497081" y="246296"/>
              <a:ext cx="368808" cy="137786"/>
              <a:chOff x="4573098" y="292240"/>
              <a:chExt cx="29815" cy="11139"/>
            </a:xfrm>
          </p:grpSpPr>
          <p:sp>
            <p:nvSpPr>
              <p:cNvPr id="171" name="Freeform: Shape 170">
                <a:extLst>
                  <a:ext uri="{FF2B5EF4-FFF2-40B4-BE49-F238E27FC236}">
                    <a16:creationId xmlns:a16="http://schemas.microsoft.com/office/drawing/2014/main" id="{5479BB0B-EA48-AA6B-8332-6E5A09D3A294}"/>
                  </a:ext>
                </a:extLst>
              </p:cNvPr>
              <p:cNvSpPr/>
              <p:nvPr>
                <p:custDataLst>
                  <p:tags r:id="rId23"/>
                </p:custDataLst>
              </p:nvPr>
            </p:nvSpPr>
            <p:spPr>
              <a:xfrm>
                <a:off x="4573098" y="294572"/>
                <a:ext cx="3569" cy="6612"/>
              </a:xfrm>
              <a:custGeom>
                <a:avLst/>
                <a:gdLst>
                  <a:gd name="connsiteX0" fmla="*/ 123 w 3569"/>
                  <a:gd name="connsiteY0" fmla="*/ 5651 h 6612"/>
                  <a:gd name="connsiteX1" fmla="*/ 77 w 3569"/>
                  <a:gd name="connsiteY1" fmla="*/ 5744 h 6612"/>
                  <a:gd name="connsiteX2" fmla="*/ 187 w 3569"/>
                  <a:gd name="connsiteY2" fmla="*/ 5863 h 6612"/>
                  <a:gd name="connsiteX3" fmla="*/ 519 w 3569"/>
                  <a:gd name="connsiteY3" fmla="*/ 5578 h 6612"/>
                  <a:gd name="connsiteX4" fmla="*/ 851 w 3569"/>
                  <a:gd name="connsiteY4" fmla="*/ 5264 h 6612"/>
                  <a:gd name="connsiteX5" fmla="*/ 1884 w 3569"/>
                  <a:gd name="connsiteY5" fmla="*/ 6675 h 6612"/>
                  <a:gd name="connsiteX6" fmla="*/ 2770 w 3569"/>
                  <a:gd name="connsiteY6" fmla="*/ 6325 h 6612"/>
                  <a:gd name="connsiteX7" fmla="*/ 3332 w 3569"/>
                  <a:gd name="connsiteY7" fmla="*/ 5780 h 6612"/>
                  <a:gd name="connsiteX8" fmla="*/ 3222 w 3569"/>
                  <a:gd name="connsiteY8" fmla="*/ 5670 h 6612"/>
                  <a:gd name="connsiteX9" fmla="*/ 3102 w 3569"/>
                  <a:gd name="connsiteY9" fmla="*/ 5753 h 6612"/>
                  <a:gd name="connsiteX10" fmla="*/ 1903 w 3569"/>
                  <a:gd name="connsiteY10" fmla="*/ 6472 h 6612"/>
                  <a:gd name="connsiteX11" fmla="*/ 1340 w 3569"/>
                  <a:gd name="connsiteY11" fmla="*/ 5273 h 6612"/>
                  <a:gd name="connsiteX12" fmla="*/ 1386 w 3569"/>
                  <a:gd name="connsiteY12" fmla="*/ 4748 h 6612"/>
                  <a:gd name="connsiteX13" fmla="*/ 1589 w 3569"/>
                  <a:gd name="connsiteY13" fmla="*/ 4517 h 6612"/>
                  <a:gd name="connsiteX14" fmla="*/ 3646 w 3569"/>
                  <a:gd name="connsiteY14" fmla="*/ 782 h 6612"/>
                  <a:gd name="connsiteX15" fmla="*/ 3102 w 3569"/>
                  <a:gd name="connsiteY15" fmla="*/ 63 h 6612"/>
                  <a:gd name="connsiteX16" fmla="*/ 1562 w 3569"/>
                  <a:gd name="connsiteY16" fmla="*/ 1797 h 6612"/>
                  <a:gd name="connsiteX17" fmla="*/ 833 w 3569"/>
                  <a:gd name="connsiteY17" fmla="*/ 4978 h 6612"/>
                  <a:gd name="connsiteX18" fmla="*/ 123 w 3569"/>
                  <a:gd name="connsiteY18" fmla="*/ 5651 h 6612"/>
                  <a:gd name="connsiteX19" fmla="*/ 1432 w 3569"/>
                  <a:gd name="connsiteY19" fmla="*/ 4360 h 6612"/>
                  <a:gd name="connsiteX20" fmla="*/ 2373 w 3569"/>
                  <a:gd name="connsiteY20" fmla="*/ 1133 h 6612"/>
                  <a:gd name="connsiteX21" fmla="*/ 3111 w 3569"/>
                  <a:gd name="connsiteY21" fmla="*/ 266 h 6612"/>
                  <a:gd name="connsiteX22" fmla="*/ 3424 w 3569"/>
                  <a:gd name="connsiteY22" fmla="*/ 745 h 6612"/>
                  <a:gd name="connsiteX23" fmla="*/ 1432 w 3569"/>
                  <a:gd name="connsiteY23" fmla="*/ 4360 h 66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</a:cxnLst>
                <a:rect l="l" t="t" r="r" b="b"/>
                <a:pathLst>
                  <a:path w="3569" h="6612">
                    <a:moveTo>
                      <a:pt x="123" y="5651"/>
                    </a:moveTo>
                    <a:cubicBezTo>
                      <a:pt x="104" y="5679"/>
                      <a:pt x="77" y="5707"/>
                      <a:pt x="77" y="5744"/>
                    </a:cubicBezTo>
                    <a:cubicBezTo>
                      <a:pt x="77" y="5790"/>
                      <a:pt x="132" y="5863"/>
                      <a:pt x="187" y="5863"/>
                    </a:cubicBezTo>
                    <a:cubicBezTo>
                      <a:pt x="233" y="5863"/>
                      <a:pt x="261" y="5836"/>
                      <a:pt x="519" y="5578"/>
                    </a:cubicBezTo>
                    <a:cubicBezTo>
                      <a:pt x="593" y="5513"/>
                      <a:pt x="778" y="5338"/>
                      <a:pt x="851" y="5264"/>
                    </a:cubicBezTo>
                    <a:cubicBezTo>
                      <a:pt x="944" y="5993"/>
                      <a:pt x="1211" y="6675"/>
                      <a:pt x="1884" y="6675"/>
                    </a:cubicBezTo>
                    <a:cubicBezTo>
                      <a:pt x="2253" y="6675"/>
                      <a:pt x="2576" y="6463"/>
                      <a:pt x="2770" y="6325"/>
                    </a:cubicBezTo>
                    <a:cubicBezTo>
                      <a:pt x="2899" y="6232"/>
                      <a:pt x="3332" y="5873"/>
                      <a:pt x="3332" y="5780"/>
                    </a:cubicBezTo>
                    <a:cubicBezTo>
                      <a:pt x="3332" y="5753"/>
                      <a:pt x="3305" y="5670"/>
                      <a:pt x="3222" y="5670"/>
                    </a:cubicBezTo>
                    <a:cubicBezTo>
                      <a:pt x="3194" y="5670"/>
                      <a:pt x="3185" y="5679"/>
                      <a:pt x="3102" y="5753"/>
                    </a:cubicBezTo>
                    <a:cubicBezTo>
                      <a:pt x="2511" y="6334"/>
                      <a:pt x="2170" y="6472"/>
                      <a:pt x="1903" y="6472"/>
                    </a:cubicBezTo>
                    <a:cubicBezTo>
                      <a:pt x="1488" y="6472"/>
                      <a:pt x="1340" y="5993"/>
                      <a:pt x="1340" y="5273"/>
                    </a:cubicBezTo>
                    <a:cubicBezTo>
                      <a:pt x="1340" y="5218"/>
                      <a:pt x="1359" y="4794"/>
                      <a:pt x="1386" y="4748"/>
                    </a:cubicBezTo>
                    <a:cubicBezTo>
                      <a:pt x="1405" y="4720"/>
                      <a:pt x="1405" y="4701"/>
                      <a:pt x="1589" y="4517"/>
                    </a:cubicBezTo>
                    <a:cubicBezTo>
                      <a:pt x="2336" y="3770"/>
                      <a:pt x="3646" y="2212"/>
                      <a:pt x="3646" y="782"/>
                    </a:cubicBezTo>
                    <a:cubicBezTo>
                      <a:pt x="3646" y="625"/>
                      <a:pt x="3646" y="63"/>
                      <a:pt x="3102" y="63"/>
                    </a:cubicBezTo>
                    <a:cubicBezTo>
                      <a:pt x="2336" y="63"/>
                      <a:pt x="1654" y="1584"/>
                      <a:pt x="1562" y="1797"/>
                    </a:cubicBezTo>
                    <a:cubicBezTo>
                      <a:pt x="1119" y="2802"/>
                      <a:pt x="833" y="3881"/>
                      <a:pt x="833" y="4978"/>
                    </a:cubicBezTo>
                    <a:lnTo>
                      <a:pt x="123" y="5651"/>
                    </a:lnTo>
                    <a:close/>
                    <a:moveTo>
                      <a:pt x="1432" y="4360"/>
                    </a:moveTo>
                    <a:cubicBezTo>
                      <a:pt x="1451" y="4259"/>
                      <a:pt x="1847" y="2212"/>
                      <a:pt x="2373" y="1133"/>
                    </a:cubicBezTo>
                    <a:cubicBezTo>
                      <a:pt x="2622" y="635"/>
                      <a:pt x="2816" y="266"/>
                      <a:pt x="3111" y="266"/>
                    </a:cubicBezTo>
                    <a:cubicBezTo>
                      <a:pt x="3424" y="266"/>
                      <a:pt x="3424" y="598"/>
                      <a:pt x="3424" y="745"/>
                    </a:cubicBezTo>
                    <a:cubicBezTo>
                      <a:pt x="3424" y="2285"/>
                      <a:pt x="1875" y="3899"/>
                      <a:pt x="1432" y="4360"/>
                    </a:cubicBez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72" name="Freeform: Shape 171">
                <a:extLst>
                  <a:ext uri="{FF2B5EF4-FFF2-40B4-BE49-F238E27FC236}">
                    <a16:creationId xmlns:a16="http://schemas.microsoft.com/office/drawing/2014/main" id="{563ECB81-B86A-D739-849C-D79A5E152EAF}"/>
                  </a:ext>
                </a:extLst>
              </p:cNvPr>
              <p:cNvSpPr/>
              <p:nvPr>
                <p:custDataLst>
                  <p:tags r:id="rId24"/>
                </p:custDataLst>
              </p:nvPr>
            </p:nvSpPr>
            <p:spPr>
              <a:xfrm>
                <a:off x="4577201" y="298074"/>
                <a:ext cx="4041" cy="4383"/>
              </a:xfrm>
              <a:custGeom>
                <a:avLst/>
                <a:gdLst>
                  <a:gd name="connsiteX0" fmla="*/ 3928 w 4041"/>
                  <a:gd name="connsiteY0" fmla="*/ 64 h 4383"/>
                  <a:gd name="connsiteX1" fmla="*/ 81 w 4041"/>
                  <a:gd name="connsiteY1" fmla="*/ 64 h 4383"/>
                  <a:gd name="connsiteX2" fmla="*/ 81 w 4041"/>
                  <a:gd name="connsiteY2" fmla="*/ 297 h 4383"/>
                  <a:gd name="connsiteX3" fmla="*/ 236 w 4041"/>
                  <a:gd name="connsiteY3" fmla="*/ 297 h 4383"/>
                  <a:gd name="connsiteX4" fmla="*/ 746 w 4041"/>
                  <a:gd name="connsiteY4" fmla="*/ 587 h 4383"/>
                  <a:gd name="connsiteX5" fmla="*/ 746 w 4041"/>
                  <a:gd name="connsiteY5" fmla="*/ 3925 h 4383"/>
                  <a:gd name="connsiteX6" fmla="*/ 236 w 4041"/>
                  <a:gd name="connsiteY6" fmla="*/ 4215 h 4383"/>
                  <a:gd name="connsiteX7" fmla="*/ 81 w 4041"/>
                  <a:gd name="connsiteY7" fmla="*/ 4215 h 4383"/>
                  <a:gd name="connsiteX8" fmla="*/ 81 w 4041"/>
                  <a:gd name="connsiteY8" fmla="*/ 4448 h 4383"/>
                  <a:gd name="connsiteX9" fmla="*/ 1062 w 4041"/>
                  <a:gd name="connsiteY9" fmla="*/ 4422 h 4383"/>
                  <a:gd name="connsiteX10" fmla="*/ 2192 w 4041"/>
                  <a:gd name="connsiteY10" fmla="*/ 4448 h 4383"/>
                  <a:gd name="connsiteX11" fmla="*/ 2192 w 4041"/>
                  <a:gd name="connsiteY11" fmla="*/ 4215 h 4383"/>
                  <a:gd name="connsiteX12" fmla="*/ 1966 w 4041"/>
                  <a:gd name="connsiteY12" fmla="*/ 4215 h 4383"/>
                  <a:gd name="connsiteX13" fmla="*/ 1359 w 4041"/>
                  <a:gd name="connsiteY13" fmla="*/ 3918 h 4383"/>
                  <a:gd name="connsiteX14" fmla="*/ 1359 w 4041"/>
                  <a:gd name="connsiteY14" fmla="*/ 2369 h 4383"/>
                  <a:gd name="connsiteX15" fmla="*/ 1985 w 4041"/>
                  <a:gd name="connsiteY15" fmla="*/ 2369 h 4383"/>
                  <a:gd name="connsiteX16" fmla="*/ 2721 w 4041"/>
                  <a:gd name="connsiteY16" fmla="*/ 3124 h 4383"/>
                  <a:gd name="connsiteX17" fmla="*/ 2941 w 4041"/>
                  <a:gd name="connsiteY17" fmla="*/ 3124 h 4383"/>
                  <a:gd name="connsiteX18" fmla="*/ 2941 w 4041"/>
                  <a:gd name="connsiteY18" fmla="*/ 1381 h 4383"/>
                  <a:gd name="connsiteX19" fmla="*/ 2721 w 4041"/>
                  <a:gd name="connsiteY19" fmla="*/ 1381 h 4383"/>
                  <a:gd name="connsiteX20" fmla="*/ 1985 w 4041"/>
                  <a:gd name="connsiteY20" fmla="*/ 2136 h 4383"/>
                  <a:gd name="connsiteX21" fmla="*/ 1359 w 4041"/>
                  <a:gd name="connsiteY21" fmla="*/ 2136 h 4383"/>
                  <a:gd name="connsiteX22" fmla="*/ 1359 w 4041"/>
                  <a:gd name="connsiteY22" fmla="*/ 548 h 4383"/>
                  <a:gd name="connsiteX23" fmla="*/ 1669 w 4041"/>
                  <a:gd name="connsiteY23" fmla="*/ 297 h 4383"/>
                  <a:gd name="connsiteX24" fmla="*/ 2573 w 4041"/>
                  <a:gd name="connsiteY24" fmla="*/ 297 h 4383"/>
                  <a:gd name="connsiteX25" fmla="*/ 3903 w 4041"/>
                  <a:gd name="connsiteY25" fmla="*/ 1549 h 4383"/>
                  <a:gd name="connsiteX26" fmla="*/ 4122 w 4041"/>
                  <a:gd name="connsiteY26" fmla="*/ 1549 h 4383"/>
                  <a:gd name="connsiteX27" fmla="*/ 3928 w 4041"/>
                  <a:gd name="connsiteY27" fmla="*/ 64 h 43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</a:cxnLst>
                <a:rect l="l" t="t" r="r" b="b"/>
                <a:pathLst>
                  <a:path w="4041" h="4383">
                    <a:moveTo>
                      <a:pt x="3928" y="64"/>
                    </a:moveTo>
                    <a:lnTo>
                      <a:pt x="81" y="64"/>
                    </a:lnTo>
                    <a:lnTo>
                      <a:pt x="81" y="297"/>
                    </a:lnTo>
                    <a:lnTo>
                      <a:pt x="236" y="297"/>
                    </a:lnTo>
                    <a:cubicBezTo>
                      <a:pt x="733" y="297"/>
                      <a:pt x="746" y="361"/>
                      <a:pt x="746" y="587"/>
                    </a:cubicBezTo>
                    <a:lnTo>
                      <a:pt x="746" y="3925"/>
                    </a:lnTo>
                    <a:cubicBezTo>
                      <a:pt x="746" y="4144"/>
                      <a:pt x="733" y="4215"/>
                      <a:pt x="236" y="4215"/>
                    </a:cubicBezTo>
                    <a:lnTo>
                      <a:pt x="81" y="4215"/>
                    </a:lnTo>
                    <a:lnTo>
                      <a:pt x="81" y="4448"/>
                    </a:lnTo>
                    <a:cubicBezTo>
                      <a:pt x="87" y="4448"/>
                      <a:pt x="817" y="4422"/>
                      <a:pt x="1062" y="4422"/>
                    </a:cubicBezTo>
                    <a:cubicBezTo>
                      <a:pt x="1327" y="4422"/>
                      <a:pt x="2095" y="4441"/>
                      <a:pt x="2192" y="4448"/>
                    </a:cubicBezTo>
                    <a:lnTo>
                      <a:pt x="2192" y="4215"/>
                    </a:lnTo>
                    <a:lnTo>
                      <a:pt x="1966" y="4215"/>
                    </a:lnTo>
                    <a:cubicBezTo>
                      <a:pt x="1359" y="4215"/>
                      <a:pt x="1359" y="4131"/>
                      <a:pt x="1359" y="3918"/>
                    </a:cubicBezTo>
                    <a:lnTo>
                      <a:pt x="1359" y="2369"/>
                    </a:lnTo>
                    <a:lnTo>
                      <a:pt x="1985" y="2369"/>
                    </a:lnTo>
                    <a:cubicBezTo>
                      <a:pt x="2631" y="2369"/>
                      <a:pt x="2721" y="2563"/>
                      <a:pt x="2721" y="3124"/>
                    </a:cubicBezTo>
                    <a:lnTo>
                      <a:pt x="2941" y="3124"/>
                    </a:lnTo>
                    <a:lnTo>
                      <a:pt x="2941" y="1381"/>
                    </a:lnTo>
                    <a:lnTo>
                      <a:pt x="2721" y="1381"/>
                    </a:lnTo>
                    <a:cubicBezTo>
                      <a:pt x="2721" y="1936"/>
                      <a:pt x="2631" y="2136"/>
                      <a:pt x="1985" y="2136"/>
                    </a:cubicBezTo>
                    <a:lnTo>
                      <a:pt x="1359" y="2136"/>
                    </a:lnTo>
                    <a:lnTo>
                      <a:pt x="1359" y="548"/>
                    </a:lnTo>
                    <a:cubicBezTo>
                      <a:pt x="1359" y="348"/>
                      <a:pt x="1366" y="297"/>
                      <a:pt x="1669" y="297"/>
                    </a:cubicBezTo>
                    <a:lnTo>
                      <a:pt x="2573" y="297"/>
                    </a:lnTo>
                    <a:cubicBezTo>
                      <a:pt x="3612" y="297"/>
                      <a:pt x="3786" y="645"/>
                      <a:pt x="3903" y="1549"/>
                    </a:cubicBezTo>
                    <a:lnTo>
                      <a:pt x="4122" y="1549"/>
                    </a:lnTo>
                    <a:lnTo>
                      <a:pt x="3928" y="64"/>
                    </a:ln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73" name="Freeform: Shape 172">
                <a:extLst>
                  <a:ext uri="{FF2B5EF4-FFF2-40B4-BE49-F238E27FC236}">
                    <a16:creationId xmlns:a16="http://schemas.microsoft.com/office/drawing/2014/main" id="{07E0EB6C-958F-AC06-5134-FF37AECA231E}"/>
                  </a:ext>
                </a:extLst>
              </p:cNvPr>
              <p:cNvSpPr/>
              <p:nvPr>
                <p:custDataLst>
                  <p:tags r:id="rId25"/>
                </p:custDataLst>
              </p:nvPr>
            </p:nvSpPr>
            <p:spPr>
              <a:xfrm>
                <a:off x="4582972" y="294157"/>
                <a:ext cx="2139" cy="9222"/>
              </a:xfrm>
              <a:custGeom>
                <a:avLst/>
                <a:gdLst>
                  <a:gd name="connsiteX0" fmla="*/ 2226 w 2139"/>
                  <a:gd name="connsiteY0" fmla="*/ 9193 h 9222"/>
                  <a:gd name="connsiteX1" fmla="*/ 2069 w 2139"/>
                  <a:gd name="connsiteY1" fmla="*/ 8990 h 9222"/>
                  <a:gd name="connsiteX2" fmla="*/ 621 w 2139"/>
                  <a:gd name="connsiteY2" fmla="*/ 4674 h 9222"/>
                  <a:gd name="connsiteX3" fmla="*/ 2106 w 2139"/>
                  <a:gd name="connsiteY3" fmla="*/ 312 h 9222"/>
                  <a:gd name="connsiteX4" fmla="*/ 2226 w 2139"/>
                  <a:gd name="connsiteY4" fmla="*/ 155 h 9222"/>
                  <a:gd name="connsiteX5" fmla="*/ 2134 w 2139"/>
                  <a:gd name="connsiteY5" fmla="*/ 63 h 9222"/>
                  <a:gd name="connsiteX6" fmla="*/ 668 w 2139"/>
                  <a:gd name="connsiteY6" fmla="*/ 1861 h 9222"/>
                  <a:gd name="connsiteX7" fmla="*/ 87 w 2139"/>
                  <a:gd name="connsiteY7" fmla="*/ 4674 h 9222"/>
                  <a:gd name="connsiteX8" fmla="*/ 695 w 2139"/>
                  <a:gd name="connsiteY8" fmla="*/ 7551 h 9222"/>
                  <a:gd name="connsiteX9" fmla="*/ 2134 w 2139"/>
                  <a:gd name="connsiteY9" fmla="*/ 9285 h 9222"/>
                  <a:gd name="connsiteX10" fmla="*/ 2226 w 2139"/>
                  <a:gd name="connsiteY10" fmla="*/ 9193 h 92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2139" h="9222">
                    <a:moveTo>
                      <a:pt x="2226" y="9193"/>
                    </a:moveTo>
                    <a:cubicBezTo>
                      <a:pt x="2226" y="9165"/>
                      <a:pt x="2226" y="9147"/>
                      <a:pt x="2069" y="8990"/>
                    </a:cubicBezTo>
                    <a:cubicBezTo>
                      <a:pt x="917" y="7828"/>
                      <a:pt x="621" y="6085"/>
                      <a:pt x="621" y="4674"/>
                    </a:cubicBezTo>
                    <a:cubicBezTo>
                      <a:pt x="621" y="3069"/>
                      <a:pt x="972" y="1465"/>
                      <a:pt x="2106" y="312"/>
                    </a:cubicBezTo>
                    <a:cubicBezTo>
                      <a:pt x="2226" y="201"/>
                      <a:pt x="2226" y="183"/>
                      <a:pt x="2226" y="155"/>
                    </a:cubicBezTo>
                    <a:cubicBezTo>
                      <a:pt x="2226" y="90"/>
                      <a:pt x="2189" y="63"/>
                      <a:pt x="2134" y="63"/>
                    </a:cubicBezTo>
                    <a:cubicBezTo>
                      <a:pt x="2042" y="63"/>
                      <a:pt x="1212" y="690"/>
                      <a:pt x="668" y="1861"/>
                    </a:cubicBezTo>
                    <a:cubicBezTo>
                      <a:pt x="197" y="2876"/>
                      <a:pt x="87" y="3899"/>
                      <a:pt x="87" y="4674"/>
                    </a:cubicBezTo>
                    <a:cubicBezTo>
                      <a:pt x="87" y="5393"/>
                      <a:pt x="188" y="6509"/>
                      <a:pt x="695" y="7551"/>
                    </a:cubicBezTo>
                    <a:cubicBezTo>
                      <a:pt x="1249" y="8685"/>
                      <a:pt x="2042" y="9285"/>
                      <a:pt x="2134" y="9285"/>
                    </a:cubicBezTo>
                    <a:cubicBezTo>
                      <a:pt x="2189" y="9285"/>
                      <a:pt x="2226" y="9257"/>
                      <a:pt x="2226" y="9193"/>
                    </a:cubicBez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78" name="Freeform: Shape 177">
                <a:extLst>
                  <a:ext uri="{FF2B5EF4-FFF2-40B4-BE49-F238E27FC236}">
                    <a16:creationId xmlns:a16="http://schemas.microsoft.com/office/drawing/2014/main" id="{283D0BCE-B34E-7A02-3E6A-1E658BC1A4BC}"/>
                  </a:ext>
                </a:extLst>
              </p:cNvPr>
              <p:cNvSpPr/>
              <p:nvPr>
                <p:custDataLst>
                  <p:tags r:id="rId26"/>
                </p:custDataLst>
              </p:nvPr>
            </p:nvSpPr>
            <p:spPr>
              <a:xfrm>
                <a:off x="4586134" y="294572"/>
                <a:ext cx="4601" cy="8392"/>
              </a:xfrm>
              <a:custGeom>
                <a:avLst/>
                <a:gdLst>
                  <a:gd name="connsiteX0" fmla="*/ 2986 w 4601"/>
                  <a:gd name="connsiteY0" fmla="*/ 2875 h 8392"/>
                  <a:gd name="connsiteX1" fmla="*/ 3779 w 4601"/>
                  <a:gd name="connsiteY1" fmla="*/ 2875 h 8392"/>
                  <a:gd name="connsiteX2" fmla="*/ 4056 w 4601"/>
                  <a:gd name="connsiteY2" fmla="*/ 2691 h 8392"/>
                  <a:gd name="connsiteX3" fmla="*/ 3807 w 4601"/>
                  <a:gd name="connsiteY3" fmla="*/ 2590 h 8392"/>
                  <a:gd name="connsiteX4" fmla="*/ 3042 w 4601"/>
                  <a:gd name="connsiteY4" fmla="*/ 2590 h 8392"/>
                  <a:gd name="connsiteX5" fmla="*/ 3235 w 4601"/>
                  <a:gd name="connsiteY5" fmla="*/ 1538 h 8392"/>
                  <a:gd name="connsiteX6" fmla="*/ 3457 w 4601"/>
                  <a:gd name="connsiteY6" fmla="*/ 579 h 8392"/>
                  <a:gd name="connsiteX7" fmla="*/ 3890 w 4601"/>
                  <a:gd name="connsiteY7" fmla="*/ 266 h 8392"/>
                  <a:gd name="connsiteX8" fmla="*/ 4342 w 4601"/>
                  <a:gd name="connsiteY8" fmla="*/ 432 h 8392"/>
                  <a:gd name="connsiteX9" fmla="*/ 3844 w 4601"/>
                  <a:gd name="connsiteY9" fmla="*/ 930 h 8392"/>
                  <a:gd name="connsiteX10" fmla="*/ 4185 w 4601"/>
                  <a:gd name="connsiteY10" fmla="*/ 1252 h 8392"/>
                  <a:gd name="connsiteX11" fmla="*/ 4692 w 4601"/>
                  <a:gd name="connsiteY11" fmla="*/ 699 h 8392"/>
                  <a:gd name="connsiteX12" fmla="*/ 3890 w 4601"/>
                  <a:gd name="connsiteY12" fmla="*/ 63 h 8392"/>
                  <a:gd name="connsiteX13" fmla="*/ 2719 w 4601"/>
                  <a:gd name="connsiteY13" fmla="*/ 1142 h 8392"/>
                  <a:gd name="connsiteX14" fmla="*/ 2414 w 4601"/>
                  <a:gd name="connsiteY14" fmla="*/ 2590 h 8392"/>
                  <a:gd name="connsiteX15" fmla="*/ 1778 w 4601"/>
                  <a:gd name="connsiteY15" fmla="*/ 2590 h 8392"/>
                  <a:gd name="connsiteX16" fmla="*/ 1501 w 4601"/>
                  <a:gd name="connsiteY16" fmla="*/ 2765 h 8392"/>
                  <a:gd name="connsiteX17" fmla="*/ 1760 w 4601"/>
                  <a:gd name="connsiteY17" fmla="*/ 2875 h 8392"/>
                  <a:gd name="connsiteX18" fmla="*/ 2368 w 4601"/>
                  <a:gd name="connsiteY18" fmla="*/ 2875 h 8392"/>
                  <a:gd name="connsiteX19" fmla="*/ 1677 w 4601"/>
                  <a:gd name="connsiteY19" fmla="*/ 6518 h 8392"/>
                  <a:gd name="connsiteX20" fmla="*/ 874 w 4601"/>
                  <a:gd name="connsiteY20" fmla="*/ 8252 h 8392"/>
                  <a:gd name="connsiteX21" fmla="*/ 432 w 4601"/>
                  <a:gd name="connsiteY21" fmla="*/ 8086 h 8392"/>
                  <a:gd name="connsiteX22" fmla="*/ 939 w 4601"/>
                  <a:gd name="connsiteY22" fmla="*/ 7588 h 8392"/>
                  <a:gd name="connsiteX23" fmla="*/ 598 w 4601"/>
                  <a:gd name="connsiteY23" fmla="*/ 7265 h 8392"/>
                  <a:gd name="connsiteX24" fmla="*/ 90 w 4601"/>
                  <a:gd name="connsiteY24" fmla="*/ 7819 h 8392"/>
                  <a:gd name="connsiteX25" fmla="*/ 874 w 4601"/>
                  <a:gd name="connsiteY25" fmla="*/ 8455 h 8392"/>
                  <a:gd name="connsiteX26" fmla="*/ 1916 w 4601"/>
                  <a:gd name="connsiteY26" fmla="*/ 7560 h 8392"/>
                  <a:gd name="connsiteX27" fmla="*/ 2433 w 4601"/>
                  <a:gd name="connsiteY27" fmla="*/ 5799 h 8392"/>
                  <a:gd name="connsiteX28" fmla="*/ 2986 w 4601"/>
                  <a:gd name="connsiteY28" fmla="*/ 2875 h 83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4601" h="8392">
                    <a:moveTo>
                      <a:pt x="2986" y="2875"/>
                    </a:moveTo>
                    <a:lnTo>
                      <a:pt x="3779" y="2875"/>
                    </a:lnTo>
                    <a:cubicBezTo>
                      <a:pt x="3964" y="2875"/>
                      <a:pt x="4056" y="2875"/>
                      <a:pt x="4056" y="2691"/>
                    </a:cubicBezTo>
                    <a:cubicBezTo>
                      <a:pt x="4056" y="2590"/>
                      <a:pt x="3964" y="2590"/>
                      <a:pt x="3807" y="2590"/>
                    </a:cubicBezTo>
                    <a:lnTo>
                      <a:pt x="3042" y="2590"/>
                    </a:lnTo>
                    <a:lnTo>
                      <a:pt x="3235" y="1538"/>
                    </a:lnTo>
                    <a:cubicBezTo>
                      <a:pt x="3272" y="1345"/>
                      <a:pt x="3401" y="690"/>
                      <a:pt x="3457" y="579"/>
                    </a:cubicBezTo>
                    <a:cubicBezTo>
                      <a:pt x="3540" y="404"/>
                      <a:pt x="3696" y="266"/>
                      <a:pt x="3890" y="266"/>
                    </a:cubicBezTo>
                    <a:cubicBezTo>
                      <a:pt x="3927" y="266"/>
                      <a:pt x="4167" y="266"/>
                      <a:pt x="4342" y="432"/>
                    </a:cubicBezTo>
                    <a:cubicBezTo>
                      <a:pt x="3936" y="469"/>
                      <a:pt x="3844" y="791"/>
                      <a:pt x="3844" y="930"/>
                    </a:cubicBezTo>
                    <a:cubicBezTo>
                      <a:pt x="3844" y="1142"/>
                      <a:pt x="4010" y="1252"/>
                      <a:pt x="4185" y="1252"/>
                    </a:cubicBezTo>
                    <a:cubicBezTo>
                      <a:pt x="4425" y="1252"/>
                      <a:pt x="4692" y="1050"/>
                      <a:pt x="4692" y="699"/>
                    </a:cubicBezTo>
                    <a:cubicBezTo>
                      <a:pt x="4692" y="275"/>
                      <a:pt x="4268" y="63"/>
                      <a:pt x="3890" y="63"/>
                    </a:cubicBezTo>
                    <a:cubicBezTo>
                      <a:pt x="3576" y="63"/>
                      <a:pt x="2995" y="229"/>
                      <a:pt x="2719" y="1142"/>
                    </a:cubicBezTo>
                    <a:cubicBezTo>
                      <a:pt x="2663" y="1335"/>
                      <a:pt x="2636" y="1428"/>
                      <a:pt x="2414" y="2590"/>
                    </a:cubicBezTo>
                    <a:lnTo>
                      <a:pt x="1778" y="2590"/>
                    </a:lnTo>
                    <a:cubicBezTo>
                      <a:pt x="1603" y="2590"/>
                      <a:pt x="1501" y="2590"/>
                      <a:pt x="1501" y="2765"/>
                    </a:cubicBezTo>
                    <a:cubicBezTo>
                      <a:pt x="1501" y="2875"/>
                      <a:pt x="1584" y="2875"/>
                      <a:pt x="1760" y="2875"/>
                    </a:cubicBezTo>
                    <a:lnTo>
                      <a:pt x="2368" y="2875"/>
                    </a:lnTo>
                    <a:lnTo>
                      <a:pt x="1677" y="6518"/>
                    </a:lnTo>
                    <a:cubicBezTo>
                      <a:pt x="1511" y="7413"/>
                      <a:pt x="1354" y="8252"/>
                      <a:pt x="874" y="8252"/>
                    </a:cubicBezTo>
                    <a:cubicBezTo>
                      <a:pt x="837" y="8252"/>
                      <a:pt x="607" y="8252"/>
                      <a:pt x="432" y="8086"/>
                    </a:cubicBezTo>
                    <a:cubicBezTo>
                      <a:pt x="856" y="8058"/>
                      <a:pt x="939" y="7726"/>
                      <a:pt x="939" y="7588"/>
                    </a:cubicBezTo>
                    <a:cubicBezTo>
                      <a:pt x="939" y="7376"/>
                      <a:pt x="773" y="7265"/>
                      <a:pt x="598" y="7265"/>
                    </a:cubicBezTo>
                    <a:cubicBezTo>
                      <a:pt x="358" y="7265"/>
                      <a:pt x="90" y="7468"/>
                      <a:pt x="90" y="7819"/>
                    </a:cubicBezTo>
                    <a:cubicBezTo>
                      <a:pt x="90" y="8234"/>
                      <a:pt x="496" y="8455"/>
                      <a:pt x="874" y="8455"/>
                    </a:cubicBezTo>
                    <a:cubicBezTo>
                      <a:pt x="1382" y="8455"/>
                      <a:pt x="1750" y="7911"/>
                      <a:pt x="1916" y="7560"/>
                    </a:cubicBezTo>
                    <a:cubicBezTo>
                      <a:pt x="2212" y="6979"/>
                      <a:pt x="2424" y="5863"/>
                      <a:pt x="2433" y="5799"/>
                    </a:cubicBezTo>
                    <a:lnTo>
                      <a:pt x="2986" y="2875"/>
                    </a:ln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79" name="Freeform: Shape 178">
                <a:extLst>
                  <a:ext uri="{FF2B5EF4-FFF2-40B4-BE49-F238E27FC236}">
                    <a16:creationId xmlns:a16="http://schemas.microsoft.com/office/drawing/2014/main" id="{8C1D6E48-8D4D-24B9-F2EA-AEC35DF7E508}"/>
                  </a:ext>
                </a:extLst>
              </p:cNvPr>
              <p:cNvSpPr/>
              <p:nvPr>
                <p:custDataLst>
                  <p:tags r:id="rId27"/>
                </p:custDataLst>
              </p:nvPr>
            </p:nvSpPr>
            <p:spPr>
              <a:xfrm>
                <a:off x="4591434" y="300096"/>
                <a:ext cx="1079" cy="2757"/>
              </a:xfrm>
              <a:custGeom>
                <a:avLst/>
                <a:gdLst>
                  <a:gd name="connsiteX0" fmla="*/ 1175 w 1079"/>
                  <a:gd name="connsiteY0" fmla="*/ 1031 h 2757"/>
                  <a:gd name="connsiteX1" fmla="*/ 585 w 1079"/>
                  <a:gd name="connsiteY1" fmla="*/ 63 h 2757"/>
                  <a:gd name="connsiteX2" fmla="*/ 96 w 1079"/>
                  <a:gd name="connsiteY2" fmla="*/ 552 h 2757"/>
                  <a:gd name="connsiteX3" fmla="*/ 585 w 1079"/>
                  <a:gd name="connsiteY3" fmla="*/ 1040 h 2757"/>
                  <a:gd name="connsiteX4" fmla="*/ 907 w 1079"/>
                  <a:gd name="connsiteY4" fmla="*/ 920 h 2757"/>
                  <a:gd name="connsiteX5" fmla="*/ 953 w 1079"/>
                  <a:gd name="connsiteY5" fmla="*/ 893 h 2757"/>
                  <a:gd name="connsiteX6" fmla="*/ 972 w 1079"/>
                  <a:gd name="connsiteY6" fmla="*/ 1031 h 2757"/>
                  <a:gd name="connsiteX7" fmla="*/ 345 w 1079"/>
                  <a:gd name="connsiteY7" fmla="*/ 2571 h 2757"/>
                  <a:gd name="connsiteX8" fmla="*/ 243 w 1079"/>
                  <a:gd name="connsiteY8" fmla="*/ 2719 h 2757"/>
                  <a:gd name="connsiteX9" fmla="*/ 336 w 1079"/>
                  <a:gd name="connsiteY9" fmla="*/ 2820 h 2757"/>
                  <a:gd name="connsiteX10" fmla="*/ 1175 w 1079"/>
                  <a:gd name="connsiteY10" fmla="*/ 1031 h 275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1079" h="2757">
                    <a:moveTo>
                      <a:pt x="1175" y="1031"/>
                    </a:moveTo>
                    <a:cubicBezTo>
                      <a:pt x="1175" y="422"/>
                      <a:pt x="944" y="63"/>
                      <a:pt x="585" y="63"/>
                    </a:cubicBezTo>
                    <a:cubicBezTo>
                      <a:pt x="280" y="63"/>
                      <a:pt x="96" y="293"/>
                      <a:pt x="96" y="552"/>
                    </a:cubicBezTo>
                    <a:cubicBezTo>
                      <a:pt x="96" y="801"/>
                      <a:pt x="280" y="1040"/>
                      <a:pt x="585" y="1040"/>
                    </a:cubicBezTo>
                    <a:cubicBezTo>
                      <a:pt x="695" y="1040"/>
                      <a:pt x="815" y="1003"/>
                      <a:pt x="907" y="920"/>
                    </a:cubicBezTo>
                    <a:cubicBezTo>
                      <a:pt x="935" y="902"/>
                      <a:pt x="944" y="893"/>
                      <a:pt x="953" y="893"/>
                    </a:cubicBezTo>
                    <a:cubicBezTo>
                      <a:pt x="963" y="893"/>
                      <a:pt x="972" y="902"/>
                      <a:pt x="972" y="1031"/>
                    </a:cubicBezTo>
                    <a:cubicBezTo>
                      <a:pt x="972" y="1714"/>
                      <a:pt x="649" y="2267"/>
                      <a:pt x="345" y="2571"/>
                    </a:cubicBezTo>
                    <a:cubicBezTo>
                      <a:pt x="243" y="2673"/>
                      <a:pt x="243" y="2691"/>
                      <a:pt x="243" y="2719"/>
                    </a:cubicBezTo>
                    <a:cubicBezTo>
                      <a:pt x="243" y="2783"/>
                      <a:pt x="289" y="2820"/>
                      <a:pt x="336" y="2820"/>
                    </a:cubicBezTo>
                    <a:cubicBezTo>
                      <a:pt x="437" y="2820"/>
                      <a:pt x="1175" y="2110"/>
                      <a:pt x="1175" y="1031"/>
                    </a:cubicBez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80" name="Freeform: Shape 179">
                <a:extLst>
                  <a:ext uri="{FF2B5EF4-FFF2-40B4-BE49-F238E27FC236}">
                    <a16:creationId xmlns:a16="http://schemas.microsoft.com/office/drawing/2014/main" id="{A83DF860-018B-44BD-D997-81178F71F4A2}"/>
                  </a:ext>
                </a:extLst>
              </p:cNvPr>
              <p:cNvSpPr/>
              <p:nvPr>
                <p:custDataLst>
                  <p:tags r:id="rId28"/>
                </p:custDataLst>
              </p:nvPr>
            </p:nvSpPr>
            <p:spPr>
              <a:xfrm>
                <a:off x="4597796" y="292240"/>
                <a:ext cx="2462" cy="1420"/>
              </a:xfrm>
              <a:custGeom>
                <a:avLst/>
                <a:gdLst>
                  <a:gd name="connsiteX0" fmla="*/ 1338 w 2462"/>
                  <a:gd name="connsiteY0" fmla="*/ 60 h 1420"/>
                  <a:gd name="connsiteX1" fmla="*/ 102 w 2462"/>
                  <a:gd name="connsiteY1" fmla="*/ 1314 h 1420"/>
                  <a:gd name="connsiteX2" fmla="*/ 268 w 2462"/>
                  <a:gd name="connsiteY2" fmla="*/ 1480 h 1420"/>
                  <a:gd name="connsiteX3" fmla="*/ 1338 w 2462"/>
                  <a:gd name="connsiteY3" fmla="*/ 540 h 1420"/>
                  <a:gd name="connsiteX4" fmla="*/ 2399 w 2462"/>
                  <a:gd name="connsiteY4" fmla="*/ 1480 h 1420"/>
                  <a:gd name="connsiteX5" fmla="*/ 2565 w 2462"/>
                  <a:gd name="connsiteY5" fmla="*/ 1314 h 1420"/>
                  <a:gd name="connsiteX6" fmla="*/ 1338 w 2462"/>
                  <a:gd name="connsiteY6" fmla="*/ 60 h 142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462" h="1420">
                    <a:moveTo>
                      <a:pt x="1338" y="60"/>
                    </a:moveTo>
                    <a:lnTo>
                      <a:pt x="102" y="1314"/>
                    </a:lnTo>
                    <a:lnTo>
                      <a:pt x="268" y="1480"/>
                    </a:lnTo>
                    <a:lnTo>
                      <a:pt x="1338" y="540"/>
                    </a:lnTo>
                    <a:lnTo>
                      <a:pt x="2399" y="1480"/>
                    </a:lnTo>
                    <a:lnTo>
                      <a:pt x="2565" y="1314"/>
                    </a:lnTo>
                    <a:lnTo>
                      <a:pt x="1338" y="60"/>
                    </a:ln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81" name="Freeform: Shape 180">
                <a:extLst>
                  <a:ext uri="{FF2B5EF4-FFF2-40B4-BE49-F238E27FC236}">
                    <a16:creationId xmlns:a16="http://schemas.microsoft.com/office/drawing/2014/main" id="{882E43A9-6461-55ED-2A8E-1A8CF6E74728}"/>
                  </a:ext>
                </a:extLst>
              </p:cNvPr>
              <p:cNvSpPr/>
              <p:nvPr>
                <p:custDataLst>
                  <p:tags r:id="rId29"/>
                </p:custDataLst>
              </p:nvPr>
            </p:nvSpPr>
            <p:spPr>
              <a:xfrm>
                <a:off x="4595229" y="294572"/>
                <a:ext cx="4601" cy="8392"/>
              </a:xfrm>
              <a:custGeom>
                <a:avLst/>
                <a:gdLst>
                  <a:gd name="connsiteX0" fmla="*/ 2996 w 4601"/>
                  <a:gd name="connsiteY0" fmla="*/ 2875 h 8392"/>
                  <a:gd name="connsiteX1" fmla="*/ 3789 w 4601"/>
                  <a:gd name="connsiteY1" fmla="*/ 2875 h 8392"/>
                  <a:gd name="connsiteX2" fmla="*/ 4066 w 4601"/>
                  <a:gd name="connsiteY2" fmla="*/ 2691 h 8392"/>
                  <a:gd name="connsiteX3" fmla="*/ 3817 w 4601"/>
                  <a:gd name="connsiteY3" fmla="*/ 2590 h 8392"/>
                  <a:gd name="connsiteX4" fmla="*/ 3051 w 4601"/>
                  <a:gd name="connsiteY4" fmla="*/ 2590 h 8392"/>
                  <a:gd name="connsiteX5" fmla="*/ 3245 w 4601"/>
                  <a:gd name="connsiteY5" fmla="*/ 1538 h 8392"/>
                  <a:gd name="connsiteX6" fmla="*/ 3466 w 4601"/>
                  <a:gd name="connsiteY6" fmla="*/ 579 h 8392"/>
                  <a:gd name="connsiteX7" fmla="*/ 3900 w 4601"/>
                  <a:gd name="connsiteY7" fmla="*/ 266 h 8392"/>
                  <a:gd name="connsiteX8" fmla="*/ 4352 w 4601"/>
                  <a:gd name="connsiteY8" fmla="*/ 432 h 8392"/>
                  <a:gd name="connsiteX9" fmla="*/ 3854 w 4601"/>
                  <a:gd name="connsiteY9" fmla="*/ 930 h 8392"/>
                  <a:gd name="connsiteX10" fmla="*/ 4195 w 4601"/>
                  <a:gd name="connsiteY10" fmla="*/ 1252 h 8392"/>
                  <a:gd name="connsiteX11" fmla="*/ 4702 w 4601"/>
                  <a:gd name="connsiteY11" fmla="*/ 699 h 8392"/>
                  <a:gd name="connsiteX12" fmla="*/ 3900 w 4601"/>
                  <a:gd name="connsiteY12" fmla="*/ 63 h 8392"/>
                  <a:gd name="connsiteX13" fmla="*/ 2729 w 4601"/>
                  <a:gd name="connsiteY13" fmla="*/ 1142 h 8392"/>
                  <a:gd name="connsiteX14" fmla="*/ 2424 w 4601"/>
                  <a:gd name="connsiteY14" fmla="*/ 2590 h 8392"/>
                  <a:gd name="connsiteX15" fmla="*/ 1788 w 4601"/>
                  <a:gd name="connsiteY15" fmla="*/ 2590 h 8392"/>
                  <a:gd name="connsiteX16" fmla="*/ 1511 w 4601"/>
                  <a:gd name="connsiteY16" fmla="*/ 2765 h 8392"/>
                  <a:gd name="connsiteX17" fmla="*/ 1769 w 4601"/>
                  <a:gd name="connsiteY17" fmla="*/ 2875 h 8392"/>
                  <a:gd name="connsiteX18" fmla="*/ 2378 w 4601"/>
                  <a:gd name="connsiteY18" fmla="*/ 2875 h 8392"/>
                  <a:gd name="connsiteX19" fmla="*/ 1686 w 4601"/>
                  <a:gd name="connsiteY19" fmla="*/ 6518 h 8392"/>
                  <a:gd name="connsiteX20" fmla="*/ 884 w 4601"/>
                  <a:gd name="connsiteY20" fmla="*/ 8252 h 8392"/>
                  <a:gd name="connsiteX21" fmla="*/ 441 w 4601"/>
                  <a:gd name="connsiteY21" fmla="*/ 8086 h 8392"/>
                  <a:gd name="connsiteX22" fmla="*/ 949 w 4601"/>
                  <a:gd name="connsiteY22" fmla="*/ 7588 h 8392"/>
                  <a:gd name="connsiteX23" fmla="*/ 607 w 4601"/>
                  <a:gd name="connsiteY23" fmla="*/ 7265 h 8392"/>
                  <a:gd name="connsiteX24" fmla="*/ 100 w 4601"/>
                  <a:gd name="connsiteY24" fmla="*/ 7819 h 8392"/>
                  <a:gd name="connsiteX25" fmla="*/ 884 w 4601"/>
                  <a:gd name="connsiteY25" fmla="*/ 8455 h 8392"/>
                  <a:gd name="connsiteX26" fmla="*/ 1926 w 4601"/>
                  <a:gd name="connsiteY26" fmla="*/ 7560 h 8392"/>
                  <a:gd name="connsiteX27" fmla="*/ 2443 w 4601"/>
                  <a:gd name="connsiteY27" fmla="*/ 5799 h 8392"/>
                  <a:gd name="connsiteX28" fmla="*/ 2996 w 4601"/>
                  <a:gd name="connsiteY28" fmla="*/ 2875 h 83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4601" h="8392">
                    <a:moveTo>
                      <a:pt x="2996" y="2875"/>
                    </a:moveTo>
                    <a:lnTo>
                      <a:pt x="3789" y="2875"/>
                    </a:lnTo>
                    <a:cubicBezTo>
                      <a:pt x="3974" y="2875"/>
                      <a:pt x="4066" y="2875"/>
                      <a:pt x="4066" y="2691"/>
                    </a:cubicBezTo>
                    <a:cubicBezTo>
                      <a:pt x="4066" y="2590"/>
                      <a:pt x="3974" y="2590"/>
                      <a:pt x="3817" y="2590"/>
                    </a:cubicBezTo>
                    <a:lnTo>
                      <a:pt x="3051" y="2590"/>
                    </a:lnTo>
                    <a:lnTo>
                      <a:pt x="3245" y="1538"/>
                    </a:lnTo>
                    <a:cubicBezTo>
                      <a:pt x="3282" y="1345"/>
                      <a:pt x="3411" y="690"/>
                      <a:pt x="3466" y="579"/>
                    </a:cubicBezTo>
                    <a:cubicBezTo>
                      <a:pt x="3549" y="404"/>
                      <a:pt x="3706" y="266"/>
                      <a:pt x="3900" y="266"/>
                    </a:cubicBezTo>
                    <a:cubicBezTo>
                      <a:pt x="3937" y="266"/>
                      <a:pt x="4176" y="266"/>
                      <a:pt x="4352" y="432"/>
                    </a:cubicBezTo>
                    <a:cubicBezTo>
                      <a:pt x="3946" y="469"/>
                      <a:pt x="3854" y="791"/>
                      <a:pt x="3854" y="930"/>
                    </a:cubicBezTo>
                    <a:cubicBezTo>
                      <a:pt x="3854" y="1142"/>
                      <a:pt x="4020" y="1252"/>
                      <a:pt x="4195" y="1252"/>
                    </a:cubicBezTo>
                    <a:cubicBezTo>
                      <a:pt x="4435" y="1252"/>
                      <a:pt x="4702" y="1050"/>
                      <a:pt x="4702" y="699"/>
                    </a:cubicBezTo>
                    <a:cubicBezTo>
                      <a:pt x="4702" y="275"/>
                      <a:pt x="4278" y="63"/>
                      <a:pt x="3900" y="63"/>
                    </a:cubicBezTo>
                    <a:cubicBezTo>
                      <a:pt x="3586" y="63"/>
                      <a:pt x="3005" y="229"/>
                      <a:pt x="2729" y="1142"/>
                    </a:cubicBezTo>
                    <a:cubicBezTo>
                      <a:pt x="2673" y="1335"/>
                      <a:pt x="2646" y="1428"/>
                      <a:pt x="2424" y="2590"/>
                    </a:cubicBezTo>
                    <a:lnTo>
                      <a:pt x="1788" y="2590"/>
                    </a:lnTo>
                    <a:cubicBezTo>
                      <a:pt x="1613" y="2590"/>
                      <a:pt x="1511" y="2590"/>
                      <a:pt x="1511" y="2765"/>
                    </a:cubicBezTo>
                    <a:cubicBezTo>
                      <a:pt x="1511" y="2875"/>
                      <a:pt x="1594" y="2875"/>
                      <a:pt x="1769" y="2875"/>
                    </a:cubicBezTo>
                    <a:lnTo>
                      <a:pt x="2378" y="2875"/>
                    </a:lnTo>
                    <a:lnTo>
                      <a:pt x="1686" y="6518"/>
                    </a:lnTo>
                    <a:cubicBezTo>
                      <a:pt x="1520" y="7413"/>
                      <a:pt x="1364" y="8252"/>
                      <a:pt x="884" y="8252"/>
                    </a:cubicBezTo>
                    <a:cubicBezTo>
                      <a:pt x="847" y="8252"/>
                      <a:pt x="617" y="8252"/>
                      <a:pt x="441" y="8086"/>
                    </a:cubicBezTo>
                    <a:cubicBezTo>
                      <a:pt x="866" y="8058"/>
                      <a:pt x="949" y="7726"/>
                      <a:pt x="949" y="7588"/>
                    </a:cubicBezTo>
                    <a:cubicBezTo>
                      <a:pt x="949" y="7376"/>
                      <a:pt x="783" y="7265"/>
                      <a:pt x="607" y="7265"/>
                    </a:cubicBezTo>
                    <a:cubicBezTo>
                      <a:pt x="368" y="7265"/>
                      <a:pt x="100" y="7468"/>
                      <a:pt x="100" y="7819"/>
                    </a:cubicBezTo>
                    <a:cubicBezTo>
                      <a:pt x="100" y="8234"/>
                      <a:pt x="506" y="8455"/>
                      <a:pt x="884" y="8455"/>
                    </a:cubicBezTo>
                    <a:cubicBezTo>
                      <a:pt x="1391" y="8455"/>
                      <a:pt x="1760" y="7911"/>
                      <a:pt x="1926" y="7560"/>
                    </a:cubicBezTo>
                    <a:cubicBezTo>
                      <a:pt x="2221" y="6979"/>
                      <a:pt x="2433" y="5863"/>
                      <a:pt x="2443" y="5799"/>
                    </a:cubicBezTo>
                    <a:lnTo>
                      <a:pt x="2996" y="2875"/>
                    </a:ln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82" name="Freeform: Shape 181">
                <a:extLst>
                  <a:ext uri="{FF2B5EF4-FFF2-40B4-BE49-F238E27FC236}">
                    <a16:creationId xmlns:a16="http://schemas.microsoft.com/office/drawing/2014/main" id="{EAE4A069-6D56-2E02-5D74-AF4652B022E8}"/>
                  </a:ext>
                </a:extLst>
              </p:cNvPr>
              <p:cNvSpPr/>
              <p:nvPr>
                <p:custDataLst>
                  <p:tags r:id="rId30"/>
                </p:custDataLst>
              </p:nvPr>
            </p:nvSpPr>
            <p:spPr>
              <a:xfrm>
                <a:off x="4600774" y="294157"/>
                <a:ext cx="2139" cy="9222"/>
              </a:xfrm>
              <a:custGeom>
                <a:avLst/>
                <a:gdLst>
                  <a:gd name="connsiteX0" fmla="*/ 2246 w 2139"/>
                  <a:gd name="connsiteY0" fmla="*/ 4674 h 9222"/>
                  <a:gd name="connsiteX1" fmla="*/ 1637 w 2139"/>
                  <a:gd name="connsiteY1" fmla="*/ 1797 h 9222"/>
                  <a:gd name="connsiteX2" fmla="*/ 198 w 2139"/>
                  <a:gd name="connsiteY2" fmla="*/ 63 h 9222"/>
                  <a:gd name="connsiteX3" fmla="*/ 106 w 2139"/>
                  <a:gd name="connsiteY3" fmla="*/ 155 h 9222"/>
                  <a:gd name="connsiteX4" fmla="*/ 281 w 2139"/>
                  <a:gd name="connsiteY4" fmla="*/ 367 h 9222"/>
                  <a:gd name="connsiteX5" fmla="*/ 1711 w 2139"/>
                  <a:gd name="connsiteY5" fmla="*/ 4674 h 9222"/>
                  <a:gd name="connsiteX6" fmla="*/ 226 w 2139"/>
                  <a:gd name="connsiteY6" fmla="*/ 9036 h 9222"/>
                  <a:gd name="connsiteX7" fmla="*/ 106 w 2139"/>
                  <a:gd name="connsiteY7" fmla="*/ 9193 h 9222"/>
                  <a:gd name="connsiteX8" fmla="*/ 198 w 2139"/>
                  <a:gd name="connsiteY8" fmla="*/ 9285 h 9222"/>
                  <a:gd name="connsiteX9" fmla="*/ 1665 w 2139"/>
                  <a:gd name="connsiteY9" fmla="*/ 7487 h 9222"/>
                  <a:gd name="connsiteX10" fmla="*/ 2246 w 2139"/>
                  <a:gd name="connsiteY10" fmla="*/ 4674 h 92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2139" h="9222">
                    <a:moveTo>
                      <a:pt x="2246" y="4674"/>
                    </a:moveTo>
                    <a:cubicBezTo>
                      <a:pt x="2246" y="3954"/>
                      <a:pt x="2144" y="2839"/>
                      <a:pt x="1637" y="1797"/>
                    </a:cubicBezTo>
                    <a:cubicBezTo>
                      <a:pt x="1084" y="662"/>
                      <a:pt x="291" y="63"/>
                      <a:pt x="198" y="63"/>
                    </a:cubicBezTo>
                    <a:cubicBezTo>
                      <a:pt x="143" y="63"/>
                      <a:pt x="106" y="100"/>
                      <a:pt x="106" y="155"/>
                    </a:cubicBezTo>
                    <a:cubicBezTo>
                      <a:pt x="106" y="183"/>
                      <a:pt x="106" y="201"/>
                      <a:pt x="281" y="367"/>
                    </a:cubicBezTo>
                    <a:cubicBezTo>
                      <a:pt x="1185" y="1280"/>
                      <a:pt x="1711" y="2746"/>
                      <a:pt x="1711" y="4674"/>
                    </a:cubicBezTo>
                    <a:cubicBezTo>
                      <a:pt x="1711" y="6251"/>
                      <a:pt x="1370" y="7874"/>
                      <a:pt x="226" y="9036"/>
                    </a:cubicBezTo>
                    <a:cubicBezTo>
                      <a:pt x="106" y="9147"/>
                      <a:pt x="106" y="9165"/>
                      <a:pt x="106" y="9193"/>
                    </a:cubicBezTo>
                    <a:cubicBezTo>
                      <a:pt x="106" y="9248"/>
                      <a:pt x="143" y="9285"/>
                      <a:pt x="198" y="9285"/>
                    </a:cubicBezTo>
                    <a:cubicBezTo>
                      <a:pt x="291" y="9285"/>
                      <a:pt x="1121" y="8658"/>
                      <a:pt x="1665" y="7487"/>
                    </a:cubicBezTo>
                    <a:cubicBezTo>
                      <a:pt x="2135" y="6472"/>
                      <a:pt x="2246" y="5448"/>
                      <a:pt x="2246" y="4674"/>
                    </a:cubicBez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</p:grp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C90458A3-5F60-105C-E9B9-1E06F69958F8}"/>
                </a:ext>
              </a:extLst>
            </p:cNvPr>
            <p:cNvCxnSpPr>
              <a:cxnSpLocks/>
            </p:cNvCxnSpPr>
            <p:nvPr/>
          </p:nvCxnSpPr>
          <p:spPr>
            <a:xfrm>
              <a:off x="4689942" y="69060"/>
              <a:ext cx="0" cy="176645"/>
            </a:xfrm>
            <a:prstGeom prst="straightConnector1">
              <a:avLst/>
            </a:prstGeom>
            <a:ln w="6350">
              <a:solidFill>
                <a:schemeClr val="tx1"/>
              </a:solidFill>
              <a:prstDash val="dash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57A06FE1-5499-CC0B-0BF5-F29BF0B2AB57}"/>
                </a:ext>
              </a:extLst>
            </p:cNvPr>
            <p:cNvCxnSpPr>
              <a:cxnSpLocks/>
            </p:cNvCxnSpPr>
            <p:nvPr/>
          </p:nvCxnSpPr>
          <p:spPr>
            <a:xfrm>
              <a:off x="2888925" y="68434"/>
              <a:ext cx="1805569" cy="0"/>
            </a:xfrm>
            <a:prstGeom prst="straightConnector1">
              <a:avLst/>
            </a:prstGeom>
            <a:ln w="6350">
              <a:solidFill>
                <a:schemeClr val="tx1"/>
              </a:solidFill>
              <a:prstDash val="dash"/>
              <a:headEnd type="non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D3CDA956-0E75-76EB-C15B-414D3A45601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349853" y="138992"/>
              <a:ext cx="150591" cy="124937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Arc 56">
              <a:extLst>
                <a:ext uri="{FF2B5EF4-FFF2-40B4-BE49-F238E27FC236}">
                  <a16:creationId xmlns:a16="http://schemas.microsoft.com/office/drawing/2014/main" id="{E3159B31-9AD0-146A-81F9-31496761CC63}"/>
                </a:ext>
              </a:extLst>
            </p:cNvPr>
            <p:cNvSpPr/>
            <p:nvPr/>
          </p:nvSpPr>
          <p:spPr>
            <a:xfrm rot="16200000">
              <a:off x="2280212" y="238065"/>
              <a:ext cx="363170" cy="307441"/>
            </a:xfrm>
            <a:prstGeom prst="arc">
              <a:avLst>
                <a:gd name="adj1" fmla="val 16068733"/>
                <a:gd name="adj2" fmla="val 198636"/>
              </a:avLst>
            </a:prstGeom>
            <a:ln>
              <a:solidFill>
                <a:schemeClr val="tx1"/>
              </a:solidFill>
              <a:prstDash val="sysDash"/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63"/>
            </a:p>
          </p:txBody>
        </p: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B4735AE1-ABF5-2D8D-2E1F-8BAE36306E94}"/>
                </a:ext>
              </a:extLst>
            </p:cNvPr>
            <p:cNvCxnSpPr>
              <a:cxnSpLocks/>
            </p:cNvCxnSpPr>
            <p:nvPr/>
          </p:nvCxnSpPr>
          <p:spPr>
            <a:xfrm>
              <a:off x="2888925" y="68110"/>
              <a:ext cx="0" cy="121328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C1CFBAB9-189A-B60C-61D2-CAABE37FEB7B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2399785" y="166363"/>
              <a:ext cx="195131" cy="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oval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6CD3AAD0-CBF1-8C6B-0F87-2A7DA60C21D8}"/>
                </a:ext>
              </a:extLst>
            </p:cNvPr>
            <p:cNvSpPr/>
            <p:nvPr/>
          </p:nvSpPr>
          <p:spPr>
            <a:xfrm>
              <a:off x="4345559" y="806058"/>
              <a:ext cx="608463" cy="2543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E Loss</a:t>
              </a:r>
            </a:p>
          </p:txBody>
        </p:sp>
        <p:pic>
          <p:nvPicPr>
            <p:cNvPr id="79" name="Picture 78">
              <a:extLst>
                <a:ext uri="{FF2B5EF4-FFF2-40B4-BE49-F238E27FC236}">
                  <a16:creationId xmlns:a16="http://schemas.microsoft.com/office/drawing/2014/main" id="{F4A8E330-69EA-034F-40E1-CD8755CEE4EB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313658" y="2727374"/>
              <a:ext cx="648000" cy="648000"/>
            </a:xfrm>
            <a:prstGeom prst="rect">
              <a:avLst/>
            </a:prstGeom>
          </p:spPr>
        </p:pic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56A9E14A-2E73-C508-0924-8AA6E0CAB6B4}"/>
                </a:ext>
              </a:extLst>
            </p:cNvPr>
            <p:cNvSpPr/>
            <p:nvPr/>
          </p:nvSpPr>
          <p:spPr>
            <a:xfrm>
              <a:off x="1156586" y="3338347"/>
              <a:ext cx="962145" cy="2543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ndom snapshot</a:t>
              </a:r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23A2E20F-CAF3-FED4-BB41-206F1A65F126}"/>
                </a:ext>
              </a:extLst>
            </p:cNvPr>
            <p:cNvSpPr/>
            <p:nvPr/>
          </p:nvSpPr>
          <p:spPr>
            <a:xfrm>
              <a:off x="1284508" y="2196103"/>
              <a:ext cx="677391" cy="363172"/>
            </a:xfrm>
            <a:prstGeom prst="rect">
              <a:avLst/>
            </a:prstGeom>
            <a:solidFill>
              <a:srgbClr val="00B0F0">
                <a:alpha val="50000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ocus finder</a:t>
              </a:r>
            </a:p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pretrained)</a:t>
              </a:r>
            </a:p>
          </p:txBody>
        </p:sp>
        <p:cxnSp>
          <p:nvCxnSpPr>
            <p:cNvPr id="82" name="Straight Arrow Connector 81">
              <a:extLst>
                <a:ext uri="{FF2B5EF4-FFF2-40B4-BE49-F238E27FC236}">
                  <a16:creationId xmlns:a16="http://schemas.microsoft.com/office/drawing/2014/main" id="{1CB56258-413D-EB3B-6A99-0CA3824B7068}"/>
                </a:ext>
              </a:extLst>
            </p:cNvPr>
            <p:cNvCxnSpPr>
              <a:cxnSpLocks/>
              <a:endCxn id="87" idx="2"/>
            </p:cNvCxnSpPr>
            <p:nvPr/>
          </p:nvCxnSpPr>
          <p:spPr>
            <a:xfrm>
              <a:off x="1973963" y="3051107"/>
              <a:ext cx="814028" cy="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Arrow Connector 82">
              <a:extLst>
                <a:ext uri="{FF2B5EF4-FFF2-40B4-BE49-F238E27FC236}">
                  <a16:creationId xmlns:a16="http://schemas.microsoft.com/office/drawing/2014/main" id="{DA75B85E-E1FC-FEB2-F95D-A1ED901B153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22622" y="2580784"/>
              <a:ext cx="0" cy="140387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F2622B13-A0AD-27F0-84AD-8DAA56B1CA27}"/>
                </a:ext>
              </a:extLst>
            </p:cNvPr>
            <p:cNvSpPr/>
            <p:nvPr/>
          </p:nvSpPr>
          <p:spPr>
            <a:xfrm>
              <a:off x="1843318" y="2452025"/>
              <a:ext cx="858368" cy="2543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edicted </a:t>
              </a:r>
            </a:p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ocus</a:t>
              </a:r>
            </a:p>
          </p:txBody>
        </p:sp>
        <p:grpSp>
          <p:nvGrpSpPr>
            <p:cNvPr id="289" name="Group 288" descr="\documentclass{article}&#10;\usepackage{amsmath}&#10;\pagestyle{empty}&#10;\begin{document}&#10;&#10;$\hat{f}$&#10;&#10;\end{document}" title="IguanaTex Vector Display">
              <a:extLst>
                <a:ext uri="{FF2B5EF4-FFF2-40B4-BE49-F238E27FC236}">
                  <a16:creationId xmlns:a16="http://schemas.microsoft.com/office/drawing/2014/main" id="{2B5392F8-32D2-5105-18C2-691F55FEC41C}"/>
                </a:ext>
              </a:extLst>
            </p:cNvPr>
            <p:cNvGrpSpPr>
              <a:grpSpLocks noChangeAspect="1"/>
            </p:cNvGrpSpPr>
            <p:nvPr>
              <p:custDataLst>
                <p:tags r:id="rId2"/>
              </p:custDataLst>
            </p:nvPr>
          </p:nvGrpSpPr>
          <p:grpSpPr>
            <a:xfrm>
              <a:off x="2242342" y="2304257"/>
              <a:ext cx="68532" cy="139512"/>
              <a:chOff x="2321925" y="2364418"/>
              <a:chExt cx="5711" cy="11626"/>
            </a:xfrm>
          </p:grpSpPr>
          <p:sp>
            <p:nvSpPr>
              <p:cNvPr id="287" name="Freeform: Shape 286">
                <a:extLst>
                  <a:ext uri="{FF2B5EF4-FFF2-40B4-BE49-F238E27FC236}">
                    <a16:creationId xmlns:a16="http://schemas.microsoft.com/office/drawing/2014/main" id="{E7F648D4-8D00-234B-6953-96F8922295CA}"/>
                  </a:ext>
                </a:extLst>
              </p:cNvPr>
              <p:cNvSpPr/>
              <p:nvPr>
                <p:custDataLst>
                  <p:tags r:id="rId21"/>
                </p:custDataLst>
              </p:nvPr>
            </p:nvSpPr>
            <p:spPr>
              <a:xfrm>
                <a:off x="2324840" y="2364418"/>
                <a:ext cx="2796" cy="1539"/>
              </a:xfrm>
              <a:custGeom>
                <a:avLst/>
                <a:gdLst>
                  <a:gd name="connsiteX0" fmla="*/ 1483 w 2796"/>
                  <a:gd name="connsiteY0" fmla="*/ 60 h 1539"/>
                  <a:gd name="connsiteX1" fmla="*/ 79 w 2796"/>
                  <a:gd name="connsiteY1" fmla="*/ 1420 h 1539"/>
                  <a:gd name="connsiteX2" fmla="*/ 267 w 2796"/>
                  <a:gd name="connsiteY2" fmla="*/ 1600 h 1539"/>
                  <a:gd name="connsiteX3" fmla="*/ 1483 w 2796"/>
                  <a:gd name="connsiteY3" fmla="*/ 580 h 1539"/>
                  <a:gd name="connsiteX4" fmla="*/ 2687 w 2796"/>
                  <a:gd name="connsiteY4" fmla="*/ 1600 h 1539"/>
                  <a:gd name="connsiteX5" fmla="*/ 2876 w 2796"/>
                  <a:gd name="connsiteY5" fmla="*/ 1420 h 1539"/>
                  <a:gd name="connsiteX6" fmla="*/ 1483 w 2796"/>
                  <a:gd name="connsiteY6" fmla="*/ 60 h 15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796" h="1539">
                    <a:moveTo>
                      <a:pt x="1483" y="60"/>
                    </a:moveTo>
                    <a:lnTo>
                      <a:pt x="79" y="1420"/>
                    </a:lnTo>
                    <a:lnTo>
                      <a:pt x="267" y="1600"/>
                    </a:lnTo>
                    <a:lnTo>
                      <a:pt x="1483" y="580"/>
                    </a:lnTo>
                    <a:lnTo>
                      <a:pt x="2687" y="1600"/>
                    </a:lnTo>
                    <a:lnTo>
                      <a:pt x="2876" y="1420"/>
                    </a:lnTo>
                    <a:lnTo>
                      <a:pt x="1483" y="6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288" name="Freeform: Shape 287">
                <a:extLst>
                  <a:ext uri="{FF2B5EF4-FFF2-40B4-BE49-F238E27FC236}">
                    <a16:creationId xmlns:a16="http://schemas.microsoft.com/office/drawing/2014/main" id="{F0AD1001-ED5D-2390-E7CE-FBD496855F61}"/>
                  </a:ext>
                </a:extLst>
              </p:cNvPr>
              <p:cNvSpPr/>
              <p:nvPr>
                <p:custDataLst>
                  <p:tags r:id="rId22"/>
                </p:custDataLst>
              </p:nvPr>
            </p:nvSpPr>
            <p:spPr>
              <a:xfrm>
                <a:off x="2321925" y="2366946"/>
                <a:ext cx="5227" cy="9098"/>
              </a:xfrm>
              <a:custGeom>
                <a:avLst/>
                <a:gdLst>
                  <a:gd name="connsiteX0" fmla="*/ 3366 w 5227"/>
                  <a:gd name="connsiteY0" fmla="*/ 3112 h 9098"/>
                  <a:gd name="connsiteX1" fmla="*/ 4267 w 5227"/>
                  <a:gd name="connsiteY1" fmla="*/ 3112 h 9098"/>
                  <a:gd name="connsiteX2" fmla="*/ 4581 w 5227"/>
                  <a:gd name="connsiteY2" fmla="*/ 2912 h 9098"/>
                  <a:gd name="connsiteX3" fmla="*/ 4298 w 5227"/>
                  <a:gd name="connsiteY3" fmla="*/ 2802 h 9098"/>
                  <a:gd name="connsiteX4" fmla="*/ 3429 w 5227"/>
                  <a:gd name="connsiteY4" fmla="*/ 2802 h 9098"/>
                  <a:gd name="connsiteX5" fmla="*/ 3649 w 5227"/>
                  <a:gd name="connsiteY5" fmla="*/ 1663 h 9098"/>
                  <a:gd name="connsiteX6" fmla="*/ 3900 w 5227"/>
                  <a:gd name="connsiteY6" fmla="*/ 623 h 9098"/>
                  <a:gd name="connsiteX7" fmla="*/ 4392 w 5227"/>
                  <a:gd name="connsiteY7" fmla="*/ 283 h 9098"/>
                  <a:gd name="connsiteX8" fmla="*/ 4906 w 5227"/>
                  <a:gd name="connsiteY8" fmla="*/ 463 h 9098"/>
                  <a:gd name="connsiteX9" fmla="*/ 4340 w 5227"/>
                  <a:gd name="connsiteY9" fmla="*/ 1003 h 9098"/>
                  <a:gd name="connsiteX10" fmla="*/ 4728 w 5227"/>
                  <a:gd name="connsiteY10" fmla="*/ 1353 h 9098"/>
                  <a:gd name="connsiteX11" fmla="*/ 5304 w 5227"/>
                  <a:gd name="connsiteY11" fmla="*/ 753 h 9098"/>
                  <a:gd name="connsiteX12" fmla="*/ 4392 w 5227"/>
                  <a:gd name="connsiteY12" fmla="*/ 63 h 9098"/>
                  <a:gd name="connsiteX13" fmla="*/ 3062 w 5227"/>
                  <a:gd name="connsiteY13" fmla="*/ 1233 h 9098"/>
                  <a:gd name="connsiteX14" fmla="*/ 2716 w 5227"/>
                  <a:gd name="connsiteY14" fmla="*/ 2802 h 9098"/>
                  <a:gd name="connsiteX15" fmla="*/ 1994 w 5227"/>
                  <a:gd name="connsiteY15" fmla="*/ 2802 h 9098"/>
                  <a:gd name="connsiteX16" fmla="*/ 1679 w 5227"/>
                  <a:gd name="connsiteY16" fmla="*/ 2992 h 9098"/>
                  <a:gd name="connsiteX17" fmla="*/ 1973 w 5227"/>
                  <a:gd name="connsiteY17" fmla="*/ 3112 h 9098"/>
                  <a:gd name="connsiteX18" fmla="*/ 2664 w 5227"/>
                  <a:gd name="connsiteY18" fmla="*/ 3112 h 9098"/>
                  <a:gd name="connsiteX19" fmla="*/ 1878 w 5227"/>
                  <a:gd name="connsiteY19" fmla="*/ 7062 h 9098"/>
                  <a:gd name="connsiteX20" fmla="*/ 967 w 5227"/>
                  <a:gd name="connsiteY20" fmla="*/ 8942 h 9098"/>
                  <a:gd name="connsiteX21" fmla="*/ 464 w 5227"/>
                  <a:gd name="connsiteY21" fmla="*/ 8762 h 9098"/>
                  <a:gd name="connsiteX22" fmla="*/ 1040 w 5227"/>
                  <a:gd name="connsiteY22" fmla="*/ 8222 h 9098"/>
                  <a:gd name="connsiteX23" fmla="*/ 653 w 5227"/>
                  <a:gd name="connsiteY23" fmla="*/ 7872 h 9098"/>
                  <a:gd name="connsiteX24" fmla="*/ 77 w 5227"/>
                  <a:gd name="connsiteY24" fmla="*/ 8472 h 9098"/>
                  <a:gd name="connsiteX25" fmla="*/ 967 w 5227"/>
                  <a:gd name="connsiteY25" fmla="*/ 9162 h 9098"/>
                  <a:gd name="connsiteX26" fmla="*/ 2151 w 5227"/>
                  <a:gd name="connsiteY26" fmla="*/ 8192 h 9098"/>
                  <a:gd name="connsiteX27" fmla="*/ 2737 w 5227"/>
                  <a:gd name="connsiteY27" fmla="*/ 6282 h 9098"/>
                  <a:gd name="connsiteX28" fmla="*/ 3366 w 5227"/>
                  <a:gd name="connsiteY28" fmla="*/ 3112 h 90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5227" h="9098">
                    <a:moveTo>
                      <a:pt x="3366" y="3112"/>
                    </a:moveTo>
                    <a:lnTo>
                      <a:pt x="4267" y="3112"/>
                    </a:lnTo>
                    <a:cubicBezTo>
                      <a:pt x="4476" y="3112"/>
                      <a:pt x="4581" y="3112"/>
                      <a:pt x="4581" y="2912"/>
                    </a:cubicBezTo>
                    <a:cubicBezTo>
                      <a:pt x="4581" y="2802"/>
                      <a:pt x="4476" y="2802"/>
                      <a:pt x="4298" y="2802"/>
                    </a:cubicBezTo>
                    <a:lnTo>
                      <a:pt x="3429" y="2802"/>
                    </a:lnTo>
                    <a:lnTo>
                      <a:pt x="3649" y="1663"/>
                    </a:lnTo>
                    <a:cubicBezTo>
                      <a:pt x="3691" y="1453"/>
                      <a:pt x="3837" y="743"/>
                      <a:pt x="3900" y="623"/>
                    </a:cubicBezTo>
                    <a:cubicBezTo>
                      <a:pt x="3994" y="433"/>
                      <a:pt x="4172" y="283"/>
                      <a:pt x="4392" y="283"/>
                    </a:cubicBezTo>
                    <a:cubicBezTo>
                      <a:pt x="4434" y="283"/>
                      <a:pt x="4707" y="283"/>
                      <a:pt x="4906" y="463"/>
                    </a:cubicBezTo>
                    <a:cubicBezTo>
                      <a:pt x="4445" y="503"/>
                      <a:pt x="4340" y="853"/>
                      <a:pt x="4340" y="1003"/>
                    </a:cubicBezTo>
                    <a:cubicBezTo>
                      <a:pt x="4340" y="1233"/>
                      <a:pt x="4529" y="1353"/>
                      <a:pt x="4728" y="1353"/>
                    </a:cubicBezTo>
                    <a:cubicBezTo>
                      <a:pt x="5000" y="1353"/>
                      <a:pt x="5304" y="1133"/>
                      <a:pt x="5304" y="753"/>
                    </a:cubicBezTo>
                    <a:cubicBezTo>
                      <a:pt x="5304" y="293"/>
                      <a:pt x="4822" y="63"/>
                      <a:pt x="4392" y="63"/>
                    </a:cubicBezTo>
                    <a:cubicBezTo>
                      <a:pt x="4036" y="63"/>
                      <a:pt x="3376" y="243"/>
                      <a:pt x="3062" y="1233"/>
                    </a:cubicBezTo>
                    <a:cubicBezTo>
                      <a:pt x="2999" y="1443"/>
                      <a:pt x="2968" y="1543"/>
                      <a:pt x="2716" y="2802"/>
                    </a:cubicBezTo>
                    <a:lnTo>
                      <a:pt x="1994" y="2802"/>
                    </a:lnTo>
                    <a:cubicBezTo>
                      <a:pt x="1795" y="2802"/>
                      <a:pt x="1679" y="2802"/>
                      <a:pt x="1679" y="2992"/>
                    </a:cubicBezTo>
                    <a:cubicBezTo>
                      <a:pt x="1679" y="3112"/>
                      <a:pt x="1774" y="3112"/>
                      <a:pt x="1973" y="3112"/>
                    </a:cubicBezTo>
                    <a:lnTo>
                      <a:pt x="2664" y="3112"/>
                    </a:lnTo>
                    <a:lnTo>
                      <a:pt x="1878" y="7062"/>
                    </a:lnTo>
                    <a:cubicBezTo>
                      <a:pt x="1690" y="8032"/>
                      <a:pt x="1512" y="8942"/>
                      <a:pt x="967" y="8942"/>
                    </a:cubicBezTo>
                    <a:cubicBezTo>
                      <a:pt x="925" y="8942"/>
                      <a:pt x="663" y="8942"/>
                      <a:pt x="464" y="8762"/>
                    </a:cubicBezTo>
                    <a:cubicBezTo>
                      <a:pt x="946" y="8732"/>
                      <a:pt x="1040" y="8372"/>
                      <a:pt x="1040" y="8222"/>
                    </a:cubicBezTo>
                    <a:cubicBezTo>
                      <a:pt x="1040" y="7992"/>
                      <a:pt x="852" y="7872"/>
                      <a:pt x="653" y="7872"/>
                    </a:cubicBezTo>
                    <a:cubicBezTo>
                      <a:pt x="380" y="7872"/>
                      <a:pt x="77" y="8092"/>
                      <a:pt x="77" y="8472"/>
                    </a:cubicBezTo>
                    <a:cubicBezTo>
                      <a:pt x="77" y="8922"/>
                      <a:pt x="538" y="9162"/>
                      <a:pt x="967" y="9162"/>
                    </a:cubicBezTo>
                    <a:cubicBezTo>
                      <a:pt x="1543" y="9162"/>
                      <a:pt x="1962" y="8572"/>
                      <a:pt x="2151" y="8192"/>
                    </a:cubicBezTo>
                    <a:cubicBezTo>
                      <a:pt x="2486" y="7562"/>
                      <a:pt x="2727" y="6352"/>
                      <a:pt x="2737" y="6282"/>
                    </a:cubicBezTo>
                    <a:lnTo>
                      <a:pt x="3366" y="3112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</p:grpSp>
        <p:cxnSp>
          <p:nvCxnSpPr>
            <p:cNvPr id="86" name="Straight Arrow Connector 85">
              <a:extLst>
                <a:ext uri="{FF2B5EF4-FFF2-40B4-BE49-F238E27FC236}">
                  <a16:creationId xmlns:a16="http://schemas.microsoft.com/office/drawing/2014/main" id="{EA452677-B722-EBEB-360A-3C1CBB1D8C93}"/>
                </a:ext>
              </a:extLst>
            </p:cNvPr>
            <p:cNvCxnSpPr>
              <a:cxnSpLocks/>
            </p:cNvCxnSpPr>
            <p:nvPr/>
          </p:nvCxnSpPr>
          <p:spPr>
            <a:xfrm>
              <a:off x="1973963" y="2374542"/>
              <a:ext cx="236273" cy="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Flowchart: Connector 86">
              <a:extLst>
                <a:ext uri="{FF2B5EF4-FFF2-40B4-BE49-F238E27FC236}">
                  <a16:creationId xmlns:a16="http://schemas.microsoft.com/office/drawing/2014/main" id="{7AD757B0-10BA-7330-C9F3-6BBDD82BFE66}"/>
                </a:ext>
              </a:extLst>
            </p:cNvPr>
            <p:cNvSpPr/>
            <p:nvPr/>
          </p:nvSpPr>
          <p:spPr>
            <a:xfrm>
              <a:off x="2787991" y="2964251"/>
              <a:ext cx="173711" cy="173711"/>
            </a:xfrm>
            <a:prstGeom prst="flowChartConnector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cxnSp>
          <p:nvCxnSpPr>
            <p:cNvPr id="103" name="Straight Arrow Connector 102">
              <a:extLst>
                <a:ext uri="{FF2B5EF4-FFF2-40B4-BE49-F238E27FC236}">
                  <a16:creationId xmlns:a16="http://schemas.microsoft.com/office/drawing/2014/main" id="{84992E75-35E3-5EFD-68F0-603060696360}"/>
                </a:ext>
              </a:extLst>
            </p:cNvPr>
            <p:cNvCxnSpPr>
              <a:cxnSpLocks/>
            </p:cNvCxnSpPr>
            <p:nvPr/>
          </p:nvCxnSpPr>
          <p:spPr>
            <a:xfrm>
              <a:off x="2874846" y="2771052"/>
              <a:ext cx="0" cy="181374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Arrow Connector 103">
              <a:extLst>
                <a:ext uri="{FF2B5EF4-FFF2-40B4-BE49-F238E27FC236}">
                  <a16:creationId xmlns:a16="http://schemas.microsoft.com/office/drawing/2014/main" id="{BC5C0919-AA08-CFEA-2474-661F5EC33136}"/>
                </a:ext>
              </a:extLst>
            </p:cNvPr>
            <p:cNvCxnSpPr>
              <a:cxnSpLocks/>
            </p:cNvCxnSpPr>
            <p:nvPr/>
          </p:nvCxnSpPr>
          <p:spPr>
            <a:xfrm>
              <a:off x="2967029" y="3050839"/>
              <a:ext cx="367597" cy="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6373E785-B3FA-D7DE-C112-963716D8B000}"/>
                </a:ext>
              </a:extLst>
            </p:cNvPr>
            <p:cNvSpPr/>
            <p:nvPr/>
          </p:nvSpPr>
          <p:spPr>
            <a:xfrm>
              <a:off x="3376934" y="3338347"/>
              <a:ext cx="962145" cy="2543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D </a:t>
              </a:r>
              <a:r>
                <a:rPr lang="en-US" sz="7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gmentor</a:t>
              </a:r>
              <a:endParaRPr lang="en-U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Rectangle: Rounded Corners 105">
              <a:extLst>
                <a:ext uri="{FF2B5EF4-FFF2-40B4-BE49-F238E27FC236}">
                  <a16:creationId xmlns:a16="http://schemas.microsoft.com/office/drawing/2014/main" id="{763AEADD-A49B-D453-7E54-3B3EDB4F9981}"/>
                </a:ext>
              </a:extLst>
            </p:cNvPr>
            <p:cNvSpPr/>
            <p:nvPr/>
          </p:nvSpPr>
          <p:spPr>
            <a:xfrm rot="16200000" flipH="1">
              <a:off x="4125069" y="2995045"/>
              <a:ext cx="519442" cy="104451"/>
            </a:xfrm>
            <a:prstGeom prst="round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gmoid</a:t>
              </a:r>
            </a:p>
          </p:txBody>
        </p:sp>
        <p:grpSp>
          <p:nvGrpSpPr>
            <p:cNvPr id="195" name="Group 194" descr="\documentclass{article}&#10;\usepackage{amsmath,bm}&#10;\pagestyle{empty}&#10;\begin{document}&#10;&#10;$\ell_{\text{S}}(\bm{p},\hat{\bm{p}})$&#10;&#10;\end{document}" title="IguanaTex Vector Display">
              <a:extLst>
                <a:ext uri="{FF2B5EF4-FFF2-40B4-BE49-F238E27FC236}">
                  <a16:creationId xmlns:a16="http://schemas.microsoft.com/office/drawing/2014/main" id="{CE5D45BA-6FBD-1D20-337F-6A4D62B5F5E9}"/>
                </a:ext>
              </a:extLst>
            </p:cNvPr>
            <p:cNvGrpSpPr>
              <a:grpSpLocks noChangeAspect="1"/>
            </p:cNvGrpSpPr>
            <p:nvPr>
              <p:custDataLst>
                <p:tags r:id="rId3"/>
              </p:custDataLst>
            </p:nvPr>
          </p:nvGrpSpPr>
          <p:grpSpPr>
            <a:xfrm>
              <a:off x="4192348" y="2408569"/>
              <a:ext cx="415858" cy="125849"/>
              <a:chOff x="4293631" y="2465424"/>
              <a:chExt cx="29710" cy="8991"/>
            </a:xfrm>
          </p:grpSpPr>
          <p:sp>
            <p:nvSpPr>
              <p:cNvPr id="187" name="Freeform: Shape 186">
                <a:extLst>
                  <a:ext uri="{FF2B5EF4-FFF2-40B4-BE49-F238E27FC236}">
                    <a16:creationId xmlns:a16="http://schemas.microsoft.com/office/drawing/2014/main" id="{FD7F10C3-FD88-E766-F248-1A07FC8EC268}"/>
                  </a:ext>
                </a:extLst>
              </p:cNvPr>
              <p:cNvSpPr/>
              <p:nvPr>
                <p:custDataLst>
                  <p:tags r:id="rId13"/>
                </p:custDataLst>
              </p:nvPr>
            </p:nvSpPr>
            <p:spPr>
              <a:xfrm>
                <a:off x="4293631" y="2465829"/>
                <a:ext cx="3569" cy="6446"/>
              </a:xfrm>
              <a:custGeom>
                <a:avLst/>
                <a:gdLst>
                  <a:gd name="connsiteX0" fmla="*/ 123 w 3569"/>
                  <a:gd name="connsiteY0" fmla="*/ 5511 h 6446"/>
                  <a:gd name="connsiteX1" fmla="*/ 77 w 3569"/>
                  <a:gd name="connsiteY1" fmla="*/ 5601 h 6446"/>
                  <a:gd name="connsiteX2" fmla="*/ 187 w 3569"/>
                  <a:gd name="connsiteY2" fmla="*/ 5718 h 6446"/>
                  <a:gd name="connsiteX3" fmla="*/ 519 w 3569"/>
                  <a:gd name="connsiteY3" fmla="*/ 5440 h 6446"/>
                  <a:gd name="connsiteX4" fmla="*/ 851 w 3569"/>
                  <a:gd name="connsiteY4" fmla="*/ 5134 h 6446"/>
                  <a:gd name="connsiteX5" fmla="*/ 1884 w 3569"/>
                  <a:gd name="connsiteY5" fmla="*/ 6510 h 6446"/>
                  <a:gd name="connsiteX6" fmla="*/ 2770 w 3569"/>
                  <a:gd name="connsiteY6" fmla="*/ 6168 h 6446"/>
                  <a:gd name="connsiteX7" fmla="*/ 3332 w 3569"/>
                  <a:gd name="connsiteY7" fmla="*/ 5637 h 6446"/>
                  <a:gd name="connsiteX8" fmla="*/ 3222 w 3569"/>
                  <a:gd name="connsiteY8" fmla="*/ 5529 h 6446"/>
                  <a:gd name="connsiteX9" fmla="*/ 3102 w 3569"/>
                  <a:gd name="connsiteY9" fmla="*/ 5610 h 6446"/>
                  <a:gd name="connsiteX10" fmla="*/ 1903 w 3569"/>
                  <a:gd name="connsiteY10" fmla="*/ 6312 h 6446"/>
                  <a:gd name="connsiteX11" fmla="*/ 1340 w 3569"/>
                  <a:gd name="connsiteY11" fmla="*/ 5143 h 6446"/>
                  <a:gd name="connsiteX12" fmla="*/ 1386 w 3569"/>
                  <a:gd name="connsiteY12" fmla="*/ 4630 h 6446"/>
                  <a:gd name="connsiteX13" fmla="*/ 1589 w 3569"/>
                  <a:gd name="connsiteY13" fmla="*/ 4406 h 6446"/>
                  <a:gd name="connsiteX14" fmla="*/ 3646 w 3569"/>
                  <a:gd name="connsiteY14" fmla="*/ 764 h 6446"/>
                  <a:gd name="connsiteX15" fmla="*/ 3102 w 3569"/>
                  <a:gd name="connsiteY15" fmla="*/ 63 h 6446"/>
                  <a:gd name="connsiteX16" fmla="*/ 1562 w 3569"/>
                  <a:gd name="connsiteY16" fmla="*/ 1753 h 6446"/>
                  <a:gd name="connsiteX17" fmla="*/ 833 w 3569"/>
                  <a:gd name="connsiteY17" fmla="*/ 4855 h 6446"/>
                  <a:gd name="connsiteX18" fmla="*/ 123 w 3569"/>
                  <a:gd name="connsiteY18" fmla="*/ 5511 h 6446"/>
                  <a:gd name="connsiteX19" fmla="*/ 1432 w 3569"/>
                  <a:gd name="connsiteY19" fmla="*/ 4253 h 6446"/>
                  <a:gd name="connsiteX20" fmla="*/ 2373 w 3569"/>
                  <a:gd name="connsiteY20" fmla="*/ 1106 h 6446"/>
                  <a:gd name="connsiteX21" fmla="*/ 3111 w 3569"/>
                  <a:gd name="connsiteY21" fmla="*/ 261 h 6446"/>
                  <a:gd name="connsiteX22" fmla="*/ 3424 w 3569"/>
                  <a:gd name="connsiteY22" fmla="*/ 728 h 6446"/>
                  <a:gd name="connsiteX23" fmla="*/ 1432 w 3569"/>
                  <a:gd name="connsiteY23" fmla="*/ 4253 h 64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</a:cxnLst>
                <a:rect l="l" t="t" r="r" b="b"/>
                <a:pathLst>
                  <a:path w="3569" h="6446">
                    <a:moveTo>
                      <a:pt x="123" y="5511"/>
                    </a:moveTo>
                    <a:cubicBezTo>
                      <a:pt x="104" y="5538"/>
                      <a:pt x="77" y="5565"/>
                      <a:pt x="77" y="5601"/>
                    </a:cubicBezTo>
                    <a:cubicBezTo>
                      <a:pt x="77" y="5646"/>
                      <a:pt x="132" y="5718"/>
                      <a:pt x="187" y="5718"/>
                    </a:cubicBezTo>
                    <a:cubicBezTo>
                      <a:pt x="233" y="5718"/>
                      <a:pt x="261" y="5691"/>
                      <a:pt x="519" y="5440"/>
                    </a:cubicBezTo>
                    <a:cubicBezTo>
                      <a:pt x="593" y="5377"/>
                      <a:pt x="778" y="5206"/>
                      <a:pt x="851" y="5134"/>
                    </a:cubicBezTo>
                    <a:cubicBezTo>
                      <a:pt x="944" y="5844"/>
                      <a:pt x="1211" y="6510"/>
                      <a:pt x="1884" y="6510"/>
                    </a:cubicBezTo>
                    <a:cubicBezTo>
                      <a:pt x="2253" y="6510"/>
                      <a:pt x="2576" y="6303"/>
                      <a:pt x="2770" y="6168"/>
                    </a:cubicBezTo>
                    <a:cubicBezTo>
                      <a:pt x="2899" y="6078"/>
                      <a:pt x="3332" y="5727"/>
                      <a:pt x="3332" y="5637"/>
                    </a:cubicBezTo>
                    <a:cubicBezTo>
                      <a:pt x="3332" y="5610"/>
                      <a:pt x="3305" y="5529"/>
                      <a:pt x="3222" y="5529"/>
                    </a:cubicBezTo>
                    <a:cubicBezTo>
                      <a:pt x="3194" y="5529"/>
                      <a:pt x="3185" y="5538"/>
                      <a:pt x="3102" y="5610"/>
                    </a:cubicBezTo>
                    <a:cubicBezTo>
                      <a:pt x="2511" y="6177"/>
                      <a:pt x="2170" y="6312"/>
                      <a:pt x="1903" y="6312"/>
                    </a:cubicBezTo>
                    <a:cubicBezTo>
                      <a:pt x="1488" y="6312"/>
                      <a:pt x="1340" y="5844"/>
                      <a:pt x="1340" y="5143"/>
                    </a:cubicBezTo>
                    <a:cubicBezTo>
                      <a:pt x="1340" y="5089"/>
                      <a:pt x="1359" y="4675"/>
                      <a:pt x="1386" y="4630"/>
                    </a:cubicBezTo>
                    <a:cubicBezTo>
                      <a:pt x="1405" y="4603"/>
                      <a:pt x="1405" y="4585"/>
                      <a:pt x="1589" y="4406"/>
                    </a:cubicBezTo>
                    <a:cubicBezTo>
                      <a:pt x="2336" y="3677"/>
                      <a:pt x="3646" y="2158"/>
                      <a:pt x="3646" y="764"/>
                    </a:cubicBezTo>
                    <a:cubicBezTo>
                      <a:pt x="3646" y="611"/>
                      <a:pt x="3646" y="63"/>
                      <a:pt x="3102" y="63"/>
                    </a:cubicBezTo>
                    <a:cubicBezTo>
                      <a:pt x="2336" y="63"/>
                      <a:pt x="1654" y="1546"/>
                      <a:pt x="1562" y="1753"/>
                    </a:cubicBezTo>
                    <a:cubicBezTo>
                      <a:pt x="1119" y="2733"/>
                      <a:pt x="833" y="3785"/>
                      <a:pt x="833" y="4855"/>
                    </a:cubicBezTo>
                    <a:lnTo>
                      <a:pt x="123" y="5511"/>
                    </a:lnTo>
                    <a:close/>
                    <a:moveTo>
                      <a:pt x="1432" y="4253"/>
                    </a:moveTo>
                    <a:cubicBezTo>
                      <a:pt x="1451" y="4154"/>
                      <a:pt x="1847" y="2158"/>
                      <a:pt x="2373" y="1106"/>
                    </a:cubicBezTo>
                    <a:cubicBezTo>
                      <a:pt x="2622" y="620"/>
                      <a:pt x="2816" y="261"/>
                      <a:pt x="3111" y="261"/>
                    </a:cubicBezTo>
                    <a:cubicBezTo>
                      <a:pt x="3424" y="261"/>
                      <a:pt x="3424" y="584"/>
                      <a:pt x="3424" y="728"/>
                    </a:cubicBezTo>
                    <a:cubicBezTo>
                      <a:pt x="3424" y="2230"/>
                      <a:pt x="1875" y="3803"/>
                      <a:pt x="1432" y="4253"/>
                    </a:cubicBez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88" name="Freeform: Shape 187">
                <a:extLst>
                  <a:ext uri="{FF2B5EF4-FFF2-40B4-BE49-F238E27FC236}">
                    <a16:creationId xmlns:a16="http://schemas.microsoft.com/office/drawing/2014/main" id="{C4D122BD-B235-95BD-EFC1-0CA1B3C37B5C}"/>
                  </a:ext>
                </a:extLst>
              </p:cNvPr>
              <p:cNvSpPr/>
              <p:nvPr>
                <p:custDataLst>
                  <p:tags r:id="rId14"/>
                </p:custDataLst>
              </p:nvPr>
            </p:nvSpPr>
            <p:spPr>
              <a:xfrm>
                <a:off x="4297824" y="2469092"/>
                <a:ext cx="3163" cy="4550"/>
              </a:xfrm>
              <a:custGeom>
                <a:avLst/>
                <a:gdLst>
                  <a:gd name="connsiteX0" fmla="*/ 1236 w 3163"/>
                  <a:gd name="connsiteY0" fmla="*/ 1864 h 4550"/>
                  <a:gd name="connsiteX1" fmla="*/ 494 w 3163"/>
                  <a:gd name="connsiteY1" fmla="*/ 1078 h 4550"/>
                  <a:gd name="connsiteX2" fmla="*/ 1475 w 3163"/>
                  <a:gd name="connsiteY2" fmla="*/ 266 h 4550"/>
                  <a:gd name="connsiteX3" fmla="*/ 2825 w 3163"/>
                  <a:gd name="connsiteY3" fmla="*/ 1493 h 4550"/>
                  <a:gd name="connsiteX4" fmla="*/ 2941 w 3163"/>
                  <a:gd name="connsiteY4" fmla="*/ 1619 h 4550"/>
                  <a:gd name="connsiteX5" fmla="*/ 3050 w 3163"/>
                  <a:gd name="connsiteY5" fmla="*/ 1455 h 4550"/>
                  <a:gd name="connsiteX6" fmla="*/ 3050 w 3163"/>
                  <a:gd name="connsiteY6" fmla="*/ 228 h 4550"/>
                  <a:gd name="connsiteX7" fmla="*/ 2960 w 3163"/>
                  <a:gd name="connsiteY7" fmla="*/ 64 h 4550"/>
                  <a:gd name="connsiteX8" fmla="*/ 2850 w 3163"/>
                  <a:gd name="connsiteY8" fmla="*/ 152 h 4550"/>
                  <a:gd name="connsiteX9" fmla="*/ 2618 w 3163"/>
                  <a:gd name="connsiteY9" fmla="*/ 505 h 4550"/>
                  <a:gd name="connsiteX10" fmla="*/ 1475 w 3163"/>
                  <a:gd name="connsiteY10" fmla="*/ 64 h 4550"/>
                  <a:gd name="connsiteX11" fmla="*/ 81 w 3163"/>
                  <a:gd name="connsiteY11" fmla="*/ 1266 h 4550"/>
                  <a:gd name="connsiteX12" fmla="*/ 475 w 3163"/>
                  <a:gd name="connsiteY12" fmla="*/ 2103 h 4550"/>
                  <a:gd name="connsiteX13" fmla="*/ 1643 w 3163"/>
                  <a:gd name="connsiteY13" fmla="*/ 2544 h 4550"/>
                  <a:gd name="connsiteX14" fmla="*/ 2547 w 3163"/>
                  <a:gd name="connsiteY14" fmla="*/ 2871 h 4550"/>
                  <a:gd name="connsiteX15" fmla="*/ 2831 w 3163"/>
                  <a:gd name="connsiteY15" fmla="*/ 3501 h 4550"/>
                  <a:gd name="connsiteX16" fmla="*/ 1837 w 3163"/>
                  <a:gd name="connsiteY16" fmla="*/ 4388 h 4550"/>
                  <a:gd name="connsiteX17" fmla="*/ 300 w 3163"/>
                  <a:gd name="connsiteY17" fmla="*/ 3199 h 4550"/>
                  <a:gd name="connsiteX18" fmla="*/ 191 w 3163"/>
                  <a:gd name="connsiteY18" fmla="*/ 3060 h 4550"/>
                  <a:gd name="connsiteX19" fmla="*/ 81 w 3163"/>
                  <a:gd name="connsiteY19" fmla="*/ 3230 h 4550"/>
                  <a:gd name="connsiteX20" fmla="*/ 81 w 3163"/>
                  <a:gd name="connsiteY20" fmla="*/ 4451 h 4550"/>
                  <a:gd name="connsiteX21" fmla="*/ 171 w 3163"/>
                  <a:gd name="connsiteY21" fmla="*/ 4615 h 4550"/>
                  <a:gd name="connsiteX22" fmla="*/ 275 w 3163"/>
                  <a:gd name="connsiteY22" fmla="*/ 4539 h 4550"/>
                  <a:gd name="connsiteX23" fmla="*/ 513 w 3163"/>
                  <a:gd name="connsiteY23" fmla="*/ 4180 h 4550"/>
                  <a:gd name="connsiteX24" fmla="*/ 1837 w 3163"/>
                  <a:gd name="connsiteY24" fmla="*/ 4615 h 4550"/>
                  <a:gd name="connsiteX25" fmla="*/ 3244 w 3163"/>
                  <a:gd name="connsiteY25" fmla="*/ 3325 h 4550"/>
                  <a:gd name="connsiteX26" fmla="*/ 2192 w 3163"/>
                  <a:gd name="connsiteY26" fmla="*/ 2078 h 4550"/>
                  <a:gd name="connsiteX27" fmla="*/ 1236 w 3163"/>
                  <a:gd name="connsiteY27" fmla="*/ 1864 h 45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</a:cxnLst>
                <a:rect l="l" t="t" r="r" b="b"/>
                <a:pathLst>
                  <a:path w="3163" h="4550">
                    <a:moveTo>
                      <a:pt x="1236" y="1864"/>
                    </a:moveTo>
                    <a:cubicBezTo>
                      <a:pt x="668" y="1738"/>
                      <a:pt x="494" y="1342"/>
                      <a:pt x="494" y="1078"/>
                    </a:cubicBezTo>
                    <a:cubicBezTo>
                      <a:pt x="494" y="662"/>
                      <a:pt x="888" y="266"/>
                      <a:pt x="1475" y="266"/>
                    </a:cubicBezTo>
                    <a:cubicBezTo>
                      <a:pt x="2347" y="266"/>
                      <a:pt x="2721" y="832"/>
                      <a:pt x="2825" y="1493"/>
                    </a:cubicBezTo>
                    <a:cubicBezTo>
                      <a:pt x="2837" y="1587"/>
                      <a:pt x="2844" y="1619"/>
                      <a:pt x="2941" y="1619"/>
                    </a:cubicBezTo>
                    <a:cubicBezTo>
                      <a:pt x="3050" y="1619"/>
                      <a:pt x="3050" y="1575"/>
                      <a:pt x="3050" y="1455"/>
                    </a:cubicBezTo>
                    <a:lnTo>
                      <a:pt x="3050" y="228"/>
                    </a:lnTo>
                    <a:cubicBezTo>
                      <a:pt x="3050" y="121"/>
                      <a:pt x="3050" y="64"/>
                      <a:pt x="2960" y="64"/>
                    </a:cubicBezTo>
                    <a:cubicBezTo>
                      <a:pt x="2908" y="64"/>
                      <a:pt x="2896" y="83"/>
                      <a:pt x="2850" y="152"/>
                    </a:cubicBezTo>
                    <a:lnTo>
                      <a:pt x="2618" y="505"/>
                    </a:lnTo>
                    <a:cubicBezTo>
                      <a:pt x="2192" y="83"/>
                      <a:pt x="1656" y="64"/>
                      <a:pt x="1475" y="64"/>
                    </a:cubicBezTo>
                    <a:cubicBezTo>
                      <a:pt x="662" y="64"/>
                      <a:pt x="81" y="631"/>
                      <a:pt x="81" y="1266"/>
                    </a:cubicBezTo>
                    <a:cubicBezTo>
                      <a:pt x="81" y="1619"/>
                      <a:pt x="242" y="1889"/>
                      <a:pt x="475" y="2103"/>
                    </a:cubicBezTo>
                    <a:cubicBezTo>
                      <a:pt x="733" y="2349"/>
                      <a:pt x="946" y="2393"/>
                      <a:pt x="1643" y="2544"/>
                    </a:cubicBezTo>
                    <a:cubicBezTo>
                      <a:pt x="2231" y="2670"/>
                      <a:pt x="2360" y="2695"/>
                      <a:pt x="2547" y="2871"/>
                    </a:cubicBezTo>
                    <a:cubicBezTo>
                      <a:pt x="2695" y="3016"/>
                      <a:pt x="2831" y="3218"/>
                      <a:pt x="2831" y="3501"/>
                    </a:cubicBezTo>
                    <a:cubicBezTo>
                      <a:pt x="2831" y="3941"/>
                      <a:pt x="2457" y="4388"/>
                      <a:pt x="1837" y="4388"/>
                    </a:cubicBezTo>
                    <a:cubicBezTo>
                      <a:pt x="1211" y="4388"/>
                      <a:pt x="346" y="4149"/>
                      <a:pt x="300" y="3199"/>
                    </a:cubicBezTo>
                    <a:cubicBezTo>
                      <a:pt x="294" y="3098"/>
                      <a:pt x="294" y="3060"/>
                      <a:pt x="191" y="3060"/>
                    </a:cubicBezTo>
                    <a:cubicBezTo>
                      <a:pt x="81" y="3060"/>
                      <a:pt x="81" y="3104"/>
                      <a:pt x="81" y="3230"/>
                    </a:cubicBezTo>
                    <a:lnTo>
                      <a:pt x="81" y="4451"/>
                    </a:lnTo>
                    <a:cubicBezTo>
                      <a:pt x="81" y="4558"/>
                      <a:pt x="81" y="4615"/>
                      <a:pt x="171" y="4615"/>
                    </a:cubicBezTo>
                    <a:cubicBezTo>
                      <a:pt x="223" y="4615"/>
                      <a:pt x="236" y="4596"/>
                      <a:pt x="275" y="4539"/>
                    </a:cubicBezTo>
                    <a:cubicBezTo>
                      <a:pt x="333" y="4464"/>
                      <a:pt x="462" y="4262"/>
                      <a:pt x="513" y="4180"/>
                    </a:cubicBezTo>
                    <a:cubicBezTo>
                      <a:pt x="920" y="4527"/>
                      <a:pt x="1417" y="4615"/>
                      <a:pt x="1837" y="4615"/>
                    </a:cubicBezTo>
                    <a:cubicBezTo>
                      <a:pt x="2689" y="4615"/>
                      <a:pt x="3244" y="3992"/>
                      <a:pt x="3244" y="3325"/>
                    </a:cubicBezTo>
                    <a:cubicBezTo>
                      <a:pt x="3244" y="2758"/>
                      <a:pt x="2837" y="2223"/>
                      <a:pt x="2192" y="2078"/>
                    </a:cubicBezTo>
                    <a:lnTo>
                      <a:pt x="1236" y="1864"/>
                    </a:ln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89" name="Freeform: Shape 188">
                <a:extLst>
                  <a:ext uri="{FF2B5EF4-FFF2-40B4-BE49-F238E27FC236}">
                    <a16:creationId xmlns:a16="http://schemas.microsoft.com/office/drawing/2014/main" id="{6EFBF94A-83D4-4208-5051-BE5FB666A01A}"/>
                  </a:ext>
                </a:extLst>
              </p:cNvPr>
              <p:cNvSpPr/>
              <p:nvPr>
                <p:custDataLst>
                  <p:tags r:id="rId15"/>
                </p:custDataLst>
              </p:nvPr>
            </p:nvSpPr>
            <p:spPr>
              <a:xfrm>
                <a:off x="4302820" y="2465424"/>
                <a:ext cx="2139" cy="8991"/>
              </a:xfrm>
              <a:custGeom>
                <a:avLst/>
                <a:gdLst>
                  <a:gd name="connsiteX0" fmla="*/ 2225 w 2139"/>
                  <a:gd name="connsiteY0" fmla="*/ 8964 h 8991"/>
                  <a:gd name="connsiteX1" fmla="*/ 2069 w 2139"/>
                  <a:gd name="connsiteY1" fmla="*/ 8766 h 8991"/>
                  <a:gd name="connsiteX2" fmla="*/ 621 w 2139"/>
                  <a:gd name="connsiteY2" fmla="*/ 4558 h 8991"/>
                  <a:gd name="connsiteX3" fmla="*/ 2105 w 2139"/>
                  <a:gd name="connsiteY3" fmla="*/ 306 h 8991"/>
                  <a:gd name="connsiteX4" fmla="*/ 2225 w 2139"/>
                  <a:gd name="connsiteY4" fmla="*/ 153 h 8991"/>
                  <a:gd name="connsiteX5" fmla="*/ 2133 w 2139"/>
                  <a:gd name="connsiteY5" fmla="*/ 63 h 8991"/>
                  <a:gd name="connsiteX6" fmla="*/ 667 w 2139"/>
                  <a:gd name="connsiteY6" fmla="*/ 1816 h 8991"/>
                  <a:gd name="connsiteX7" fmla="*/ 86 w 2139"/>
                  <a:gd name="connsiteY7" fmla="*/ 4558 h 8991"/>
                  <a:gd name="connsiteX8" fmla="*/ 694 w 2139"/>
                  <a:gd name="connsiteY8" fmla="*/ 7364 h 8991"/>
                  <a:gd name="connsiteX9" fmla="*/ 2133 w 2139"/>
                  <a:gd name="connsiteY9" fmla="*/ 9054 h 8991"/>
                  <a:gd name="connsiteX10" fmla="*/ 2225 w 2139"/>
                  <a:gd name="connsiteY10" fmla="*/ 8964 h 899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2139" h="8991">
                    <a:moveTo>
                      <a:pt x="2225" y="8964"/>
                    </a:moveTo>
                    <a:cubicBezTo>
                      <a:pt x="2225" y="8937"/>
                      <a:pt x="2225" y="8919"/>
                      <a:pt x="2069" y="8766"/>
                    </a:cubicBezTo>
                    <a:cubicBezTo>
                      <a:pt x="916" y="7633"/>
                      <a:pt x="621" y="5934"/>
                      <a:pt x="621" y="4558"/>
                    </a:cubicBezTo>
                    <a:cubicBezTo>
                      <a:pt x="621" y="2994"/>
                      <a:pt x="971" y="1429"/>
                      <a:pt x="2105" y="306"/>
                    </a:cubicBezTo>
                    <a:cubicBezTo>
                      <a:pt x="2225" y="198"/>
                      <a:pt x="2225" y="180"/>
                      <a:pt x="2225" y="153"/>
                    </a:cubicBezTo>
                    <a:cubicBezTo>
                      <a:pt x="2225" y="90"/>
                      <a:pt x="2188" y="63"/>
                      <a:pt x="2133" y="63"/>
                    </a:cubicBezTo>
                    <a:cubicBezTo>
                      <a:pt x="2041" y="63"/>
                      <a:pt x="1211" y="674"/>
                      <a:pt x="667" y="1816"/>
                    </a:cubicBezTo>
                    <a:cubicBezTo>
                      <a:pt x="196" y="2805"/>
                      <a:pt x="86" y="3803"/>
                      <a:pt x="86" y="4558"/>
                    </a:cubicBezTo>
                    <a:cubicBezTo>
                      <a:pt x="86" y="5260"/>
                      <a:pt x="187" y="6348"/>
                      <a:pt x="694" y="7364"/>
                    </a:cubicBezTo>
                    <a:cubicBezTo>
                      <a:pt x="1248" y="8470"/>
                      <a:pt x="2041" y="9054"/>
                      <a:pt x="2133" y="9054"/>
                    </a:cubicBezTo>
                    <a:cubicBezTo>
                      <a:pt x="2188" y="9054"/>
                      <a:pt x="2225" y="9027"/>
                      <a:pt x="2225" y="8964"/>
                    </a:cubicBez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90" name="Freeform: Shape 189">
                <a:extLst>
                  <a:ext uri="{FF2B5EF4-FFF2-40B4-BE49-F238E27FC236}">
                    <a16:creationId xmlns:a16="http://schemas.microsoft.com/office/drawing/2014/main" id="{042096E5-4C2F-FC99-B17E-775FBDD38F76}"/>
                  </a:ext>
                </a:extLst>
              </p:cNvPr>
              <p:cNvSpPr/>
              <p:nvPr>
                <p:custDataLst>
                  <p:tags r:id="rId16"/>
                </p:custDataLst>
              </p:nvPr>
            </p:nvSpPr>
            <p:spPr>
              <a:xfrm>
                <a:off x="4305355" y="2468103"/>
                <a:ext cx="5542" cy="5808"/>
              </a:xfrm>
              <a:custGeom>
                <a:avLst/>
                <a:gdLst>
                  <a:gd name="connsiteX0" fmla="*/ 708 w 5542"/>
                  <a:gd name="connsiteY0" fmla="*/ 5287 h 5808"/>
                  <a:gd name="connsiteX1" fmla="*/ 652 w 5542"/>
                  <a:gd name="connsiteY1" fmla="*/ 5431 h 5808"/>
                  <a:gd name="connsiteX2" fmla="*/ 412 w 5542"/>
                  <a:gd name="connsiteY2" fmla="*/ 5449 h 5808"/>
                  <a:gd name="connsiteX3" fmla="*/ 90 w 5542"/>
                  <a:gd name="connsiteY3" fmla="*/ 5700 h 5808"/>
                  <a:gd name="connsiteX4" fmla="*/ 265 w 5542"/>
                  <a:gd name="connsiteY4" fmla="*/ 5871 h 5808"/>
                  <a:gd name="connsiteX5" fmla="*/ 1113 w 5542"/>
                  <a:gd name="connsiteY5" fmla="*/ 5844 h 5808"/>
                  <a:gd name="connsiteX6" fmla="*/ 2100 w 5542"/>
                  <a:gd name="connsiteY6" fmla="*/ 5871 h 5808"/>
                  <a:gd name="connsiteX7" fmla="*/ 2340 w 5542"/>
                  <a:gd name="connsiteY7" fmla="*/ 5610 h 5808"/>
                  <a:gd name="connsiteX8" fmla="*/ 2100 w 5542"/>
                  <a:gd name="connsiteY8" fmla="*/ 5449 h 5808"/>
                  <a:gd name="connsiteX9" fmla="*/ 1704 w 5542"/>
                  <a:gd name="connsiteY9" fmla="*/ 5440 h 5808"/>
                  <a:gd name="connsiteX10" fmla="*/ 2100 w 5542"/>
                  <a:gd name="connsiteY10" fmla="*/ 3875 h 5808"/>
                  <a:gd name="connsiteX11" fmla="*/ 3032 w 5542"/>
                  <a:gd name="connsiteY11" fmla="*/ 4199 h 5808"/>
                  <a:gd name="connsiteX12" fmla="*/ 5632 w 5542"/>
                  <a:gd name="connsiteY12" fmla="*/ 1546 h 5808"/>
                  <a:gd name="connsiteX13" fmla="*/ 4018 w 5542"/>
                  <a:gd name="connsiteY13" fmla="*/ 63 h 5808"/>
                  <a:gd name="connsiteX14" fmla="*/ 2736 w 5542"/>
                  <a:gd name="connsiteY14" fmla="*/ 548 h 5808"/>
                  <a:gd name="connsiteX15" fmla="*/ 1676 w 5542"/>
                  <a:gd name="connsiteY15" fmla="*/ 63 h 5808"/>
                  <a:gd name="connsiteX16" fmla="*/ 874 w 5542"/>
                  <a:gd name="connsiteY16" fmla="*/ 575 h 5808"/>
                  <a:gd name="connsiteX17" fmla="*/ 523 w 5542"/>
                  <a:gd name="connsiteY17" fmla="*/ 1465 h 5808"/>
                  <a:gd name="connsiteX18" fmla="*/ 744 w 5542"/>
                  <a:gd name="connsiteY18" fmla="*/ 1591 h 5808"/>
                  <a:gd name="connsiteX19" fmla="*/ 929 w 5542"/>
                  <a:gd name="connsiteY19" fmla="*/ 1546 h 5808"/>
                  <a:gd name="connsiteX20" fmla="*/ 1003 w 5542"/>
                  <a:gd name="connsiteY20" fmla="*/ 1286 h 5808"/>
                  <a:gd name="connsiteX21" fmla="*/ 1630 w 5542"/>
                  <a:gd name="connsiteY21" fmla="*/ 386 h 5808"/>
                  <a:gd name="connsiteX22" fmla="*/ 1842 w 5542"/>
                  <a:gd name="connsiteY22" fmla="*/ 719 h 5808"/>
                  <a:gd name="connsiteX23" fmla="*/ 1787 w 5542"/>
                  <a:gd name="connsiteY23" fmla="*/ 1106 h 5808"/>
                  <a:gd name="connsiteX24" fmla="*/ 708 w 5542"/>
                  <a:gd name="connsiteY24" fmla="*/ 5287 h 5808"/>
                  <a:gd name="connsiteX25" fmla="*/ 2829 w 5542"/>
                  <a:gd name="connsiteY25" fmla="*/ 971 h 5808"/>
                  <a:gd name="connsiteX26" fmla="*/ 3972 w 5542"/>
                  <a:gd name="connsiteY26" fmla="*/ 386 h 5808"/>
                  <a:gd name="connsiteX27" fmla="*/ 4590 w 5542"/>
                  <a:gd name="connsiteY27" fmla="*/ 1070 h 5808"/>
                  <a:gd name="connsiteX28" fmla="*/ 4129 w 5542"/>
                  <a:gd name="connsiteY28" fmla="*/ 2994 h 5808"/>
                  <a:gd name="connsiteX29" fmla="*/ 3013 w 5542"/>
                  <a:gd name="connsiteY29" fmla="*/ 3875 h 5808"/>
                  <a:gd name="connsiteX30" fmla="*/ 2248 w 5542"/>
                  <a:gd name="connsiteY30" fmla="*/ 3354 h 5808"/>
                  <a:gd name="connsiteX31" fmla="*/ 2266 w 5542"/>
                  <a:gd name="connsiteY31" fmla="*/ 3228 h 5808"/>
                  <a:gd name="connsiteX32" fmla="*/ 2829 w 5542"/>
                  <a:gd name="connsiteY32" fmla="*/ 971 h 580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</a:cxnLst>
                <a:rect l="l" t="t" r="r" b="b"/>
                <a:pathLst>
                  <a:path w="5542" h="5808">
                    <a:moveTo>
                      <a:pt x="708" y="5287"/>
                    </a:moveTo>
                    <a:cubicBezTo>
                      <a:pt x="671" y="5413"/>
                      <a:pt x="661" y="5422"/>
                      <a:pt x="652" y="5431"/>
                    </a:cubicBezTo>
                    <a:cubicBezTo>
                      <a:pt x="597" y="5449"/>
                      <a:pt x="495" y="5449"/>
                      <a:pt x="412" y="5449"/>
                    </a:cubicBezTo>
                    <a:cubicBezTo>
                      <a:pt x="256" y="5449"/>
                      <a:pt x="90" y="5449"/>
                      <a:pt x="90" y="5700"/>
                    </a:cubicBezTo>
                    <a:cubicBezTo>
                      <a:pt x="90" y="5799"/>
                      <a:pt x="163" y="5871"/>
                      <a:pt x="265" y="5871"/>
                    </a:cubicBezTo>
                    <a:cubicBezTo>
                      <a:pt x="532" y="5871"/>
                      <a:pt x="837" y="5844"/>
                      <a:pt x="1113" y="5844"/>
                    </a:cubicBezTo>
                    <a:cubicBezTo>
                      <a:pt x="1436" y="5844"/>
                      <a:pt x="1787" y="5871"/>
                      <a:pt x="2100" y="5871"/>
                    </a:cubicBezTo>
                    <a:cubicBezTo>
                      <a:pt x="2165" y="5871"/>
                      <a:pt x="2340" y="5871"/>
                      <a:pt x="2340" y="5610"/>
                    </a:cubicBezTo>
                    <a:cubicBezTo>
                      <a:pt x="2340" y="5458"/>
                      <a:pt x="2192" y="5449"/>
                      <a:pt x="2100" y="5449"/>
                    </a:cubicBezTo>
                    <a:cubicBezTo>
                      <a:pt x="1971" y="5449"/>
                      <a:pt x="1823" y="5449"/>
                      <a:pt x="1704" y="5440"/>
                    </a:cubicBezTo>
                    <a:lnTo>
                      <a:pt x="2100" y="3875"/>
                    </a:lnTo>
                    <a:cubicBezTo>
                      <a:pt x="2238" y="4001"/>
                      <a:pt x="2543" y="4199"/>
                      <a:pt x="3032" y="4199"/>
                    </a:cubicBezTo>
                    <a:cubicBezTo>
                      <a:pt x="4636" y="4199"/>
                      <a:pt x="5632" y="2778"/>
                      <a:pt x="5632" y="1546"/>
                    </a:cubicBezTo>
                    <a:cubicBezTo>
                      <a:pt x="5632" y="440"/>
                      <a:pt x="4784" y="63"/>
                      <a:pt x="4018" y="63"/>
                    </a:cubicBezTo>
                    <a:cubicBezTo>
                      <a:pt x="3364" y="63"/>
                      <a:pt x="2884" y="413"/>
                      <a:pt x="2736" y="548"/>
                    </a:cubicBezTo>
                    <a:cubicBezTo>
                      <a:pt x="2386" y="63"/>
                      <a:pt x="1777" y="63"/>
                      <a:pt x="1676" y="63"/>
                    </a:cubicBezTo>
                    <a:cubicBezTo>
                      <a:pt x="1335" y="63"/>
                      <a:pt x="1067" y="252"/>
                      <a:pt x="874" y="575"/>
                    </a:cubicBezTo>
                    <a:cubicBezTo>
                      <a:pt x="643" y="935"/>
                      <a:pt x="523" y="1420"/>
                      <a:pt x="523" y="1465"/>
                    </a:cubicBezTo>
                    <a:cubicBezTo>
                      <a:pt x="523" y="1591"/>
                      <a:pt x="661" y="1591"/>
                      <a:pt x="744" y="1591"/>
                    </a:cubicBezTo>
                    <a:cubicBezTo>
                      <a:pt x="846" y="1591"/>
                      <a:pt x="883" y="1591"/>
                      <a:pt x="929" y="1546"/>
                    </a:cubicBezTo>
                    <a:cubicBezTo>
                      <a:pt x="947" y="1528"/>
                      <a:pt x="947" y="1510"/>
                      <a:pt x="1003" y="1286"/>
                    </a:cubicBezTo>
                    <a:cubicBezTo>
                      <a:pt x="1187" y="566"/>
                      <a:pt x="1399" y="386"/>
                      <a:pt x="1630" y="386"/>
                    </a:cubicBezTo>
                    <a:cubicBezTo>
                      <a:pt x="1731" y="386"/>
                      <a:pt x="1842" y="422"/>
                      <a:pt x="1842" y="719"/>
                    </a:cubicBezTo>
                    <a:cubicBezTo>
                      <a:pt x="1842" y="854"/>
                      <a:pt x="1823" y="980"/>
                      <a:pt x="1787" y="1106"/>
                    </a:cubicBezTo>
                    <a:lnTo>
                      <a:pt x="708" y="5287"/>
                    </a:lnTo>
                    <a:close/>
                    <a:moveTo>
                      <a:pt x="2829" y="971"/>
                    </a:moveTo>
                    <a:cubicBezTo>
                      <a:pt x="3096" y="665"/>
                      <a:pt x="3530" y="386"/>
                      <a:pt x="3972" y="386"/>
                    </a:cubicBezTo>
                    <a:cubicBezTo>
                      <a:pt x="4544" y="386"/>
                      <a:pt x="4590" y="872"/>
                      <a:pt x="4590" y="1070"/>
                    </a:cubicBezTo>
                    <a:cubicBezTo>
                      <a:pt x="4590" y="1537"/>
                      <a:pt x="4277" y="2643"/>
                      <a:pt x="4129" y="2994"/>
                    </a:cubicBezTo>
                    <a:cubicBezTo>
                      <a:pt x="3843" y="3650"/>
                      <a:pt x="3391" y="3875"/>
                      <a:pt x="3013" y="3875"/>
                    </a:cubicBezTo>
                    <a:cubicBezTo>
                      <a:pt x="2469" y="3875"/>
                      <a:pt x="2248" y="3452"/>
                      <a:pt x="2248" y="3354"/>
                    </a:cubicBezTo>
                    <a:lnTo>
                      <a:pt x="2266" y="3228"/>
                    </a:lnTo>
                    <a:lnTo>
                      <a:pt x="2829" y="971"/>
                    </a:ln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91" name="Freeform: Shape 190">
                <a:extLst>
                  <a:ext uri="{FF2B5EF4-FFF2-40B4-BE49-F238E27FC236}">
                    <a16:creationId xmlns:a16="http://schemas.microsoft.com/office/drawing/2014/main" id="{98565265-4094-F433-1C6B-0B322FDC5829}"/>
                  </a:ext>
                </a:extLst>
              </p:cNvPr>
              <p:cNvSpPr/>
              <p:nvPr>
                <p:custDataLst>
                  <p:tags r:id="rId17"/>
                </p:custDataLst>
              </p:nvPr>
            </p:nvSpPr>
            <p:spPr>
              <a:xfrm>
                <a:off x="4311828" y="2471214"/>
                <a:ext cx="1079" cy="2688"/>
              </a:xfrm>
              <a:custGeom>
                <a:avLst/>
                <a:gdLst>
                  <a:gd name="connsiteX0" fmla="*/ 1175 w 1079"/>
                  <a:gd name="connsiteY0" fmla="*/ 1007 h 2688"/>
                  <a:gd name="connsiteX1" fmla="*/ 584 w 1079"/>
                  <a:gd name="connsiteY1" fmla="*/ 63 h 2688"/>
                  <a:gd name="connsiteX2" fmla="*/ 96 w 1079"/>
                  <a:gd name="connsiteY2" fmla="*/ 539 h 2688"/>
                  <a:gd name="connsiteX3" fmla="*/ 584 w 1079"/>
                  <a:gd name="connsiteY3" fmla="*/ 1016 h 2688"/>
                  <a:gd name="connsiteX4" fmla="*/ 907 w 1079"/>
                  <a:gd name="connsiteY4" fmla="*/ 899 h 2688"/>
                  <a:gd name="connsiteX5" fmla="*/ 953 w 1079"/>
                  <a:gd name="connsiteY5" fmla="*/ 872 h 2688"/>
                  <a:gd name="connsiteX6" fmla="*/ 972 w 1079"/>
                  <a:gd name="connsiteY6" fmla="*/ 1007 h 2688"/>
                  <a:gd name="connsiteX7" fmla="*/ 345 w 1079"/>
                  <a:gd name="connsiteY7" fmla="*/ 2508 h 2688"/>
                  <a:gd name="connsiteX8" fmla="*/ 243 w 1079"/>
                  <a:gd name="connsiteY8" fmla="*/ 2652 h 2688"/>
                  <a:gd name="connsiteX9" fmla="*/ 335 w 1079"/>
                  <a:gd name="connsiteY9" fmla="*/ 2751 h 2688"/>
                  <a:gd name="connsiteX10" fmla="*/ 1175 w 1079"/>
                  <a:gd name="connsiteY10" fmla="*/ 1007 h 26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1079" h="2688">
                    <a:moveTo>
                      <a:pt x="1175" y="1007"/>
                    </a:moveTo>
                    <a:cubicBezTo>
                      <a:pt x="1175" y="413"/>
                      <a:pt x="944" y="63"/>
                      <a:pt x="584" y="63"/>
                    </a:cubicBezTo>
                    <a:cubicBezTo>
                      <a:pt x="280" y="63"/>
                      <a:pt x="96" y="288"/>
                      <a:pt x="96" y="539"/>
                    </a:cubicBezTo>
                    <a:cubicBezTo>
                      <a:pt x="96" y="782"/>
                      <a:pt x="280" y="1016"/>
                      <a:pt x="584" y="1016"/>
                    </a:cubicBezTo>
                    <a:cubicBezTo>
                      <a:pt x="695" y="1016"/>
                      <a:pt x="815" y="980"/>
                      <a:pt x="907" y="899"/>
                    </a:cubicBezTo>
                    <a:cubicBezTo>
                      <a:pt x="935" y="881"/>
                      <a:pt x="944" y="872"/>
                      <a:pt x="953" y="872"/>
                    </a:cubicBezTo>
                    <a:cubicBezTo>
                      <a:pt x="963" y="872"/>
                      <a:pt x="972" y="881"/>
                      <a:pt x="972" y="1007"/>
                    </a:cubicBezTo>
                    <a:cubicBezTo>
                      <a:pt x="972" y="1672"/>
                      <a:pt x="649" y="2212"/>
                      <a:pt x="345" y="2508"/>
                    </a:cubicBezTo>
                    <a:cubicBezTo>
                      <a:pt x="243" y="2607"/>
                      <a:pt x="243" y="2625"/>
                      <a:pt x="243" y="2652"/>
                    </a:cubicBezTo>
                    <a:cubicBezTo>
                      <a:pt x="243" y="2715"/>
                      <a:pt x="289" y="2751"/>
                      <a:pt x="335" y="2751"/>
                    </a:cubicBezTo>
                    <a:cubicBezTo>
                      <a:pt x="437" y="2751"/>
                      <a:pt x="1175" y="2059"/>
                      <a:pt x="1175" y="1007"/>
                    </a:cubicBez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92" name="Freeform: Shape 191">
                <a:extLst>
                  <a:ext uri="{FF2B5EF4-FFF2-40B4-BE49-F238E27FC236}">
                    <a16:creationId xmlns:a16="http://schemas.microsoft.com/office/drawing/2014/main" id="{B01A7390-37C4-7C0E-DA11-617104018EE3}"/>
                  </a:ext>
                </a:extLst>
              </p:cNvPr>
              <p:cNvSpPr/>
              <p:nvPr>
                <p:custDataLst>
                  <p:tags r:id="rId18"/>
                </p:custDataLst>
              </p:nvPr>
            </p:nvSpPr>
            <p:spPr>
              <a:xfrm>
                <a:off x="4317553" y="2465803"/>
                <a:ext cx="2462" cy="1384"/>
              </a:xfrm>
              <a:custGeom>
                <a:avLst/>
                <a:gdLst>
                  <a:gd name="connsiteX0" fmla="*/ 1337 w 2462"/>
                  <a:gd name="connsiteY0" fmla="*/ 63 h 1384"/>
                  <a:gd name="connsiteX1" fmla="*/ 102 w 2462"/>
                  <a:gd name="connsiteY1" fmla="*/ 1285 h 1384"/>
                  <a:gd name="connsiteX2" fmla="*/ 268 w 2462"/>
                  <a:gd name="connsiteY2" fmla="*/ 1447 h 1384"/>
                  <a:gd name="connsiteX3" fmla="*/ 1337 w 2462"/>
                  <a:gd name="connsiteY3" fmla="*/ 530 h 1384"/>
                  <a:gd name="connsiteX4" fmla="*/ 2398 w 2462"/>
                  <a:gd name="connsiteY4" fmla="*/ 1447 h 1384"/>
                  <a:gd name="connsiteX5" fmla="*/ 2564 w 2462"/>
                  <a:gd name="connsiteY5" fmla="*/ 1285 h 1384"/>
                  <a:gd name="connsiteX6" fmla="*/ 1337 w 2462"/>
                  <a:gd name="connsiteY6" fmla="*/ 63 h 13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462" h="1384">
                    <a:moveTo>
                      <a:pt x="1337" y="63"/>
                    </a:moveTo>
                    <a:lnTo>
                      <a:pt x="102" y="1285"/>
                    </a:lnTo>
                    <a:lnTo>
                      <a:pt x="268" y="1447"/>
                    </a:lnTo>
                    <a:lnTo>
                      <a:pt x="1337" y="530"/>
                    </a:lnTo>
                    <a:lnTo>
                      <a:pt x="2398" y="1447"/>
                    </a:lnTo>
                    <a:lnTo>
                      <a:pt x="2564" y="1285"/>
                    </a:lnTo>
                    <a:lnTo>
                      <a:pt x="1337" y="63"/>
                    </a:ln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93" name="Freeform: Shape 192">
                <a:extLst>
                  <a:ext uri="{FF2B5EF4-FFF2-40B4-BE49-F238E27FC236}">
                    <a16:creationId xmlns:a16="http://schemas.microsoft.com/office/drawing/2014/main" id="{B67A3169-7487-BAF5-C0FE-A65D5F84D5A4}"/>
                  </a:ext>
                </a:extLst>
              </p:cNvPr>
              <p:cNvSpPr/>
              <p:nvPr>
                <p:custDataLst>
                  <p:tags r:id="rId19"/>
                </p:custDataLst>
              </p:nvPr>
            </p:nvSpPr>
            <p:spPr>
              <a:xfrm>
                <a:off x="4314996" y="2468103"/>
                <a:ext cx="5542" cy="5808"/>
              </a:xfrm>
              <a:custGeom>
                <a:avLst/>
                <a:gdLst>
                  <a:gd name="connsiteX0" fmla="*/ 718 w 5542"/>
                  <a:gd name="connsiteY0" fmla="*/ 5287 h 5808"/>
                  <a:gd name="connsiteX1" fmla="*/ 663 w 5542"/>
                  <a:gd name="connsiteY1" fmla="*/ 5431 h 5808"/>
                  <a:gd name="connsiteX2" fmla="*/ 423 w 5542"/>
                  <a:gd name="connsiteY2" fmla="*/ 5449 h 5808"/>
                  <a:gd name="connsiteX3" fmla="*/ 100 w 5542"/>
                  <a:gd name="connsiteY3" fmla="*/ 5700 h 5808"/>
                  <a:gd name="connsiteX4" fmla="*/ 275 w 5542"/>
                  <a:gd name="connsiteY4" fmla="*/ 5871 h 5808"/>
                  <a:gd name="connsiteX5" fmla="*/ 1124 w 5542"/>
                  <a:gd name="connsiteY5" fmla="*/ 5844 h 5808"/>
                  <a:gd name="connsiteX6" fmla="*/ 2111 w 5542"/>
                  <a:gd name="connsiteY6" fmla="*/ 5871 h 5808"/>
                  <a:gd name="connsiteX7" fmla="*/ 2350 w 5542"/>
                  <a:gd name="connsiteY7" fmla="*/ 5610 h 5808"/>
                  <a:gd name="connsiteX8" fmla="*/ 2111 w 5542"/>
                  <a:gd name="connsiteY8" fmla="*/ 5449 h 5808"/>
                  <a:gd name="connsiteX9" fmla="*/ 1714 w 5542"/>
                  <a:gd name="connsiteY9" fmla="*/ 5440 h 5808"/>
                  <a:gd name="connsiteX10" fmla="*/ 2111 w 5542"/>
                  <a:gd name="connsiteY10" fmla="*/ 3875 h 5808"/>
                  <a:gd name="connsiteX11" fmla="*/ 3042 w 5542"/>
                  <a:gd name="connsiteY11" fmla="*/ 4199 h 5808"/>
                  <a:gd name="connsiteX12" fmla="*/ 5643 w 5542"/>
                  <a:gd name="connsiteY12" fmla="*/ 1546 h 5808"/>
                  <a:gd name="connsiteX13" fmla="*/ 4029 w 5542"/>
                  <a:gd name="connsiteY13" fmla="*/ 63 h 5808"/>
                  <a:gd name="connsiteX14" fmla="*/ 2747 w 5542"/>
                  <a:gd name="connsiteY14" fmla="*/ 548 h 5808"/>
                  <a:gd name="connsiteX15" fmla="*/ 1686 w 5542"/>
                  <a:gd name="connsiteY15" fmla="*/ 63 h 5808"/>
                  <a:gd name="connsiteX16" fmla="*/ 884 w 5542"/>
                  <a:gd name="connsiteY16" fmla="*/ 575 h 5808"/>
                  <a:gd name="connsiteX17" fmla="*/ 534 w 5542"/>
                  <a:gd name="connsiteY17" fmla="*/ 1465 h 5808"/>
                  <a:gd name="connsiteX18" fmla="*/ 755 w 5542"/>
                  <a:gd name="connsiteY18" fmla="*/ 1591 h 5808"/>
                  <a:gd name="connsiteX19" fmla="*/ 939 w 5542"/>
                  <a:gd name="connsiteY19" fmla="*/ 1546 h 5808"/>
                  <a:gd name="connsiteX20" fmla="*/ 1013 w 5542"/>
                  <a:gd name="connsiteY20" fmla="*/ 1286 h 5808"/>
                  <a:gd name="connsiteX21" fmla="*/ 1640 w 5542"/>
                  <a:gd name="connsiteY21" fmla="*/ 386 h 5808"/>
                  <a:gd name="connsiteX22" fmla="*/ 1852 w 5542"/>
                  <a:gd name="connsiteY22" fmla="*/ 719 h 5808"/>
                  <a:gd name="connsiteX23" fmla="*/ 1797 w 5542"/>
                  <a:gd name="connsiteY23" fmla="*/ 1106 h 5808"/>
                  <a:gd name="connsiteX24" fmla="*/ 718 w 5542"/>
                  <a:gd name="connsiteY24" fmla="*/ 5287 h 5808"/>
                  <a:gd name="connsiteX25" fmla="*/ 2839 w 5542"/>
                  <a:gd name="connsiteY25" fmla="*/ 971 h 5808"/>
                  <a:gd name="connsiteX26" fmla="*/ 3983 w 5542"/>
                  <a:gd name="connsiteY26" fmla="*/ 386 h 5808"/>
                  <a:gd name="connsiteX27" fmla="*/ 4601 w 5542"/>
                  <a:gd name="connsiteY27" fmla="*/ 1070 h 5808"/>
                  <a:gd name="connsiteX28" fmla="*/ 4139 w 5542"/>
                  <a:gd name="connsiteY28" fmla="*/ 2994 h 5808"/>
                  <a:gd name="connsiteX29" fmla="*/ 3024 w 5542"/>
                  <a:gd name="connsiteY29" fmla="*/ 3875 h 5808"/>
                  <a:gd name="connsiteX30" fmla="*/ 2258 w 5542"/>
                  <a:gd name="connsiteY30" fmla="*/ 3354 h 5808"/>
                  <a:gd name="connsiteX31" fmla="*/ 2277 w 5542"/>
                  <a:gd name="connsiteY31" fmla="*/ 3228 h 5808"/>
                  <a:gd name="connsiteX32" fmla="*/ 2839 w 5542"/>
                  <a:gd name="connsiteY32" fmla="*/ 971 h 580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</a:cxnLst>
                <a:rect l="l" t="t" r="r" b="b"/>
                <a:pathLst>
                  <a:path w="5542" h="5808">
                    <a:moveTo>
                      <a:pt x="718" y="5287"/>
                    </a:moveTo>
                    <a:cubicBezTo>
                      <a:pt x="681" y="5413"/>
                      <a:pt x="672" y="5422"/>
                      <a:pt x="663" y="5431"/>
                    </a:cubicBezTo>
                    <a:cubicBezTo>
                      <a:pt x="607" y="5449"/>
                      <a:pt x="506" y="5449"/>
                      <a:pt x="423" y="5449"/>
                    </a:cubicBezTo>
                    <a:cubicBezTo>
                      <a:pt x="266" y="5449"/>
                      <a:pt x="100" y="5449"/>
                      <a:pt x="100" y="5700"/>
                    </a:cubicBezTo>
                    <a:cubicBezTo>
                      <a:pt x="100" y="5799"/>
                      <a:pt x="174" y="5871"/>
                      <a:pt x="275" y="5871"/>
                    </a:cubicBezTo>
                    <a:cubicBezTo>
                      <a:pt x="543" y="5871"/>
                      <a:pt x="847" y="5844"/>
                      <a:pt x="1124" y="5844"/>
                    </a:cubicBezTo>
                    <a:cubicBezTo>
                      <a:pt x="1447" y="5844"/>
                      <a:pt x="1797" y="5871"/>
                      <a:pt x="2111" y="5871"/>
                    </a:cubicBezTo>
                    <a:cubicBezTo>
                      <a:pt x="2175" y="5871"/>
                      <a:pt x="2350" y="5871"/>
                      <a:pt x="2350" y="5610"/>
                    </a:cubicBezTo>
                    <a:cubicBezTo>
                      <a:pt x="2350" y="5458"/>
                      <a:pt x="2203" y="5449"/>
                      <a:pt x="2111" y="5449"/>
                    </a:cubicBezTo>
                    <a:cubicBezTo>
                      <a:pt x="1981" y="5449"/>
                      <a:pt x="1834" y="5449"/>
                      <a:pt x="1714" y="5440"/>
                    </a:cubicBezTo>
                    <a:lnTo>
                      <a:pt x="2111" y="3875"/>
                    </a:lnTo>
                    <a:cubicBezTo>
                      <a:pt x="2249" y="4001"/>
                      <a:pt x="2553" y="4199"/>
                      <a:pt x="3042" y="4199"/>
                    </a:cubicBezTo>
                    <a:cubicBezTo>
                      <a:pt x="4647" y="4199"/>
                      <a:pt x="5643" y="2778"/>
                      <a:pt x="5643" y="1546"/>
                    </a:cubicBezTo>
                    <a:cubicBezTo>
                      <a:pt x="5643" y="440"/>
                      <a:pt x="4794" y="63"/>
                      <a:pt x="4029" y="63"/>
                    </a:cubicBezTo>
                    <a:cubicBezTo>
                      <a:pt x="3374" y="63"/>
                      <a:pt x="2894" y="413"/>
                      <a:pt x="2747" y="548"/>
                    </a:cubicBezTo>
                    <a:cubicBezTo>
                      <a:pt x="2396" y="63"/>
                      <a:pt x="1788" y="63"/>
                      <a:pt x="1686" y="63"/>
                    </a:cubicBezTo>
                    <a:cubicBezTo>
                      <a:pt x="1345" y="63"/>
                      <a:pt x="1078" y="252"/>
                      <a:pt x="884" y="575"/>
                    </a:cubicBezTo>
                    <a:cubicBezTo>
                      <a:pt x="653" y="935"/>
                      <a:pt x="534" y="1420"/>
                      <a:pt x="534" y="1465"/>
                    </a:cubicBezTo>
                    <a:cubicBezTo>
                      <a:pt x="534" y="1591"/>
                      <a:pt x="672" y="1591"/>
                      <a:pt x="755" y="1591"/>
                    </a:cubicBezTo>
                    <a:cubicBezTo>
                      <a:pt x="856" y="1591"/>
                      <a:pt x="893" y="1591"/>
                      <a:pt x="939" y="1546"/>
                    </a:cubicBezTo>
                    <a:cubicBezTo>
                      <a:pt x="958" y="1528"/>
                      <a:pt x="958" y="1510"/>
                      <a:pt x="1013" y="1286"/>
                    </a:cubicBezTo>
                    <a:cubicBezTo>
                      <a:pt x="1198" y="566"/>
                      <a:pt x="1410" y="386"/>
                      <a:pt x="1640" y="386"/>
                    </a:cubicBezTo>
                    <a:cubicBezTo>
                      <a:pt x="1742" y="386"/>
                      <a:pt x="1852" y="422"/>
                      <a:pt x="1852" y="719"/>
                    </a:cubicBezTo>
                    <a:cubicBezTo>
                      <a:pt x="1852" y="854"/>
                      <a:pt x="1834" y="980"/>
                      <a:pt x="1797" y="1106"/>
                    </a:cubicBezTo>
                    <a:lnTo>
                      <a:pt x="718" y="5287"/>
                    </a:lnTo>
                    <a:close/>
                    <a:moveTo>
                      <a:pt x="2839" y="971"/>
                    </a:moveTo>
                    <a:cubicBezTo>
                      <a:pt x="3107" y="665"/>
                      <a:pt x="3540" y="386"/>
                      <a:pt x="3983" y="386"/>
                    </a:cubicBezTo>
                    <a:cubicBezTo>
                      <a:pt x="4554" y="386"/>
                      <a:pt x="4601" y="872"/>
                      <a:pt x="4601" y="1070"/>
                    </a:cubicBezTo>
                    <a:cubicBezTo>
                      <a:pt x="4601" y="1537"/>
                      <a:pt x="4287" y="2643"/>
                      <a:pt x="4139" y="2994"/>
                    </a:cubicBezTo>
                    <a:cubicBezTo>
                      <a:pt x="3854" y="3650"/>
                      <a:pt x="3402" y="3875"/>
                      <a:pt x="3024" y="3875"/>
                    </a:cubicBezTo>
                    <a:cubicBezTo>
                      <a:pt x="2479" y="3875"/>
                      <a:pt x="2258" y="3452"/>
                      <a:pt x="2258" y="3354"/>
                    </a:cubicBezTo>
                    <a:lnTo>
                      <a:pt x="2277" y="3228"/>
                    </a:lnTo>
                    <a:lnTo>
                      <a:pt x="2839" y="971"/>
                    </a:ln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94" name="Freeform: Shape 193">
                <a:extLst>
                  <a:ext uri="{FF2B5EF4-FFF2-40B4-BE49-F238E27FC236}">
                    <a16:creationId xmlns:a16="http://schemas.microsoft.com/office/drawing/2014/main" id="{15AD2505-1262-C923-CF2B-5980B6C82428}"/>
                  </a:ext>
                </a:extLst>
              </p:cNvPr>
              <p:cNvSpPr/>
              <p:nvPr>
                <p:custDataLst>
                  <p:tags r:id="rId20"/>
                </p:custDataLst>
              </p:nvPr>
            </p:nvSpPr>
            <p:spPr>
              <a:xfrm>
                <a:off x="4321202" y="2465424"/>
                <a:ext cx="2139" cy="8991"/>
              </a:xfrm>
              <a:custGeom>
                <a:avLst/>
                <a:gdLst>
                  <a:gd name="connsiteX0" fmla="*/ 2246 w 2139"/>
                  <a:gd name="connsiteY0" fmla="*/ 4558 h 8991"/>
                  <a:gd name="connsiteX1" fmla="*/ 1637 w 2139"/>
                  <a:gd name="connsiteY1" fmla="*/ 1753 h 8991"/>
                  <a:gd name="connsiteX2" fmla="*/ 198 w 2139"/>
                  <a:gd name="connsiteY2" fmla="*/ 63 h 8991"/>
                  <a:gd name="connsiteX3" fmla="*/ 106 w 2139"/>
                  <a:gd name="connsiteY3" fmla="*/ 153 h 8991"/>
                  <a:gd name="connsiteX4" fmla="*/ 281 w 2139"/>
                  <a:gd name="connsiteY4" fmla="*/ 359 h 8991"/>
                  <a:gd name="connsiteX5" fmla="*/ 1711 w 2139"/>
                  <a:gd name="connsiteY5" fmla="*/ 4558 h 8991"/>
                  <a:gd name="connsiteX6" fmla="*/ 226 w 2139"/>
                  <a:gd name="connsiteY6" fmla="*/ 8811 h 8991"/>
                  <a:gd name="connsiteX7" fmla="*/ 106 w 2139"/>
                  <a:gd name="connsiteY7" fmla="*/ 8964 h 8991"/>
                  <a:gd name="connsiteX8" fmla="*/ 198 w 2139"/>
                  <a:gd name="connsiteY8" fmla="*/ 9054 h 8991"/>
                  <a:gd name="connsiteX9" fmla="*/ 1665 w 2139"/>
                  <a:gd name="connsiteY9" fmla="*/ 7301 h 8991"/>
                  <a:gd name="connsiteX10" fmla="*/ 2246 w 2139"/>
                  <a:gd name="connsiteY10" fmla="*/ 4558 h 899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2139" h="8991">
                    <a:moveTo>
                      <a:pt x="2246" y="4558"/>
                    </a:moveTo>
                    <a:cubicBezTo>
                      <a:pt x="2246" y="3857"/>
                      <a:pt x="2144" y="2769"/>
                      <a:pt x="1637" y="1753"/>
                    </a:cubicBezTo>
                    <a:cubicBezTo>
                      <a:pt x="1084" y="647"/>
                      <a:pt x="290" y="63"/>
                      <a:pt x="198" y="63"/>
                    </a:cubicBezTo>
                    <a:cubicBezTo>
                      <a:pt x="143" y="63"/>
                      <a:pt x="106" y="99"/>
                      <a:pt x="106" y="153"/>
                    </a:cubicBezTo>
                    <a:cubicBezTo>
                      <a:pt x="106" y="180"/>
                      <a:pt x="106" y="198"/>
                      <a:pt x="281" y="359"/>
                    </a:cubicBezTo>
                    <a:cubicBezTo>
                      <a:pt x="1185" y="1250"/>
                      <a:pt x="1711" y="2679"/>
                      <a:pt x="1711" y="4558"/>
                    </a:cubicBezTo>
                    <a:cubicBezTo>
                      <a:pt x="1711" y="6096"/>
                      <a:pt x="1370" y="7678"/>
                      <a:pt x="226" y="8811"/>
                    </a:cubicBezTo>
                    <a:cubicBezTo>
                      <a:pt x="106" y="8919"/>
                      <a:pt x="106" y="8937"/>
                      <a:pt x="106" y="8964"/>
                    </a:cubicBezTo>
                    <a:cubicBezTo>
                      <a:pt x="106" y="9018"/>
                      <a:pt x="143" y="9054"/>
                      <a:pt x="198" y="9054"/>
                    </a:cubicBezTo>
                    <a:cubicBezTo>
                      <a:pt x="290" y="9054"/>
                      <a:pt x="1121" y="8443"/>
                      <a:pt x="1665" y="7301"/>
                    </a:cubicBezTo>
                    <a:cubicBezTo>
                      <a:pt x="2135" y="6312"/>
                      <a:pt x="2246" y="5314"/>
                      <a:pt x="2246" y="4558"/>
                    </a:cubicBezTo>
                    <a:close/>
                  </a:path>
                </a:pathLst>
              </a:custGeom>
              <a:solidFill>
                <a:srgbClr val="000000"/>
              </a:solidFill>
              <a:ln w="86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</p:grpSp>
        <p:cxnSp>
          <p:nvCxnSpPr>
            <p:cNvPr id="108" name="Straight Arrow Connector 107">
              <a:extLst>
                <a:ext uri="{FF2B5EF4-FFF2-40B4-BE49-F238E27FC236}">
                  <a16:creationId xmlns:a16="http://schemas.microsoft.com/office/drawing/2014/main" id="{78BFB397-E1E8-83FA-51D7-E2E57CFC9509}"/>
                </a:ext>
              </a:extLst>
            </p:cNvPr>
            <p:cNvCxnSpPr>
              <a:cxnSpLocks/>
            </p:cNvCxnSpPr>
            <p:nvPr/>
          </p:nvCxnSpPr>
          <p:spPr>
            <a:xfrm>
              <a:off x="4442361" y="3050838"/>
              <a:ext cx="73442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Arrow Connector 108">
              <a:extLst>
                <a:ext uri="{FF2B5EF4-FFF2-40B4-BE49-F238E27FC236}">
                  <a16:creationId xmlns:a16="http://schemas.microsoft.com/office/drawing/2014/main" id="{538261A7-DBBE-E01C-A08C-070ED12547E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15803" y="2548164"/>
              <a:ext cx="0" cy="50460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EAEDB8D7-3798-188C-3EFD-45E071D26905}"/>
                </a:ext>
              </a:extLst>
            </p:cNvPr>
            <p:cNvSpPr/>
            <p:nvPr/>
          </p:nvSpPr>
          <p:spPr>
            <a:xfrm>
              <a:off x="2492760" y="1341638"/>
              <a:ext cx="677391" cy="36317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pose</a:t>
              </a:r>
              <a:endParaRPr lang="en-U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7" name="Straight Arrow Connector 116">
              <a:extLst>
                <a:ext uri="{FF2B5EF4-FFF2-40B4-BE49-F238E27FC236}">
                  <a16:creationId xmlns:a16="http://schemas.microsoft.com/office/drawing/2014/main" id="{366E72F1-CC8B-C5B3-1E1D-3428016FF867}"/>
                </a:ext>
              </a:extLst>
            </p:cNvPr>
            <p:cNvCxnSpPr>
              <a:cxnSpLocks/>
            </p:cNvCxnSpPr>
            <p:nvPr/>
          </p:nvCxnSpPr>
          <p:spPr>
            <a:xfrm>
              <a:off x="2257478" y="1523224"/>
              <a:ext cx="213911" cy="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8FD54502-3C4C-9FA0-5EED-2484B4DC3A18}"/>
                </a:ext>
              </a:extLst>
            </p:cNvPr>
            <p:cNvSpPr/>
            <p:nvPr/>
          </p:nvSpPr>
          <p:spPr>
            <a:xfrm>
              <a:off x="3646957" y="2340118"/>
              <a:ext cx="608463" cy="2543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ce Loss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8CBB5631-4E23-0F14-4875-E380E22B917B}"/>
                </a:ext>
              </a:extLst>
            </p:cNvPr>
            <p:cNvSpPr txBox="1"/>
            <p:nvPr/>
          </p:nvSpPr>
          <p:spPr>
            <a:xfrm>
              <a:off x="1087321" y="1947045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cxnSp>
          <p:nvCxnSpPr>
            <p:cNvPr id="120" name="Straight Arrow Connector 119">
              <a:extLst>
                <a:ext uri="{FF2B5EF4-FFF2-40B4-BE49-F238E27FC236}">
                  <a16:creationId xmlns:a16="http://schemas.microsoft.com/office/drawing/2014/main" id="{DC07DA69-4E65-9CE8-48FA-CFC16D9A2C2A}"/>
                </a:ext>
              </a:extLst>
            </p:cNvPr>
            <p:cNvCxnSpPr>
              <a:cxnSpLocks/>
            </p:cNvCxnSpPr>
            <p:nvPr/>
          </p:nvCxnSpPr>
          <p:spPr>
            <a:xfrm>
              <a:off x="2351568" y="2374875"/>
              <a:ext cx="227083" cy="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Arrow Connector 126">
              <a:extLst>
                <a:ext uri="{FF2B5EF4-FFF2-40B4-BE49-F238E27FC236}">
                  <a16:creationId xmlns:a16="http://schemas.microsoft.com/office/drawing/2014/main" id="{CECAAC21-E607-88FF-6BE7-D3B68A7504D8}"/>
                </a:ext>
              </a:extLst>
            </p:cNvPr>
            <p:cNvCxnSpPr>
              <a:cxnSpLocks/>
            </p:cNvCxnSpPr>
            <p:nvPr/>
          </p:nvCxnSpPr>
          <p:spPr>
            <a:xfrm>
              <a:off x="4408603" y="2062164"/>
              <a:ext cx="0" cy="342791"/>
            </a:xfrm>
            <a:prstGeom prst="straightConnector1">
              <a:avLst/>
            </a:prstGeom>
            <a:ln w="6350">
              <a:solidFill>
                <a:schemeClr val="tx1"/>
              </a:solidFill>
              <a:prstDash val="dash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Rectangle: Rounded Corners 127">
              <a:extLst>
                <a:ext uri="{FF2B5EF4-FFF2-40B4-BE49-F238E27FC236}">
                  <a16:creationId xmlns:a16="http://schemas.microsoft.com/office/drawing/2014/main" id="{366F2521-8A10-2466-AB6A-955F8DA2B7FC}"/>
                </a:ext>
              </a:extLst>
            </p:cNvPr>
            <p:cNvSpPr/>
            <p:nvPr/>
          </p:nvSpPr>
          <p:spPr>
            <a:xfrm rot="16200000" flipH="1">
              <a:off x="3194288" y="1400804"/>
              <a:ext cx="744685" cy="244839"/>
            </a:xfrm>
            <a:prstGeom prst="round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st-process &amp; Binarize</a:t>
              </a:r>
            </a:p>
          </p:txBody>
        </p:sp>
        <p:cxnSp>
          <p:nvCxnSpPr>
            <p:cNvPr id="129" name="Straight Arrow Connector 128">
              <a:extLst>
                <a:ext uri="{FF2B5EF4-FFF2-40B4-BE49-F238E27FC236}">
                  <a16:creationId xmlns:a16="http://schemas.microsoft.com/office/drawing/2014/main" id="{2F21E970-E2F7-5957-23AA-FB2AC9A3EB11}"/>
                </a:ext>
              </a:extLst>
            </p:cNvPr>
            <p:cNvCxnSpPr>
              <a:cxnSpLocks/>
            </p:cNvCxnSpPr>
            <p:nvPr/>
          </p:nvCxnSpPr>
          <p:spPr>
            <a:xfrm>
              <a:off x="3205659" y="1523224"/>
              <a:ext cx="213911" cy="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Arrow Connector 129">
              <a:extLst>
                <a:ext uri="{FF2B5EF4-FFF2-40B4-BE49-F238E27FC236}">
                  <a16:creationId xmlns:a16="http://schemas.microsoft.com/office/drawing/2014/main" id="{F8A94982-34DD-7D16-AF32-4CB63AA36FBB}"/>
                </a:ext>
              </a:extLst>
            </p:cNvPr>
            <p:cNvCxnSpPr>
              <a:cxnSpLocks/>
            </p:cNvCxnSpPr>
            <p:nvPr/>
          </p:nvCxnSpPr>
          <p:spPr>
            <a:xfrm>
              <a:off x="3709652" y="1523224"/>
              <a:ext cx="213911" cy="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98BBF990-534C-A508-9E10-B55BDBC65874}"/>
                </a:ext>
              </a:extLst>
            </p:cNvPr>
            <p:cNvSpPr txBox="1"/>
            <p:nvPr/>
          </p:nvSpPr>
          <p:spPr>
            <a:xfrm>
              <a:off x="4883586" y="1193710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1CDD69AB-1B2D-E7F4-258E-629FDE46E0A7}"/>
                </a:ext>
              </a:extLst>
            </p:cNvPr>
            <p:cNvCxnSpPr>
              <a:cxnSpLocks/>
            </p:cNvCxnSpPr>
            <p:nvPr/>
          </p:nvCxnSpPr>
          <p:spPr>
            <a:xfrm>
              <a:off x="2494408" y="68434"/>
              <a:ext cx="392136" cy="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0189EBA6-1DDA-FD09-7125-340933DD78E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41210" y="1123022"/>
              <a:ext cx="826654" cy="2434680"/>
              <a:chOff x="323647" y="2008901"/>
              <a:chExt cx="1739556" cy="5058839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3C4A69B2-F3B7-0835-B9D1-6B9E70D884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4"/>
              <a:srcRect l="14776" t="7536" r="72717" b="10507"/>
              <a:stretch/>
            </p:blipFill>
            <p:spPr>
              <a:xfrm>
                <a:off x="1232577" y="2011762"/>
                <a:ext cx="830626" cy="5001496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5CC34471-5979-AF91-3606-3BA0B19A152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4"/>
              <a:srcRect l="55459" t="7536" r="31013" b="10507"/>
              <a:stretch/>
            </p:blipFill>
            <p:spPr>
              <a:xfrm>
                <a:off x="323647" y="2008901"/>
                <a:ext cx="898433" cy="5001500"/>
              </a:xfrm>
              <a:prstGeom prst="rect">
                <a:avLst/>
              </a:prstGeom>
            </p:spPr>
          </p:pic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0AD93D1E-CD29-8861-DF42-B81586F47C2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92502" y="6892411"/>
                <a:ext cx="22621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11" name="TextBox 11 6 1">
                    <a:extLst>
                      <a:ext uri="{FF2B5EF4-FFF2-40B4-BE49-F238E27FC236}">
                        <a16:creationId xmlns:a16="http://schemas.microsoft.com/office/drawing/2014/main" id="{BE2851D9-E85D-E238-C001-4DCB3F6C181A}"/>
                      </a:ext>
                    </a:extLst>
                  </p:cNvPr>
                  <p:cNvSpPr txBox="1"/>
                  <p:nvPr/>
                </p:nvSpPr>
                <p:spPr>
                  <a:xfrm>
                    <a:off x="506160" y="2473031"/>
                    <a:ext cx="361952" cy="41567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>
                    <a:defPPr>
                      <a:defRPr lang="en-IL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a:rPr lang="en-US" sz="700" i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−60 </m:t>
                          </m:r>
                          <m:r>
                            <m:rPr>
                              <m:sty m:val="p"/>
                            </m:rPr>
                            <a:rPr lang="en-US" sz="700" i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μm</m:t>
                          </m:r>
                        </m:oMath>
                      </m:oMathPara>
                    </a14:m>
                    <a:endParaRPr lang="en-IL" sz="700" dirty="0">
                      <a:solidFill>
                        <a:schemeClr val="bg1"/>
                      </a:solidFill>
                      <a:latin typeface="Symbol" panose="05050102010706020507" pitchFamily="18" charset="2"/>
                    </a:endParaRPr>
                  </a:p>
                </p:txBody>
              </p:sp>
            </mc:Choice>
            <mc:Fallback xmlns="">
              <p:sp>
                <p:nvSpPr>
                  <p:cNvPr id="11" name="TextBox 11 6 1">
                    <a:extLst>
                      <a:ext uri="{FF2B5EF4-FFF2-40B4-BE49-F238E27FC236}">
                        <a16:creationId xmlns:a16="http://schemas.microsoft.com/office/drawing/2014/main" id="{BE2851D9-E85D-E238-C001-4DCB3F6C181A}"/>
                      </a:ext>
                    </a:extLst>
                  </p:cNvPr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506160" y="2473031"/>
                    <a:ext cx="361952" cy="415679"/>
                  </a:xfrm>
                  <a:prstGeom prst="rect">
                    <a:avLst/>
                  </a:prstGeom>
                  <a:blipFill>
                    <a:blip r:embed="rId39"/>
                    <a:stretch>
                      <a:fillRect l="-57143" r="-50000"/>
                    </a:stretch>
                  </a:blipFill>
                </p:spPr>
                <p:txBody>
                  <a:bodyPr/>
                  <a:lstStyle/>
                  <a:p>
                    <a:r>
                      <a:rPr lang="en-US">
                        <a:noFill/>
                      </a:rPr>
                      <a:t> </a:t>
                    </a:r>
                  </a:p>
                </p:txBody>
              </p:sp>
            </mc:Fallback>
          </mc:AlternateContent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12" name="TextBox 11 7">
                    <a:extLst>
                      <a:ext uri="{FF2B5EF4-FFF2-40B4-BE49-F238E27FC236}">
                        <a16:creationId xmlns:a16="http://schemas.microsoft.com/office/drawing/2014/main" id="{7FE77332-AE06-BAE8-82B8-E36F9BCA2EF2}"/>
                      </a:ext>
                    </a:extLst>
                  </p:cNvPr>
                  <p:cNvSpPr txBox="1"/>
                  <p:nvPr/>
                </p:nvSpPr>
                <p:spPr>
                  <a:xfrm>
                    <a:off x="506160" y="4562548"/>
                    <a:ext cx="361952" cy="41567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>
                    <a:defPPr>
                      <a:defRPr lang="en-IL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a:rPr lang="en-US" sz="700" i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0 </m:t>
                          </m:r>
                          <m:r>
                            <m:rPr>
                              <m:sty m:val="p"/>
                            </m:rPr>
                            <a:rPr lang="en-US" sz="700" i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μm</m:t>
                          </m:r>
                        </m:oMath>
                      </m:oMathPara>
                    </a14:m>
                    <a:endParaRPr lang="en-IL" sz="700" dirty="0">
                      <a:solidFill>
                        <a:schemeClr val="bg1"/>
                      </a:solidFill>
                    </a:endParaRPr>
                  </a:p>
                </p:txBody>
              </p:sp>
            </mc:Choice>
            <mc:Fallback xmlns="">
              <p:sp>
                <p:nvSpPr>
                  <p:cNvPr id="12" name="TextBox 11 7">
                    <a:extLst>
                      <a:ext uri="{FF2B5EF4-FFF2-40B4-BE49-F238E27FC236}">
                        <a16:creationId xmlns:a16="http://schemas.microsoft.com/office/drawing/2014/main" id="{7FE77332-AE06-BAE8-82B8-E36F9BCA2EF2}"/>
                      </a:ext>
                    </a:extLst>
                  </p:cNvPr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506160" y="4562548"/>
                    <a:ext cx="361952" cy="415679"/>
                  </a:xfrm>
                  <a:prstGeom prst="rect">
                    <a:avLst/>
                  </a:prstGeom>
                  <a:blipFill>
                    <a:blip r:embed="rId40"/>
                    <a:stretch>
                      <a:fillRect l="-31034" r="-13793"/>
                    </a:stretch>
                  </a:blipFill>
                </p:spPr>
                <p:txBody>
                  <a:bodyPr/>
                  <a:lstStyle/>
                  <a:p>
                    <a:r>
                      <a:rPr lang="en-US">
                        <a:noFill/>
                      </a:rPr>
                      <a:t> </a:t>
                    </a:r>
                  </a:p>
                </p:txBody>
              </p:sp>
            </mc:Fallback>
          </mc:AlternateContent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13" name="TextBox 11 8">
                    <a:extLst>
                      <a:ext uri="{FF2B5EF4-FFF2-40B4-BE49-F238E27FC236}">
                        <a16:creationId xmlns:a16="http://schemas.microsoft.com/office/drawing/2014/main" id="{65A0EC2C-F06B-682A-A6A3-054BCBC8A009}"/>
                      </a:ext>
                    </a:extLst>
                  </p:cNvPr>
                  <p:cNvSpPr txBox="1"/>
                  <p:nvPr/>
                </p:nvSpPr>
                <p:spPr>
                  <a:xfrm>
                    <a:off x="506160" y="6652061"/>
                    <a:ext cx="361950" cy="41567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>
                    <a:defPPr>
                      <a:defRPr lang="en-IL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a:rPr lang="en-US" sz="700" i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+60 </m:t>
                          </m:r>
                          <m:r>
                            <m:rPr>
                              <m:sty m:val="p"/>
                            </m:rPr>
                            <a:rPr lang="en-US" sz="700" i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μm</m:t>
                          </m:r>
                        </m:oMath>
                      </m:oMathPara>
                    </a14:m>
                    <a:endParaRPr lang="en-IL" sz="700" dirty="0">
                      <a:solidFill>
                        <a:schemeClr val="bg1"/>
                      </a:solidFill>
                    </a:endParaRPr>
                  </a:p>
                </p:txBody>
              </p:sp>
            </mc:Choice>
            <mc:Fallback xmlns="">
              <p:sp>
                <p:nvSpPr>
                  <p:cNvPr id="13" name="TextBox 11 8">
                    <a:extLst>
                      <a:ext uri="{FF2B5EF4-FFF2-40B4-BE49-F238E27FC236}">
                        <a16:creationId xmlns:a16="http://schemas.microsoft.com/office/drawing/2014/main" id="{65A0EC2C-F06B-682A-A6A3-054BCBC8A009}"/>
                      </a:ext>
                    </a:extLst>
                  </p:cNvPr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506160" y="6652061"/>
                    <a:ext cx="361950" cy="415679"/>
                  </a:xfrm>
                  <a:prstGeom prst="rect">
                    <a:avLst/>
                  </a:prstGeom>
                  <a:blipFill>
                    <a:blip r:embed="rId41"/>
                    <a:stretch>
                      <a:fillRect l="-62069" r="-48276"/>
                    </a:stretch>
                  </a:blipFill>
                </p:spPr>
                <p:txBody>
                  <a:bodyPr/>
                  <a:lstStyle/>
                  <a:p>
                    <a:r>
                      <a:rPr lang="en-US">
                        <a:noFill/>
                      </a:rPr>
                      <a:t> </a:t>
                    </a:r>
                  </a:p>
                </p:txBody>
              </p:sp>
            </mc:Fallback>
          </mc:AlternateContent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0494E26C-1CD2-03FB-BFCF-4DCC31CD2878}"/>
                </a:ext>
              </a:extLst>
            </p:cNvPr>
            <p:cNvGrpSpPr/>
            <p:nvPr/>
          </p:nvGrpSpPr>
          <p:grpSpPr>
            <a:xfrm>
              <a:off x="3337941" y="2791118"/>
              <a:ext cx="958902" cy="519442"/>
              <a:chOff x="4558651" y="429272"/>
              <a:chExt cx="2520233" cy="1365222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64D441C0-9338-5FDB-264C-3AB4A615E013}"/>
                  </a:ext>
                </a:extLst>
              </p:cNvPr>
              <p:cNvGrpSpPr/>
              <p:nvPr/>
            </p:nvGrpSpPr>
            <p:grpSpPr>
              <a:xfrm>
                <a:off x="4558651" y="429272"/>
                <a:ext cx="2520233" cy="1365222"/>
                <a:chOff x="3645617" y="219168"/>
                <a:chExt cx="2520233" cy="1365222"/>
              </a:xfrm>
            </p:grpSpPr>
            <p:sp>
              <p:nvSpPr>
                <p:cNvPr id="25" name="Rectangle: Rounded Corners 24">
                  <a:extLst>
                    <a:ext uri="{FF2B5EF4-FFF2-40B4-BE49-F238E27FC236}">
                      <a16:creationId xmlns:a16="http://schemas.microsoft.com/office/drawing/2014/main" id="{73F2BED9-153C-D7FF-FBC3-ABD6D11B9123}"/>
                    </a:ext>
                  </a:extLst>
                </p:cNvPr>
                <p:cNvSpPr/>
                <p:nvPr/>
              </p:nvSpPr>
              <p:spPr>
                <a:xfrm>
                  <a:off x="3645617" y="219168"/>
                  <a:ext cx="274524" cy="1365222"/>
                </a:xfrm>
                <a:prstGeom prst="roundRect">
                  <a:avLst/>
                </a:prstGeom>
                <a:solidFill>
                  <a:schemeClr val="bg1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63" dirty="0"/>
                </a:p>
              </p:txBody>
            </p:sp>
            <p:sp>
              <p:nvSpPr>
                <p:cNvPr id="26" name="Rectangle: Rounded Corners 25">
                  <a:extLst>
                    <a:ext uri="{FF2B5EF4-FFF2-40B4-BE49-F238E27FC236}">
                      <a16:creationId xmlns:a16="http://schemas.microsoft.com/office/drawing/2014/main" id="{169BABEF-2685-737B-62C9-CD975EF38D7B}"/>
                    </a:ext>
                  </a:extLst>
                </p:cNvPr>
                <p:cNvSpPr/>
                <p:nvPr/>
              </p:nvSpPr>
              <p:spPr>
                <a:xfrm>
                  <a:off x="4019902" y="355690"/>
                  <a:ext cx="274524" cy="1092178"/>
                </a:xfrm>
                <a:prstGeom prst="roundRect">
                  <a:avLst/>
                </a:prstGeom>
                <a:solidFill>
                  <a:schemeClr val="bg1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63"/>
                </a:p>
              </p:txBody>
            </p:sp>
            <p:sp>
              <p:nvSpPr>
                <p:cNvPr id="27" name="Rectangle: Rounded Corners 26">
                  <a:extLst>
                    <a:ext uri="{FF2B5EF4-FFF2-40B4-BE49-F238E27FC236}">
                      <a16:creationId xmlns:a16="http://schemas.microsoft.com/office/drawing/2014/main" id="{268B5F49-FE11-3506-CF59-0800E402CC10}"/>
                    </a:ext>
                  </a:extLst>
                </p:cNvPr>
                <p:cNvSpPr/>
                <p:nvPr/>
              </p:nvSpPr>
              <p:spPr>
                <a:xfrm>
                  <a:off x="4394187" y="492212"/>
                  <a:ext cx="274524" cy="819133"/>
                </a:xfrm>
                <a:prstGeom prst="roundRect">
                  <a:avLst/>
                </a:prstGeom>
                <a:solidFill>
                  <a:schemeClr val="bg1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63"/>
                </a:p>
              </p:txBody>
            </p:sp>
            <p:sp>
              <p:nvSpPr>
                <p:cNvPr id="28" name="Rectangle: Rounded Corners 27">
                  <a:extLst>
                    <a:ext uri="{FF2B5EF4-FFF2-40B4-BE49-F238E27FC236}">
                      <a16:creationId xmlns:a16="http://schemas.microsoft.com/office/drawing/2014/main" id="{63976999-FC79-98CF-0A2A-9F26D9EF133F}"/>
                    </a:ext>
                  </a:extLst>
                </p:cNvPr>
                <p:cNvSpPr/>
                <p:nvPr/>
              </p:nvSpPr>
              <p:spPr>
                <a:xfrm>
                  <a:off x="4768472" y="628735"/>
                  <a:ext cx="274524" cy="546089"/>
                </a:xfrm>
                <a:prstGeom prst="roundRect">
                  <a:avLst/>
                </a:prstGeom>
                <a:solidFill>
                  <a:schemeClr val="bg1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63" dirty="0"/>
                </a:p>
              </p:txBody>
            </p:sp>
            <p:sp>
              <p:nvSpPr>
                <p:cNvPr id="29" name="Rectangle: Rounded Corners 28">
                  <a:extLst>
                    <a:ext uri="{FF2B5EF4-FFF2-40B4-BE49-F238E27FC236}">
                      <a16:creationId xmlns:a16="http://schemas.microsoft.com/office/drawing/2014/main" id="{44058A18-80C4-068A-BF61-10CA2AEDAFF3}"/>
                    </a:ext>
                  </a:extLst>
                </p:cNvPr>
                <p:cNvSpPr/>
                <p:nvPr/>
              </p:nvSpPr>
              <p:spPr>
                <a:xfrm flipH="1">
                  <a:off x="5891326" y="219168"/>
                  <a:ext cx="274524" cy="1365222"/>
                </a:xfrm>
                <a:prstGeom prst="roundRect">
                  <a:avLst/>
                </a:prstGeom>
                <a:solidFill>
                  <a:schemeClr val="bg1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63"/>
                </a:p>
              </p:txBody>
            </p:sp>
            <p:sp>
              <p:nvSpPr>
                <p:cNvPr id="30" name="Rectangle: Rounded Corners 29">
                  <a:extLst>
                    <a:ext uri="{FF2B5EF4-FFF2-40B4-BE49-F238E27FC236}">
                      <a16:creationId xmlns:a16="http://schemas.microsoft.com/office/drawing/2014/main" id="{3DC7F825-4B72-5CC2-1018-2FD9D2D52BB1}"/>
                    </a:ext>
                  </a:extLst>
                </p:cNvPr>
                <p:cNvSpPr/>
                <p:nvPr/>
              </p:nvSpPr>
              <p:spPr>
                <a:xfrm flipH="1">
                  <a:off x="5517042" y="355690"/>
                  <a:ext cx="274524" cy="1092178"/>
                </a:xfrm>
                <a:prstGeom prst="roundRect">
                  <a:avLst/>
                </a:prstGeom>
                <a:solidFill>
                  <a:schemeClr val="bg1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63"/>
                </a:p>
              </p:txBody>
            </p:sp>
            <p:sp>
              <p:nvSpPr>
                <p:cNvPr id="31" name="Rectangle: Rounded Corners 30">
                  <a:extLst>
                    <a:ext uri="{FF2B5EF4-FFF2-40B4-BE49-F238E27FC236}">
                      <a16:creationId xmlns:a16="http://schemas.microsoft.com/office/drawing/2014/main" id="{4506B8AD-9941-A28B-C653-9282F933C4AE}"/>
                    </a:ext>
                  </a:extLst>
                </p:cNvPr>
                <p:cNvSpPr/>
                <p:nvPr/>
              </p:nvSpPr>
              <p:spPr>
                <a:xfrm flipH="1">
                  <a:off x="5142757" y="492212"/>
                  <a:ext cx="274524" cy="819133"/>
                </a:xfrm>
                <a:prstGeom prst="roundRect">
                  <a:avLst/>
                </a:prstGeom>
                <a:solidFill>
                  <a:schemeClr val="bg1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63"/>
                </a:p>
              </p:txBody>
            </p:sp>
          </p:grp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4E1B41D1-69AD-88FE-11F5-640CB6C37A50}"/>
                  </a:ext>
                </a:extLst>
              </p:cNvPr>
              <p:cNvGrpSpPr/>
              <p:nvPr/>
            </p:nvGrpSpPr>
            <p:grpSpPr>
              <a:xfrm>
                <a:off x="4833175" y="491944"/>
                <a:ext cx="1971185" cy="279400"/>
                <a:chOff x="4833175" y="491944"/>
                <a:chExt cx="1971185" cy="279400"/>
              </a:xfrm>
            </p:grpSpPr>
            <p:cxnSp>
              <p:nvCxnSpPr>
                <p:cNvPr id="22" name="Straight Arrow Connector 21">
                  <a:extLst>
                    <a:ext uri="{FF2B5EF4-FFF2-40B4-BE49-F238E27FC236}">
                      <a16:creationId xmlns:a16="http://schemas.microsoft.com/office/drawing/2014/main" id="{9840056F-4111-FC23-CA4C-F4B9597CA31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81745" y="771344"/>
                  <a:ext cx="474047" cy="0"/>
                </a:xfrm>
                <a:prstGeom prst="straightConnector1">
                  <a:avLst/>
                </a:prstGeom>
                <a:ln w="63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Arrow Connector 22">
                  <a:extLst>
                    <a:ext uri="{FF2B5EF4-FFF2-40B4-BE49-F238E27FC236}">
                      <a16:creationId xmlns:a16="http://schemas.microsoft.com/office/drawing/2014/main" id="{A6AF0416-ED5D-3D79-2D92-FEB5C13A84E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07459" y="637995"/>
                  <a:ext cx="1222617" cy="0"/>
                </a:xfrm>
                <a:prstGeom prst="straightConnector1">
                  <a:avLst/>
                </a:prstGeom>
                <a:ln w="63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Arrow Connector 23">
                  <a:extLst>
                    <a:ext uri="{FF2B5EF4-FFF2-40B4-BE49-F238E27FC236}">
                      <a16:creationId xmlns:a16="http://schemas.microsoft.com/office/drawing/2014/main" id="{34991FE3-B419-EC0D-C578-4C0F8134F95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33175" y="491944"/>
                  <a:ext cx="1971185" cy="0"/>
                </a:xfrm>
                <a:prstGeom prst="straightConnector1">
                  <a:avLst/>
                </a:prstGeom>
                <a:ln w="63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EE10650B-F337-BA01-ED39-AA67CC4E3BCE}"/>
                </a:ext>
              </a:extLst>
            </p:cNvPr>
            <p:cNvGrpSpPr/>
            <p:nvPr/>
          </p:nvGrpSpPr>
          <p:grpSpPr>
            <a:xfrm>
              <a:off x="1374824" y="-125551"/>
              <a:ext cx="990520" cy="1185972"/>
              <a:chOff x="1341483" y="-139840"/>
              <a:chExt cx="990520" cy="1185972"/>
            </a:xfrm>
          </p:grpSpPr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AA2322BA-68BB-D409-2346-11CE45B312BF}"/>
                  </a:ext>
                </a:extLst>
              </p:cNvPr>
              <p:cNvSpPr/>
              <p:nvPr/>
            </p:nvSpPr>
            <p:spPr>
              <a:xfrm>
                <a:off x="1341483" y="791769"/>
                <a:ext cx="990520" cy="25436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trapod z-stack</a:t>
                </a:r>
              </a:p>
            </p:txBody>
          </p: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B7AC2978-3E74-6D9F-D861-55EB180AC5D3}"/>
                  </a:ext>
                </a:extLst>
              </p:cNvPr>
              <p:cNvGrpSpPr/>
              <p:nvPr/>
            </p:nvGrpSpPr>
            <p:grpSpPr>
              <a:xfrm>
                <a:off x="1390218" y="-139840"/>
                <a:ext cx="874505" cy="1173013"/>
                <a:chOff x="1266150" y="-18252"/>
                <a:chExt cx="874505" cy="1173013"/>
              </a:xfrm>
            </p:grpSpPr>
            <p:sp>
              <p:nvSpPr>
                <p:cNvPr id="38" name="Rectangle 37">
                  <a:extLst>
                    <a:ext uri="{FF2B5EF4-FFF2-40B4-BE49-F238E27FC236}">
                      <a16:creationId xmlns:a16="http://schemas.microsoft.com/office/drawing/2014/main" id="{310DAC08-E4F2-5FD7-A47F-48BCAC831346}"/>
                    </a:ext>
                  </a:extLst>
                </p:cNvPr>
                <p:cNvSpPr/>
                <p:nvPr/>
              </p:nvSpPr>
              <p:spPr>
                <a:xfrm rot="16200000">
                  <a:off x="1486902" y="476541"/>
                  <a:ext cx="275989" cy="18573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…</a:t>
                  </a:r>
                </a:p>
              </p:txBody>
            </p:sp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8DC4AFA6-4E99-3603-DD03-D1C8EC32B0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1266150" y="-18252"/>
                  <a:ext cx="720000" cy="720000"/>
                </a:xfrm>
                <a:prstGeom prst="rect">
                  <a:avLst/>
                </a:prstGeom>
                <a:scene3d>
                  <a:camera prst="isometricOffAxis2Top"/>
                  <a:lightRig rig="threePt" dir="t"/>
                </a:scene3d>
              </p:spPr>
            </p:pic>
            <p:pic>
              <p:nvPicPr>
                <p:cNvPr id="40" name="Picture 39">
                  <a:extLst>
                    <a:ext uri="{FF2B5EF4-FFF2-40B4-BE49-F238E27FC236}">
                      <a16:creationId xmlns:a16="http://schemas.microsoft.com/office/drawing/2014/main" id="{24E802FD-C7F0-7D90-9B9C-55B5EF265CE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1266150" y="434761"/>
                  <a:ext cx="720000" cy="720000"/>
                </a:xfrm>
                <a:prstGeom prst="rect">
                  <a:avLst/>
                </a:prstGeom>
                <a:scene3d>
                  <a:camera prst="isometricOffAxis2Top"/>
                  <a:lightRig rig="threePt" dir="t"/>
                </a:scene3d>
              </p:spPr>
            </p:pic>
            <p:cxnSp>
              <p:nvCxnSpPr>
                <p:cNvPr id="41" name="Straight Arrow Connector 40">
                  <a:extLst>
                    <a:ext uri="{FF2B5EF4-FFF2-40B4-BE49-F238E27FC236}">
                      <a16:creationId xmlns:a16="http://schemas.microsoft.com/office/drawing/2014/main" id="{0C5F0073-1D07-3E6D-9FAB-01E51AE277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062925" y="226605"/>
                  <a:ext cx="77730" cy="73336"/>
                </a:xfrm>
                <a:prstGeom prst="straightConnector1">
                  <a:avLst/>
                </a:prstGeom>
                <a:ln w="6350">
                  <a:solidFill>
                    <a:schemeClr val="tx1"/>
                  </a:solidFill>
                  <a:tailEnd type="oval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Arrow Connector 41">
                  <a:extLst>
                    <a:ext uri="{FF2B5EF4-FFF2-40B4-BE49-F238E27FC236}">
                      <a16:creationId xmlns:a16="http://schemas.microsoft.com/office/drawing/2014/main" id="{5F6899DA-E480-50A8-D14C-9380F6084DB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062925" y="680668"/>
                  <a:ext cx="77730" cy="73336"/>
                </a:xfrm>
                <a:prstGeom prst="straightConnector1">
                  <a:avLst/>
                </a:prstGeom>
                <a:ln w="6350">
                  <a:solidFill>
                    <a:schemeClr val="tx1"/>
                  </a:solidFill>
                  <a:tailEnd type="oval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CCBD8181-81E9-2DB7-207D-22BA35AF13CA}"/>
                </a:ext>
              </a:extLst>
            </p:cNvPr>
            <p:cNvGrpSpPr/>
            <p:nvPr/>
          </p:nvGrpSpPr>
          <p:grpSpPr>
            <a:xfrm>
              <a:off x="4463513" y="386898"/>
              <a:ext cx="342645" cy="126000"/>
              <a:chOff x="4479969" y="372609"/>
              <a:chExt cx="342645" cy="126000"/>
            </a:xfrm>
          </p:grpSpPr>
          <p:cxnSp>
            <p:nvCxnSpPr>
              <p:cNvPr id="52" name="Straight Arrow Connector 51">
                <a:extLst>
                  <a:ext uri="{FF2B5EF4-FFF2-40B4-BE49-F238E27FC236}">
                    <a16:creationId xmlns:a16="http://schemas.microsoft.com/office/drawing/2014/main" id="{6D32F23E-3138-52D6-9B50-840D6E0455C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79969" y="496690"/>
                <a:ext cx="342645" cy="0"/>
              </a:xfrm>
              <a:prstGeom prst="straightConnector1">
                <a:avLst/>
              </a:prstGeom>
              <a:ln w="6350">
                <a:solidFill>
                  <a:schemeClr val="tx1"/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>
                <a:extLst>
                  <a:ext uri="{FF2B5EF4-FFF2-40B4-BE49-F238E27FC236}">
                    <a16:creationId xmlns:a16="http://schemas.microsoft.com/office/drawing/2014/main" id="{230AC4F6-EEE1-863B-87F9-601C436602DC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4757233" y="435609"/>
                <a:ext cx="126000" cy="0"/>
              </a:xfrm>
              <a:prstGeom prst="straightConnector1">
                <a:avLst/>
              </a:prstGeom>
              <a:ln w="6350"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CD4D6856-4B41-99E4-2555-7577E5FF4935}"/>
                </a:ext>
              </a:extLst>
            </p:cNvPr>
            <p:cNvGrpSpPr/>
            <p:nvPr/>
          </p:nvGrpSpPr>
          <p:grpSpPr>
            <a:xfrm>
              <a:off x="3205559" y="207603"/>
              <a:ext cx="1262196" cy="852103"/>
              <a:chOff x="3240123" y="193314"/>
              <a:chExt cx="1262196" cy="852103"/>
            </a:xfrm>
          </p:grpSpPr>
          <p:sp>
            <p:nvSpPr>
              <p:cNvPr id="61" name="Rectangle 60">
                <a:extLst>
                  <a:ext uri="{FF2B5EF4-FFF2-40B4-BE49-F238E27FC236}">
                    <a16:creationId xmlns:a16="http://schemas.microsoft.com/office/drawing/2014/main" id="{3BB2E6A5-8906-4280-6C7B-5480F19E3D35}"/>
                  </a:ext>
                </a:extLst>
              </p:cNvPr>
              <p:cNvSpPr/>
              <p:nvPr/>
            </p:nvSpPr>
            <p:spPr>
              <a:xfrm>
                <a:off x="3300295" y="193314"/>
                <a:ext cx="1202024" cy="598454"/>
              </a:xfrm>
              <a:prstGeom prst="rect">
                <a:avLst/>
              </a:prstGeom>
              <a:solidFill>
                <a:srgbClr val="00B0F0">
                  <a:alpha val="50000"/>
                </a:srgb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63" dirty="0"/>
              </a:p>
            </p:txBody>
          </p:sp>
          <p:grpSp>
            <p:nvGrpSpPr>
              <p:cNvPr id="62" name="Group 61">
                <a:extLst>
                  <a:ext uri="{FF2B5EF4-FFF2-40B4-BE49-F238E27FC236}">
                    <a16:creationId xmlns:a16="http://schemas.microsoft.com/office/drawing/2014/main" id="{B5B6EE4C-B575-74D2-0F2A-4AC4C1E68C94}"/>
                  </a:ext>
                </a:extLst>
              </p:cNvPr>
              <p:cNvGrpSpPr/>
              <p:nvPr/>
            </p:nvGrpSpPr>
            <p:grpSpPr>
              <a:xfrm>
                <a:off x="3370485" y="238953"/>
                <a:ext cx="1107657" cy="520393"/>
                <a:chOff x="2563932" y="413576"/>
                <a:chExt cx="1107657" cy="520393"/>
              </a:xfrm>
            </p:grpSpPr>
            <p:grpSp>
              <p:nvGrpSpPr>
                <p:cNvPr id="65" name="Group 64">
                  <a:extLst>
                    <a:ext uri="{FF2B5EF4-FFF2-40B4-BE49-F238E27FC236}">
                      <a16:creationId xmlns:a16="http://schemas.microsoft.com/office/drawing/2014/main" id="{3F305E8E-6878-6C07-3324-BB94DA0D909E}"/>
                    </a:ext>
                  </a:extLst>
                </p:cNvPr>
                <p:cNvGrpSpPr/>
                <p:nvPr/>
              </p:nvGrpSpPr>
              <p:grpSpPr>
                <a:xfrm>
                  <a:off x="2563932" y="413576"/>
                  <a:ext cx="958902" cy="519442"/>
                  <a:chOff x="4558651" y="429272"/>
                  <a:chExt cx="2520233" cy="1365222"/>
                </a:xfrm>
              </p:grpSpPr>
              <p:grpSp>
                <p:nvGrpSpPr>
                  <p:cNvPr id="67" name="Group 66">
                    <a:extLst>
                      <a:ext uri="{FF2B5EF4-FFF2-40B4-BE49-F238E27FC236}">
                        <a16:creationId xmlns:a16="http://schemas.microsoft.com/office/drawing/2014/main" id="{8C706DD2-4DD1-BACA-BE77-FB32AAED265F}"/>
                      </a:ext>
                    </a:extLst>
                  </p:cNvPr>
                  <p:cNvGrpSpPr/>
                  <p:nvPr/>
                </p:nvGrpSpPr>
                <p:grpSpPr>
                  <a:xfrm>
                    <a:off x="4558651" y="429272"/>
                    <a:ext cx="2520233" cy="1365222"/>
                    <a:chOff x="3645617" y="219168"/>
                    <a:chExt cx="2520233" cy="1365222"/>
                  </a:xfrm>
                </p:grpSpPr>
                <p:sp>
                  <p:nvSpPr>
                    <p:cNvPr id="72" name="Rectangle: Rounded Corners 71">
                      <a:extLst>
                        <a:ext uri="{FF2B5EF4-FFF2-40B4-BE49-F238E27FC236}">
                          <a16:creationId xmlns:a16="http://schemas.microsoft.com/office/drawing/2014/main" id="{9946C518-81D3-A0AE-4EE7-0D2CF809E94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645617" y="219168"/>
                      <a:ext cx="274524" cy="1365222"/>
                    </a:xfrm>
                    <a:prstGeom prst="round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463" dirty="0"/>
                    </a:p>
                  </p:txBody>
                </p:sp>
                <p:sp>
                  <p:nvSpPr>
                    <p:cNvPr id="73" name="Rectangle: Rounded Corners 72">
                      <a:extLst>
                        <a:ext uri="{FF2B5EF4-FFF2-40B4-BE49-F238E27FC236}">
                          <a16:creationId xmlns:a16="http://schemas.microsoft.com/office/drawing/2014/main" id="{B2CC32BC-75CC-0513-B9A7-E45ECCA7A08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19902" y="355690"/>
                      <a:ext cx="274524" cy="1092178"/>
                    </a:xfrm>
                    <a:prstGeom prst="round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463"/>
                    </a:p>
                  </p:txBody>
                </p:sp>
                <p:sp>
                  <p:nvSpPr>
                    <p:cNvPr id="74" name="Rectangle: Rounded Corners 73">
                      <a:extLst>
                        <a:ext uri="{FF2B5EF4-FFF2-40B4-BE49-F238E27FC236}">
                          <a16:creationId xmlns:a16="http://schemas.microsoft.com/office/drawing/2014/main" id="{8EF14DBC-BF70-EF75-291E-86558E631E1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94187" y="492212"/>
                      <a:ext cx="274524" cy="819133"/>
                    </a:xfrm>
                    <a:prstGeom prst="round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463"/>
                    </a:p>
                  </p:txBody>
                </p:sp>
                <p:sp>
                  <p:nvSpPr>
                    <p:cNvPr id="75" name="Rectangle: Rounded Corners 74">
                      <a:extLst>
                        <a:ext uri="{FF2B5EF4-FFF2-40B4-BE49-F238E27FC236}">
                          <a16:creationId xmlns:a16="http://schemas.microsoft.com/office/drawing/2014/main" id="{B0BDB7FB-5C27-1846-3F50-EC43E1A781D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68472" y="628735"/>
                      <a:ext cx="274524" cy="546089"/>
                    </a:xfrm>
                    <a:prstGeom prst="round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463" dirty="0"/>
                    </a:p>
                  </p:txBody>
                </p:sp>
                <p:sp>
                  <p:nvSpPr>
                    <p:cNvPr id="76" name="Rectangle: Rounded Corners 75">
                      <a:extLst>
                        <a:ext uri="{FF2B5EF4-FFF2-40B4-BE49-F238E27FC236}">
                          <a16:creationId xmlns:a16="http://schemas.microsoft.com/office/drawing/2014/main" id="{74B43ACF-1B70-0B9A-20D0-7BD6F9AE1676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891326" y="219168"/>
                      <a:ext cx="274524" cy="1365222"/>
                    </a:xfrm>
                    <a:prstGeom prst="round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463"/>
                    </a:p>
                  </p:txBody>
                </p:sp>
                <p:sp>
                  <p:nvSpPr>
                    <p:cNvPr id="77" name="Rectangle: Rounded Corners 76">
                      <a:extLst>
                        <a:ext uri="{FF2B5EF4-FFF2-40B4-BE49-F238E27FC236}">
                          <a16:creationId xmlns:a16="http://schemas.microsoft.com/office/drawing/2014/main" id="{A4C8032E-E3FB-E6DA-32D4-E05A29B0061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517042" y="355690"/>
                      <a:ext cx="274524" cy="1092178"/>
                    </a:xfrm>
                    <a:prstGeom prst="round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463"/>
                    </a:p>
                  </p:txBody>
                </p:sp>
                <p:sp>
                  <p:nvSpPr>
                    <p:cNvPr id="78" name="Rectangle: Rounded Corners 77">
                      <a:extLst>
                        <a:ext uri="{FF2B5EF4-FFF2-40B4-BE49-F238E27FC236}">
                          <a16:creationId xmlns:a16="http://schemas.microsoft.com/office/drawing/2014/main" id="{FBF3B4F7-981C-2DC3-5FD5-B8DCD15B8481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142757" y="492212"/>
                      <a:ext cx="274524" cy="819133"/>
                    </a:xfrm>
                    <a:prstGeom prst="round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463"/>
                    </a:p>
                  </p:txBody>
                </p:sp>
              </p:grpSp>
              <p:grpSp>
                <p:nvGrpSpPr>
                  <p:cNvPr id="68" name="Group 67">
                    <a:extLst>
                      <a:ext uri="{FF2B5EF4-FFF2-40B4-BE49-F238E27FC236}">
                        <a16:creationId xmlns:a16="http://schemas.microsoft.com/office/drawing/2014/main" id="{BA88AC07-676B-C79F-8922-35E92C9F2734}"/>
                      </a:ext>
                    </a:extLst>
                  </p:cNvPr>
                  <p:cNvGrpSpPr/>
                  <p:nvPr/>
                </p:nvGrpSpPr>
                <p:grpSpPr>
                  <a:xfrm>
                    <a:off x="4833175" y="491944"/>
                    <a:ext cx="1971185" cy="279400"/>
                    <a:chOff x="4833175" y="491944"/>
                    <a:chExt cx="1971185" cy="279400"/>
                  </a:xfrm>
                </p:grpSpPr>
                <p:cxnSp>
                  <p:nvCxnSpPr>
                    <p:cNvPr id="69" name="Straight Arrow Connector 68">
                      <a:extLst>
                        <a:ext uri="{FF2B5EF4-FFF2-40B4-BE49-F238E27FC236}">
                          <a16:creationId xmlns:a16="http://schemas.microsoft.com/office/drawing/2014/main" id="{D1952D92-BA34-3538-1FC1-665800B630E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581745" y="771344"/>
                      <a:ext cx="474047" cy="0"/>
                    </a:xfrm>
                    <a:prstGeom prst="straightConnector1">
                      <a:avLst/>
                    </a:prstGeom>
                    <a:ln w="6350">
                      <a:solidFill>
                        <a:schemeClr val="tx1"/>
                      </a:solidFill>
                      <a:tailEnd type="triangle" w="sm" len="sm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0" name="Straight Arrow Connector 69">
                      <a:extLst>
                        <a:ext uri="{FF2B5EF4-FFF2-40B4-BE49-F238E27FC236}">
                          <a16:creationId xmlns:a16="http://schemas.microsoft.com/office/drawing/2014/main" id="{BC72F2D8-341A-D458-59E1-A0B71779AAB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207459" y="637995"/>
                      <a:ext cx="1222617" cy="0"/>
                    </a:xfrm>
                    <a:prstGeom prst="straightConnector1">
                      <a:avLst/>
                    </a:prstGeom>
                    <a:ln w="6350">
                      <a:solidFill>
                        <a:schemeClr val="tx1"/>
                      </a:solidFill>
                      <a:tailEnd type="triangle" w="sm" len="sm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" name="Straight Arrow Connector 70">
                      <a:extLst>
                        <a:ext uri="{FF2B5EF4-FFF2-40B4-BE49-F238E27FC236}">
                          <a16:creationId xmlns:a16="http://schemas.microsoft.com/office/drawing/2014/main" id="{1D3596B0-2034-58F1-2C0B-6C60F8A3B53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833175" y="491944"/>
                      <a:ext cx="1971185" cy="0"/>
                    </a:xfrm>
                    <a:prstGeom prst="straightConnector1">
                      <a:avLst/>
                    </a:prstGeom>
                    <a:ln w="6350">
                      <a:solidFill>
                        <a:schemeClr val="tx1"/>
                      </a:solidFill>
                      <a:tailEnd type="triangle" w="sm" len="sm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66" name="Rectangle: Rounded Corners 65">
                  <a:extLst>
                    <a:ext uri="{FF2B5EF4-FFF2-40B4-BE49-F238E27FC236}">
                      <a16:creationId xmlns:a16="http://schemas.microsoft.com/office/drawing/2014/main" id="{8D7B7E45-3A67-61BB-1B72-816D1E078572}"/>
                    </a:ext>
                  </a:extLst>
                </p:cNvPr>
                <p:cNvSpPr/>
                <p:nvPr/>
              </p:nvSpPr>
              <p:spPr>
                <a:xfrm rot="16200000" flipH="1">
                  <a:off x="3359643" y="622022"/>
                  <a:ext cx="519442" cy="104451"/>
                </a:xfrm>
                <a:prstGeom prst="round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educe</a:t>
                  </a:r>
                </a:p>
              </p:txBody>
            </p:sp>
          </p:grpSp>
          <p:cxnSp>
            <p:nvCxnSpPr>
              <p:cNvPr id="63" name="Straight Arrow Connector 62">
                <a:extLst>
                  <a:ext uri="{FF2B5EF4-FFF2-40B4-BE49-F238E27FC236}">
                    <a16:creationId xmlns:a16="http://schemas.microsoft.com/office/drawing/2014/main" id="{E7442199-BF1B-6806-9E54-7A54661E93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40123" y="496690"/>
                <a:ext cx="126000" cy="0"/>
              </a:xfrm>
              <a:prstGeom prst="straightConnector1">
                <a:avLst/>
              </a:prstGeom>
              <a:ln w="6350"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Rectangle 63">
                <a:extLst>
                  <a:ext uri="{FF2B5EF4-FFF2-40B4-BE49-F238E27FC236}">
                    <a16:creationId xmlns:a16="http://schemas.microsoft.com/office/drawing/2014/main" id="{5361F288-38A6-DDD0-CA7D-1B969C8B19B5}"/>
                  </a:ext>
                </a:extLst>
              </p:cNvPr>
              <p:cNvSpPr/>
              <p:nvPr/>
            </p:nvSpPr>
            <p:spPr>
              <a:xfrm>
                <a:off x="3418080" y="791054"/>
                <a:ext cx="962145" cy="25436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cus finder</a:t>
                </a:r>
              </a:p>
            </p:txBody>
          </p:sp>
        </p:grp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86FF8AF7-DB80-14FD-D4FA-FF3BDE30FBFA}"/>
                </a:ext>
              </a:extLst>
            </p:cNvPr>
            <p:cNvGrpSpPr/>
            <p:nvPr/>
          </p:nvGrpSpPr>
          <p:grpSpPr>
            <a:xfrm>
              <a:off x="2616990" y="2201243"/>
              <a:ext cx="540009" cy="540578"/>
              <a:chOff x="6063901" y="2320556"/>
              <a:chExt cx="786096" cy="755936"/>
            </a:xfrm>
          </p:grpSpPr>
          <p:sp>
            <p:nvSpPr>
              <p:cNvPr id="93" name="Rectangle 92">
                <a:extLst>
                  <a:ext uri="{FF2B5EF4-FFF2-40B4-BE49-F238E27FC236}">
                    <a16:creationId xmlns:a16="http://schemas.microsoft.com/office/drawing/2014/main" id="{7BB62F41-A935-4395-DF16-49ACACB8356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063913" y="2320690"/>
                <a:ext cx="786084" cy="7558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63" dirty="0"/>
              </a:p>
            </p:txBody>
          </p:sp>
          <p:sp>
            <p:nvSpPr>
              <p:cNvPr id="101" name="Rectangle 100">
                <a:extLst>
                  <a:ext uri="{FF2B5EF4-FFF2-40B4-BE49-F238E27FC236}">
                    <a16:creationId xmlns:a16="http://schemas.microsoft.com/office/drawing/2014/main" id="{EF586859-F185-FC72-CE0E-F41957A3D090}"/>
                  </a:ext>
                </a:extLst>
              </p:cNvPr>
              <p:cNvSpPr/>
              <p:nvPr/>
            </p:nvSpPr>
            <p:spPr>
              <a:xfrm>
                <a:off x="6063913" y="2320556"/>
                <a:ext cx="219099" cy="21909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63"/>
              </a:p>
            </p:txBody>
          </p:sp>
          <p:sp>
            <p:nvSpPr>
              <p:cNvPr id="99" name="Rectangle 98">
                <a:extLst>
                  <a:ext uri="{FF2B5EF4-FFF2-40B4-BE49-F238E27FC236}">
                    <a16:creationId xmlns:a16="http://schemas.microsoft.com/office/drawing/2014/main" id="{10F89CE0-6427-1EA7-DA96-E366F1325808}"/>
                  </a:ext>
                </a:extLst>
              </p:cNvPr>
              <p:cNvSpPr/>
              <p:nvPr/>
            </p:nvSpPr>
            <p:spPr>
              <a:xfrm>
                <a:off x="6283013" y="2320557"/>
                <a:ext cx="219099" cy="21909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63"/>
              </a:p>
            </p:txBody>
          </p:sp>
          <p:sp>
            <p:nvSpPr>
              <p:cNvPr id="97" name="Rectangle 96">
                <a:extLst>
                  <a:ext uri="{FF2B5EF4-FFF2-40B4-BE49-F238E27FC236}">
                    <a16:creationId xmlns:a16="http://schemas.microsoft.com/office/drawing/2014/main" id="{74C0AAB1-3498-8E2F-041B-89A18EFB831F}"/>
                  </a:ext>
                </a:extLst>
              </p:cNvPr>
              <p:cNvSpPr/>
              <p:nvPr/>
            </p:nvSpPr>
            <p:spPr>
              <a:xfrm>
                <a:off x="6063901" y="2539659"/>
                <a:ext cx="219099" cy="21909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63"/>
              </a:p>
            </p:txBody>
          </p:sp>
        </p:grp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7531706A-8541-88A8-0A90-7AEF9C6CC50F}"/>
                </a:ext>
              </a:extLst>
            </p:cNvPr>
            <p:cNvSpPr/>
            <p:nvPr/>
          </p:nvSpPr>
          <p:spPr>
            <a:xfrm rot="16200000">
              <a:off x="2556678" y="2545296"/>
              <a:ext cx="203776" cy="13173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37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…</a:t>
              </a:r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CE9B1B21-4081-A31B-B092-F6D9639F2114}"/>
                </a:ext>
              </a:extLst>
            </p:cNvPr>
            <p:cNvSpPr/>
            <p:nvPr/>
          </p:nvSpPr>
          <p:spPr>
            <a:xfrm rot="10800000">
              <a:off x="2911087" y="2251917"/>
              <a:ext cx="195752" cy="13713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37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…</a:t>
              </a:r>
            </a:p>
          </p:txBody>
        </p:sp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B737191A-6939-61E8-B5DD-95158BB1DE8B}"/>
                </a:ext>
              </a:extLst>
            </p:cNvPr>
            <p:cNvSpPr/>
            <p:nvPr/>
          </p:nvSpPr>
          <p:spPr>
            <a:xfrm rot="13496733">
              <a:off x="2730562" y="2402646"/>
              <a:ext cx="195752" cy="13713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37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…</a:t>
              </a:r>
            </a:p>
          </p:txBody>
        </p:sp>
        <p:grpSp>
          <p:nvGrpSpPr>
            <p:cNvPr id="111" name="Group 110">
              <a:extLst>
                <a:ext uri="{FF2B5EF4-FFF2-40B4-BE49-F238E27FC236}">
                  <a16:creationId xmlns:a16="http://schemas.microsoft.com/office/drawing/2014/main" id="{79F2ADBF-4627-5A31-F8C5-F97D29103A56}"/>
                </a:ext>
              </a:extLst>
            </p:cNvPr>
            <p:cNvGrpSpPr/>
            <p:nvPr/>
          </p:nvGrpSpPr>
          <p:grpSpPr>
            <a:xfrm>
              <a:off x="1377170" y="928273"/>
              <a:ext cx="990520" cy="1185972"/>
              <a:chOff x="1341483" y="-139840"/>
              <a:chExt cx="990520" cy="1185972"/>
            </a:xfrm>
          </p:grpSpPr>
          <p:sp>
            <p:nvSpPr>
              <p:cNvPr id="112" name="Rectangle 111 1">
                <a:extLst>
                  <a:ext uri="{FF2B5EF4-FFF2-40B4-BE49-F238E27FC236}">
                    <a16:creationId xmlns:a16="http://schemas.microsoft.com/office/drawing/2014/main" id="{9E91CBBE-0331-151F-E37D-3C7F99F71A78}"/>
                  </a:ext>
                </a:extLst>
              </p:cNvPr>
              <p:cNvSpPr/>
              <p:nvPr/>
            </p:nvSpPr>
            <p:spPr>
              <a:xfrm>
                <a:off x="1341483" y="791769"/>
                <a:ext cx="990520" cy="25436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andard z-stack</a:t>
                </a:r>
              </a:p>
            </p:txBody>
          </p:sp>
          <p:grpSp>
            <p:nvGrpSpPr>
              <p:cNvPr id="113" name="Group 112">
                <a:extLst>
                  <a:ext uri="{FF2B5EF4-FFF2-40B4-BE49-F238E27FC236}">
                    <a16:creationId xmlns:a16="http://schemas.microsoft.com/office/drawing/2014/main" id="{7C4D12B0-C472-8F07-BB92-5DDF5A2235C6}"/>
                  </a:ext>
                </a:extLst>
              </p:cNvPr>
              <p:cNvGrpSpPr/>
              <p:nvPr/>
            </p:nvGrpSpPr>
            <p:grpSpPr>
              <a:xfrm>
                <a:off x="1390218" y="-139840"/>
                <a:ext cx="720000" cy="1173013"/>
                <a:chOff x="1266150" y="-18252"/>
                <a:chExt cx="720000" cy="1173013"/>
              </a:xfrm>
            </p:grpSpPr>
            <p:sp>
              <p:nvSpPr>
                <p:cNvPr id="114" name="Rectangle 113">
                  <a:extLst>
                    <a:ext uri="{FF2B5EF4-FFF2-40B4-BE49-F238E27FC236}">
                      <a16:creationId xmlns:a16="http://schemas.microsoft.com/office/drawing/2014/main" id="{1F865909-379F-C4D5-EE79-75FAFB9A459C}"/>
                    </a:ext>
                  </a:extLst>
                </p:cNvPr>
                <p:cNvSpPr/>
                <p:nvPr/>
              </p:nvSpPr>
              <p:spPr>
                <a:xfrm rot="16200000">
                  <a:off x="1486902" y="476541"/>
                  <a:ext cx="275989" cy="18573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…</a:t>
                  </a:r>
                </a:p>
              </p:txBody>
            </p:sp>
            <p:pic>
              <p:nvPicPr>
                <p:cNvPr id="115" name="Picture 114">
                  <a:extLst>
                    <a:ext uri="{FF2B5EF4-FFF2-40B4-BE49-F238E27FC236}">
                      <a16:creationId xmlns:a16="http://schemas.microsoft.com/office/drawing/2014/main" id="{1177AA0F-90F5-B41B-A8F2-F61E6DF237B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1266150" y="-18252"/>
                  <a:ext cx="720000" cy="720000"/>
                </a:xfrm>
                <a:prstGeom prst="rect">
                  <a:avLst/>
                </a:prstGeom>
                <a:scene3d>
                  <a:camera prst="isometricOffAxis2Top"/>
                  <a:lightRig rig="threePt" dir="t"/>
                </a:scene3d>
              </p:spPr>
            </p:pic>
            <p:pic>
              <p:nvPicPr>
                <p:cNvPr id="116" name="Picture 115">
                  <a:extLst>
                    <a:ext uri="{FF2B5EF4-FFF2-40B4-BE49-F238E27FC236}">
                      <a16:creationId xmlns:a16="http://schemas.microsoft.com/office/drawing/2014/main" id="{53BBD7FA-5C45-4083-EB5B-F303D6226CE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1266150" y="434761"/>
                  <a:ext cx="720000" cy="720000"/>
                </a:xfrm>
                <a:prstGeom prst="rect">
                  <a:avLst/>
                </a:prstGeom>
                <a:scene3d>
                  <a:camera prst="isometricOffAxis2Top"/>
                  <a:lightRig rig="threePt" dir="t"/>
                </a:scene3d>
              </p:spPr>
            </p:pic>
          </p:grpSp>
        </p:grp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36CC8B0E-528A-BF08-2435-C940DE621EE6}"/>
                </a:ext>
              </a:extLst>
            </p:cNvPr>
            <p:cNvGrpSpPr/>
            <p:nvPr/>
          </p:nvGrpSpPr>
          <p:grpSpPr>
            <a:xfrm>
              <a:off x="3921694" y="928273"/>
              <a:ext cx="990520" cy="1185972"/>
              <a:chOff x="1341483" y="-139840"/>
              <a:chExt cx="990520" cy="1185972"/>
            </a:xfrm>
          </p:grpSpPr>
          <p:sp>
            <p:nvSpPr>
              <p:cNvPr id="122" name="Rectangle 121">
                <a:extLst>
                  <a:ext uri="{FF2B5EF4-FFF2-40B4-BE49-F238E27FC236}">
                    <a16:creationId xmlns:a16="http://schemas.microsoft.com/office/drawing/2014/main" id="{607DBC3B-D75A-C622-0896-5F190BA92722}"/>
                  </a:ext>
                </a:extLst>
              </p:cNvPr>
              <p:cNvSpPr/>
              <p:nvPr/>
            </p:nvSpPr>
            <p:spPr>
              <a:xfrm>
                <a:off x="1341483" y="791769"/>
                <a:ext cx="990520" cy="25436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gmented z-stack</a:t>
                </a:r>
              </a:p>
            </p:txBody>
          </p:sp>
          <p:grpSp>
            <p:nvGrpSpPr>
              <p:cNvPr id="123" name="Group 122">
                <a:extLst>
                  <a:ext uri="{FF2B5EF4-FFF2-40B4-BE49-F238E27FC236}">
                    <a16:creationId xmlns:a16="http://schemas.microsoft.com/office/drawing/2014/main" id="{6BA5B2D7-606F-5F74-768F-5527BD652F72}"/>
                  </a:ext>
                </a:extLst>
              </p:cNvPr>
              <p:cNvGrpSpPr/>
              <p:nvPr/>
            </p:nvGrpSpPr>
            <p:grpSpPr>
              <a:xfrm>
                <a:off x="1390218" y="-139840"/>
                <a:ext cx="720000" cy="1173013"/>
                <a:chOff x="1266150" y="-18252"/>
                <a:chExt cx="720000" cy="1173013"/>
              </a:xfrm>
            </p:grpSpPr>
            <p:sp>
              <p:nvSpPr>
                <p:cNvPr id="124" name="Rectangle 123">
                  <a:extLst>
                    <a:ext uri="{FF2B5EF4-FFF2-40B4-BE49-F238E27FC236}">
                      <a16:creationId xmlns:a16="http://schemas.microsoft.com/office/drawing/2014/main" id="{AE6E1A0D-637C-FF45-BA8E-EC0D6A7B81BE}"/>
                    </a:ext>
                  </a:extLst>
                </p:cNvPr>
                <p:cNvSpPr/>
                <p:nvPr/>
              </p:nvSpPr>
              <p:spPr>
                <a:xfrm rot="16200000">
                  <a:off x="1486902" y="476541"/>
                  <a:ext cx="275989" cy="18573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…</a:t>
                  </a:r>
                </a:p>
              </p:txBody>
            </p:sp>
            <p:pic>
              <p:nvPicPr>
                <p:cNvPr id="125" name="Picture 124">
                  <a:extLst>
                    <a:ext uri="{FF2B5EF4-FFF2-40B4-BE49-F238E27FC236}">
                      <a16:creationId xmlns:a16="http://schemas.microsoft.com/office/drawing/2014/main" id="{DA0AC2CD-A900-3578-8623-1EFE3F23105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1266150" y="-18252"/>
                  <a:ext cx="720000" cy="720000"/>
                </a:xfrm>
                <a:prstGeom prst="rect">
                  <a:avLst/>
                </a:prstGeom>
                <a:scene3d>
                  <a:camera prst="isometricOffAxis2Top"/>
                  <a:lightRig rig="threePt" dir="t"/>
                </a:scene3d>
              </p:spPr>
            </p:pic>
            <p:pic>
              <p:nvPicPr>
                <p:cNvPr id="126" name="Picture 125">
                  <a:extLst>
                    <a:ext uri="{FF2B5EF4-FFF2-40B4-BE49-F238E27FC236}">
                      <a16:creationId xmlns:a16="http://schemas.microsoft.com/office/drawing/2014/main" id="{644314C4-67C5-625E-92FB-B3FB79D5E2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1266150" y="434761"/>
                  <a:ext cx="720000" cy="720000"/>
                </a:xfrm>
                <a:prstGeom prst="rect">
                  <a:avLst/>
                </a:prstGeom>
                <a:scene3d>
                  <a:camera prst="isometricOffAxis2Top"/>
                  <a:lightRig rig="threePt" dir="t"/>
                </a:scene3d>
              </p:spPr>
            </p:pic>
          </p:grpSp>
        </p:grpSp>
        <p:grpSp>
          <p:nvGrpSpPr>
            <p:cNvPr id="142" name="Group 141">
              <a:extLst>
                <a:ext uri="{FF2B5EF4-FFF2-40B4-BE49-F238E27FC236}">
                  <a16:creationId xmlns:a16="http://schemas.microsoft.com/office/drawing/2014/main" id="{946FF98A-9C48-7FC2-F9F3-5D91007D80EF}"/>
                </a:ext>
              </a:extLst>
            </p:cNvPr>
            <p:cNvGrpSpPr/>
            <p:nvPr/>
          </p:nvGrpSpPr>
          <p:grpSpPr>
            <a:xfrm>
              <a:off x="5059721" y="1306268"/>
              <a:ext cx="1258126" cy="1217724"/>
              <a:chOff x="5073989" y="1358645"/>
              <a:chExt cx="1210517" cy="1171644"/>
            </a:xfrm>
          </p:grpSpPr>
          <p:pic>
            <p:nvPicPr>
              <p:cNvPr id="149" name="Picture 148">
                <a:extLst>
                  <a:ext uri="{FF2B5EF4-FFF2-40B4-BE49-F238E27FC236}">
                    <a16:creationId xmlns:a16="http://schemas.microsoft.com/office/drawing/2014/main" id="{96DDE40E-8935-DB0F-0FC7-17BBAAA6F6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427" t="20041" r="9500" b="6352"/>
              <a:stretch/>
            </p:blipFill>
            <p:spPr>
              <a:xfrm>
                <a:off x="5121075" y="1358645"/>
                <a:ext cx="1163431" cy="1056285"/>
              </a:xfrm>
              <a:prstGeom prst="rect">
                <a:avLst/>
              </a:prstGeom>
            </p:spPr>
          </p:pic>
          <p:sp>
            <p:nvSpPr>
              <p:cNvPr id="156" name="Rectangle 155">
                <a:extLst>
                  <a:ext uri="{FF2B5EF4-FFF2-40B4-BE49-F238E27FC236}">
                    <a16:creationId xmlns:a16="http://schemas.microsoft.com/office/drawing/2014/main" id="{BE410361-168C-8424-3ADB-8A3C8DFC905D}"/>
                  </a:ext>
                </a:extLst>
              </p:cNvPr>
              <p:cNvSpPr/>
              <p:nvPr/>
            </p:nvSpPr>
            <p:spPr>
              <a:xfrm>
                <a:off x="5073989" y="2115681"/>
                <a:ext cx="1184269" cy="414608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7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w 3D reconstruction</a:t>
                </a:r>
              </a:p>
            </p:txBody>
          </p:sp>
          <p:grpSp>
            <p:nvGrpSpPr>
              <p:cNvPr id="177" name="Group 176">
                <a:extLst>
                  <a:ext uri="{FF2B5EF4-FFF2-40B4-BE49-F238E27FC236}">
                    <a16:creationId xmlns:a16="http://schemas.microsoft.com/office/drawing/2014/main" id="{D4FC6430-A314-E72B-1E50-ABB3AEC5473E}"/>
                  </a:ext>
                </a:extLst>
              </p:cNvPr>
              <p:cNvGrpSpPr/>
              <p:nvPr/>
            </p:nvGrpSpPr>
            <p:grpSpPr>
              <a:xfrm>
                <a:off x="5139111" y="1473200"/>
                <a:ext cx="229910" cy="379714"/>
                <a:chOff x="5231647" y="1640867"/>
                <a:chExt cx="225830" cy="372976"/>
              </a:xfrm>
            </p:grpSpPr>
            <p:cxnSp>
              <p:nvCxnSpPr>
                <p:cNvPr id="150" name="Straight Arrow Connector 149">
                  <a:extLst>
                    <a:ext uri="{FF2B5EF4-FFF2-40B4-BE49-F238E27FC236}">
                      <a16:creationId xmlns:a16="http://schemas.microsoft.com/office/drawing/2014/main" id="{533E06F4-DAA6-E7C5-CD57-E2908215A0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257961" y="1758016"/>
                  <a:ext cx="119324" cy="50871"/>
                </a:xfrm>
                <a:prstGeom prst="straightConnector1">
                  <a:avLst/>
                </a:prstGeom>
                <a:ln w="6350">
                  <a:solidFill>
                    <a:schemeClr val="bg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2" name="Straight Arrow Connector 151">
                  <a:extLst>
                    <a:ext uri="{FF2B5EF4-FFF2-40B4-BE49-F238E27FC236}">
                      <a16:creationId xmlns:a16="http://schemas.microsoft.com/office/drawing/2014/main" id="{6A976515-0CD0-F563-7E0B-4BD1895E722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57961" y="1806870"/>
                  <a:ext cx="0" cy="125886"/>
                </a:xfrm>
                <a:prstGeom prst="straightConnector1">
                  <a:avLst/>
                </a:prstGeom>
                <a:ln w="6350">
                  <a:solidFill>
                    <a:schemeClr val="bg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Straight Arrow Connector 154">
                  <a:extLst>
                    <a:ext uri="{FF2B5EF4-FFF2-40B4-BE49-F238E27FC236}">
                      <a16:creationId xmlns:a16="http://schemas.microsoft.com/office/drawing/2014/main" id="{1C874399-4FF3-CE00-EC79-4C6B0FC8220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57961" y="1806870"/>
                  <a:ext cx="97469" cy="69920"/>
                </a:xfrm>
                <a:prstGeom prst="straightConnector1">
                  <a:avLst/>
                </a:prstGeom>
                <a:ln w="6350">
                  <a:solidFill>
                    <a:schemeClr val="bg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4" name="Rectangle 173">
                  <a:extLst>
                    <a:ext uri="{FF2B5EF4-FFF2-40B4-BE49-F238E27FC236}">
                      <a16:creationId xmlns:a16="http://schemas.microsoft.com/office/drawing/2014/main" id="{134DDD5B-F94A-9222-DD75-FADDC05597FB}"/>
                    </a:ext>
                  </a:extLst>
                </p:cNvPr>
                <p:cNvSpPr/>
                <p:nvPr/>
              </p:nvSpPr>
              <p:spPr>
                <a:xfrm>
                  <a:off x="5231647" y="1876790"/>
                  <a:ext cx="125731" cy="137053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z</a:t>
                  </a:r>
                </a:p>
              </p:txBody>
            </p:sp>
            <p:sp>
              <p:nvSpPr>
                <p:cNvPr id="175" name="Rectangle 174">
                  <a:extLst>
                    <a:ext uri="{FF2B5EF4-FFF2-40B4-BE49-F238E27FC236}">
                      <a16:creationId xmlns:a16="http://schemas.microsoft.com/office/drawing/2014/main" id="{F308FB36-4FF7-3FFF-270A-08C815EAEEBD}"/>
                    </a:ext>
                  </a:extLst>
                </p:cNvPr>
                <p:cNvSpPr/>
                <p:nvPr/>
              </p:nvSpPr>
              <p:spPr>
                <a:xfrm>
                  <a:off x="5331746" y="1758016"/>
                  <a:ext cx="125731" cy="137053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y</a:t>
                  </a:r>
                </a:p>
              </p:txBody>
            </p:sp>
            <p:sp>
              <p:nvSpPr>
                <p:cNvPr id="176" name="Rectangle 175">
                  <a:extLst>
                    <a:ext uri="{FF2B5EF4-FFF2-40B4-BE49-F238E27FC236}">
                      <a16:creationId xmlns:a16="http://schemas.microsoft.com/office/drawing/2014/main" id="{1B6C1521-D47F-116E-46F8-25016FB34805}"/>
                    </a:ext>
                  </a:extLst>
                </p:cNvPr>
                <p:cNvSpPr/>
                <p:nvPr/>
              </p:nvSpPr>
              <p:spPr>
                <a:xfrm>
                  <a:off x="5301722" y="1640867"/>
                  <a:ext cx="125731" cy="137053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x</a:t>
                  </a:r>
                </a:p>
              </p:txBody>
            </p:sp>
          </p:grpSp>
        </p:grpSp>
        <p:grpSp>
          <p:nvGrpSpPr>
            <p:cNvPr id="299" name="Group 298" descr="\documentclass{article}&#10;\usepackage{amsmath}&#10;\pagestyle{empty}&#10;\begin{document}&#10;&#10;$\hat{f}$&#10;&#10;\end{document}" title="IguanaTex Vector Display">
              <a:extLst>
                <a:ext uri="{FF2B5EF4-FFF2-40B4-BE49-F238E27FC236}">
                  <a16:creationId xmlns:a16="http://schemas.microsoft.com/office/drawing/2014/main" id="{2C3C1A0E-A3D9-AAFD-3D09-7B1ADD1D4D45}"/>
                </a:ext>
              </a:extLst>
            </p:cNvPr>
            <p:cNvGrpSpPr>
              <a:grpSpLocks noChangeAspect="1"/>
            </p:cNvGrpSpPr>
            <p:nvPr>
              <p:custDataLst>
                <p:tags r:id="rId4"/>
              </p:custDataLst>
            </p:nvPr>
          </p:nvGrpSpPr>
          <p:grpSpPr>
            <a:xfrm>
              <a:off x="2657781" y="2207748"/>
              <a:ext cx="68532" cy="139512"/>
              <a:chOff x="2321925" y="2364418"/>
              <a:chExt cx="5711" cy="11626"/>
            </a:xfrm>
          </p:grpSpPr>
          <p:sp>
            <p:nvSpPr>
              <p:cNvPr id="300" name="Freeform: Shape 299">
                <a:extLst>
                  <a:ext uri="{FF2B5EF4-FFF2-40B4-BE49-F238E27FC236}">
                    <a16:creationId xmlns:a16="http://schemas.microsoft.com/office/drawing/2014/main" id="{BBA6FB46-BB0B-9C48-7ADE-A169C6FAB711}"/>
                  </a:ext>
                </a:extLst>
              </p:cNvPr>
              <p:cNvSpPr/>
              <p:nvPr>
                <p:custDataLst>
                  <p:tags r:id="rId11"/>
                </p:custDataLst>
              </p:nvPr>
            </p:nvSpPr>
            <p:spPr>
              <a:xfrm>
                <a:off x="2324840" y="2364418"/>
                <a:ext cx="2796" cy="1539"/>
              </a:xfrm>
              <a:custGeom>
                <a:avLst/>
                <a:gdLst>
                  <a:gd name="connsiteX0" fmla="*/ 1483 w 2796"/>
                  <a:gd name="connsiteY0" fmla="*/ 60 h 1539"/>
                  <a:gd name="connsiteX1" fmla="*/ 79 w 2796"/>
                  <a:gd name="connsiteY1" fmla="*/ 1420 h 1539"/>
                  <a:gd name="connsiteX2" fmla="*/ 267 w 2796"/>
                  <a:gd name="connsiteY2" fmla="*/ 1600 h 1539"/>
                  <a:gd name="connsiteX3" fmla="*/ 1483 w 2796"/>
                  <a:gd name="connsiteY3" fmla="*/ 580 h 1539"/>
                  <a:gd name="connsiteX4" fmla="*/ 2687 w 2796"/>
                  <a:gd name="connsiteY4" fmla="*/ 1600 h 1539"/>
                  <a:gd name="connsiteX5" fmla="*/ 2876 w 2796"/>
                  <a:gd name="connsiteY5" fmla="*/ 1420 h 1539"/>
                  <a:gd name="connsiteX6" fmla="*/ 1483 w 2796"/>
                  <a:gd name="connsiteY6" fmla="*/ 60 h 15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796" h="1539">
                    <a:moveTo>
                      <a:pt x="1483" y="60"/>
                    </a:moveTo>
                    <a:lnTo>
                      <a:pt x="79" y="1420"/>
                    </a:lnTo>
                    <a:lnTo>
                      <a:pt x="267" y="1600"/>
                    </a:lnTo>
                    <a:lnTo>
                      <a:pt x="1483" y="580"/>
                    </a:lnTo>
                    <a:lnTo>
                      <a:pt x="2687" y="1600"/>
                    </a:lnTo>
                    <a:lnTo>
                      <a:pt x="2876" y="1420"/>
                    </a:lnTo>
                    <a:lnTo>
                      <a:pt x="1483" y="6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01" name="Freeform: Shape 300">
                <a:extLst>
                  <a:ext uri="{FF2B5EF4-FFF2-40B4-BE49-F238E27FC236}">
                    <a16:creationId xmlns:a16="http://schemas.microsoft.com/office/drawing/2014/main" id="{B53A0A9C-A5DB-4860-291D-4433B0E59730}"/>
                  </a:ext>
                </a:extLst>
              </p:cNvPr>
              <p:cNvSpPr/>
              <p:nvPr>
                <p:custDataLst>
                  <p:tags r:id="rId12"/>
                </p:custDataLst>
              </p:nvPr>
            </p:nvSpPr>
            <p:spPr>
              <a:xfrm>
                <a:off x="2321925" y="2366946"/>
                <a:ext cx="5227" cy="9098"/>
              </a:xfrm>
              <a:custGeom>
                <a:avLst/>
                <a:gdLst>
                  <a:gd name="connsiteX0" fmla="*/ 3366 w 5227"/>
                  <a:gd name="connsiteY0" fmla="*/ 3112 h 9098"/>
                  <a:gd name="connsiteX1" fmla="*/ 4267 w 5227"/>
                  <a:gd name="connsiteY1" fmla="*/ 3112 h 9098"/>
                  <a:gd name="connsiteX2" fmla="*/ 4581 w 5227"/>
                  <a:gd name="connsiteY2" fmla="*/ 2912 h 9098"/>
                  <a:gd name="connsiteX3" fmla="*/ 4298 w 5227"/>
                  <a:gd name="connsiteY3" fmla="*/ 2802 h 9098"/>
                  <a:gd name="connsiteX4" fmla="*/ 3429 w 5227"/>
                  <a:gd name="connsiteY4" fmla="*/ 2802 h 9098"/>
                  <a:gd name="connsiteX5" fmla="*/ 3649 w 5227"/>
                  <a:gd name="connsiteY5" fmla="*/ 1663 h 9098"/>
                  <a:gd name="connsiteX6" fmla="*/ 3900 w 5227"/>
                  <a:gd name="connsiteY6" fmla="*/ 623 h 9098"/>
                  <a:gd name="connsiteX7" fmla="*/ 4392 w 5227"/>
                  <a:gd name="connsiteY7" fmla="*/ 283 h 9098"/>
                  <a:gd name="connsiteX8" fmla="*/ 4906 w 5227"/>
                  <a:gd name="connsiteY8" fmla="*/ 463 h 9098"/>
                  <a:gd name="connsiteX9" fmla="*/ 4340 w 5227"/>
                  <a:gd name="connsiteY9" fmla="*/ 1003 h 9098"/>
                  <a:gd name="connsiteX10" fmla="*/ 4728 w 5227"/>
                  <a:gd name="connsiteY10" fmla="*/ 1353 h 9098"/>
                  <a:gd name="connsiteX11" fmla="*/ 5304 w 5227"/>
                  <a:gd name="connsiteY11" fmla="*/ 753 h 9098"/>
                  <a:gd name="connsiteX12" fmla="*/ 4392 w 5227"/>
                  <a:gd name="connsiteY12" fmla="*/ 63 h 9098"/>
                  <a:gd name="connsiteX13" fmla="*/ 3062 w 5227"/>
                  <a:gd name="connsiteY13" fmla="*/ 1233 h 9098"/>
                  <a:gd name="connsiteX14" fmla="*/ 2716 w 5227"/>
                  <a:gd name="connsiteY14" fmla="*/ 2802 h 9098"/>
                  <a:gd name="connsiteX15" fmla="*/ 1994 w 5227"/>
                  <a:gd name="connsiteY15" fmla="*/ 2802 h 9098"/>
                  <a:gd name="connsiteX16" fmla="*/ 1679 w 5227"/>
                  <a:gd name="connsiteY16" fmla="*/ 2992 h 9098"/>
                  <a:gd name="connsiteX17" fmla="*/ 1973 w 5227"/>
                  <a:gd name="connsiteY17" fmla="*/ 3112 h 9098"/>
                  <a:gd name="connsiteX18" fmla="*/ 2664 w 5227"/>
                  <a:gd name="connsiteY18" fmla="*/ 3112 h 9098"/>
                  <a:gd name="connsiteX19" fmla="*/ 1878 w 5227"/>
                  <a:gd name="connsiteY19" fmla="*/ 7062 h 9098"/>
                  <a:gd name="connsiteX20" fmla="*/ 967 w 5227"/>
                  <a:gd name="connsiteY20" fmla="*/ 8942 h 9098"/>
                  <a:gd name="connsiteX21" fmla="*/ 464 w 5227"/>
                  <a:gd name="connsiteY21" fmla="*/ 8762 h 9098"/>
                  <a:gd name="connsiteX22" fmla="*/ 1040 w 5227"/>
                  <a:gd name="connsiteY22" fmla="*/ 8222 h 9098"/>
                  <a:gd name="connsiteX23" fmla="*/ 653 w 5227"/>
                  <a:gd name="connsiteY23" fmla="*/ 7872 h 9098"/>
                  <a:gd name="connsiteX24" fmla="*/ 77 w 5227"/>
                  <a:gd name="connsiteY24" fmla="*/ 8472 h 9098"/>
                  <a:gd name="connsiteX25" fmla="*/ 967 w 5227"/>
                  <a:gd name="connsiteY25" fmla="*/ 9162 h 9098"/>
                  <a:gd name="connsiteX26" fmla="*/ 2151 w 5227"/>
                  <a:gd name="connsiteY26" fmla="*/ 8192 h 9098"/>
                  <a:gd name="connsiteX27" fmla="*/ 2737 w 5227"/>
                  <a:gd name="connsiteY27" fmla="*/ 6282 h 9098"/>
                  <a:gd name="connsiteX28" fmla="*/ 3366 w 5227"/>
                  <a:gd name="connsiteY28" fmla="*/ 3112 h 90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5227" h="9098">
                    <a:moveTo>
                      <a:pt x="3366" y="3112"/>
                    </a:moveTo>
                    <a:lnTo>
                      <a:pt x="4267" y="3112"/>
                    </a:lnTo>
                    <a:cubicBezTo>
                      <a:pt x="4476" y="3112"/>
                      <a:pt x="4581" y="3112"/>
                      <a:pt x="4581" y="2912"/>
                    </a:cubicBezTo>
                    <a:cubicBezTo>
                      <a:pt x="4581" y="2802"/>
                      <a:pt x="4476" y="2802"/>
                      <a:pt x="4298" y="2802"/>
                    </a:cubicBezTo>
                    <a:lnTo>
                      <a:pt x="3429" y="2802"/>
                    </a:lnTo>
                    <a:lnTo>
                      <a:pt x="3649" y="1663"/>
                    </a:lnTo>
                    <a:cubicBezTo>
                      <a:pt x="3691" y="1453"/>
                      <a:pt x="3837" y="743"/>
                      <a:pt x="3900" y="623"/>
                    </a:cubicBezTo>
                    <a:cubicBezTo>
                      <a:pt x="3994" y="433"/>
                      <a:pt x="4172" y="283"/>
                      <a:pt x="4392" y="283"/>
                    </a:cubicBezTo>
                    <a:cubicBezTo>
                      <a:pt x="4434" y="283"/>
                      <a:pt x="4707" y="283"/>
                      <a:pt x="4906" y="463"/>
                    </a:cubicBezTo>
                    <a:cubicBezTo>
                      <a:pt x="4445" y="503"/>
                      <a:pt x="4340" y="853"/>
                      <a:pt x="4340" y="1003"/>
                    </a:cubicBezTo>
                    <a:cubicBezTo>
                      <a:pt x="4340" y="1233"/>
                      <a:pt x="4529" y="1353"/>
                      <a:pt x="4728" y="1353"/>
                    </a:cubicBezTo>
                    <a:cubicBezTo>
                      <a:pt x="5000" y="1353"/>
                      <a:pt x="5304" y="1133"/>
                      <a:pt x="5304" y="753"/>
                    </a:cubicBezTo>
                    <a:cubicBezTo>
                      <a:pt x="5304" y="293"/>
                      <a:pt x="4822" y="63"/>
                      <a:pt x="4392" y="63"/>
                    </a:cubicBezTo>
                    <a:cubicBezTo>
                      <a:pt x="4036" y="63"/>
                      <a:pt x="3376" y="243"/>
                      <a:pt x="3062" y="1233"/>
                    </a:cubicBezTo>
                    <a:cubicBezTo>
                      <a:pt x="2999" y="1443"/>
                      <a:pt x="2968" y="1543"/>
                      <a:pt x="2716" y="2802"/>
                    </a:cubicBezTo>
                    <a:lnTo>
                      <a:pt x="1994" y="2802"/>
                    </a:lnTo>
                    <a:cubicBezTo>
                      <a:pt x="1795" y="2802"/>
                      <a:pt x="1679" y="2802"/>
                      <a:pt x="1679" y="2992"/>
                    </a:cubicBezTo>
                    <a:cubicBezTo>
                      <a:pt x="1679" y="3112"/>
                      <a:pt x="1774" y="3112"/>
                      <a:pt x="1973" y="3112"/>
                    </a:cubicBezTo>
                    <a:lnTo>
                      <a:pt x="2664" y="3112"/>
                    </a:lnTo>
                    <a:lnTo>
                      <a:pt x="1878" y="7062"/>
                    </a:lnTo>
                    <a:cubicBezTo>
                      <a:pt x="1690" y="8032"/>
                      <a:pt x="1512" y="8942"/>
                      <a:pt x="967" y="8942"/>
                    </a:cubicBezTo>
                    <a:cubicBezTo>
                      <a:pt x="925" y="8942"/>
                      <a:pt x="663" y="8942"/>
                      <a:pt x="464" y="8762"/>
                    </a:cubicBezTo>
                    <a:cubicBezTo>
                      <a:pt x="946" y="8732"/>
                      <a:pt x="1040" y="8372"/>
                      <a:pt x="1040" y="8222"/>
                    </a:cubicBezTo>
                    <a:cubicBezTo>
                      <a:pt x="1040" y="7992"/>
                      <a:pt x="852" y="7872"/>
                      <a:pt x="653" y="7872"/>
                    </a:cubicBezTo>
                    <a:cubicBezTo>
                      <a:pt x="380" y="7872"/>
                      <a:pt x="77" y="8092"/>
                      <a:pt x="77" y="8472"/>
                    </a:cubicBezTo>
                    <a:cubicBezTo>
                      <a:pt x="77" y="8922"/>
                      <a:pt x="538" y="9162"/>
                      <a:pt x="967" y="9162"/>
                    </a:cubicBezTo>
                    <a:cubicBezTo>
                      <a:pt x="1543" y="9162"/>
                      <a:pt x="1962" y="8572"/>
                      <a:pt x="2151" y="8192"/>
                    </a:cubicBezTo>
                    <a:cubicBezTo>
                      <a:pt x="2486" y="7562"/>
                      <a:pt x="2727" y="6352"/>
                      <a:pt x="2737" y="6282"/>
                    </a:cubicBezTo>
                    <a:lnTo>
                      <a:pt x="3366" y="3112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</p:grpSp>
        <p:grpSp>
          <p:nvGrpSpPr>
            <p:cNvPr id="302" name="Group 301" descr="\documentclass{article}&#10;\usepackage{amsmath}&#10;\pagestyle{empty}&#10;\begin{document}&#10;&#10;$\hat{f}$&#10;&#10;\end{document}" title="IguanaTex Vector Display">
              <a:extLst>
                <a:ext uri="{FF2B5EF4-FFF2-40B4-BE49-F238E27FC236}">
                  <a16:creationId xmlns:a16="http://schemas.microsoft.com/office/drawing/2014/main" id="{6769B86D-6BB3-D398-9F3B-80601059B893}"/>
                </a:ext>
              </a:extLst>
            </p:cNvPr>
            <p:cNvGrpSpPr>
              <a:grpSpLocks noChangeAspect="1"/>
            </p:cNvGrpSpPr>
            <p:nvPr>
              <p:custDataLst>
                <p:tags r:id="rId5"/>
              </p:custDataLst>
            </p:nvPr>
          </p:nvGrpSpPr>
          <p:grpSpPr>
            <a:xfrm>
              <a:off x="2810615" y="2210737"/>
              <a:ext cx="68532" cy="139512"/>
              <a:chOff x="2321925" y="2364418"/>
              <a:chExt cx="5711" cy="11626"/>
            </a:xfrm>
          </p:grpSpPr>
          <p:sp>
            <p:nvSpPr>
              <p:cNvPr id="303" name="Freeform: Shape 302">
                <a:extLst>
                  <a:ext uri="{FF2B5EF4-FFF2-40B4-BE49-F238E27FC236}">
                    <a16:creationId xmlns:a16="http://schemas.microsoft.com/office/drawing/2014/main" id="{B49F8505-42DF-DE8F-39EB-3516666D2376}"/>
                  </a:ext>
                </a:extLst>
              </p:cNvPr>
              <p:cNvSpPr/>
              <p:nvPr>
                <p:custDataLst>
                  <p:tags r:id="rId9"/>
                </p:custDataLst>
              </p:nvPr>
            </p:nvSpPr>
            <p:spPr>
              <a:xfrm>
                <a:off x="2324840" y="2364418"/>
                <a:ext cx="2796" cy="1539"/>
              </a:xfrm>
              <a:custGeom>
                <a:avLst/>
                <a:gdLst>
                  <a:gd name="connsiteX0" fmla="*/ 1483 w 2796"/>
                  <a:gd name="connsiteY0" fmla="*/ 60 h 1539"/>
                  <a:gd name="connsiteX1" fmla="*/ 79 w 2796"/>
                  <a:gd name="connsiteY1" fmla="*/ 1420 h 1539"/>
                  <a:gd name="connsiteX2" fmla="*/ 267 w 2796"/>
                  <a:gd name="connsiteY2" fmla="*/ 1600 h 1539"/>
                  <a:gd name="connsiteX3" fmla="*/ 1483 w 2796"/>
                  <a:gd name="connsiteY3" fmla="*/ 580 h 1539"/>
                  <a:gd name="connsiteX4" fmla="*/ 2687 w 2796"/>
                  <a:gd name="connsiteY4" fmla="*/ 1600 h 1539"/>
                  <a:gd name="connsiteX5" fmla="*/ 2876 w 2796"/>
                  <a:gd name="connsiteY5" fmla="*/ 1420 h 1539"/>
                  <a:gd name="connsiteX6" fmla="*/ 1483 w 2796"/>
                  <a:gd name="connsiteY6" fmla="*/ 60 h 15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796" h="1539">
                    <a:moveTo>
                      <a:pt x="1483" y="60"/>
                    </a:moveTo>
                    <a:lnTo>
                      <a:pt x="79" y="1420"/>
                    </a:lnTo>
                    <a:lnTo>
                      <a:pt x="267" y="1600"/>
                    </a:lnTo>
                    <a:lnTo>
                      <a:pt x="1483" y="580"/>
                    </a:lnTo>
                    <a:lnTo>
                      <a:pt x="2687" y="1600"/>
                    </a:lnTo>
                    <a:lnTo>
                      <a:pt x="2876" y="1420"/>
                    </a:lnTo>
                    <a:lnTo>
                      <a:pt x="1483" y="6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04" name="Freeform: Shape 303">
                <a:extLst>
                  <a:ext uri="{FF2B5EF4-FFF2-40B4-BE49-F238E27FC236}">
                    <a16:creationId xmlns:a16="http://schemas.microsoft.com/office/drawing/2014/main" id="{2EF3C263-FD6F-5CE3-03D0-F336F3B48823}"/>
                  </a:ext>
                </a:extLst>
              </p:cNvPr>
              <p:cNvSpPr/>
              <p:nvPr>
                <p:custDataLst>
                  <p:tags r:id="rId10"/>
                </p:custDataLst>
              </p:nvPr>
            </p:nvSpPr>
            <p:spPr>
              <a:xfrm>
                <a:off x="2321925" y="2366946"/>
                <a:ext cx="5227" cy="9098"/>
              </a:xfrm>
              <a:custGeom>
                <a:avLst/>
                <a:gdLst>
                  <a:gd name="connsiteX0" fmla="*/ 3366 w 5227"/>
                  <a:gd name="connsiteY0" fmla="*/ 3112 h 9098"/>
                  <a:gd name="connsiteX1" fmla="*/ 4267 w 5227"/>
                  <a:gd name="connsiteY1" fmla="*/ 3112 h 9098"/>
                  <a:gd name="connsiteX2" fmla="*/ 4581 w 5227"/>
                  <a:gd name="connsiteY2" fmla="*/ 2912 h 9098"/>
                  <a:gd name="connsiteX3" fmla="*/ 4298 w 5227"/>
                  <a:gd name="connsiteY3" fmla="*/ 2802 h 9098"/>
                  <a:gd name="connsiteX4" fmla="*/ 3429 w 5227"/>
                  <a:gd name="connsiteY4" fmla="*/ 2802 h 9098"/>
                  <a:gd name="connsiteX5" fmla="*/ 3649 w 5227"/>
                  <a:gd name="connsiteY5" fmla="*/ 1663 h 9098"/>
                  <a:gd name="connsiteX6" fmla="*/ 3900 w 5227"/>
                  <a:gd name="connsiteY6" fmla="*/ 623 h 9098"/>
                  <a:gd name="connsiteX7" fmla="*/ 4392 w 5227"/>
                  <a:gd name="connsiteY7" fmla="*/ 283 h 9098"/>
                  <a:gd name="connsiteX8" fmla="*/ 4906 w 5227"/>
                  <a:gd name="connsiteY8" fmla="*/ 463 h 9098"/>
                  <a:gd name="connsiteX9" fmla="*/ 4340 w 5227"/>
                  <a:gd name="connsiteY9" fmla="*/ 1003 h 9098"/>
                  <a:gd name="connsiteX10" fmla="*/ 4728 w 5227"/>
                  <a:gd name="connsiteY10" fmla="*/ 1353 h 9098"/>
                  <a:gd name="connsiteX11" fmla="*/ 5304 w 5227"/>
                  <a:gd name="connsiteY11" fmla="*/ 753 h 9098"/>
                  <a:gd name="connsiteX12" fmla="*/ 4392 w 5227"/>
                  <a:gd name="connsiteY12" fmla="*/ 63 h 9098"/>
                  <a:gd name="connsiteX13" fmla="*/ 3062 w 5227"/>
                  <a:gd name="connsiteY13" fmla="*/ 1233 h 9098"/>
                  <a:gd name="connsiteX14" fmla="*/ 2716 w 5227"/>
                  <a:gd name="connsiteY14" fmla="*/ 2802 h 9098"/>
                  <a:gd name="connsiteX15" fmla="*/ 1994 w 5227"/>
                  <a:gd name="connsiteY15" fmla="*/ 2802 h 9098"/>
                  <a:gd name="connsiteX16" fmla="*/ 1679 w 5227"/>
                  <a:gd name="connsiteY16" fmla="*/ 2992 h 9098"/>
                  <a:gd name="connsiteX17" fmla="*/ 1973 w 5227"/>
                  <a:gd name="connsiteY17" fmla="*/ 3112 h 9098"/>
                  <a:gd name="connsiteX18" fmla="*/ 2664 w 5227"/>
                  <a:gd name="connsiteY18" fmla="*/ 3112 h 9098"/>
                  <a:gd name="connsiteX19" fmla="*/ 1878 w 5227"/>
                  <a:gd name="connsiteY19" fmla="*/ 7062 h 9098"/>
                  <a:gd name="connsiteX20" fmla="*/ 967 w 5227"/>
                  <a:gd name="connsiteY20" fmla="*/ 8942 h 9098"/>
                  <a:gd name="connsiteX21" fmla="*/ 464 w 5227"/>
                  <a:gd name="connsiteY21" fmla="*/ 8762 h 9098"/>
                  <a:gd name="connsiteX22" fmla="*/ 1040 w 5227"/>
                  <a:gd name="connsiteY22" fmla="*/ 8222 h 9098"/>
                  <a:gd name="connsiteX23" fmla="*/ 653 w 5227"/>
                  <a:gd name="connsiteY23" fmla="*/ 7872 h 9098"/>
                  <a:gd name="connsiteX24" fmla="*/ 77 w 5227"/>
                  <a:gd name="connsiteY24" fmla="*/ 8472 h 9098"/>
                  <a:gd name="connsiteX25" fmla="*/ 967 w 5227"/>
                  <a:gd name="connsiteY25" fmla="*/ 9162 h 9098"/>
                  <a:gd name="connsiteX26" fmla="*/ 2151 w 5227"/>
                  <a:gd name="connsiteY26" fmla="*/ 8192 h 9098"/>
                  <a:gd name="connsiteX27" fmla="*/ 2737 w 5227"/>
                  <a:gd name="connsiteY27" fmla="*/ 6282 h 9098"/>
                  <a:gd name="connsiteX28" fmla="*/ 3366 w 5227"/>
                  <a:gd name="connsiteY28" fmla="*/ 3112 h 90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5227" h="9098">
                    <a:moveTo>
                      <a:pt x="3366" y="3112"/>
                    </a:moveTo>
                    <a:lnTo>
                      <a:pt x="4267" y="3112"/>
                    </a:lnTo>
                    <a:cubicBezTo>
                      <a:pt x="4476" y="3112"/>
                      <a:pt x="4581" y="3112"/>
                      <a:pt x="4581" y="2912"/>
                    </a:cubicBezTo>
                    <a:cubicBezTo>
                      <a:pt x="4581" y="2802"/>
                      <a:pt x="4476" y="2802"/>
                      <a:pt x="4298" y="2802"/>
                    </a:cubicBezTo>
                    <a:lnTo>
                      <a:pt x="3429" y="2802"/>
                    </a:lnTo>
                    <a:lnTo>
                      <a:pt x="3649" y="1663"/>
                    </a:lnTo>
                    <a:cubicBezTo>
                      <a:pt x="3691" y="1453"/>
                      <a:pt x="3837" y="743"/>
                      <a:pt x="3900" y="623"/>
                    </a:cubicBezTo>
                    <a:cubicBezTo>
                      <a:pt x="3994" y="433"/>
                      <a:pt x="4172" y="283"/>
                      <a:pt x="4392" y="283"/>
                    </a:cubicBezTo>
                    <a:cubicBezTo>
                      <a:pt x="4434" y="283"/>
                      <a:pt x="4707" y="283"/>
                      <a:pt x="4906" y="463"/>
                    </a:cubicBezTo>
                    <a:cubicBezTo>
                      <a:pt x="4445" y="503"/>
                      <a:pt x="4340" y="853"/>
                      <a:pt x="4340" y="1003"/>
                    </a:cubicBezTo>
                    <a:cubicBezTo>
                      <a:pt x="4340" y="1233"/>
                      <a:pt x="4529" y="1353"/>
                      <a:pt x="4728" y="1353"/>
                    </a:cubicBezTo>
                    <a:cubicBezTo>
                      <a:pt x="5000" y="1353"/>
                      <a:pt x="5304" y="1133"/>
                      <a:pt x="5304" y="753"/>
                    </a:cubicBezTo>
                    <a:cubicBezTo>
                      <a:pt x="5304" y="293"/>
                      <a:pt x="4822" y="63"/>
                      <a:pt x="4392" y="63"/>
                    </a:cubicBezTo>
                    <a:cubicBezTo>
                      <a:pt x="4036" y="63"/>
                      <a:pt x="3376" y="243"/>
                      <a:pt x="3062" y="1233"/>
                    </a:cubicBezTo>
                    <a:cubicBezTo>
                      <a:pt x="2999" y="1443"/>
                      <a:pt x="2968" y="1543"/>
                      <a:pt x="2716" y="2802"/>
                    </a:cubicBezTo>
                    <a:lnTo>
                      <a:pt x="1994" y="2802"/>
                    </a:lnTo>
                    <a:cubicBezTo>
                      <a:pt x="1795" y="2802"/>
                      <a:pt x="1679" y="2802"/>
                      <a:pt x="1679" y="2992"/>
                    </a:cubicBezTo>
                    <a:cubicBezTo>
                      <a:pt x="1679" y="3112"/>
                      <a:pt x="1774" y="3112"/>
                      <a:pt x="1973" y="3112"/>
                    </a:cubicBezTo>
                    <a:lnTo>
                      <a:pt x="2664" y="3112"/>
                    </a:lnTo>
                    <a:lnTo>
                      <a:pt x="1878" y="7062"/>
                    </a:lnTo>
                    <a:cubicBezTo>
                      <a:pt x="1690" y="8032"/>
                      <a:pt x="1512" y="8942"/>
                      <a:pt x="967" y="8942"/>
                    </a:cubicBezTo>
                    <a:cubicBezTo>
                      <a:pt x="925" y="8942"/>
                      <a:pt x="663" y="8942"/>
                      <a:pt x="464" y="8762"/>
                    </a:cubicBezTo>
                    <a:cubicBezTo>
                      <a:pt x="946" y="8732"/>
                      <a:pt x="1040" y="8372"/>
                      <a:pt x="1040" y="8222"/>
                    </a:cubicBezTo>
                    <a:cubicBezTo>
                      <a:pt x="1040" y="7992"/>
                      <a:pt x="852" y="7872"/>
                      <a:pt x="653" y="7872"/>
                    </a:cubicBezTo>
                    <a:cubicBezTo>
                      <a:pt x="380" y="7872"/>
                      <a:pt x="77" y="8092"/>
                      <a:pt x="77" y="8472"/>
                    </a:cubicBezTo>
                    <a:cubicBezTo>
                      <a:pt x="77" y="8922"/>
                      <a:pt x="538" y="9162"/>
                      <a:pt x="967" y="9162"/>
                    </a:cubicBezTo>
                    <a:cubicBezTo>
                      <a:pt x="1543" y="9162"/>
                      <a:pt x="1962" y="8572"/>
                      <a:pt x="2151" y="8192"/>
                    </a:cubicBezTo>
                    <a:cubicBezTo>
                      <a:pt x="2486" y="7562"/>
                      <a:pt x="2727" y="6352"/>
                      <a:pt x="2737" y="6282"/>
                    </a:cubicBezTo>
                    <a:lnTo>
                      <a:pt x="3366" y="3112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</p:grpSp>
        <p:grpSp>
          <p:nvGrpSpPr>
            <p:cNvPr id="305" name="Group 304" descr="\documentclass{article}&#10;\usepackage{amsmath}&#10;\pagestyle{empty}&#10;\begin{document}&#10;&#10;$\hat{f}$&#10;&#10;\end{document}" title="IguanaTex Vector Display">
              <a:extLst>
                <a:ext uri="{FF2B5EF4-FFF2-40B4-BE49-F238E27FC236}">
                  <a16:creationId xmlns:a16="http://schemas.microsoft.com/office/drawing/2014/main" id="{0255F66F-9335-EC25-E5DE-E40005164744}"/>
                </a:ext>
              </a:extLst>
            </p:cNvPr>
            <p:cNvGrpSpPr>
              <a:grpSpLocks noChangeAspect="1"/>
            </p:cNvGrpSpPr>
            <p:nvPr>
              <p:custDataLst>
                <p:tags r:id="rId6"/>
              </p:custDataLst>
            </p:nvPr>
          </p:nvGrpSpPr>
          <p:grpSpPr>
            <a:xfrm>
              <a:off x="2654971" y="2367419"/>
              <a:ext cx="68532" cy="139512"/>
              <a:chOff x="2321925" y="2364418"/>
              <a:chExt cx="5711" cy="11626"/>
            </a:xfrm>
          </p:grpSpPr>
          <p:sp>
            <p:nvSpPr>
              <p:cNvPr id="306" name="Freeform: Shape 305">
                <a:extLst>
                  <a:ext uri="{FF2B5EF4-FFF2-40B4-BE49-F238E27FC236}">
                    <a16:creationId xmlns:a16="http://schemas.microsoft.com/office/drawing/2014/main" id="{E3F27027-E8EB-5DCD-C3EB-91BAB90489E2}"/>
                  </a:ext>
                </a:extLst>
              </p:cNvPr>
              <p:cNvSpPr/>
              <p:nvPr>
                <p:custDataLst>
                  <p:tags r:id="rId7"/>
                </p:custDataLst>
              </p:nvPr>
            </p:nvSpPr>
            <p:spPr>
              <a:xfrm>
                <a:off x="2324840" y="2364418"/>
                <a:ext cx="2796" cy="1539"/>
              </a:xfrm>
              <a:custGeom>
                <a:avLst/>
                <a:gdLst>
                  <a:gd name="connsiteX0" fmla="*/ 1483 w 2796"/>
                  <a:gd name="connsiteY0" fmla="*/ 60 h 1539"/>
                  <a:gd name="connsiteX1" fmla="*/ 79 w 2796"/>
                  <a:gd name="connsiteY1" fmla="*/ 1420 h 1539"/>
                  <a:gd name="connsiteX2" fmla="*/ 267 w 2796"/>
                  <a:gd name="connsiteY2" fmla="*/ 1600 h 1539"/>
                  <a:gd name="connsiteX3" fmla="*/ 1483 w 2796"/>
                  <a:gd name="connsiteY3" fmla="*/ 580 h 1539"/>
                  <a:gd name="connsiteX4" fmla="*/ 2687 w 2796"/>
                  <a:gd name="connsiteY4" fmla="*/ 1600 h 1539"/>
                  <a:gd name="connsiteX5" fmla="*/ 2876 w 2796"/>
                  <a:gd name="connsiteY5" fmla="*/ 1420 h 1539"/>
                  <a:gd name="connsiteX6" fmla="*/ 1483 w 2796"/>
                  <a:gd name="connsiteY6" fmla="*/ 60 h 15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796" h="1539">
                    <a:moveTo>
                      <a:pt x="1483" y="60"/>
                    </a:moveTo>
                    <a:lnTo>
                      <a:pt x="79" y="1420"/>
                    </a:lnTo>
                    <a:lnTo>
                      <a:pt x="267" y="1600"/>
                    </a:lnTo>
                    <a:lnTo>
                      <a:pt x="1483" y="580"/>
                    </a:lnTo>
                    <a:lnTo>
                      <a:pt x="2687" y="1600"/>
                    </a:lnTo>
                    <a:lnTo>
                      <a:pt x="2876" y="1420"/>
                    </a:lnTo>
                    <a:lnTo>
                      <a:pt x="1483" y="6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07" name="Freeform: Shape 306">
                <a:extLst>
                  <a:ext uri="{FF2B5EF4-FFF2-40B4-BE49-F238E27FC236}">
                    <a16:creationId xmlns:a16="http://schemas.microsoft.com/office/drawing/2014/main" id="{1CB7D605-D076-62BA-9C55-124933841C99}"/>
                  </a:ext>
                </a:extLst>
              </p:cNvPr>
              <p:cNvSpPr/>
              <p:nvPr>
                <p:custDataLst>
                  <p:tags r:id="rId8"/>
                </p:custDataLst>
              </p:nvPr>
            </p:nvSpPr>
            <p:spPr>
              <a:xfrm>
                <a:off x="2321925" y="2366946"/>
                <a:ext cx="5227" cy="9098"/>
              </a:xfrm>
              <a:custGeom>
                <a:avLst/>
                <a:gdLst>
                  <a:gd name="connsiteX0" fmla="*/ 3366 w 5227"/>
                  <a:gd name="connsiteY0" fmla="*/ 3112 h 9098"/>
                  <a:gd name="connsiteX1" fmla="*/ 4267 w 5227"/>
                  <a:gd name="connsiteY1" fmla="*/ 3112 h 9098"/>
                  <a:gd name="connsiteX2" fmla="*/ 4581 w 5227"/>
                  <a:gd name="connsiteY2" fmla="*/ 2912 h 9098"/>
                  <a:gd name="connsiteX3" fmla="*/ 4298 w 5227"/>
                  <a:gd name="connsiteY3" fmla="*/ 2802 h 9098"/>
                  <a:gd name="connsiteX4" fmla="*/ 3429 w 5227"/>
                  <a:gd name="connsiteY4" fmla="*/ 2802 h 9098"/>
                  <a:gd name="connsiteX5" fmla="*/ 3649 w 5227"/>
                  <a:gd name="connsiteY5" fmla="*/ 1663 h 9098"/>
                  <a:gd name="connsiteX6" fmla="*/ 3900 w 5227"/>
                  <a:gd name="connsiteY6" fmla="*/ 623 h 9098"/>
                  <a:gd name="connsiteX7" fmla="*/ 4392 w 5227"/>
                  <a:gd name="connsiteY7" fmla="*/ 283 h 9098"/>
                  <a:gd name="connsiteX8" fmla="*/ 4906 w 5227"/>
                  <a:gd name="connsiteY8" fmla="*/ 463 h 9098"/>
                  <a:gd name="connsiteX9" fmla="*/ 4340 w 5227"/>
                  <a:gd name="connsiteY9" fmla="*/ 1003 h 9098"/>
                  <a:gd name="connsiteX10" fmla="*/ 4728 w 5227"/>
                  <a:gd name="connsiteY10" fmla="*/ 1353 h 9098"/>
                  <a:gd name="connsiteX11" fmla="*/ 5304 w 5227"/>
                  <a:gd name="connsiteY11" fmla="*/ 753 h 9098"/>
                  <a:gd name="connsiteX12" fmla="*/ 4392 w 5227"/>
                  <a:gd name="connsiteY12" fmla="*/ 63 h 9098"/>
                  <a:gd name="connsiteX13" fmla="*/ 3062 w 5227"/>
                  <a:gd name="connsiteY13" fmla="*/ 1233 h 9098"/>
                  <a:gd name="connsiteX14" fmla="*/ 2716 w 5227"/>
                  <a:gd name="connsiteY14" fmla="*/ 2802 h 9098"/>
                  <a:gd name="connsiteX15" fmla="*/ 1994 w 5227"/>
                  <a:gd name="connsiteY15" fmla="*/ 2802 h 9098"/>
                  <a:gd name="connsiteX16" fmla="*/ 1679 w 5227"/>
                  <a:gd name="connsiteY16" fmla="*/ 2992 h 9098"/>
                  <a:gd name="connsiteX17" fmla="*/ 1973 w 5227"/>
                  <a:gd name="connsiteY17" fmla="*/ 3112 h 9098"/>
                  <a:gd name="connsiteX18" fmla="*/ 2664 w 5227"/>
                  <a:gd name="connsiteY18" fmla="*/ 3112 h 9098"/>
                  <a:gd name="connsiteX19" fmla="*/ 1878 w 5227"/>
                  <a:gd name="connsiteY19" fmla="*/ 7062 h 9098"/>
                  <a:gd name="connsiteX20" fmla="*/ 967 w 5227"/>
                  <a:gd name="connsiteY20" fmla="*/ 8942 h 9098"/>
                  <a:gd name="connsiteX21" fmla="*/ 464 w 5227"/>
                  <a:gd name="connsiteY21" fmla="*/ 8762 h 9098"/>
                  <a:gd name="connsiteX22" fmla="*/ 1040 w 5227"/>
                  <a:gd name="connsiteY22" fmla="*/ 8222 h 9098"/>
                  <a:gd name="connsiteX23" fmla="*/ 653 w 5227"/>
                  <a:gd name="connsiteY23" fmla="*/ 7872 h 9098"/>
                  <a:gd name="connsiteX24" fmla="*/ 77 w 5227"/>
                  <a:gd name="connsiteY24" fmla="*/ 8472 h 9098"/>
                  <a:gd name="connsiteX25" fmla="*/ 967 w 5227"/>
                  <a:gd name="connsiteY25" fmla="*/ 9162 h 9098"/>
                  <a:gd name="connsiteX26" fmla="*/ 2151 w 5227"/>
                  <a:gd name="connsiteY26" fmla="*/ 8192 h 9098"/>
                  <a:gd name="connsiteX27" fmla="*/ 2737 w 5227"/>
                  <a:gd name="connsiteY27" fmla="*/ 6282 h 9098"/>
                  <a:gd name="connsiteX28" fmla="*/ 3366 w 5227"/>
                  <a:gd name="connsiteY28" fmla="*/ 3112 h 90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5227" h="9098">
                    <a:moveTo>
                      <a:pt x="3366" y="3112"/>
                    </a:moveTo>
                    <a:lnTo>
                      <a:pt x="4267" y="3112"/>
                    </a:lnTo>
                    <a:cubicBezTo>
                      <a:pt x="4476" y="3112"/>
                      <a:pt x="4581" y="3112"/>
                      <a:pt x="4581" y="2912"/>
                    </a:cubicBezTo>
                    <a:cubicBezTo>
                      <a:pt x="4581" y="2802"/>
                      <a:pt x="4476" y="2802"/>
                      <a:pt x="4298" y="2802"/>
                    </a:cubicBezTo>
                    <a:lnTo>
                      <a:pt x="3429" y="2802"/>
                    </a:lnTo>
                    <a:lnTo>
                      <a:pt x="3649" y="1663"/>
                    </a:lnTo>
                    <a:cubicBezTo>
                      <a:pt x="3691" y="1453"/>
                      <a:pt x="3837" y="743"/>
                      <a:pt x="3900" y="623"/>
                    </a:cubicBezTo>
                    <a:cubicBezTo>
                      <a:pt x="3994" y="433"/>
                      <a:pt x="4172" y="283"/>
                      <a:pt x="4392" y="283"/>
                    </a:cubicBezTo>
                    <a:cubicBezTo>
                      <a:pt x="4434" y="283"/>
                      <a:pt x="4707" y="283"/>
                      <a:pt x="4906" y="463"/>
                    </a:cubicBezTo>
                    <a:cubicBezTo>
                      <a:pt x="4445" y="503"/>
                      <a:pt x="4340" y="853"/>
                      <a:pt x="4340" y="1003"/>
                    </a:cubicBezTo>
                    <a:cubicBezTo>
                      <a:pt x="4340" y="1233"/>
                      <a:pt x="4529" y="1353"/>
                      <a:pt x="4728" y="1353"/>
                    </a:cubicBezTo>
                    <a:cubicBezTo>
                      <a:pt x="5000" y="1353"/>
                      <a:pt x="5304" y="1133"/>
                      <a:pt x="5304" y="753"/>
                    </a:cubicBezTo>
                    <a:cubicBezTo>
                      <a:pt x="5304" y="293"/>
                      <a:pt x="4822" y="63"/>
                      <a:pt x="4392" y="63"/>
                    </a:cubicBezTo>
                    <a:cubicBezTo>
                      <a:pt x="4036" y="63"/>
                      <a:pt x="3376" y="243"/>
                      <a:pt x="3062" y="1233"/>
                    </a:cubicBezTo>
                    <a:cubicBezTo>
                      <a:pt x="2999" y="1443"/>
                      <a:pt x="2968" y="1543"/>
                      <a:pt x="2716" y="2802"/>
                    </a:cubicBezTo>
                    <a:lnTo>
                      <a:pt x="1994" y="2802"/>
                    </a:lnTo>
                    <a:cubicBezTo>
                      <a:pt x="1795" y="2802"/>
                      <a:pt x="1679" y="2802"/>
                      <a:pt x="1679" y="2992"/>
                    </a:cubicBezTo>
                    <a:cubicBezTo>
                      <a:pt x="1679" y="3112"/>
                      <a:pt x="1774" y="3112"/>
                      <a:pt x="1973" y="3112"/>
                    </a:cubicBezTo>
                    <a:lnTo>
                      <a:pt x="2664" y="3112"/>
                    </a:lnTo>
                    <a:lnTo>
                      <a:pt x="1878" y="7062"/>
                    </a:lnTo>
                    <a:cubicBezTo>
                      <a:pt x="1690" y="8032"/>
                      <a:pt x="1512" y="8942"/>
                      <a:pt x="967" y="8942"/>
                    </a:cubicBezTo>
                    <a:cubicBezTo>
                      <a:pt x="925" y="8942"/>
                      <a:pt x="663" y="8942"/>
                      <a:pt x="464" y="8762"/>
                    </a:cubicBezTo>
                    <a:cubicBezTo>
                      <a:pt x="946" y="8732"/>
                      <a:pt x="1040" y="8372"/>
                      <a:pt x="1040" y="8222"/>
                    </a:cubicBezTo>
                    <a:cubicBezTo>
                      <a:pt x="1040" y="7992"/>
                      <a:pt x="852" y="7872"/>
                      <a:pt x="653" y="7872"/>
                    </a:cubicBezTo>
                    <a:cubicBezTo>
                      <a:pt x="380" y="7872"/>
                      <a:pt x="77" y="8092"/>
                      <a:pt x="77" y="8472"/>
                    </a:cubicBezTo>
                    <a:cubicBezTo>
                      <a:pt x="77" y="8922"/>
                      <a:pt x="538" y="9162"/>
                      <a:pt x="967" y="9162"/>
                    </a:cubicBezTo>
                    <a:cubicBezTo>
                      <a:pt x="1543" y="9162"/>
                      <a:pt x="1962" y="8572"/>
                      <a:pt x="2151" y="8192"/>
                    </a:cubicBezTo>
                    <a:cubicBezTo>
                      <a:pt x="2486" y="7562"/>
                      <a:pt x="2727" y="6352"/>
                      <a:pt x="2737" y="6282"/>
                    </a:cubicBezTo>
                    <a:lnTo>
                      <a:pt x="3366" y="3112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</p:grp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3F09726D-BA82-2739-4B36-BF0D2F37BE38}"/>
                </a:ext>
              </a:extLst>
            </p:cNvPr>
            <p:cNvSpPr/>
            <p:nvPr/>
          </p:nvSpPr>
          <p:spPr>
            <a:xfrm>
              <a:off x="2412380" y="806058"/>
              <a:ext cx="962145" cy="2543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ndom snapshot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02BE0AF7-04EE-FF3B-E36A-F879E67310D7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565419" y="188965"/>
              <a:ext cx="648000" cy="648000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CF526A4A-2276-92E1-0A0F-1984A5476628}"/>
                </a:ext>
              </a:extLst>
            </p:cNvPr>
            <p:cNvCxnSpPr>
              <a:cxnSpLocks/>
            </p:cNvCxnSpPr>
            <p:nvPr/>
          </p:nvCxnSpPr>
          <p:spPr>
            <a:xfrm>
              <a:off x="2603193" y="791054"/>
              <a:ext cx="1944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52E274A-043D-F836-DD97-184B78299340}"/>
                </a:ext>
              </a:extLst>
            </p:cNvPr>
            <p:cNvSpPr txBox="1"/>
            <p:nvPr/>
          </p:nvSpPr>
          <p:spPr>
            <a:xfrm>
              <a:off x="35578" y="16871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35BA82D-DFB3-D3C7-096C-66E0834C591F}"/>
                </a:ext>
              </a:extLst>
            </p:cNvPr>
            <p:cNvSpPr txBox="1"/>
            <p:nvPr/>
          </p:nvSpPr>
          <p:spPr>
            <a:xfrm>
              <a:off x="1085527" y="933862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40E987D-BE38-8847-1D86-8D9ACD6483B3}"/>
                </a:ext>
              </a:extLst>
            </p:cNvPr>
            <p:cNvSpPr txBox="1"/>
            <p:nvPr/>
          </p:nvSpPr>
          <p:spPr>
            <a:xfrm>
              <a:off x="1085527" y="16871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20BF134A-467A-43B9-E4FA-3D950B79AA3D}"/>
                </a:ext>
              </a:extLst>
            </p:cNvPr>
            <p:cNvSpPr/>
            <p:nvPr/>
          </p:nvSpPr>
          <p:spPr>
            <a:xfrm rot="16200000">
              <a:off x="626127" y="413927"/>
              <a:ext cx="990520" cy="2543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ase (rad)</a:t>
              </a:r>
            </a:p>
          </p:txBody>
        </p: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ACBEDF35-AA22-FCAC-FFEE-74310F7B1D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9"/>
            <a:srcRect l="12590" t="7019" r="13278" b="10205"/>
            <a:stretch/>
          </p:blipFill>
          <p:spPr>
            <a:xfrm>
              <a:off x="231880" y="151198"/>
              <a:ext cx="820051" cy="779486"/>
            </a:xfrm>
            <a:prstGeom prst="rect">
              <a:avLst/>
            </a:prstGeom>
          </p:spPr>
        </p:pic>
        <mc:AlternateContent xmlns:mc="http://schemas.openxmlformats.org/markup-compatibility/2006">
          <mc:Choice xmlns:a14="http://schemas.microsoft.com/office/drawing/2010/main" Requires="a14">
            <p:sp>
              <p:nvSpPr>
                <p:cNvPr id="47" name="TextBox 11 4">
                  <a:extLst>
                    <a:ext uri="{FF2B5EF4-FFF2-40B4-BE49-F238E27FC236}">
                      <a16:creationId xmlns:a16="http://schemas.microsoft.com/office/drawing/2014/main" id="{6612B8BE-5B26-3B78-277E-F44D142AECBD}"/>
                    </a:ext>
                  </a:extLst>
                </p:cNvPr>
                <p:cNvSpPr txBox="1"/>
                <p:nvPr/>
              </p:nvSpPr>
              <p:spPr>
                <a:xfrm>
                  <a:off x="847625" y="750678"/>
                  <a:ext cx="171689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>
                  <a:defPPr>
                    <a:defRPr lang="en-IL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700" i="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</a:rPr>
                          <m:t>−</m:t>
                        </m:r>
                        <m:r>
                          <m:rPr>
                            <m:sty m:val="p"/>
                          </m:rPr>
                          <a:rPr lang="en-US" sz="700" i="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</a:rPr>
                          <m:t>π</m:t>
                        </m:r>
                      </m:oMath>
                    </m:oMathPara>
                  </a14:m>
                  <a:endParaRPr lang="en-IL" sz="700" dirty="0">
                    <a:solidFill>
                      <a:schemeClr val="bg1"/>
                    </a:solidFill>
                    <a:latin typeface="Symbol" panose="05050102010706020507" pitchFamily="18" charset="2"/>
                  </a:endParaRPr>
                </a:p>
              </p:txBody>
            </p:sp>
          </mc:Choice>
          <mc:Fallback>
            <p:sp>
              <p:nvSpPr>
                <p:cNvPr id="47" name="TextBox 11 4">
                  <a:extLst>
                    <a:ext uri="{FF2B5EF4-FFF2-40B4-BE49-F238E27FC236}">
                      <a16:creationId xmlns:a16="http://schemas.microsoft.com/office/drawing/2014/main" id="{6612B8BE-5B26-3B78-277E-F44D142AECBD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847625" y="750678"/>
                  <a:ext cx="171689" cy="200055"/>
                </a:xfrm>
                <a:prstGeom prst="rect">
                  <a:avLst/>
                </a:prstGeom>
                <a:blipFill>
                  <a:blip r:embed="rId50"/>
                  <a:stretch>
                    <a:fillRect l="-3571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0" name="TextBox 11 5">
                  <a:extLst>
                    <a:ext uri="{FF2B5EF4-FFF2-40B4-BE49-F238E27FC236}">
                      <a16:creationId xmlns:a16="http://schemas.microsoft.com/office/drawing/2014/main" id="{B36BDEAF-10A3-D97C-27C6-83639541890B}"/>
                    </a:ext>
                  </a:extLst>
                </p:cNvPr>
                <p:cNvSpPr txBox="1"/>
                <p:nvPr/>
              </p:nvSpPr>
              <p:spPr>
                <a:xfrm>
                  <a:off x="847625" y="115933"/>
                  <a:ext cx="171689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>
                  <a:defPPr>
                    <a:defRPr lang="en-IL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700" i="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</a:rPr>
                          <m:t>+</m:t>
                        </m:r>
                        <m:r>
                          <m:rPr>
                            <m:sty m:val="p"/>
                          </m:rPr>
                          <a:rPr lang="en-US" sz="700" i="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</a:rPr>
                          <m:t>π</m:t>
                        </m:r>
                      </m:oMath>
                    </m:oMathPara>
                  </a14:m>
                  <a:endParaRPr lang="en-IL" sz="700" dirty="0">
                    <a:solidFill>
                      <a:schemeClr val="bg1"/>
                    </a:solidFill>
                  </a:endParaRPr>
                </a:p>
              </p:txBody>
            </p:sp>
          </mc:Choice>
          <mc:Fallback>
            <p:sp>
              <p:nvSpPr>
                <p:cNvPr id="50" name="TextBox 11 5">
                  <a:extLst>
                    <a:ext uri="{FF2B5EF4-FFF2-40B4-BE49-F238E27FC236}">
                      <a16:creationId xmlns:a16="http://schemas.microsoft.com/office/drawing/2014/main" id="{B36BDEAF-10A3-D97C-27C6-83639541890B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847625" y="115933"/>
                  <a:ext cx="171689" cy="200055"/>
                </a:xfrm>
                <a:prstGeom prst="rect">
                  <a:avLst/>
                </a:prstGeom>
                <a:blipFill>
                  <a:blip r:embed="rId51"/>
                  <a:stretch>
                    <a:fillRect l="-7143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grpSp>
          <p:nvGrpSpPr>
            <p:cNvPr id="1217" name="Group 1216">
              <a:extLst>
                <a:ext uri="{FF2B5EF4-FFF2-40B4-BE49-F238E27FC236}">
                  <a16:creationId xmlns:a16="http://schemas.microsoft.com/office/drawing/2014/main" id="{7A4363C0-457A-5ACC-AA9B-6877FFC0EBB1}"/>
                </a:ext>
              </a:extLst>
            </p:cNvPr>
            <p:cNvGrpSpPr/>
            <p:nvPr/>
          </p:nvGrpSpPr>
          <p:grpSpPr>
            <a:xfrm>
              <a:off x="5058590" y="53062"/>
              <a:ext cx="1260000" cy="1190183"/>
              <a:chOff x="6518367" y="11215"/>
              <a:chExt cx="1260000" cy="1190183"/>
            </a:xfrm>
          </p:grpSpPr>
          <p:sp>
            <p:nvSpPr>
              <p:cNvPr id="1157" name="Rectangle 75">
                <a:extLst>
                  <a:ext uri="{FF2B5EF4-FFF2-40B4-BE49-F238E27FC236}">
                    <a16:creationId xmlns:a16="http://schemas.microsoft.com/office/drawing/2014/main" id="{5AB7DF5F-B31E-3EC5-E5FA-569DF4E1EF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83804" y="11215"/>
                <a:ext cx="994563" cy="995222"/>
              </a:xfrm>
              <a:prstGeom prst="rect">
                <a:avLst/>
              </a:prstGeom>
              <a:solidFill>
                <a:srgbClr val="EAEA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8" name="Line 76">
                <a:extLst>
                  <a:ext uri="{FF2B5EF4-FFF2-40B4-BE49-F238E27FC236}">
                    <a16:creationId xmlns:a16="http://schemas.microsoft.com/office/drawing/2014/main" id="{F1404540-134A-9A87-9B50-D3D65C7CAC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829250" y="11215"/>
                <a:ext cx="0" cy="995222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9" name="Freeform 77">
                <a:extLst>
                  <a:ext uri="{FF2B5EF4-FFF2-40B4-BE49-F238E27FC236}">
                    <a16:creationId xmlns:a16="http://schemas.microsoft.com/office/drawing/2014/main" id="{FE09518C-DFB9-F061-F4F7-6C626B59BDF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810150" y="1043321"/>
                <a:ext cx="38202" cy="56644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0" name="Line 78">
                <a:extLst>
                  <a:ext uri="{FF2B5EF4-FFF2-40B4-BE49-F238E27FC236}">
                    <a16:creationId xmlns:a16="http://schemas.microsoft.com/office/drawing/2014/main" id="{8FD0DFC9-9F84-D153-EC89-3FDAF50223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151989" y="11215"/>
                <a:ext cx="0" cy="995222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1" name="Freeform 79">
                <a:extLst>
                  <a:ext uri="{FF2B5EF4-FFF2-40B4-BE49-F238E27FC236}">
                    <a16:creationId xmlns:a16="http://schemas.microsoft.com/office/drawing/2014/main" id="{EE888256-F308-3F9D-5ADC-B3292205D94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10495" y="1043980"/>
                <a:ext cx="34909" cy="55986"/>
              </a:xfrm>
              <a:custGeom>
                <a:avLst/>
                <a:gdLst>
                  <a:gd name="T0" fmla="*/ 31 w 472"/>
                  <a:gd name="T1" fmla="*/ 0 h 742"/>
                  <a:gd name="T2" fmla="*/ 418 w 472"/>
                  <a:gd name="T3" fmla="*/ 0 h 742"/>
                  <a:gd name="T4" fmla="*/ 418 w 472"/>
                  <a:gd name="T5" fmla="*/ 83 h 742"/>
                  <a:gd name="T6" fmla="*/ 121 w 472"/>
                  <a:gd name="T7" fmla="*/ 83 h 742"/>
                  <a:gd name="T8" fmla="*/ 121 w 472"/>
                  <a:gd name="T9" fmla="*/ 262 h 742"/>
                  <a:gd name="T10" fmla="*/ 164 w 472"/>
                  <a:gd name="T11" fmla="*/ 251 h 742"/>
                  <a:gd name="T12" fmla="*/ 207 w 472"/>
                  <a:gd name="T13" fmla="*/ 247 h 742"/>
                  <a:gd name="T14" fmla="*/ 400 w 472"/>
                  <a:gd name="T15" fmla="*/ 314 h 742"/>
                  <a:gd name="T16" fmla="*/ 472 w 472"/>
                  <a:gd name="T17" fmla="*/ 495 h 742"/>
                  <a:gd name="T18" fmla="*/ 398 w 472"/>
                  <a:gd name="T19" fmla="*/ 678 h 742"/>
                  <a:gd name="T20" fmla="*/ 192 w 472"/>
                  <a:gd name="T21" fmla="*/ 742 h 742"/>
                  <a:gd name="T22" fmla="*/ 98 w 472"/>
                  <a:gd name="T23" fmla="*/ 735 h 742"/>
                  <a:gd name="T24" fmla="*/ 0 w 472"/>
                  <a:gd name="T25" fmla="*/ 712 h 742"/>
                  <a:gd name="T26" fmla="*/ 0 w 472"/>
                  <a:gd name="T27" fmla="*/ 613 h 742"/>
                  <a:gd name="T28" fmla="*/ 91 w 472"/>
                  <a:gd name="T29" fmla="*/ 649 h 742"/>
                  <a:gd name="T30" fmla="*/ 190 w 472"/>
                  <a:gd name="T31" fmla="*/ 660 h 742"/>
                  <a:gd name="T32" fmla="*/ 324 w 472"/>
                  <a:gd name="T33" fmla="*/ 616 h 742"/>
                  <a:gd name="T34" fmla="*/ 373 w 472"/>
                  <a:gd name="T35" fmla="*/ 495 h 742"/>
                  <a:gd name="T36" fmla="*/ 324 w 472"/>
                  <a:gd name="T37" fmla="*/ 375 h 742"/>
                  <a:gd name="T38" fmla="*/ 190 w 472"/>
                  <a:gd name="T39" fmla="*/ 330 h 742"/>
                  <a:gd name="T40" fmla="*/ 111 w 472"/>
                  <a:gd name="T41" fmla="*/ 339 h 742"/>
                  <a:gd name="T42" fmla="*/ 31 w 472"/>
                  <a:gd name="T43" fmla="*/ 366 h 742"/>
                  <a:gd name="T44" fmla="*/ 31 w 472"/>
                  <a:gd name="T45" fmla="*/ 0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72" h="742">
                    <a:moveTo>
                      <a:pt x="31" y="0"/>
                    </a:moveTo>
                    <a:lnTo>
                      <a:pt x="418" y="0"/>
                    </a:lnTo>
                    <a:lnTo>
                      <a:pt x="418" y="83"/>
                    </a:lnTo>
                    <a:lnTo>
                      <a:pt x="121" y="83"/>
                    </a:lnTo>
                    <a:lnTo>
                      <a:pt x="121" y="262"/>
                    </a:lnTo>
                    <a:cubicBezTo>
                      <a:pt x="135" y="257"/>
                      <a:pt x="150" y="253"/>
                      <a:pt x="164" y="251"/>
                    </a:cubicBezTo>
                    <a:cubicBezTo>
                      <a:pt x="178" y="249"/>
                      <a:pt x="193" y="247"/>
                      <a:pt x="207" y="247"/>
                    </a:cubicBezTo>
                    <a:cubicBezTo>
                      <a:pt x="288" y="247"/>
                      <a:pt x="352" y="270"/>
                      <a:pt x="400" y="314"/>
                    </a:cubicBezTo>
                    <a:cubicBezTo>
                      <a:pt x="448" y="359"/>
                      <a:pt x="472" y="419"/>
                      <a:pt x="472" y="495"/>
                    </a:cubicBezTo>
                    <a:cubicBezTo>
                      <a:pt x="472" y="574"/>
                      <a:pt x="447" y="635"/>
                      <a:pt x="398" y="678"/>
                    </a:cubicBezTo>
                    <a:cubicBezTo>
                      <a:pt x="349" y="721"/>
                      <a:pt x="280" y="742"/>
                      <a:pt x="192" y="742"/>
                    </a:cubicBezTo>
                    <a:cubicBezTo>
                      <a:pt x="161" y="742"/>
                      <a:pt x="130" y="739"/>
                      <a:pt x="98" y="735"/>
                    </a:cubicBezTo>
                    <a:cubicBezTo>
                      <a:pt x="66" y="730"/>
                      <a:pt x="34" y="723"/>
                      <a:pt x="0" y="712"/>
                    </a:cubicBezTo>
                    <a:lnTo>
                      <a:pt x="0" y="613"/>
                    </a:lnTo>
                    <a:cubicBezTo>
                      <a:pt x="29" y="629"/>
                      <a:pt x="59" y="641"/>
                      <a:pt x="91" y="649"/>
                    </a:cubicBezTo>
                    <a:cubicBezTo>
                      <a:pt x="122" y="657"/>
                      <a:pt x="155" y="660"/>
                      <a:pt x="190" y="660"/>
                    </a:cubicBezTo>
                    <a:cubicBezTo>
                      <a:pt x="246" y="660"/>
                      <a:pt x="291" y="646"/>
                      <a:pt x="324" y="616"/>
                    </a:cubicBezTo>
                    <a:cubicBezTo>
                      <a:pt x="356" y="586"/>
                      <a:pt x="373" y="546"/>
                      <a:pt x="373" y="495"/>
                    </a:cubicBezTo>
                    <a:cubicBezTo>
                      <a:pt x="373" y="445"/>
                      <a:pt x="356" y="405"/>
                      <a:pt x="324" y="375"/>
                    </a:cubicBezTo>
                    <a:cubicBezTo>
                      <a:pt x="291" y="345"/>
                      <a:pt x="246" y="330"/>
                      <a:pt x="190" y="330"/>
                    </a:cubicBezTo>
                    <a:cubicBezTo>
                      <a:pt x="164" y="330"/>
                      <a:pt x="137" y="333"/>
                      <a:pt x="111" y="339"/>
                    </a:cubicBezTo>
                    <a:cubicBezTo>
                      <a:pt x="85" y="345"/>
                      <a:pt x="58" y="354"/>
                      <a:pt x="31" y="366"/>
                    </a:cubicBezTo>
                    <a:lnTo>
                      <a:pt x="31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2" name="Freeform 80">
                <a:extLst>
                  <a:ext uri="{FF2B5EF4-FFF2-40B4-BE49-F238E27FC236}">
                    <a16:creationId xmlns:a16="http://schemas.microsoft.com/office/drawing/2014/main" id="{06F0432B-1123-92F1-1E0F-0A3D8F919E0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157259" y="1043321"/>
                <a:ext cx="37543" cy="56644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3" name="Line 81">
                <a:extLst>
                  <a:ext uri="{FF2B5EF4-FFF2-40B4-BE49-F238E27FC236}">
                    <a16:creationId xmlns:a16="http://schemas.microsoft.com/office/drawing/2014/main" id="{7DEEA630-DE93-6645-E2B5-2B5A267F78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474729" y="11215"/>
                <a:ext cx="0" cy="995222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4" name="Freeform 82">
                <a:extLst>
                  <a:ext uri="{FF2B5EF4-FFF2-40B4-BE49-F238E27FC236}">
                    <a16:creationId xmlns:a16="http://schemas.microsoft.com/office/drawing/2014/main" id="{266C92C2-FF2B-85B5-A062-8A236556913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12157" y="1043980"/>
                <a:ext cx="32274" cy="54668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5" name="Freeform 83">
                <a:extLst>
                  <a:ext uri="{FF2B5EF4-FFF2-40B4-BE49-F238E27FC236}">
                    <a16:creationId xmlns:a16="http://schemas.microsoft.com/office/drawing/2014/main" id="{669B00A2-C0CE-2CD8-D981-251822BE9EE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456286" y="1043321"/>
                <a:ext cx="37543" cy="56644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6" name="Freeform 84">
                <a:extLst>
                  <a:ext uri="{FF2B5EF4-FFF2-40B4-BE49-F238E27FC236}">
                    <a16:creationId xmlns:a16="http://schemas.microsoft.com/office/drawing/2014/main" id="{4E3132C0-A0B5-0CB5-CD98-D6F90EDA75E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503709" y="1043321"/>
                <a:ext cx="37543" cy="56644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7" name="Freeform 85">
                <a:extLst>
                  <a:ext uri="{FF2B5EF4-FFF2-40B4-BE49-F238E27FC236}">
                    <a16:creationId xmlns:a16="http://schemas.microsoft.com/office/drawing/2014/main" id="{5371B0BD-38BD-FB93-FE98-29588622C8F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80855" y="1131581"/>
                <a:ext cx="30957" cy="54668"/>
              </a:xfrm>
              <a:custGeom>
                <a:avLst/>
                <a:gdLst>
                  <a:gd name="T0" fmla="*/ 0 w 419"/>
                  <a:gd name="T1" fmla="*/ 0 h 729"/>
                  <a:gd name="T2" fmla="*/ 419 w 419"/>
                  <a:gd name="T3" fmla="*/ 0 h 729"/>
                  <a:gd name="T4" fmla="*/ 419 w 419"/>
                  <a:gd name="T5" fmla="*/ 83 h 729"/>
                  <a:gd name="T6" fmla="*/ 99 w 419"/>
                  <a:gd name="T7" fmla="*/ 83 h 729"/>
                  <a:gd name="T8" fmla="*/ 99 w 419"/>
                  <a:gd name="T9" fmla="*/ 298 h 729"/>
                  <a:gd name="T10" fmla="*/ 388 w 419"/>
                  <a:gd name="T11" fmla="*/ 298 h 729"/>
                  <a:gd name="T12" fmla="*/ 388 w 419"/>
                  <a:gd name="T13" fmla="*/ 381 h 729"/>
                  <a:gd name="T14" fmla="*/ 99 w 419"/>
                  <a:gd name="T15" fmla="*/ 381 h 729"/>
                  <a:gd name="T16" fmla="*/ 99 w 419"/>
                  <a:gd name="T17" fmla="*/ 729 h 729"/>
                  <a:gd name="T18" fmla="*/ 0 w 419"/>
                  <a:gd name="T19" fmla="*/ 729 h 729"/>
                  <a:gd name="T20" fmla="*/ 0 w 419"/>
                  <a:gd name="T21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419" h="729">
                    <a:moveTo>
                      <a:pt x="0" y="0"/>
                    </a:moveTo>
                    <a:lnTo>
                      <a:pt x="419" y="0"/>
                    </a:lnTo>
                    <a:lnTo>
                      <a:pt x="419" y="83"/>
                    </a:lnTo>
                    <a:lnTo>
                      <a:pt x="99" y="83"/>
                    </a:lnTo>
                    <a:lnTo>
                      <a:pt x="99" y="298"/>
                    </a:lnTo>
                    <a:lnTo>
                      <a:pt x="388" y="298"/>
                    </a:lnTo>
                    <a:lnTo>
                      <a:pt x="388" y="381"/>
                    </a:lnTo>
                    <a:lnTo>
                      <a:pt x="99" y="381"/>
                    </a:lnTo>
                    <a:lnTo>
                      <a:pt x="99" y="729"/>
                    </a:lnTo>
                    <a:lnTo>
                      <a:pt x="0" y="729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8" name="Freeform 86">
                <a:extLst>
                  <a:ext uri="{FF2B5EF4-FFF2-40B4-BE49-F238E27FC236}">
                    <a16:creationId xmlns:a16="http://schemas.microsoft.com/office/drawing/2014/main" id="{03EE6193-0A7C-28A6-7D30-F6F586A4F8A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117740" y="1144095"/>
                <a:ext cx="37543" cy="42813"/>
              </a:xfrm>
              <a:custGeom>
                <a:avLst/>
                <a:gdLst>
                  <a:gd name="T0" fmla="*/ 251 w 502"/>
                  <a:gd name="T1" fmla="*/ 76 h 573"/>
                  <a:gd name="T2" fmla="*/ 137 w 502"/>
                  <a:gd name="T3" fmla="*/ 133 h 573"/>
                  <a:gd name="T4" fmla="*/ 95 w 502"/>
                  <a:gd name="T5" fmla="*/ 287 h 573"/>
                  <a:gd name="T6" fmla="*/ 136 w 502"/>
                  <a:gd name="T7" fmla="*/ 442 h 573"/>
                  <a:gd name="T8" fmla="*/ 251 w 502"/>
                  <a:gd name="T9" fmla="*/ 498 h 573"/>
                  <a:gd name="T10" fmla="*/ 365 w 502"/>
                  <a:gd name="T11" fmla="*/ 442 h 573"/>
                  <a:gd name="T12" fmla="*/ 407 w 502"/>
                  <a:gd name="T13" fmla="*/ 287 h 573"/>
                  <a:gd name="T14" fmla="*/ 365 w 502"/>
                  <a:gd name="T15" fmla="*/ 133 h 573"/>
                  <a:gd name="T16" fmla="*/ 251 w 502"/>
                  <a:gd name="T17" fmla="*/ 76 h 573"/>
                  <a:gd name="T18" fmla="*/ 251 w 502"/>
                  <a:gd name="T19" fmla="*/ 0 h 573"/>
                  <a:gd name="T20" fmla="*/ 435 w 502"/>
                  <a:gd name="T21" fmla="*/ 76 h 573"/>
                  <a:gd name="T22" fmla="*/ 502 w 502"/>
                  <a:gd name="T23" fmla="*/ 287 h 573"/>
                  <a:gd name="T24" fmla="*/ 435 w 502"/>
                  <a:gd name="T25" fmla="*/ 497 h 573"/>
                  <a:gd name="T26" fmla="*/ 251 w 502"/>
                  <a:gd name="T27" fmla="*/ 573 h 573"/>
                  <a:gd name="T28" fmla="*/ 66 w 502"/>
                  <a:gd name="T29" fmla="*/ 497 h 573"/>
                  <a:gd name="T30" fmla="*/ 0 w 502"/>
                  <a:gd name="T31" fmla="*/ 287 h 573"/>
                  <a:gd name="T32" fmla="*/ 66 w 502"/>
                  <a:gd name="T33" fmla="*/ 76 h 573"/>
                  <a:gd name="T34" fmla="*/ 251 w 502"/>
                  <a:gd name="T35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2" h="573">
                    <a:moveTo>
                      <a:pt x="251" y="76"/>
                    </a:moveTo>
                    <a:cubicBezTo>
                      <a:pt x="203" y="76"/>
                      <a:pt x="165" y="95"/>
                      <a:pt x="137" y="133"/>
                    </a:cubicBezTo>
                    <a:cubicBezTo>
                      <a:pt x="109" y="171"/>
                      <a:pt x="95" y="222"/>
                      <a:pt x="95" y="287"/>
                    </a:cubicBezTo>
                    <a:cubicBezTo>
                      <a:pt x="95" y="353"/>
                      <a:pt x="108" y="404"/>
                      <a:pt x="136" y="442"/>
                    </a:cubicBezTo>
                    <a:cubicBezTo>
                      <a:pt x="164" y="480"/>
                      <a:pt x="202" y="498"/>
                      <a:pt x="251" y="498"/>
                    </a:cubicBezTo>
                    <a:cubicBezTo>
                      <a:pt x="299" y="498"/>
                      <a:pt x="337" y="480"/>
                      <a:pt x="365" y="442"/>
                    </a:cubicBezTo>
                    <a:cubicBezTo>
                      <a:pt x="393" y="404"/>
                      <a:pt x="407" y="353"/>
                      <a:pt x="407" y="287"/>
                    </a:cubicBezTo>
                    <a:cubicBezTo>
                      <a:pt x="407" y="223"/>
                      <a:pt x="393" y="171"/>
                      <a:pt x="365" y="133"/>
                    </a:cubicBezTo>
                    <a:cubicBezTo>
                      <a:pt x="337" y="95"/>
                      <a:pt x="299" y="76"/>
                      <a:pt x="251" y="76"/>
                    </a:cubicBezTo>
                    <a:close/>
                    <a:moveTo>
                      <a:pt x="251" y="0"/>
                    </a:moveTo>
                    <a:cubicBezTo>
                      <a:pt x="329" y="0"/>
                      <a:pt x="390" y="26"/>
                      <a:pt x="435" y="76"/>
                    </a:cubicBezTo>
                    <a:cubicBezTo>
                      <a:pt x="479" y="127"/>
                      <a:pt x="502" y="197"/>
                      <a:pt x="502" y="287"/>
                    </a:cubicBezTo>
                    <a:cubicBezTo>
                      <a:pt x="502" y="377"/>
                      <a:pt x="479" y="447"/>
                      <a:pt x="435" y="497"/>
                    </a:cubicBezTo>
                    <a:cubicBezTo>
                      <a:pt x="390" y="548"/>
                      <a:pt x="329" y="573"/>
                      <a:pt x="251" y="573"/>
                    </a:cubicBezTo>
                    <a:cubicBezTo>
                      <a:pt x="172" y="573"/>
                      <a:pt x="110" y="548"/>
                      <a:pt x="66" y="497"/>
                    </a:cubicBezTo>
                    <a:cubicBezTo>
                      <a:pt x="22" y="447"/>
                      <a:pt x="0" y="377"/>
                      <a:pt x="0" y="287"/>
                    </a:cubicBezTo>
                    <a:cubicBezTo>
                      <a:pt x="0" y="197"/>
                      <a:pt x="22" y="127"/>
                      <a:pt x="66" y="76"/>
                    </a:cubicBezTo>
                    <a:cubicBezTo>
                      <a:pt x="110" y="26"/>
                      <a:pt x="172" y="0"/>
                      <a:pt x="251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9" name="Freeform 87">
                <a:extLst>
                  <a:ext uri="{FF2B5EF4-FFF2-40B4-BE49-F238E27FC236}">
                    <a16:creationId xmlns:a16="http://schemas.microsoft.com/office/drawing/2014/main" id="{039797DE-3B4E-CE7F-05D8-56FD5BB6B84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63187" y="1144095"/>
                <a:ext cx="32933" cy="42813"/>
              </a:xfrm>
              <a:custGeom>
                <a:avLst/>
                <a:gdLst>
                  <a:gd name="T0" fmla="*/ 433 w 433"/>
                  <a:gd name="T1" fmla="*/ 34 h 573"/>
                  <a:gd name="T2" fmla="*/ 433 w 433"/>
                  <a:gd name="T3" fmla="*/ 118 h 573"/>
                  <a:gd name="T4" fmla="*/ 356 w 433"/>
                  <a:gd name="T5" fmla="*/ 87 h 573"/>
                  <a:gd name="T6" fmla="*/ 279 w 433"/>
                  <a:gd name="T7" fmla="*/ 76 h 573"/>
                  <a:gd name="T8" fmla="*/ 143 w 433"/>
                  <a:gd name="T9" fmla="*/ 132 h 573"/>
                  <a:gd name="T10" fmla="*/ 95 w 433"/>
                  <a:gd name="T11" fmla="*/ 287 h 573"/>
                  <a:gd name="T12" fmla="*/ 143 w 433"/>
                  <a:gd name="T13" fmla="*/ 443 h 573"/>
                  <a:gd name="T14" fmla="*/ 279 w 433"/>
                  <a:gd name="T15" fmla="*/ 498 h 573"/>
                  <a:gd name="T16" fmla="*/ 356 w 433"/>
                  <a:gd name="T17" fmla="*/ 488 h 573"/>
                  <a:gd name="T18" fmla="*/ 433 w 433"/>
                  <a:gd name="T19" fmla="*/ 456 h 573"/>
                  <a:gd name="T20" fmla="*/ 433 w 433"/>
                  <a:gd name="T21" fmla="*/ 539 h 573"/>
                  <a:gd name="T22" fmla="*/ 355 w 433"/>
                  <a:gd name="T23" fmla="*/ 565 h 573"/>
                  <a:gd name="T24" fmla="*/ 269 w 433"/>
                  <a:gd name="T25" fmla="*/ 573 h 573"/>
                  <a:gd name="T26" fmla="*/ 73 w 433"/>
                  <a:gd name="T27" fmla="*/ 496 h 573"/>
                  <a:gd name="T28" fmla="*/ 0 w 433"/>
                  <a:gd name="T29" fmla="*/ 287 h 573"/>
                  <a:gd name="T30" fmla="*/ 73 w 433"/>
                  <a:gd name="T31" fmla="*/ 77 h 573"/>
                  <a:gd name="T32" fmla="*/ 275 w 433"/>
                  <a:gd name="T33" fmla="*/ 0 h 573"/>
                  <a:gd name="T34" fmla="*/ 356 w 433"/>
                  <a:gd name="T35" fmla="*/ 9 h 573"/>
                  <a:gd name="T36" fmla="*/ 433 w 433"/>
                  <a:gd name="T37" fmla="*/ 34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433" h="573">
                    <a:moveTo>
                      <a:pt x="433" y="34"/>
                    </a:moveTo>
                    <a:lnTo>
                      <a:pt x="433" y="118"/>
                    </a:lnTo>
                    <a:cubicBezTo>
                      <a:pt x="407" y="104"/>
                      <a:pt x="382" y="94"/>
                      <a:pt x="356" y="87"/>
                    </a:cubicBezTo>
                    <a:cubicBezTo>
                      <a:pt x="330" y="80"/>
                      <a:pt x="305" y="76"/>
                      <a:pt x="279" y="76"/>
                    </a:cubicBezTo>
                    <a:cubicBezTo>
                      <a:pt x="221" y="76"/>
                      <a:pt x="175" y="95"/>
                      <a:pt x="143" y="132"/>
                    </a:cubicBezTo>
                    <a:cubicBezTo>
                      <a:pt x="111" y="169"/>
                      <a:pt x="95" y="221"/>
                      <a:pt x="95" y="287"/>
                    </a:cubicBezTo>
                    <a:cubicBezTo>
                      <a:pt x="95" y="354"/>
                      <a:pt x="111" y="406"/>
                      <a:pt x="143" y="443"/>
                    </a:cubicBezTo>
                    <a:cubicBezTo>
                      <a:pt x="175" y="480"/>
                      <a:pt x="221" y="498"/>
                      <a:pt x="279" y="498"/>
                    </a:cubicBezTo>
                    <a:cubicBezTo>
                      <a:pt x="305" y="498"/>
                      <a:pt x="330" y="495"/>
                      <a:pt x="356" y="488"/>
                    </a:cubicBezTo>
                    <a:cubicBezTo>
                      <a:pt x="382" y="481"/>
                      <a:pt x="407" y="470"/>
                      <a:pt x="433" y="456"/>
                    </a:cubicBezTo>
                    <a:lnTo>
                      <a:pt x="433" y="539"/>
                    </a:lnTo>
                    <a:cubicBezTo>
                      <a:pt x="407" y="551"/>
                      <a:pt x="381" y="560"/>
                      <a:pt x="355" y="565"/>
                    </a:cubicBezTo>
                    <a:cubicBezTo>
                      <a:pt x="328" y="570"/>
                      <a:pt x="299" y="573"/>
                      <a:pt x="269" y="573"/>
                    </a:cubicBezTo>
                    <a:cubicBezTo>
                      <a:pt x="187" y="573"/>
                      <a:pt x="121" y="548"/>
                      <a:pt x="73" y="496"/>
                    </a:cubicBezTo>
                    <a:cubicBezTo>
                      <a:pt x="24" y="445"/>
                      <a:pt x="0" y="375"/>
                      <a:pt x="0" y="287"/>
                    </a:cubicBezTo>
                    <a:cubicBezTo>
                      <a:pt x="0" y="198"/>
                      <a:pt x="24" y="128"/>
                      <a:pt x="73" y="77"/>
                    </a:cubicBezTo>
                    <a:cubicBezTo>
                      <a:pt x="122" y="26"/>
                      <a:pt x="189" y="0"/>
                      <a:pt x="275" y="0"/>
                    </a:cubicBezTo>
                    <a:cubicBezTo>
                      <a:pt x="303" y="0"/>
                      <a:pt x="330" y="3"/>
                      <a:pt x="356" y="9"/>
                    </a:cubicBezTo>
                    <a:cubicBezTo>
                      <a:pt x="382" y="15"/>
                      <a:pt x="408" y="23"/>
                      <a:pt x="433" y="34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0" name="Freeform 88">
                <a:extLst>
                  <a:ext uri="{FF2B5EF4-FFF2-40B4-BE49-F238E27FC236}">
                    <a16:creationId xmlns:a16="http://schemas.microsoft.com/office/drawing/2014/main" id="{03B95C2B-E173-85D5-236E-D17214AE3C8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206658" y="1144095"/>
                <a:ext cx="34250" cy="42813"/>
              </a:xfrm>
              <a:custGeom>
                <a:avLst/>
                <a:gdLst>
                  <a:gd name="T0" fmla="*/ 0 w 458"/>
                  <a:gd name="T1" fmla="*/ 344 h 573"/>
                  <a:gd name="T2" fmla="*/ 0 w 458"/>
                  <a:gd name="T3" fmla="*/ 13 h 573"/>
                  <a:gd name="T4" fmla="*/ 90 w 458"/>
                  <a:gd name="T5" fmla="*/ 13 h 573"/>
                  <a:gd name="T6" fmla="*/ 90 w 458"/>
                  <a:gd name="T7" fmla="*/ 341 h 573"/>
                  <a:gd name="T8" fmla="*/ 120 w 458"/>
                  <a:gd name="T9" fmla="*/ 457 h 573"/>
                  <a:gd name="T10" fmla="*/ 211 w 458"/>
                  <a:gd name="T11" fmla="*/ 496 h 573"/>
                  <a:gd name="T12" fmla="*/ 326 w 458"/>
                  <a:gd name="T13" fmla="*/ 450 h 573"/>
                  <a:gd name="T14" fmla="*/ 368 w 458"/>
                  <a:gd name="T15" fmla="*/ 323 h 573"/>
                  <a:gd name="T16" fmla="*/ 368 w 458"/>
                  <a:gd name="T17" fmla="*/ 13 h 573"/>
                  <a:gd name="T18" fmla="*/ 458 w 458"/>
                  <a:gd name="T19" fmla="*/ 13 h 573"/>
                  <a:gd name="T20" fmla="*/ 458 w 458"/>
                  <a:gd name="T21" fmla="*/ 560 h 573"/>
                  <a:gd name="T22" fmla="*/ 368 w 458"/>
                  <a:gd name="T23" fmla="*/ 560 h 573"/>
                  <a:gd name="T24" fmla="*/ 368 w 458"/>
                  <a:gd name="T25" fmla="*/ 476 h 573"/>
                  <a:gd name="T26" fmla="*/ 292 w 458"/>
                  <a:gd name="T27" fmla="*/ 550 h 573"/>
                  <a:gd name="T28" fmla="*/ 192 w 458"/>
                  <a:gd name="T29" fmla="*/ 573 h 573"/>
                  <a:gd name="T30" fmla="*/ 49 w 458"/>
                  <a:gd name="T31" fmla="*/ 515 h 573"/>
                  <a:gd name="T32" fmla="*/ 0 w 458"/>
                  <a:gd name="T33" fmla="*/ 344 h 573"/>
                  <a:gd name="T34" fmla="*/ 226 w 458"/>
                  <a:gd name="T35" fmla="*/ 0 h 573"/>
                  <a:gd name="T36" fmla="*/ 227 w 458"/>
                  <a:gd name="T37" fmla="*/ 0 h 573"/>
                  <a:gd name="T38" fmla="*/ 226 w 458"/>
                  <a:gd name="T39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458" h="573">
                    <a:moveTo>
                      <a:pt x="0" y="344"/>
                    </a:moveTo>
                    <a:lnTo>
                      <a:pt x="0" y="13"/>
                    </a:lnTo>
                    <a:lnTo>
                      <a:pt x="90" y="13"/>
                    </a:lnTo>
                    <a:lnTo>
                      <a:pt x="90" y="341"/>
                    </a:lnTo>
                    <a:cubicBezTo>
                      <a:pt x="90" y="393"/>
                      <a:pt x="100" y="431"/>
                      <a:pt x="120" y="457"/>
                    </a:cubicBezTo>
                    <a:cubicBezTo>
                      <a:pt x="140" y="483"/>
                      <a:pt x="170" y="496"/>
                      <a:pt x="211" y="496"/>
                    </a:cubicBezTo>
                    <a:cubicBezTo>
                      <a:pt x="259" y="496"/>
                      <a:pt x="298" y="481"/>
                      <a:pt x="326" y="450"/>
                    </a:cubicBezTo>
                    <a:cubicBezTo>
                      <a:pt x="354" y="419"/>
                      <a:pt x="368" y="377"/>
                      <a:pt x="368" y="323"/>
                    </a:cubicBezTo>
                    <a:lnTo>
                      <a:pt x="368" y="13"/>
                    </a:lnTo>
                    <a:lnTo>
                      <a:pt x="458" y="13"/>
                    </a:ln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476"/>
                    </a:lnTo>
                    <a:cubicBezTo>
                      <a:pt x="346" y="510"/>
                      <a:pt x="320" y="534"/>
                      <a:pt x="292" y="550"/>
                    </a:cubicBezTo>
                    <a:cubicBezTo>
                      <a:pt x="263" y="565"/>
                      <a:pt x="230" y="573"/>
                      <a:pt x="192" y="573"/>
                    </a:cubicBezTo>
                    <a:cubicBezTo>
                      <a:pt x="129" y="573"/>
                      <a:pt x="81" y="554"/>
                      <a:pt x="49" y="515"/>
                    </a:cubicBezTo>
                    <a:cubicBezTo>
                      <a:pt x="16" y="477"/>
                      <a:pt x="0" y="420"/>
                      <a:pt x="0" y="344"/>
                    </a:cubicBezTo>
                    <a:close/>
                    <a:moveTo>
                      <a:pt x="226" y="0"/>
                    </a:moveTo>
                    <a:lnTo>
                      <a:pt x="227" y="0"/>
                    </a:lnTo>
                    <a:lnTo>
                      <a:pt x="226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1" name="Freeform 89">
                <a:extLst>
                  <a:ext uri="{FF2B5EF4-FFF2-40B4-BE49-F238E27FC236}">
                    <a16:creationId xmlns:a16="http://schemas.microsoft.com/office/drawing/2014/main" id="{57A95E53-57F9-9980-5331-BBA15A4BC8C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52104" y="1144095"/>
                <a:ext cx="30957" cy="42813"/>
              </a:xfrm>
              <a:custGeom>
                <a:avLst/>
                <a:gdLst>
                  <a:gd name="T0" fmla="*/ 389 w 418"/>
                  <a:gd name="T1" fmla="*/ 29 h 573"/>
                  <a:gd name="T2" fmla="*/ 389 w 418"/>
                  <a:gd name="T3" fmla="*/ 114 h 573"/>
                  <a:gd name="T4" fmla="*/ 310 w 418"/>
                  <a:gd name="T5" fmla="*/ 85 h 573"/>
                  <a:gd name="T6" fmla="*/ 225 w 418"/>
                  <a:gd name="T7" fmla="*/ 75 h 573"/>
                  <a:gd name="T8" fmla="*/ 124 w 418"/>
                  <a:gd name="T9" fmla="*/ 96 h 573"/>
                  <a:gd name="T10" fmla="*/ 91 w 418"/>
                  <a:gd name="T11" fmla="*/ 157 h 573"/>
                  <a:gd name="T12" fmla="*/ 115 w 418"/>
                  <a:gd name="T13" fmla="*/ 206 h 573"/>
                  <a:gd name="T14" fmla="*/ 211 w 418"/>
                  <a:gd name="T15" fmla="*/ 240 h 573"/>
                  <a:gd name="T16" fmla="*/ 242 w 418"/>
                  <a:gd name="T17" fmla="*/ 247 h 573"/>
                  <a:gd name="T18" fmla="*/ 378 w 418"/>
                  <a:gd name="T19" fmla="*/ 305 h 573"/>
                  <a:gd name="T20" fmla="*/ 418 w 418"/>
                  <a:gd name="T21" fmla="*/ 409 h 573"/>
                  <a:gd name="T22" fmla="*/ 358 w 418"/>
                  <a:gd name="T23" fmla="*/ 529 h 573"/>
                  <a:gd name="T24" fmla="*/ 192 w 418"/>
                  <a:gd name="T25" fmla="*/ 573 h 573"/>
                  <a:gd name="T26" fmla="*/ 100 w 418"/>
                  <a:gd name="T27" fmla="*/ 565 h 573"/>
                  <a:gd name="T28" fmla="*/ 0 w 418"/>
                  <a:gd name="T29" fmla="*/ 540 h 573"/>
                  <a:gd name="T30" fmla="*/ 0 w 418"/>
                  <a:gd name="T31" fmla="*/ 447 h 573"/>
                  <a:gd name="T32" fmla="*/ 98 w 418"/>
                  <a:gd name="T33" fmla="*/ 486 h 573"/>
                  <a:gd name="T34" fmla="*/ 194 w 418"/>
                  <a:gd name="T35" fmla="*/ 499 h 573"/>
                  <a:gd name="T36" fmla="*/ 292 w 418"/>
                  <a:gd name="T37" fmla="*/ 478 h 573"/>
                  <a:gd name="T38" fmla="*/ 326 w 418"/>
                  <a:gd name="T39" fmla="*/ 416 h 573"/>
                  <a:gd name="T40" fmla="*/ 301 w 418"/>
                  <a:gd name="T41" fmla="*/ 360 h 573"/>
                  <a:gd name="T42" fmla="*/ 193 w 418"/>
                  <a:gd name="T43" fmla="*/ 322 h 573"/>
                  <a:gd name="T44" fmla="*/ 162 w 418"/>
                  <a:gd name="T45" fmla="*/ 315 h 573"/>
                  <a:gd name="T46" fmla="*/ 41 w 418"/>
                  <a:gd name="T47" fmla="*/ 261 h 573"/>
                  <a:gd name="T48" fmla="*/ 4 w 418"/>
                  <a:gd name="T49" fmla="*/ 161 h 573"/>
                  <a:gd name="T50" fmla="*/ 58 w 418"/>
                  <a:gd name="T51" fmla="*/ 42 h 573"/>
                  <a:gd name="T52" fmla="*/ 214 w 418"/>
                  <a:gd name="T53" fmla="*/ 0 h 573"/>
                  <a:gd name="T54" fmla="*/ 308 w 418"/>
                  <a:gd name="T55" fmla="*/ 8 h 573"/>
                  <a:gd name="T56" fmla="*/ 389 w 418"/>
                  <a:gd name="T57" fmla="*/ 29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418" h="573">
                    <a:moveTo>
                      <a:pt x="389" y="29"/>
                    </a:moveTo>
                    <a:lnTo>
                      <a:pt x="389" y="114"/>
                    </a:lnTo>
                    <a:cubicBezTo>
                      <a:pt x="363" y="102"/>
                      <a:pt x="337" y="92"/>
                      <a:pt x="310" y="85"/>
                    </a:cubicBezTo>
                    <a:cubicBezTo>
                      <a:pt x="282" y="79"/>
                      <a:pt x="254" y="75"/>
                      <a:pt x="225" y="75"/>
                    </a:cubicBezTo>
                    <a:cubicBezTo>
                      <a:pt x="180" y="75"/>
                      <a:pt x="146" y="82"/>
                      <a:pt x="124" y="96"/>
                    </a:cubicBezTo>
                    <a:cubicBezTo>
                      <a:pt x="102" y="110"/>
                      <a:pt x="91" y="130"/>
                      <a:pt x="91" y="157"/>
                    </a:cubicBezTo>
                    <a:cubicBezTo>
                      <a:pt x="91" y="178"/>
                      <a:pt x="99" y="194"/>
                      <a:pt x="115" y="206"/>
                    </a:cubicBezTo>
                    <a:cubicBezTo>
                      <a:pt x="131" y="218"/>
                      <a:pt x="163" y="230"/>
                      <a:pt x="211" y="240"/>
                    </a:cubicBezTo>
                    <a:lnTo>
                      <a:pt x="242" y="247"/>
                    </a:lnTo>
                    <a:cubicBezTo>
                      <a:pt x="306" y="261"/>
                      <a:pt x="351" y="281"/>
                      <a:pt x="378" y="305"/>
                    </a:cubicBezTo>
                    <a:cubicBezTo>
                      <a:pt x="404" y="330"/>
                      <a:pt x="418" y="365"/>
                      <a:pt x="418" y="409"/>
                    </a:cubicBezTo>
                    <a:cubicBezTo>
                      <a:pt x="418" y="460"/>
                      <a:pt x="398" y="500"/>
                      <a:pt x="358" y="529"/>
                    </a:cubicBezTo>
                    <a:cubicBezTo>
                      <a:pt x="318" y="559"/>
                      <a:pt x="262" y="573"/>
                      <a:pt x="192" y="573"/>
                    </a:cubicBezTo>
                    <a:cubicBezTo>
                      <a:pt x="162" y="573"/>
                      <a:pt x="132" y="570"/>
                      <a:pt x="100" y="565"/>
                    </a:cubicBezTo>
                    <a:cubicBezTo>
                      <a:pt x="68" y="560"/>
                      <a:pt x="35" y="552"/>
                      <a:pt x="0" y="540"/>
                    </a:cubicBezTo>
                    <a:lnTo>
                      <a:pt x="0" y="447"/>
                    </a:lnTo>
                    <a:cubicBezTo>
                      <a:pt x="33" y="465"/>
                      <a:pt x="66" y="478"/>
                      <a:pt x="98" y="486"/>
                    </a:cubicBezTo>
                    <a:cubicBezTo>
                      <a:pt x="130" y="495"/>
                      <a:pt x="162" y="499"/>
                      <a:pt x="194" y="499"/>
                    </a:cubicBezTo>
                    <a:cubicBezTo>
                      <a:pt x="236" y="499"/>
                      <a:pt x="269" y="492"/>
                      <a:pt x="292" y="478"/>
                    </a:cubicBezTo>
                    <a:cubicBezTo>
                      <a:pt x="314" y="464"/>
                      <a:pt x="326" y="443"/>
                      <a:pt x="326" y="416"/>
                    </a:cubicBezTo>
                    <a:cubicBezTo>
                      <a:pt x="326" y="392"/>
                      <a:pt x="317" y="373"/>
                      <a:pt x="301" y="360"/>
                    </a:cubicBezTo>
                    <a:cubicBezTo>
                      <a:pt x="285" y="347"/>
                      <a:pt x="249" y="334"/>
                      <a:pt x="193" y="322"/>
                    </a:cubicBezTo>
                    <a:lnTo>
                      <a:pt x="162" y="315"/>
                    </a:lnTo>
                    <a:cubicBezTo>
                      <a:pt x="106" y="303"/>
                      <a:pt x="65" y="285"/>
                      <a:pt x="41" y="261"/>
                    </a:cubicBezTo>
                    <a:cubicBezTo>
                      <a:pt x="16" y="237"/>
                      <a:pt x="4" y="204"/>
                      <a:pt x="4" y="161"/>
                    </a:cubicBezTo>
                    <a:cubicBezTo>
                      <a:pt x="4" y="110"/>
                      <a:pt x="22" y="70"/>
                      <a:pt x="58" y="42"/>
                    </a:cubicBezTo>
                    <a:cubicBezTo>
                      <a:pt x="94" y="14"/>
                      <a:pt x="146" y="0"/>
                      <a:pt x="214" y="0"/>
                    </a:cubicBezTo>
                    <a:cubicBezTo>
                      <a:pt x="247" y="0"/>
                      <a:pt x="278" y="3"/>
                      <a:pt x="308" y="8"/>
                    </a:cubicBezTo>
                    <a:cubicBezTo>
                      <a:pt x="337" y="13"/>
                      <a:pt x="364" y="20"/>
                      <a:pt x="38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2" name="Freeform 90">
                <a:extLst>
                  <a:ext uri="{FF2B5EF4-FFF2-40B4-BE49-F238E27FC236}">
                    <a16:creationId xmlns:a16="http://schemas.microsoft.com/office/drawing/2014/main" id="{2AE7D0A0-B57F-301F-AF95-87887D40C21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17311" y="1129604"/>
                <a:ext cx="16466" cy="66524"/>
              </a:xfrm>
              <a:custGeom>
                <a:avLst/>
                <a:gdLst>
                  <a:gd name="T0" fmla="*/ 224 w 224"/>
                  <a:gd name="T1" fmla="*/ 0 h 890"/>
                  <a:gd name="T2" fmla="*/ 127 w 224"/>
                  <a:gd name="T3" fmla="*/ 223 h 890"/>
                  <a:gd name="T4" fmla="*/ 95 w 224"/>
                  <a:gd name="T5" fmla="*/ 445 h 890"/>
                  <a:gd name="T6" fmla="*/ 127 w 224"/>
                  <a:gd name="T7" fmla="*/ 668 h 890"/>
                  <a:gd name="T8" fmla="*/ 224 w 224"/>
                  <a:gd name="T9" fmla="*/ 890 h 890"/>
                  <a:gd name="T10" fmla="*/ 146 w 224"/>
                  <a:gd name="T11" fmla="*/ 890 h 890"/>
                  <a:gd name="T12" fmla="*/ 36 w 224"/>
                  <a:gd name="T13" fmla="*/ 665 h 890"/>
                  <a:gd name="T14" fmla="*/ 0 w 224"/>
                  <a:gd name="T15" fmla="*/ 445 h 890"/>
                  <a:gd name="T16" fmla="*/ 36 w 224"/>
                  <a:gd name="T17" fmla="*/ 226 h 890"/>
                  <a:gd name="T18" fmla="*/ 146 w 224"/>
                  <a:gd name="T19" fmla="*/ 0 h 890"/>
                  <a:gd name="T20" fmla="*/ 224 w 224"/>
                  <a:gd name="T21" fmla="*/ 0 h 8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224" h="890">
                    <a:moveTo>
                      <a:pt x="224" y="0"/>
                    </a:moveTo>
                    <a:cubicBezTo>
                      <a:pt x="180" y="76"/>
                      <a:pt x="148" y="150"/>
                      <a:pt x="127" y="223"/>
                    </a:cubicBezTo>
                    <a:cubicBezTo>
                      <a:pt x="105" y="296"/>
                      <a:pt x="95" y="370"/>
                      <a:pt x="95" y="445"/>
                    </a:cubicBezTo>
                    <a:cubicBezTo>
                      <a:pt x="95" y="521"/>
                      <a:pt x="105" y="595"/>
                      <a:pt x="127" y="668"/>
                    </a:cubicBezTo>
                    <a:cubicBezTo>
                      <a:pt x="148" y="742"/>
                      <a:pt x="180" y="815"/>
                      <a:pt x="224" y="890"/>
                    </a:cubicBezTo>
                    <a:lnTo>
                      <a:pt x="146" y="890"/>
                    </a:lnTo>
                    <a:cubicBezTo>
                      <a:pt x="97" y="813"/>
                      <a:pt x="60" y="739"/>
                      <a:pt x="36" y="665"/>
                    </a:cubicBezTo>
                    <a:cubicBezTo>
                      <a:pt x="12" y="591"/>
                      <a:pt x="0" y="518"/>
                      <a:pt x="0" y="445"/>
                    </a:cubicBezTo>
                    <a:cubicBezTo>
                      <a:pt x="0" y="373"/>
                      <a:pt x="12" y="300"/>
                      <a:pt x="36" y="226"/>
                    </a:cubicBezTo>
                    <a:cubicBezTo>
                      <a:pt x="60" y="152"/>
                      <a:pt x="96" y="77"/>
                      <a:pt x="146" y="0"/>
                    </a:cubicBezTo>
                    <a:lnTo>
                      <a:pt x="224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3" name="Freeform 91">
                <a:extLst>
                  <a:ext uri="{FF2B5EF4-FFF2-40B4-BE49-F238E27FC236}">
                    <a16:creationId xmlns:a16="http://schemas.microsoft.com/office/drawing/2014/main" id="{41C58068-D137-E25F-45AC-AA61D91735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94373" y="1144095"/>
                <a:ext cx="59279" cy="42154"/>
              </a:xfrm>
              <a:custGeom>
                <a:avLst/>
                <a:gdLst>
                  <a:gd name="T0" fmla="*/ 429 w 798"/>
                  <a:gd name="T1" fmla="*/ 118 h 560"/>
                  <a:gd name="T2" fmla="*/ 509 w 798"/>
                  <a:gd name="T3" fmla="*/ 29 h 560"/>
                  <a:gd name="T4" fmla="*/ 620 w 798"/>
                  <a:gd name="T5" fmla="*/ 0 h 560"/>
                  <a:gd name="T6" fmla="*/ 751 w 798"/>
                  <a:gd name="T7" fmla="*/ 60 h 560"/>
                  <a:gd name="T8" fmla="*/ 798 w 798"/>
                  <a:gd name="T9" fmla="*/ 230 h 560"/>
                  <a:gd name="T10" fmla="*/ 798 w 798"/>
                  <a:gd name="T11" fmla="*/ 560 h 560"/>
                  <a:gd name="T12" fmla="*/ 708 w 798"/>
                  <a:gd name="T13" fmla="*/ 560 h 560"/>
                  <a:gd name="T14" fmla="*/ 708 w 798"/>
                  <a:gd name="T15" fmla="*/ 233 h 560"/>
                  <a:gd name="T16" fmla="*/ 680 w 798"/>
                  <a:gd name="T17" fmla="*/ 116 h 560"/>
                  <a:gd name="T18" fmla="*/ 595 w 798"/>
                  <a:gd name="T19" fmla="*/ 78 h 560"/>
                  <a:gd name="T20" fmla="*/ 484 w 798"/>
                  <a:gd name="T21" fmla="*/ 125 h 560"/>
                  <a:gd name="T22" fmla="*/ 444 w 798"/>
                  <a:gd name="T23" fmla="*/ 251 h 560"/>
                  <a:gd name="T24" fmla="*/ 444 w 798"/>
                  <a:gd name="T25" fmla="*/ 560 h 560"/>
                  <a:gd name="T26" fmla="*/ 354 w 798"/>
                  <a:gd name="T27" fmla="*/ 560 h 560"/>
                  <a:gd name="T28" fmla="*/ 354 w 798"/>
                  <a:gd name="T29" fmla="*/ 233 h 560"/>
                  <a:gd name="T30" fmla="*/ 326 w 798"/>
                  <a:gd name="T31" fmla="*/ 116 h 560"/>
                  <a:gd name="T32" fmla="*/ 240 w 798"/>
                  <a:gd name="T33" fmla="*/ 78 h 560"/>
                  <a:gd name="T34" fmla="*/ 130 w 798"/>
                  <a:gd name="T35" fmla="*/ 125 h 560"/>
                  <a:gd name="T36" fmla="*/ 90 w 798"/>
                  <a:gd name="T37" fmla="*/ 251 h 560"/>
                  <a:gd name="T38" fmla="*/ 90 w 798"/>
                  <a:gd name="T39" fmla="*/ 560 h 560"/>
                  <a:gd name="T40" fmla="*/ 0 w 798"/>
                  <a:gd name="T41" fmla="*/ 560 h 560"/>
                  <a:gd name="T42" fmla="*/ 0 w 798"/>
                  <a:gd name="T43" fmla="*/ 13 h 560"/>
                  <a:gd name="T44" fmla="*/ 90 w 798"/>
                  <a:gd name="T45" fmla="*/ 13 h 560"/>
                  <a:gd name="T46" fmla="*/ 90 w 798"/>
                  <a:gd name="T47" fmla="*/ 98 h 560"/>
                  <a:gd name="T48" fmla="*/ 164 w 798"/>
                  <a:gd name="T49" fmla="*/ 24 h 560"/>
                  <a:gd name="T50" fmla="*/ 266 w 798"/>
                  <a:gd name="T51" fmla="*/ 0 h 560"/>
                  <a:gd name="T52" fmla="*/ 367 w 798"/>
                  <a:gd name="T53" fmla="*/ 30 h 560"/>
                  <a:gd name="T54" fmla="*/ 429 w 798"/>
                  <a:gd name="T55" fmla="*/ 118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798" h="560">
                    <a:moveTo>
                      <a:pt x="429" y="118"/>
                    </a:moveTo>
                    <a:cubicBezTo>
                      <a:pt x="451" y="78"/>
                      <a:pt x="478" y="49"/>
                      <a:pt x="509" y="29"/>
                    </a:cubicBezTo>
                    <a:cubicBezTo>
                      <a:pt x="540" y="10"/>
                      <a:pt x="577" y="0"/>
                      <a:pt x="620" y="0"/>
                    </a:cubicBezTo>
                    <a:cubicBezTo>
                      <a:pt x="676" y="0"/>
                      <a:pt x="720" y="20"/>
                      <a:pt x="751" y="60"/>
                    </a:cubicBezTo>
                    <a:cubicBezTo>
                      <a:pt x="782" y="100"/>
                      <a:pt x="798" y="157"/>
                      <a:pt x="798" y="230"/>
                    </a:cubicBezTo>
                    <a:lnTo>
                      <a:pt x="798" y="560"/>
                    </a:lnTo>
                    <a:lnTo>
                      <a:pt x="708" y="560"/>
                    </a:lnTo>
                    <a:lnTo>
                      <a:pt x="708" y="233"/>
                    </a:lnTo>
                    <a:cubicBezTo>
                      <a:pt x="708" y="181"/>
                      <a:pt x="698" y="142"/>
                      <a:pt x="680" y="116"/>
                    </a:cubicBezTo>
                    <a:cubicBezTo>
                      <a:pt x="661" y="91"/>
                      <a:pt x="633" y="78"/>
                      <a:pt x="595" y="78"/>
                    </a:cubicBezTo>
                    <a:cubicBezTo>
                      <a:pt x="548" y="78"/>
                      <a:pt x="511" y="94"/>
                      <a:pt x="484" y="125"/>
                    </a:cubicBezTo>
                    <a:cubicBezTo>
                      <a:pt x="457" y="156"/>
                      <a:pt x="444" y="198"/>
                      <a:pt x="444" y="251"/>
                    </a:cubicBezTo>
                    <a:lnTo>
                      <a:pt x="444" y="560"/>
                    </a:lnTo>
                    <a:lnTo>
                      <a:pt x="354" y="560"/>
                    </a:lnTo>
                    <a:lnTo>
                      <a:pt x="354" y="233"/>
                    </a:lnTo>
                    <a:cubicBezTo>
                      <a:pt x="354" y="181"/>
                      <a:pt x="344" y="142"/>
                      <a:pt x="326" y="116"/>
                    </a:cubicBezTo>
                    <a:cubicBezTo>
                      <a:pt x="307" y="91"/>
                      <a:pt x="278" y="78"/>
                      <a:pt x="240" y="78"/>
                    </a:cubicBezTo>
                    <a:cubicBezTo>
                      <a:pt x="194" y="78"/>
                      <a:pt x="157" y="94"/>
                      <a:pt x="130" y="125"/>
                    </a:cubicBezTo>
                    <a:cubicBezTo>
                      <a:pt x="103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0" y="65"/>
                      <a:pt x="135" y="40"/>
                      <a:pt x="164" y="24"/>
                    </a:cubicBezTo>
                    <a:cubicBezTo>
                      <a:pt x="192" y="8"/>
                      <a:pt x="226" y="0"/>
                      <a:pt x="266" y="0"/>
                    </a:cubicBezTo>
                    <a:cubicBezTo>
                      <a:pt x="306" y="0"/>
                      <a:pt x="339" y="10"/>
                      <a:pt x="367" y="30"/>
                    </a:cubicBezTo>
                    <a:cubicBezTo>
                      <a:pt x="395" y="50"/>
                      <a:pt x="415" y="80"/>
                      <a:pt x="429" y="11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4" name="Freeform 92">
                <a:extLst>
                  <a:ext uri="{FF2B5EF4-FFF2-40B4-BE49-F238E27FC236}">
                    <a16:creationId xmlns:a16="http://schemas.microsoft.com/office/drawing/2014/main" id="{E4AEBB91-6242-1CA9-29BB-72FAC7FD11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66166" y="1129604"/>
                <a:ext cx="17125" cy="66524"/>
              </a:xfrm>
              <a:custGeom>
                <a:avLst/>
                <a:gdLst>
                  <a:gd name="T0" fmla="*/ 0 w 224"/>
                  <a:gd name="T1" fmla="*/ 0 h 890"/>
                  <a:gd name="T2" fmla="*/ 78 w 224"/>
                  <a:gd name="T3" fmla="*/ 0 h 890"/>
                  <a:gd name="T4" fmla="*/ 187 w 224"/>
                  <a:gd name="T5" fmla="*/ 226 h 890"/>
                  <a:gd name="T6" fmla="*/ 224 w 224"/>
                  <a:gd name="T7" fmla="*/ 445 h 890"/>
                  <a:gd name="T8" fmla="*/ 187 w 224"/>
                  <a:gd name="T9" fmla="*/ 665 h 890"/>
                  <a:gd name="T10" fmla="*/ 78 w 224"/>
                  <a:gd name="T11" fmla="*/ 890 h 890"/>
                  <a:gd name="T12" fmla="*/ 0 w 224"/>
                  <a:gd name="T13" fmla="*/ 890 h 890"/>
                  <a:gd name="T14" fmla="*/ 97 w 224"/>
                  <a:gd name="T15" fmla="*/ 668 h 890"/>
                  <a:gd name="T16" fmla="*/ 129 w 224"/>
                  <a:gd name="T17" fmla="*/ 445 h 890"/>
                  <a:gd name="T18" fmla="*/ 97 w 224"/>
                  <a:gd name="T19" fmla="*/ 223 h 890"/>
                  <a:gd name="T20" fmla="*/ 0 w 224"/>
                  <a:gd name="T21" fmla="*/ 0 h 8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224" h="890">
                    <a:moveTo>
                      <a:pt x="0" y="0"/>
                    </a:moveTo>
                    <a:lnTo>
                      <a:pt x="78" y="0"/>
                    </a:lnTo>
                    <a:cubicBezTo>
                      <a:pt x="126" y="77"/>
                      <a:pt x="163" y="152"/>
                      <a:pt x="187" y="226"/>
                    </a:cubicBezTo>
                    <a:cubicBezTo>
                      <a:pt x="211" y="300"/>
                      <a:pt x="224" y="373"/>
                      <a:pt x="224" y="445"/>
                    </a:cubicBezTo>
                    <a:cubicBezTo>
                      <a:pt x="224" y="518"/>
                      <a:pt x="211" y="591"/>
                      <a:pt x="187" y="665"/>
                    </a:cubicBezTo>
                    <a:cubicBezTo>
                      <a:pt x="163" y="739"/>
                      <a:pt x="126" y="813"/>
                      <a:pt x="78" y="890"/>
                    </a:cubicBezTo>
                    <a:lnTo>
                      <a:pt x="0" y="890"/>
                    </a:lnTo>
                    <a:cubicBezTo>
                      <a:pt x="43" y="815"/>
                      <a:pt x="75" y="742"/>
                      <a:pt x="97" y="668"/>
                    </a:cubicBezTo>
                    <a:cubicBezTo>
                      <a:pt x="118" y="595"/>
                      <a:pt x="129" y="521"/>
                      <a:pt x="129" y="445"/>
                    </a:cubicBezTo>
                    <a:cubicBezTo>
                      <a:pt x="129" y="370"/>
                      <a:pt x="118" y="296"/>
                      <a:pt x="97" y="223"/>
                    </a:cubicBezTo>
                    <a:cubicBezTo>
                      <a:pt x="75" y="150"/>
                      <a:pt x="43" y="76"/>
                      <a:pt x="0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5" name="Freeform 93">
                <a:extLst>
                  <a:ext uri="{FF2B5EF4-FFF2-40B4-BE49-F238E27FC236}">
                    <a16:creationId xmlns:a16="http://schemas.microsoft.com/office/drawing/2014/main" id="{F8811C6E-354A-849F-2DC9-C000282C071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46292" y="1145412"/>
                <a:ext cx="39519" cy="55986"/>
              </a:xfrm>
              <a:custGeom>
                <a:avLst/>
                <a:gdLst>
                  <a:gd name="T0" fmla="*/ 0 w 527"/>
                  <a:gd name="T1" fmla="*/ 754 h 754"/>
                  <a:gd name="T2" fmla="*/ 0 w 527"/>
                  <a:gd name="T3" fmla="*/ 0 h 754"/>
                  <a:gd name="T4" fmla="*/ 90 w 527"/>
                  <a:gd name="T5" fmla="*/ 0 h 754"/>
                  <a:gd name="T6" fmla="*/ 90 w 527"/>
                  <a:gd name="T7" fmla="*/ 340 h 754"/>
                  <a:gd name="T8" fmla="*/ 123 w 527"/>
                  <a:gd name="T9" fmla="*/ 447 h 754"/>
                  <a:gd name="T10" fmla="*/ 223 w 527"/>
                  <a:gd name="T11" fmla="*/ 483 h 754"/>
                  <a:gd name="T12" fmla="*/ 331 w 527"/>
                  <a:gd name="T13" fmla="*/ 442 h 754"/>
                  <a:gd name="T14" fmla="*/ 368 w 527"/>
                  <a:gd name="T15" fmla="*/ 319 h 754"/>
                  <a:gd name="T16" fmla="*/ 368 w 527"/>
                  <a:gd name="T17" fmla="*/ 0 h 754"/>
                  <a:gd name="T18" fmla="*/ 458 w 527"/>
                  <a:gd name="T19" fmla="*/ 0 h 754"/>
                  <a:gd name="T20" fmla="*/ 458 w 527"/>
                  <a:gd name="T21" fmla="*/ 421 h 754"/>
                  <a:gd name="T22" fmla="*/ 466 w 527"/>
                  <a:gd name="T23" fmla="*/ 464 h 754"/>
                  <a:gd name="T24" fmla="*/ 493 w 527"/>
                  <a:gd name="T25" fmla="*/ 478 h 754"/>
                  <a:gd name="T26" fmla="*/ 505 w 527"/>
                  <a:gd name="T27" fmla="*/ 476 h 754"/>
                  <a:gd name="T28" fmla="*/ 527 w 527"/>
                  <a:gd name="T29" fmla="*/ 467 h 754"/>
                  <a:gd name="T30" fmla="*/ 527 w 527"/>
                  <a:gd name="T31" fmla="*/ 539 h 754"/>
                  <a:gd name="T32" fmla="*/ 489 w 527"/>
                  <a:gd name="T33" fmla="*/ 554 h 754"/>
                  <a:gd name="T34" fmla="*/ 454 w 527"/>
                  <a:gd name="T35" fmla="*/ 560 h 754"/>
                  <a:gd name="T36" fmla="*/ 400 w 527"/>
                  <a:gd name="T37" fmla="*/ 542 h 754"/>
                  <a:gd name="T38" fmla="*/ 373 w 527"/>
                  <a:gd name="T39" fmla="*/ 484 h 754"/>
                  <a:gd name="T40" fmla="*/ 313 w 527"/>
                  <a:gd name="T41" fmla="*/ 542 h 754"/>
                  <a:gd name="T42" fmla="*/ 230 w 527"/>
                  <a:gd name="T43" fmla="*/ 560 h 754"/>
                  <a:gd name="T44" fmla="*/ 145 w 527"/>
                  <a:gd name="T45" fmla="*/ 542 h 754"/>
                  <a:gd name="T46" fmla="*/ 90 w 527"/>
                  <a:gd name="T47" fmla="*/ 485 h 754"/>
                  <a:gd name="T48" fmla="*/ 90 w 527"/>
                  <a:gd name="T49" fmla="*/ 754 h 754"/>
                  <a:gd name="T50" fmla="*/ 0 w 527"/>
                  <a:gd name="T51" fmla="*/ 754 h 7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</a:cxnLst>
                <a:rect l="0" t="0" r="r" b="b"/>
                <a:pathLst>
                  <a:path w="527" h="754">
                    <a:moveTo>
                      <a:pt x="0" y="754"/>
                    </a:moveTo>
                    <a:lnTo>
                      <a:pt x="0" y="0"/>
                    </a:lnTo>
                    <a:lnTo>
                      <a:pt x="90" y="0"/>
                    </a:lnTo>
                    <a:lnTo>
                      <a:pt x="90" y="340"/>
                    </a:lnTo>
                    <a:cubicBezTo>
                      <a:pt x="90" y="388"/>
                      <a:pt x="101" y="423"/>
                      <a:pt x="123" y="447"/>
                    </a:cubicBezTo>
                    <a:cubicBezTo>
                      <a:pt x="145" y="471"/>
                      <a:pt x="179" y="483"/>
                      <a:pt x="223" y="483"/>
                    </a:cubicBezTo>
                    <a:cubicBezTo>
                      <a:pt x="271" y="483"/>
                      <a:pt x="307" y="470"/>
                      <a:pt x="331" y="442"/>
                    </a:cubicBezTo>
                    <a:cubicBezTo>
                      <a:pt x="355" y="415"/>
                      <a:pt x="368" y="374"/>
                      <a:pt x="368" y="319"/>
                    </a:cubicBezTo>
                    <a:lnTo>
                      <a:pt x="368" y="0"/>
                    </a:lnTo>
                    <a:lnTo>
                      <a:pt x="458" y="0"/>
                    </a:lnTo>
                    <a:lnTo>
                      <a:pt x="458" y="421"/>
                    </a:lnTo>
                    <a:cubicBezTo>
                      <a:pt x="458" y="441"/>
                      <a:pt x="460" y="455"/>
                      <a:pt x="466" y="464"/>
                    </a:cubicBezTo>
                    <a:cubicBezTo>
                      <a:pt x="472" y="474"/>
                      <a:pt x="481" y="478"/>
                      <a:pt x="493" y="478"/>
                    </a:cubicBezTo>
                    <a:cubicBezTo>
                      <a:pt x="496" y="478"/>
                      <a:pt x="500" y="478"/>
                      <a:pt x="505" y="476"/>
                    </a:cubicBezTo>
                    <a:cubicBezTo>
                      <a:pt x="510" y="474"/>
                      <a:pt x="517" y="471"/>
                      <a:pt x="527" y="467"/>
                    </a:cubicBezTo>
                    <a:lnTo>
                      <a:pt x="527" y="539"/>
                    </a:lnTo>
                    <a:cubicBezTo>
                      <a:pt x="513" y="546"/>
                      <a:pt x="501" y="550"/>
                      <a:pt x="489" y="554"/>
                    </a:cubicBezTo>
                    <a:cubicBezTo>
                      <a:pt x="477" y="558"/>
                      <a:pt x="465" y="560"/>
                      <a:pt x="454" y="560"/>
                    </a:cubicBezTo>
                    <a:cubicBezTo>
                      <a:pt x="431" y="560"/>
                      <a:pt x="413" y="554"/>
                      <a:pt x="400" y="542"/>
                    </a:cubicBezTo>
                    <a:cubicBezTo>
                      <a:pt x="386" y="530"/>
                      <a:pt x="377" y="510"/>
                      <a:pt x="373" y="484"/>
                    </a:cubicBezTo>
                    <a:cubicBezTo>
                      <a:pt x="357" y="510"/>
                      <a:pt x="337" y="530"/>
                      <a:pt x="313" y="542"/>
                    </a:cubicBezTo>
                    <a:cubicBezTo>
                      <a:pt x="289" y="554"/>
                      <a:pt x="262" y="560"/>
                      <a:pt x="230" y="560"/>
                    </a:cubicBezTo>
                    <a:cubicBezTo>
                      <a:pt x="196" y="560"/>
                      <a:pt x="168" y="554"/>
                      <a:pt x="145" y="542"/>
                    </a:cubicBezTo>
                    <a:cubicBezTo>
                      <a:pt x="121" y="530"/>
                      <a:pt x="103" y="511"/>
                      <a:pt x="90" y="485"/>
                    </a:cubicBezTo>
                    <a:lnTo>
                      <a:pt x="90" y="754"/>
                    </a:lnTo>
                    <a:lnTo>
                      <a:pt x="0" y="754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6" name="Line 94">
                <a:extLst>
                  <a:ext uri="{FF2B5EF4-FFF2-40B4-BE49-F238E27FC236}">
                    <a16:creationId xmlns:a16="http://schemas.microsoft.com/office/drawing/2014/main" id="{652D5299-6F80-62E3-2C34-D364E5F6C0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83804" y="960990"/>
                <a:ext cx="994563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7" name="Freeform 95">
                <a:extLst>
                  <a:ext uri="{FF2B5EF4-FFF2-40B4-BE49-F238E27FC236}">
                    <a16:creationId xmlns:a16="http://schemas.microsoft.com/office/drawing/2014/main" id="{2AAD8E3B-3D82-EB29-C7CD-24FF4D8B557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706083" y="933985"/>
                <a:ext cx="37543" cy="56644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8" name="Line 96">
                <a:extLst>
                  <a:ext uri="{FF2B5EF4-FFF2-40B4-BE49-F238E27FC236}">
                    <a16:creationId xmlns:a16="http://schemas.microsoft.com/office/drawing/2014/main" id="{C27625BA-C46A-6B65-CCDA-70C2676FC7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83804" y="638251"/>
                <a:ext cx="994563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9" name="Freeform 97">
                <a:extLst>
                  <a:ext uri="{FF2B5EF4-FFF2-40B4-BE49-F238E27FC236}">
                    <a16:creationId xmlns:a16="http://schemas.microsoft.com/office/drawing/2014/main" id="{D60D310E-B8CE-93CA-2479-6DFC71AF2B4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659318" y="611905"/>
                <a:ext cx="34909" cy="55327"/>
              </a:xfrm>
              <a:custGeom>
                <a:avLst/>
                <a:gdLst>
                  <a:gd name="T0" fmla="*/ 31 w 472"/>
                  <a:gd name="T1" fmla="*/ 0 h 742"/>
                  <a:gd name="T2" fmla="*/ 418 w 472"/>
                  <a:gd name="T3" fmla="*/ 0 h 742"/>
                  <a:gd name="T4" fmla="*/ 418 w 472"/>
                  <a:gd name="T5" fmla="*/ 83 h 742"/>
                  <a:gd name="T6" fmla="*/ 121 w 472"/>
                  <a:gd name="T7" fmla="*/ 83 h 742"/>
                  <a:gd name="T8" fmla="*/ 121 w 472"/>
                  <a:gd name="T9" fmla="*/ 262 h 742"/>
                  <a:gd name="T10" fmla="*/ 164 w 472"/>
                  <a:gd name="T11" fmla="*/ 251 h 742"/>
                  <a:gd name="T12" fmla="*/ 207 w 472"/>
                  <a:gd name="T13" fmla="*/ 247 h 742"/>
                  <a:gd name="T14" fmla="*/ 400 w 472"/>
                  <a:gd name="T15" fmla="*/ 314 h 742"/>
                  <a:gd name="T16" fmla="*/ 472 w 472"/>
                  <a:gd name="T17" fmla="*/ 495 h 742"/>
                  <a:gd name="T18" fmla="*/ 398 w 472"/>
                  <a:gd name="T19" fmla="*/ 678 h 742"/>
                  <a:gd name="T20" fmla="*/ 192 w 472"/>
                  <a:gd name="T21" fmla="*/ 742 h 742"/>
                  <a:gd name="T22" fmla="*/ 98 w 472"/>
                  <a:gd name="T23" fmla="*/ 735 h 742"/>
                  <a:gd name="T24" fmla="*/ 0 w 472"/>
                  <a:gd name="T25" fmla="*/ 712 h 742"/>
                  <a:gd name="T26" fmla="*/ 0 w 472"/>
                  <a:gd name="T27" fmla="*/ 613 h 742"/>
                  <a:gd name="T28" fmla="*/ 91 w 472"/>
                  <a:gd name="T29" fmla="*/ 649 h 742"/>
                  <a:gd name="T30" fmla="*/ 190 w 472"/>
                  <a:gd name="T31" fmla="*/ 660 h 742"/>
                  <a:gd name="T32" fmla="*/ 324 w 472"/>
                  <a:gd name="T33" fmla="*/ 616 h 742"/>
                  <a:gd name="T34" fmla="*/ 373 w 472"/>
                  <a:gd name="T35" fmla="*/ 495 h 742"/>
                  <a:gd name="T36" fmla="*/ 324 w 472"/>
                  <a:gd name="T37" fmla="*/ 375 h 742"/>
                  <a:gd name="T38" fmla="*/ 190 w 472"/>
                  <a:gd name="T39" fmla="*/ 330 h 742"/>
                  <a:gd name="T40" fmla="*/ 111 w 472"/>
                  <a:gd name="T41" fmla="*/ 339 h 742"/>
                  <a:gd name="T42" fmla="*/ 31 w 472"/>
                  <a:gd name="T43" fmla="*/ 366 h 742"/>
                  <a:gd name="T44" fmla="*/ 31 w 472"/>
                  <a:gd name="T45" fmla="*/ 0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72" h="742">
                    <a:moveTo>
                      <a:pt x="31" y="0"/>
                    </a:moveTo>
                    <a:lnTo>
                      <a:pt x="418" y="0"/>
                    </a:lnTo>
                    <a:lnTo>
                      <a:pt x="418" y="83"/>
                    </a:lnTo>
                    <a:lnTo>
                      <a:pt x="121" y="83"/>
                    </a:lnTo>
                    <a:lnTo>
                      <a:pt x="121" y="262"/>
                    </a:lnTo>
                    <a:cubicBezTo>
                      <a:pt x="135" y="257"/>
                      <a:pt x="150" y="253"/>
                      <a:pt x="164" y="251"/>
                    </a:cubicBezTo>
                    <a:cubicBezTo>
                      <a:pt x="178" y="249"/>
                      <a:pt x="193" y="247"/>
                      <a:pt x="207" y="247"/>
                    </a:cubicBezTo>
                    <a:cubicBezTo>
                      <a:pt x="288" y="247"/>
                      <a:pt x="352" y="270"/>
                      <a:pt x="400" y="314"/>
                    </a:cubicBezTo>
                    <a:cubicBezTo>
                      <a:pt x="448" y="359"/>
                      <a:pt x="472" y="419"/>
                      <a:pt x="472" y="495"/>
                    </a:cubicBezTo>
                    <a:cubicBezTo>
                      <a:pt x="472" y="574"/>
                      <a:pt x="447" y="635"/>
                      <a:pt x="398" y="678"/>
                    </a:cubicBezTo>
                    <a:cubicBezTo>
                      <a:pt x="349" y="721"/>
                      <a:pt x="280" y="742"/>
                      <a:pt x="192" y="742"/>
                    </a:cubicBezTo>
                    <a:cubicBezTo>
                      <a:pt x="161" y="742"/>
                      <a:pt x="130" y="739"/>
                      <a:pt x="98" y="735"/>
                    </a:cubicBezTo>
                    <a:cubicBezTo>
                      <a:pt x="66" y="730"/>
                      <a:pt x="34" y="723"/>
                      <a:pt x="0" y="712"/>
                    </a:cubicBezTo>
                    <a:lnTo>
                      <a:pt x="0" y="613"/>
                    </a:lnTo>
                    <a:cubicBezTo>
                      <a:pt x="29" y="629"/>
                      <a:pt x="59" y="641"/>
                      <a:pt x="91" y="649"/>
                    </a:cubicBezTo>
                    <a:cubicBezTo>
                      <a:pt x="122" y="657"/>
                      <a:pt x="155" y="660"/>
                      <a:pt x="190" y="660"/>
                    </a:cubicBezTo>
                    <a:cubicBezTo>
                      <a:pt x="246" y="660"/>
                      <a:pt x="291" y="646"/>
                      <a:pt x="324" y="616"/>
                    </a:cubicBezTo>
                    <a:cubicBezTo>
                      <a:pt x="356" y="586"/>
                      <a:pt x="373" y="546"/>
                      <a:pt x="373" y="495"/>
                    </a:cubicBezTo>
                    <a:cubicBezTo>
                      <a:pt x="373" y="445"/>
                      <a:pt x="356" y="405"/>
                      <a:pt x="324" y="375"/>
                    </a:cubicBezTo>
                    <a:cubicBezTo>
                      <a:pt x="291" y="345"/>
                      <a:pt x="246" y="330"/>
                      <a:pt x="190" y="330"/>
                    </a:cubicBezTo>
                    <a:cubicBezTo>
                      <a:pt x="164" y="330"/>
                      <a:pt x="137" y="333"/>
                      <a:pt x="111" y="339"/>
                    </a:cubicBezTo>
                    <a:cubicBezTo>
                      <a:pt x="85" y="345"/>
                      <a:pt x="58" y="354"/>
                      <a:pt x="31" y="366"/>
                    </a:cubicBezTo>
                    <a:lnTo>
                      <a:pt x="31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0" name="Freeform 98">
                <a:extLst>
                  <a:ext uri="{FF2B5EF4-FFF2-40B4-BE49-F238E27FC236}">
                    <a16:creationId xmlns:a16="http://schemas.microsoft.com/office/drawing/2014/main" id="{FE530A46-6F1F-3415-DAEB-A18FDC1D946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706083" y="610587"/>
                <a:ext cx="37543" cy="56644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1" name="Line 99">
                <a:extLst>
                  <a:ext uri="{FF2B5EF4-FFF2-40B4-BE49-F238E27FC236}">
                    <a16:creationId xmlns:a16="http://schemas.microsoft.com/office/drawing/2014/main" id="{E1D2DDAC-55B2-F8E0-7371-DF2F84B469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83804" y="314853"/>
                <a:ext cx="994563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2" name="Freeform 100">
                <a:extLst>
                  <a:ext uri="{FF2B5EF4-FFF2-40B4-BE49-F238E27FC236}">
                    <a16:creationId xmlns:a16="http://schemas.microsoft.com/office/drawing/2014/main" id="{0CB83204-4681-90C7-D225-A9F9690E3EF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613872" y="288507"/>
                <a:ext cx="32274" cy="54668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3" name="Freeform 101">
                <a:extLst>
                  <a:ext uri="{FF2B5EF4-FFF2-40B4-BE49-F238E27FC236}">
                    <a16:creationId xmlns:a16="http://schemas.microsoft.com/office/drawing/2014/main" id="{ED48ACA3-2221-E276-D0B0-3001148BEF2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658001" y="287848"/>
                <a:ext cx="38202" cy="56644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4" name="Freeform 102">
                <a:extLst>
                  <a:ext uri="{FF2B5EF4-FFF2-40B4-BE49-F238E27FC236}">
                    <a16:creationId xmlns:a16="http://schemas.microsoft.com/office/drawing/2014/main" id="{9582F07E-68AD-6A93-6554-C8E78A694DB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706083" y="287848"/>
                <a:ext cx="37543" cy="56644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5" name="Freeform 103">
                <a:extLst>
                  <a:ext uri="{FF2B5EF4-FFF2-40B4-BE49-F238E27FC236}">
                    <a16:creationId xmlns:a16="http://schemas.microsoft.com/office/drawing/2014/main" id="{4639C603-F48C-454F-00A7-BD785ACAA95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21002" y="759443"/>
                <a:ext cx="54009" cy="30957"/>
              </a:xfrm>
              <a:custGeom>
                <a:avLst/>
                <a:gdLst>
                  <a:gd name="T0" fmla="*/ 0 w 729"/>
                  <a:gd name="T1" fmla="*/ 419 h 419"/>
                  <a:gd name="T2" fmla="*/ 0 w 729"/>
                  <a:gd name="T3" fmla="*/ 0 h 419"/>
                  <a:gd name="T4" fmla="*/ 83 w 729"/>
                  <a:gd name="T5" fmla="*/ 0 h 419"/>
                  <a:gd name="T6" fmla="*/ 83 w 729"/>
                  <a:gd name="T7" fmla="*/ 320 h 419"/>
                  <a:gd name="T8" fmla="*/ 298 w 729"/>
                  <a:gd name="T9" fmla="*/ 320 h 419"/>
                  <a:gd name="T10" fmla="*/ 298 w 729"/>
                  <a:gd name="T11" fmla="*/ 31 h 419"/>
                  <a:gd name="T12" fmla="*/ 381 w 729"/>
                  <a:gd name="T13" fmla="*/ 31 h 419"/>
                  <a:gd name="T14" fmla="*/ 381 w 729"/>
                  <a:gd name="T15" fmla="*/ 320 h 419"/>
                  <a:gd name="T16" fmla="*/ 729 w 729"/>
                  <a:gd name="T17" fmla="*/ 320 h 419"/>
                  <a:gd name="T18" fmla="*/ 729 w 729"/>
                  <a:gd name="T19" fmla="*/ 419 h 419"/>
                  <a:gd name="T20" fmla="*/ 0 w 729"/>
                  <a:gd name="T21" fmla="*/ 419 h 4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729" h="419">
                    <a:moveTo>
                      <a:pt x="0" y="419"/>
                    </a:moveTo>
                    <a:lnTo>
                      <a:pt x="0" y="0"/>
                    </a:lnTo>
                    <a:lnTo>
                      <a:pt x="83" y="0"/>
                    </a:lnTo>
                    <a:lnTo>
                      <a:pt x="83" y="320"/>
                    </a:lnTo>
                    <a:lnTo>
                      <a:pt x="298" y="320"/>
                    </a:lnTo>
                    <a:lnTo>
                      <a:pt x="298" y="31"/>
                    </a:lnTo>
                    <a:lnTo>
                      <a:pt x="381" y="31"/>
                    </a:lnTo>
                    <a:lnTo>
                      <a:pt x="381" y="320"/>
                    </a:lnTo>
                    <a:lnTo>
                      <a:pt x="729" y="320"/>
                    </a:lnTo>
                    <a:lnTo>
                      <a:pt x="729" y="419"/>
                    </a:lnTo>
                    <a:lnTo>
                      <a:pt x="0" y="419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6" name="Freeform 104">
                <a:extLst>
                  <a:ext uri="{FF2B5EF4-FFF2-40B4-BE49-F238E27FC236}">
                    <a16:creationId xmlns:a16="http://schemas.microsoft.com/office/drawing/2014/main" id="{953E376B-0A90-8514-401B-844EED855B7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533516" y="715972"/>
                <a:ext cx="42813" cy="37543"/>
              </a:xfrm>
              <a:custGeom>
                <a:avLst/>
                <a:gdLst>
                  <a:gd name="T0" fmla="*/ 76 w 573"/>
                  <a:gd name="T1" fmla="*/ 251 h 502"/>
                  <a:gd name="T2" fmla="*/ 133 w 573"/>
                  <a:gd name="T3" fmla="*/ 365 h 502"/>
                  <a:gd name="T4" fmla="*/ 287 w 573"/>
                  <a:gd name="T5" fmla="*/ 407 h 502"/>
                  <a:gd name="T6" fmla="*/ 442 w 573"/>
                  <a:gd name="T7" fmla="*/ 366 h 502"/>
                  <a:gd name="T8" fmla="*/ 498 w 573"/>
                  <a:gd name="T9" fmla="*/ 251 h 502"/>
                  <a:gd name="T10" fmla="*/ 442 w 573"/>
                  <a:gd name="T11" fmla="*/ 137 h 502"/>
                  <a:gd name="T12" fmla="*/ 287 w 573"/>
                  <a:gd name="T13" fmla="*/ 95 h 502"/>
                  <a:gd name="T14" fmla="*/ 133 w 573"/>
                  <a:gd name="T15" fmla="*/ 137 h 502"/>
                  <a:gd name="T16" fmla="*/ 76 w 573"/>
                  <a:gd name="T17" fmla="*/ 251 h 502"/>
                  <a:gd name="T18" fmla="*/ 0 w 573"/>
                  <a:gd name="T19" fmla="*/ 251 h 502"/>
                  <a:gd name="T20" fmla="*/ 76 w 573"/>
                  <a:gd name="T21" fmla="*/ 67 h 502"/>
                  <a:gd name="T22" fmla="*/ 287 w 573"/>
                  <a:gd name="T23" fmla="*/ 0 h 502"/>
                  <a:gd name="T24" fmla="*/ 497 w 573"/>
                  <a:gd name="T25" fmla="*/ 67 h 502"/>
                  <a:gd name="T26" fmla="*/ 573 w 573"/>
                  <a:gd name="T27" fmla="*/ 251 h 502"/>
                  <a:gd name="T28" fmla="*/ 497 w 573"/>
                  <a:gd name="T29" fmla="*/ 436 h 502"/>
                  <a:gd name="T30" fmla="*/ 287 w 573"/>
                  <a:gd name="T31" fmla="*/ 502 h 502"/>
                  <a:gd name="T32" fmla="*/ 76 w 573"/>
                  <a:gd name="T33" fmla="*/ 436 h 502"/>
                  <a:gd name="T34" fmla="*/ 0 w 573"/>
                  <a:gd name="T35" fmla="*/ 251 h 5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73" h="502">
                    <a:moveTo>
                      <a:pt x="76" y="251"/>
                    </a:moveTo>
                    <a:cubicBezTo>
                      <a:pt x="76" y="299"/>
                      <a:pt x="95" y="337"/>
                      <a:pt x="133" y="365"/>
                    </a:cubicBezTo>
                    <a:cubicBezTo>
                      <a:pt x="171" y="393"/>
                      <a:pt x="222" y="407"/>
                      <a:pt x="287" y="407"/>
                    </a:cubicBezTo>
                    <a:cubicBezTo>
                      <a:pt x="353" y="407"/>
                      <a:pt x="404" y="394"/>
                      <a:pt x="442" y="366"/>
                    </a:cubicBezTo>
                    <a:cubicBezTo>
                      <a:pt x="480" y="338"/>
                      <a:pt x="498" y="300"/>
                      <a:pt x="498" y="251"/>
                    </a:cubicBezTo>
                    <a:cubicBezTo>
                      <a:pt x="498" y="203"/>
                      <a:pt x="480" y="165"/>
                      <a:pt x="442" y="137"/>
                    </a:cubicBezTo>
                    <a:cubicBezTo>
                      <a:pt x="404" y="109"/>
                      <a:pt x="353" y="95"/>
                      <a:pt x="287" y="95"/>
                    </a:cubicBezTo>
                    <a:cubicBezTo>
                      <a:pt x="223" y="95"/>
                      <a:pt x="171" y="109"/>
                      <a:pt x="133" y="137"/>
                    </a:cubicBezTo>
                    <a:cubicBezTo>
                      <a:pt x="95" y="165"/>
                      <a:pt x="76" y="203"/>
                      <a:pt x="76" y="251"/>
                    </a:cubicBezTo>
                    <a:close/>
                    <a:moveTo>
                      <a:pt x="0" y="251"/>
                    </a:moveTo>
                    <a:cubicBezTo>
                      <a:pt x="0" y="173"/>
                      <a:pt x="26" y="112"/>
                      <a:pt x="76" y="67"/>
                    </a:cubicBezTo>
                    <a:cubicBezTo>
                      <a:pt x="127" y="23"/>
                      <a:pt x="197" y="0"/>
                      <a:pt x="287" y="0"/>
                    </a:cubicBezTo>
                    <a:cubicBezTo>
                      <a:pt x="377" y="0"/>
                      <a:pt x="447" y="23"/>
                      <a:pt x="497" y="67"/>
                    </a:cubicBezTo>
                    <a:cubicBezTo>
                      <a:pt x="548" y="112"/>
                      <a:pt x="573" y="173"/>
                      <a:pt x="573" y="251"/>
                    </a:cubicBezTo>
                    <a:cubicBezTo>
                      <a:pt x="573" y="330"/>
                      <a:pt x="548" y="392"/>
                      <a:pt x="497" y="436"/>
                    </a:cubicBezTo>
                    <a:cubicBezTo>
                      <a:pt x="447" y="480"/>
                      <a:pt x="377" y="502"/>
                      <a:pt x="287" y="502"/>
                    </a:cubicBezTo>
                    <a:cubicBezTo>
                      <a:pt x="197" y="502"/>
                      <a:pt x="127" y="480"/>
                      <a:pt x="76" y="436"/>
                    </a:cubicBezTo>
                    <a:cubicBezTo>
                      <a:pt x="26" y="392"/>
                      <a:pt x="0" y="330"/>
                      <a:pt x="0" y="251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7" name="Freeform 105">
                <a:extLst>
                  <a:ext uri="{FF2B5EF4-FFF2-40B4-BE49-F238E27FC236}">
                    <a16:creationId xmlns:a16="http://schemas.microsoft.com/office/drawing/2014/main" id="{39270F69-C7D4-1EE3-DE4E-6BBE224EE88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33516" y="675135"/>
                <a:ext cx="42813" cy="32274"/>
              </a:xfrm>
              <a:custGeom>
                <a:avLst/>
                <a:gdLst>
                  <a:gd name="T0" fmla="*/ 34 w 573"/>
                  <a:gd name="T1" fmla="*/ 0 h 433"/>
                  <a:gd name="T2" fmla="*/ 118 w 573"/>
                  <a:gd name="T3" fmla="*/ 0 h 433"/>
                  <a:gd name="T4" fmla="*/ 87 w 573"/>
                  <a:gd name="T5" fmla="*/ 77 h 433"/>
                  <a:gd name="T6" fmla="*/ 76 w 573"/>
                  <a:gd name="T7" fmla="*/ 154 h 433"/>
                  <a:gd name="T8" fmla="*/ 132 w 573"/>
                  <a:gd name="T9" fmla="*/ 290 h 433"/>
                  <a:gd name="T10" fmla="*/ 287 w 573"/>
                  <a:gd name="T11" fmla="*/ 338 h 433"/>
                  <a:gd name="T12" fmla="*/ 443 w 573"/>
                  <a:gd name="T13" fmla="*/ 290 h 433"/>
                  <a:gd name="T14" fmla="*/ 498 w 573"/>
                  <a:gd name="T15" fmla="*/ 154 h 433"/>
                  <a:gd name="T16" fmla="*/ 488 w 573"/>
                  <a:gd name="T17" fmla="*/ 77 h 433"/>
                  <a:gd name="T18" fmla="*/ 456 w 573"/>
                  <a:gd name="T19" fmla="*/ 0 h 433"/>
                  <a:gd name="T20" fmla="*/ 539 w 573"/>
                  <a:gd name="T21" fmla="*/ 0 h 433"/>
                  <a:gd name="T22" fmla="*/ 565 w 573"/>
                  <a:gd name="T23" fmla="*/ 78 h 433"/>
                  <a:gd name="T24" fmla="*/ 573 w 573"/>
                  <a:gd name="T25" fmla="*/ 164 h 433"/>
                  <a:gd name="T26" fmla="*/ 496 w 573"/>
                  <a:gd name="T27" fmla="*/ 360 h 433"/>
                  <a:gd name="T28" fmla="*/ 287 w 573"/>
                  <a:gd name="T29" fmla="*/ 433 h 433"/>
                  <a:gd name="T30" fmla="*/ 77 w 573"/>
                  <a:gd name="T31" fmla="*/ 360 h 433"/>
                  <a:gd name="T32" fmla="*/ 0 w 573"/>
                  <a:gd name="T33" fmla="*/ 158 h 433"/>
                  <a:gd name="T34" fmla="*/ 9 w 573"/>
                  <a:gd name="T35" fmla="*/ 77 h 433"/>
                  <a:gd name="T36" fmla="*/ 34 w 573"/>
                  <a:gd name="T37" fmla="*/ 0 h 4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73" h="433">
                    <a:moveTo>
                      <a:pt x="34" y="0"/>
                    </a:moveTo>
                    <a:lnTo>
                      <a:pt x="118" y="0"/>
                    </a:lnTo>
                    <a:cubicBezTo>
                      <a:pt x="104" y="26"/>
                      <a:pt x="94" y="51"/>
                      <a:pt x="87" y="77"/>
                    </a:cubicBezTo>
                    <a:cubicBezTo>
                      <a:pt x="80" y="103"/>
                      <a:pt x="76" y="128"/>
                      <a:pt x="76" y="154"/>
                    </a:cubicBezTo>
                    <a:cubicBezTo>
                      <a:pt x="76" y="212"/>
                      <a:pt x="95" y="258"/>
                      <a:pt x="132" y="290"/>
                    </a:cubicBezTo>
                    <a:cubicBezTo>
                      <a:pt x="169" y="322"/>
                      <a:pt x="221" y="338"/>
                      <a:pt x="287" y="338"/>
                    </a:cubicBezTo>
                    <a:cubicBezTo>
                      <a:pt x="354" y="338"/>
                      <a:pt x="406" y="322"/>
                      <a:pt x="443" y="290"/>
                    </a:cubicBezTo>
                    <a:cubicBezTo>
                      <a:pt x="480" y="258"/>
                      <a:pt x="498" y="212"/>
                      <a:pt x="498" y="154"/>
                    </a:cubicBezTo>
                    <a:cubicBezTo>
                      <a:pt x="498" y="128"/>
                      <a:pt x="495" y="103"/>
                      <a:pt x="488" y="77"/>
                    </a:cubicBezTo>
                    <a:cubicBezTo>
                      <a:pt x="481" y="51"/>
                      <a:pt x="470" y="26"/>
                      <a:pt x="456" y="0"/>
                    </a:cubicBezTo>
                    <a:lnTo>
                      <a:pt x="539" y="0"/>
                    </a:lnTo>
                    <a:cubicBezTo>
                      <a:pt x="551" y="26"/>
                      <a:pt x="560" y="52"/>
                      <a:pt x="565" y="78"/>
                    </a:cubicBezTo>
                    <a:cubicBezTo>
                      <a:pt x="570" y="105"/>
                      <a:pt x="573" y="134"/>
                      <a:pt x="573" y="164"/>
                    </a:cubicBezTo>
                    <a:cubicBezTo>
                      <a:pt x="573" y="246"/>
                      <a:pt x="548" y="312"/>
                      <a:pt x="496" y="360"/>
                    </a:cubicBezTo>
                    <a:cubicBezTo>
                      <a:pt x="445" y="409"/>
                      <a:pt x="375" y="433"/>
                      <a:pt x="287" y="433"/>
                    </a:cubicBezTo>
                    <a:cubicBezTo>
                      <a:pt x="198" y="433"/>
                      <a:pt x="128" y="409"/>
                      <a:pt x="77" y="360"/>
                    </a:cubicBezTo>
                    <a:cubicBezTo>
                      <a:pt x="26" y="311"/>
                      <a:pt x="0" y="244"/>
                      <a:pt x="0" y="158"/>
                    </a:cubicBezTo>
                    <a:cubicBezTo>
                      <a:pt x="0" y="130"/>
                      <a:pt x="3" y="103"/>
                      <a:pt x="9" y="77"/>
                    </a:cubicBezTo>
                    <a:cubicBezTo>
                      <a:pt x="15" y="51"/>
                      <a:pt x="23" y="25"/>
                      <a:pt x="34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8" name="Freeform 106">
                <a:extLst>
                  <a:ext uri="{FF2B5EF4-FFF2-40B4-BE49-F238E27FC236}">
                    <a16:creationId xmlns:a16="http://schemas.microsoft.com/office/drawing/2014/main" id="{642A8644-AC41-DF05-4AE4-66E46125D20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533516" y="629688"/>
                <a:ext cx="42813" cy="34250"/>
              </a:xfrm>
              <a:custGeom>
                <a:avLst/>
                <a:gdLst>
                  <a:gd name="T0" fmla="*/ 344 w 573"/>
                  <a:gd name="T1" fmla="*/ 458 h 458"/>
                  <a:gd name="T2" fmla="*/ 13 w 573"/>
                  <a:gd name="T3" fmla="*/ 458 h 458"/>
                  <a:gd name="T4" fmla="*/ 13 w 573"/>
                  <a:gd name="T5" fmla="*/ 368 h 458"/>
                  <a:gd name="T6" fmla="*/ 341 w 573"/>
                  <a:gd name="T7" fmla="*/ 368 h 458"/>
                  <a:gd name="T8" fmla="*/ 457 w 573"/>
                  <a:gd name="T9" fmla="*/ 338 h 458"/>
                  <a:gd name="T10" fmla="*/ 496 w 573"/>
                  <a:gd name="T11" fmla="*/ 247 h 458"/>
                  <a:gd name="T12" fmla="*/ 450 w 573"/>
                  <a:gd name="T13" fmla="*/ 132 h 458"/>
                  <a:gd name="T14" fmla="*/ 323 w 573"/>
                  <a:gd name="T15" fmla="*/ 90 h 458"/>
                  <a:gd name="T16" fmla="*/ 13 w 573"/>
                  <a:gd name="T17" fmla="*/ 90 h 458"/>
                  <a:gd name="T18" fmla="*/ 13 w 573"/>
                  <a:gd name="T19" fmla="*/ 0 h 458"/>
                  <a:gd name="T20" fmla="*/ 560 w 573"/>
                  <a:gd name="T21" fmla="*/ 0 h 458"/>
                  <a:gd name="T22" fmla="*/ 560 w 573"/>
                  <a:gd name="T23" fmla="*/ 90 h 458"/>
                  <a:gd name="T24" fmla="*/ 476 w 573"/>
                  <a:gd name="T25" fmla="*/ 90 h 458"/>
                  <a:gd name="T26" fmla="*/ 550 w 573"/>
                  <a:gd name="T27" fmla="*/ 166 h 458"/>
                  <a:gd name="T28" fmla="*/ 573 w 573"/>
                  <a:gd name="T29" fmla="*/ 266 h 458"/>
                  <a:gd name="T30" fmla="*/ 515 w 573"/>
                  <a:gd name="T31" fmla="*/ 409 h 458"/>
                  <a:gd name="T32" fmla="*/ 344 w 573"/>
                  <a:gd name="T33" fmla="*/ 458 h 458"/>
                  <a:gd name="T34" fmla="*/ 0 w 573"/>
                  <a:gd name="T35" fmla="*/ 232 h 458"/>
                  <a:gd name="T36" fmla="*/ 1 w 573"/>
                  <a:gd name="T37" fmla="*/ 232 h 458"/>
                  <a:gd name="T38" fmla="*/ 0 w 573"/>
                  <a:gd name="T39" fmla="*/ 232 h 4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573" h="458">
                    <a:moveTo>
                      <a:pt x="344" y="458"/>
                    </a:moveTo>
                    <a:lnTo>
                      <a:pt x="13" y="458"/>
                    </a:lnTo>
                    <a:lnTo>
                      <a:pt x="13" y="368"/>
                    </a:lnTo>
                    <a:lnTo>
                      <a:pt x="341" y="368"/>
                    </a:lnTo>
                    <a:cubicBezTo>
                      <a:pt x="393" y="368"/>
                      <a:pt x="431" y="358"/>
                      <a:pt x="457" y="338"/>
                    </a:cubicBezTo>
                    <a:cubicBezTo>
                      <a:pt x="483" y="318"/>
                      <a:pt x="496" y="288"/>
                      <a:pt x="496" y="247"/>
                    </a:cubicBezTo>
                    <a:cubicBezTo>
                      <a:pt x="496" y="199"/>
                      <a:pt x="481" y="160"/>
                      <a:pt x="450" y="132"/>
                    </a:cubicBezTo>
                    <a:cubicBezTo>
                      <a:pt x="419" y="104"/>
                      <a:pt x="377" y="90"/>
                      <a:pt x="323" y="90"/>
                    </a:cubicBezTo>
                    <a:lnTo>
                      <a:pt x="13" y="90"/>
                    </a:lnTo>
                    <a:lnTo>
                      <a:pt x="13" y="0"/>
                    </a:lnTo>
                    <a:lnTo>
                      <a:pt x="560" y="0"/>
                    </a:lnTo>
                    <a:lnTo>
                      <a:pt x="560" y="90"/>
                    </a:lnTo>
                    <a:lnTo>
                      <a:pt x="476" y="90"/>
                    </a:lnTo>
                    <a:cubicBezTo>
                      <a:pt x="510" y="112"/>
                      <a:pt x="534" y="138"/>
                      <a:pt x="550" y="166"/>
                    </a:cubicBezTo>
                    <a:cubicBezTo>
                      <a:pt x="565" y="195"/>
                      <a:pt x="573" y="228"/>
                      <a:pt x="573" y="266"/>
                    </a:cubicBezTo>
                    <a:cubicBezTo>
                      <a:pt x="573" y="329"/>
                      <a:pt x="554" y="377"/>
                      <a:pt x="515" y="409"/>
                    </a:cubicBezTo>
                    <a:cubicBezTo>
                      <a:pt x="477" y="442"/>
                      <a:pt x="420" y="458"/>
                      <a:pt x="344" y="458"/>
                    </a:cubicBezTo>
                    <a:close/>
                    <a:moveTo>
                      <a:pt x="0" y="232"/>
                    </a:moveTo>
                    <a:lnTo>
                      <a:pt x="1" y="232"/>
                    </a:lnTo>
                    <a:lnTo>
                      <a:pt x="0" y="232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9" name="Freeform 107">
                <a:extLst>
                  <a:ext uri="{FF2B5EF4-FFF2-40B4-BE49-F238E27FC236}">
                    <a16:creationId xmlns:a16="http://schemas.microsoft.com/office/drawing/2014/main" id="{C7E40F80-189D-4DC3-66BA-03E146CF049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33516" y="587535"/>
                <a:ext cx="42813" cy="31615"/>
              </a:xfrm>
              <a:custGeom>
                <a:avLst/>
                <a:gdLst>
                  <a:gd name="T0" fmla="*/ 29 w 573"/>
                  <a:gd name="T1" fmla="*/ 29 h 418"/>
                  <a:gd name="T2" fmla="*/ 114 w 573"/>
                  <a:gd name="T3" fmla="*/ 29 h 418"/>
                  <a:gd name="T4" fmla="*/ 85 w 573"/>
                  <a:gd name="T5" fmla="*/ 108 h 418"/>
                  <a:gd name="T6" fmla="*/ 75 w 573"/>
                  <a:gd name="T7" fmla="*/ 193 h 418"/>
                  <a:gd name="T8" fmla="*/ 96 w 573"/>
                  <a:gd name="T9" fmla="*/ 294 h 418"/>
                  <a:gd name="T10" fmla="*/ 157 w 573"/>
                  <a:gd name="T11" fmla="*/ 327 h 418"/>
                  <a:gd name="T12" fmla="*/ 206 w 573"/>
                  <a:gd name="T13" fmla="*/ 303 h 418"/>
                  <a:gd name="T14" fmla="*/ 240 w 573"/>
                  <a:gd name="T15" fmla="*/ 207 h 418"/>
                  <a:gd name="T16" fmla="*/ 247 w 573"/>
                  <a:gd name="T17" fmla="*/ 176 h 418"/>
                  <a:gd name="T18" fmla="*/ 305 w 573"/>
                  <a:gd name="T19" fmla="*/ 40 h 418"/>
                  <a:gd name="T20" fmla="*/ 409 w 573"/>
                  <a:gd name="T21" fmla="*/ 0 h 418"/>
                  <a:gd name="T22" fmla="*/ 529 w 573"/>
                  <a:gd name="T23" fmla="*/ 60 h 418"/>
                  <a:gd name="T24" fmla="*/ 573 w 573"/>
                  <a:gd name="T25" fmla="*/ 226 h 418"/>
                  <a:gd name="T26" fmla="*/ 565 w 573"/>
                  <a:gd name="T27" fmla="*/ 318 h 418"/>
                  <a:gd name="T28" fmla="*/ 540 w 573"/>
                  <a:gd name="T29" fmla="*/ 418 h 418"/>
                  <a:gd name="T30" fmla="*/ 447 w 573"/>
                  <a:gd name="T31" fmla="*/ 418 h 418"/>
                  <a:gd name="T32" fmla="*/ 486 w 573"/>
                  <a:gd name="T33" fmla="*/ 320 h 418"/>
                  <a:gd name="T34" fmla="*/ 499 w 573"/>
                  <a:gd name="T35" fmla="*/ 224 h 418"/>
                  <a:gd name="T36" fmla="*/ 478 w 573"/>
                  <a:gd name="T37" fmla="*/ 126 h 418"/>
                  <a:gd name="T38" fmla="*/ 416 w 573"/>
                  <a:gd name="T39" fmla="*/ 92 h 418"/>
                  <a:gd name="T40" fmla="*/ 360 w 573"/>
                  <a:gd name="T41" fmla="*/ 117 h 418"/>
                  <a:gd name="T42" fmla="*/ 322 w 573"/>
                  <a:gd name="T43" fmla="*/ 225 h 418"/>
                  <a:gd name="T44" fmla="*/ 315 w 573"/>
                  <a:gd name="T45" fmla="*/ 256 h 418"/>
                  <a:gd name="T46" fmla="*/ 261 w 573"/>
                  <a:gd name="T47" fmla="*/ 377 h 418"/>
                  <a:gd name="T48" fmla="*/ 161 w 573"/>
                  <a:gd name="T49" fmla="*/ 414 h 418"/>
                  <a:gd name="T50" fmla="*/ 42 w 573"/>
                  <a:gd name="T51" fmla="*/ 360 h 418"/>
                  <a:gd name="T52" fmla="*/ 0 w 573"/>
                  <a:gd name="T53" fmla="*/ 204 h 418"/>
                  <a:gd name="T54" fmla="*/ 8 w 573"/>
                  <a:gd name="T55" fmla="*/ 110 h 418"/>
                  <a:gd name="T56" fmla="*/ 29 w 573"/>
                  <a:gd name="T57" fmla="*/ 29 h 4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573" h="418">
                    <a:moveTo>
                      <a:pt x="29" y="29"/>
                    </a:moveTo>
                    <a:lnTo>
                      <a:pt x="114" y="29"/>
                    </a:lnTo>
                    <a:cubicBezTo>
                      <a:pt x="102" y="55"/>
                      <a:pt x="92" y="81"/>
                      <a:pt x="85" y="108"/>
                    </a:cubicBezTo>
                    <a:cubicBezTo>
                      <a:pt x="79" y="136"/>
                      <a:pt x="75" y="164"/>
                      <a:pt x="75" y="193"/>
                    </a:cubicBezTo>
                    <a:cubicBezTo>
                      <a:pt x="75" y="238"/>
                      <a:pt x="82" y="272"/>
                      <a:pt x="96" y="294"/>
                    </a:cubicBezTo>
                    <a:cubicBezTo>
                      <a:pt x="110" y="316"/>
                      <a:pt x="130" y="327"/>
                      <a:pt x="157" y="327"/>
                    </a:cubicBezTo>
                    <a:cubicBezTo>
                      <a:pt x="178" y="327"/>
                      <a:pt x="194" y="319"/>
                      <a:pt x="206" y="303"/>
                    </a:cubicBezTo>
                    <a:cubicBezTo>
                      <a:pt x="218" y="287"/>
                      <a:pt x="230" y="255"/>
                      <a:pt x="240" y="207"/>
                    </a:cubicBezTo>
                    <a:lnTo>
                      <a:pt x="247" y="176"/>
                    </a:lnTo>
                    <a:cubicBezTo>
                      <a:pt x="261" y="112"/>
                      <a:pt x="281" y="67"/>
                      <a:pt x="305" y="40"/>
                    </a:cubicBezTo>
                    <a:cubicBezTo>
                      <a:pt x="330" y="14"/>
                      <a:pt x="365" y="0"/>
                      <a:pt x="409" y="0"/>
                    </a:cubicBezTo>
                    <a:cubicBezTo>
                      <a:pt x="460" y="0"/>
                      <a:pt x="500" y="20"/>
                      <a:pt x="529" y="60"/>
                    </a:cubicBezTo>
                    <a:cubicBezTo>
                      <a:pt x="559" y="100"/>
                      <a:pt x="573" y="156"/>
                      <a:pt x="573" y="226"/>
                    </a:cubicBezTo>
                    <a:cubicBezTo>
                      <a:pt x="573" y="256"/>
                      <a:pt x="570" y="286"/>
                      <a:pt x="565" y="318"/>
                    </a:cubicBezTo>
                    <a:cubicBezTo>
                      <a:pt x="560" y="350"/>
                      <a:pt x="552" y="383"/>
                      <a:pt x="540" y="418"/>
                    </a:cubicBezTo>
                    <a:lnTo>
                      <a:pt x="447" y="418"/>
                    </a:lnTo>
                    <a:cubicBezTo>
                      <a:pt x="465" y="385"/>
                      <a:pt x="478" y="352"/>
                      <a:pt x="486" y="320"/>
                    </a:cubicBezTo>
                    <a:cubicBezTo>
                      <a:pt x="495" y="288"/>
                      <a:pt x="499" y="256"/>
                      <a:pt x="499" y="224"/>
                    </a:cubicBezTo>
                    <a:cubicBezTo>
                      <a:pt x="499" y="182"/>
                      <a:pt x="492" y="149"/>
                      <a:pt x="478" y="126"/>
                    </a:cubicBezTo>
                    <a:cubicBezTo>
                      <a:pt x="464" y="104"/>
                      <a:pt x="443" y="92"/>
                      <a:pt x="416" y="92"/>
                    </a:cubicBezTo>
                    <a:cubicBezTo>
                      <a:pt x="392" y="92"/>
                      <a:pt x="373" y="101"/>
                      <a:pt x="360" y="117"/>
                    </a:cubicBezTo>
                    <a:cubicBezTo>
                      <a:pt x="347" y="133"/>
                      <a:pt x="334" y="169"/>
                      <a:pt x="322" y="225"/>
                    </a:cubicBezTo>
                    <a:lnTo>
                      <a:pt x="315" y="256"/>
                    </a:lnTo>
                    <a:cubicBezTo>
                      <a:pt x="303" y="312"/>
                      <a:pt x="285" y="353"/>
                      <a:pt x="261" y="377"/>
                    </a:cubicBezTo>
                    <a:cubicBezTo>
                      <a:pt x="237" y="402"/>
                      <a:pt x="204" y="414"/>
                      <a:pt x="161" y="414"/>
                    </a:cubicBezTo>
                    <a:cubicBezTo>
                      <a:pt x="110" y="414"/>
                      <a:pt x="70" y="396"/>
                      <a:pt x="42" y="360"/>
                    </a:cubicBezTo>
                    <a:cubicBezTo>
                      <a:pt x="14" y="324"/>
                      <a:pt x="0" y="272"/>
                      <a:pt x="0" y="204"/>
                    </a:cubicBezTo>
                    <a:cubicBezTo>
                      <a:pt x="0" y="171"/>
                      <a:pt x="3" y="140"/>
                      <a:pt x="8" y="110"/>
                    </a:cubicBezTo>
                    <a:cubicBezTo>
                      <a:pt x="13" y="81"/>
                      <a:pt x="20" y="54"/>
                      <a:pt x="2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0" name="Freeform 108">
                <a:extLst>
                  <a:ext uri="{FF2B5EF4-FFF2-40B4-BE49-F238E27FC236}">
                    <a16:creationId xmlns:a16="http://schemas.microsoft.com/office/drawing/2014/main" id="{7A4DCB3C-7C9B-D46A-43B0-B3A6D6948B0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533516" y="518376"/>
                <a:ext cx="42813" cy="37543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1" name="Freeform 109">
                <a:extLst>
                  <a:ext uri="{FF2B5EF4-FFF2-40B4-BE49-F238E27FC236}">
                    <a16:creationId xmlns:a16="http://schemas.microsoft.com/office/drawing/2014/main" id="{6D170D64-BBA8-A378-120C-A345438B7CC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33516" y="478857"/>
                <a:ext cx="42813" cy="31615"/>
              </a:xfrm>
              <a:custGeom>
                <a:avLst/>
                <a:gdLst>
                  <a:gd name="T0" fmla="*/ 29 w 573"/>
                  <a:gd name="T1" fmla="*/ 29 h 418"/>
                  <a:gd name="T2" fmla="*/ 114 w 573"/>
                  <a:gd name="T3" fmla="*/ 29 h 418"/>
                  <a:gd name="T4" fmla="*/ 85 w 573"/>
                  <a:gd name="T5" fmla="*/ 108 h 418"/>
                  <a:gd name="T6" fmla="*/ 75 w 573"/>
                  <a:gd name="T7" fmla="*/ 193 h 418"/>
                  <a:gd name="T8" fmla="*/ 96 w 573"/>
                  <a:gd name="T9" fmla="*/ 294 h 418"/>
                  <a:gd name="T10" fmla="*/ 157 w 573"/>
                  <a:gd name="T11" fmla="*/ 327 h 418"/>
                  <a:gd name="T12" fmla="*/ 206 w 573"/>
                  <a:gd name="T13" fmla="*/ 303 h 418"/>
                  <a:gd name="T14" fmla="*/ 240 w 573"/>
                  <a:gd name="T15" fmla="*/ 207 h 418"/>
                  <a:gd name="T16" fmla="*/ 247 w 573"/>
                  <a:gd name="T17" fmla="*/ 176 h 418"/>
                  <a:gd name="T18" fmla="*/ 305 w 573"/>
                  <a:gd name="T19" fmla="*/ 40 h 418"/>
                  <a:gd name="T20" fmla="*/ 409 w 573"/>
                  <a:gd name="T21" fmla="*/ 0 h 418"/>
                  <a:gd name="T22" fmla="*/ 529 w 573"/>
                  <a:gd name="T23" fmla="*/ 60 h 418"/>
                  <a:gd name="T24" fmla="*/ 573 w 573"/>
                  <a:gd name="T25" fmla="*/ 226 h 418"/>
                  <a:gd name="T26" fmla="*/ 565 w 573"/>
                  <a:gd name="T27" fmla="*/ 318 h 418"/>
                  <a:gd name="T28" fmla="*/ 540 w 573"/>
                  <a:gd name="T29" fmla="*/ 418 h 418"/>
                  <a:gd name="T30" fmla="*/ 447 w 573"/>
                  <a:gd name="T31" fmla="*/ 418 h 418"/>
                  <a:gd name="T32" fmla="*/ 486 w 573"/>
                  <a:gd name="T33" fmla="*/ 320 h 418"/>
                  <a:gd name="T34" fmla="*/ 499 w 573"/>
                  <a:gd name="T35" fmla="*/ 224 h 418"/>
                  <a:gd name="T36" fmla="*/ 478 w 573"/>
                  <a:gd name="T37" fmla="*/ 126 h 418"/>
                  <a:gd name="T38" fmla="*/ 416 w 573"/>
                  <a:gd name="T39" fmla="*/ 92 h 418"/>
                  <a:gd name="T40" fmla="*/ 360 w 573"/>
                  <a:gd name="T41" fmla="*/ 117 h 418"/>
                  <a:gd name="T42" fmla="*/ 322 w 573"/>
                  <a:gd name="T43" fmla="*/ 225 h 418"/>
                  <a:gd name="T44" fmla="*/ 315 w 573"/>
                  <a:gd name="T45" fmla="*/ 256 h 418"/>
                  <a:gd name="T46" fmla="*/ 261 w 573"/>
                  <a:gd name="T47" fmla="*/ 377 h 418"/>
                  <a:gd name="T48" fmla="*/ 161 w 573"/>
                  <a:gd name="T49" fmla="*/ 414 h 418"/>
                  <a:gd name="T50" fmla="*/ 42 w 573"/>
                  <a:gd name="T51" fmla="*/ 360 h 418"/>
                  <a:gd name="T52" fmla="*/ 0 w 573"/>
                  <a:gd name="T53" fmla="*/ 204 h 418"/>
                  <a:gd name="T54" fmla="*/ 8 w 573"/>
                  <a:gd name="T55" fmla="*/ 110 h 418"/>
                  <a:gd name="T56" fmla="*/ 29 w 573"/>
                  <a:gd name="T57" fmla="*/ 29 h 4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573" h="418">
                    <a:moveTo>
                      <a:pt x="29" y="29"/>
                    </a:moveTo>
                    <a:lnTo>
                      <a:pt x="114" y="29"/>
                    </a:lnTo>
                    <a:cubicBezTo>
                      <a:pt x="102" y="55"/>
                      <a:pt x="92" y="81"/>
                      <a:pt x="85" y="108"/>
                    </a:cubicBezTo>
                    <a:cubicBezTo>
                      <a:pt x="79" y="136"/>
                      <a:pt x="75" y="164"/>
                      <a:pt x="75" y="193"/>
                    </a:cubicBezTo>
                    <a:cubicBezTo>
                      <a:pt x="75" y="238"/>
                      <a:pt x="82" y="272"/>
                      <a:pt x="96" y="294"/>
                    </a:cubicBezTo>
                    <a:cubicBezTo>
                      <a:pt x="110" y="316"/>
                      <a:pt x="130" y="327"/>
                      <a:pt x="157" y="327"/>
                    </a:cubicBezTo>
                    <a:cubicBezTo>
                      <a:pt x="178" y="327"/>
                      <a:pt x="194" y="319"/>
                      <a:pt x="206" y="303"/>
                    </a:cubicBezTo>
                    <a:cubicBezTo>
                      <a:pt x="218" y="287"/>
                      <a:pt x="230" y="255"/>
                      <a:pt x="240" y="207"/>
                    </a:cubicBezTo>
                    <a:lnTo>
                      <a:pt x="247" y="176"/>
                    </a:lnTo>
                    <a:cubicBezTo>
                      <a:pt x="261" y="112"/>
                      <a:pt x="281" y="67"/>
                      <a:pt x="305" y="40"/>
                    </a:cubicBezTo>
                    <a:cubicBezTo>
                      <a:pt x="330" y="14"/>
                      <a:pt x="365" y="0"/>
                      <a:pt x="409" y="0"/>
                    </a:cubicBezTo>
                    <a:cubicBezTo>
                      <a:pt x="460" y="0"/>
                      <a:pt x="500" y="20"/>
                      <a:pt x="529" y="60"/>
                    </a:cubicBezTo>
                    <a:cubicBezTo>
                      <a:pt x="559" y="100"/>
                      <a:pt x="573" y="156"/>
                      <a:pt x="573" y="226"/>
                    </a:cubicBezTo>
                    <a:cubicBezTo>
                      <a:pt x="573" y="256"/>
                      <a:pt x="570" y="286"/>
                      <a:pt x="565" y="318"/>
                    </a:cubicBezTo>
                    <a:cubicBezTo>
                      <a:pt x="560" y="350"/>
                      <a:pt x="552" y="383"/>
                      <a:pt x="540" y="418"/>
                    </a:cubicBezTo>
                    <a:lnTo>
                      <a:pt x="447" y="418"/>
                    </a:lnTo>
                    <a:cubicBezTo>
                      <a:pt x="465" y="385"/>
                      <a:pt x="478" y="352"/>
                      <a:pt x="486" y="320"/>
                    </a:cubicBezTo>
                    <a:cubicBezTo>
                      <a:pt x="495" y="288"/>
                      <a:pt x="499" y="256"/>
                      <a:pt x="499" y="224"/>
                    </a:cubicBezTo>
                    <a:cubicBezTo>
                      <a:pt x="499" y="182"/>
                      <a:pt x="492" y="149"/>
                      <a:pt x="478" y="126"/>
                    </a:cubicBezTo>
                    <a:cubicBezTo>
                      <a:pt x="464" y="104"/>
                      <a:pt x="443" y="92"/>
                      <a:pt x="416" y="92"/>
                    </a:cubicBezTo>
                    <a:cubicBezTo>
                      <a:pt x="392" y="92"/>
                      <a:pt x="373" y="101"/>
                      <a:pt x="360" y="117"/>
                    </a:cubicBezTo>
                    <a:cubicBezTo>
                      <a:pt x="347" y="133"/>
                      <a:pt x="334" y="169"/>
                      <a:pt x="322" y="225"/>
                    </a:cubicBezTo>
                    <a:lnTo>
                      <a:pt x="315" y="256"/>
                    </a:lnTo>
                    <a:cubicBezTo>
                      <a:pt x="303" y="312"/>
                      <a:pt x="285" y="353"/>
                      <a:pt x="261" y="377"/>
                    </a:cubicBezTo>
                    <a:cubicBezTo>
                      <a:pt x="237" y="402"/>
                      <a:pt x="204" y="414"/>
                      <a:pt x="161" y="414"/>
                    </a:cubicBezTo>
                    <a:cubicBezTo>
                      <a:pt x="110" y="414"/>
                      <a:pt x="70" y="396"/>
                      <a:pt x="42" y="360"/>
                    </a:cubicBezTo>
                    <a:cubicBezTo>
                      <a:pt x="14" y="324"/>
                      <a:pt x="0" y="272"/>
                      <a:pt x="0" y="204"/>
                    </a:cubicBezTo>
                    <a:cubicBezTo>
                      <a:pt x="0" y="171"/>
                      <a:pt x="3" y="140"/>
                      <a:pt x="8" y="110"/>
                    </a:cubicBezTo>
                    <a:cubicBezTo>
                      <a:pt x="13" y="81"/>
                      <a:pt x="20" y="54"/>
                      <a:pt x="2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2" name="Freeform 110">
                <a:extLst>
                  <a:ext uri="{FF2B5EF4-FFF2-40B4-BE49-F238E27FC236}">
                    <a16:creationId xmlns:a16="http://schemas.microsoft.com/office/drawing/2014/main" id="{DD36073C-A8EC-FE4A-85F0-B778132264C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22978" y="447901"/>
                <a:ext cx="52034" cy="25029"/>
              </a:xfrm>
              <a:custGeom>
                <a:avLst/>
                <a:gdLst>
                  <a:gd name="T0" fmla="*/ 0 w 702"/>
                  <a:gd name="T1" fmla="*/ 185 h 341"/>
                  <a:gd name="T2" fmla="*/ 155 w 702"/>
                  <a:gd name="T3" fmla="*/ 185 h 341"/>
                  <a:gd name="T4" fmla="*/ 155 w 702"/>
                  <a:gd name="T5" fmla="*/ 0 h 341"/>
                  <a:gd name="T6" fmla="*/ 225 w 702"/>
                  <a:gd name="T7" fmla="*/ 0 h 341"/>
                  <a:gd name="T8" fmla="*/ 225 w 702"/>
                  <a:gd name="T9" fmla="*/ 185 h 341"/>
                  <a:gd name="T10" fmla="*/ 522 w 702"/>
                  <a:gd name="T11" fmla="*/ 185 h 341"/>
                  <a:gd name="T12" fmla="*/ 608 w 702"/>
                  <a:gd name="T13" fmla="*/ 167 h 341"/>
                  <a:gd name="T14" fmla="*/ 627 w 702"/>
                  <a:gd name="T15" fmla="*/ 92 h 341"/>
                  <a:gd name="T16" fmla="*/ 627 w 702"/>
                  <a:gd name="T17" fmla="*/ 0 h 341"/>
                  <a:gd name="T18" fmla="*/ 702 w 702"/>
                  <a:gd name="T19" fmla="*/ 0 h 341"/>
                  <a:gd name="T20" fmla="*/ 702 w 702"/>
                  <a:gd name="T21" fmla="*/ 92 h 341"/>
                  <a:gd name="T22" fmla="*/ 663 w 702"/>
                  <a:gd name="T23" fmla="*/ 236 h 341"/>
                  <a:gd name="T24" fmla="*/ 522 w 702"/>
                  <a:gd name="T25" fmla="*/ 275 h 341"/>
                  <a:gd name="T26" fmla="*/ 225 w 702"/>
                  <a:gd name="T27" fmla="*/ 275 h 341"/>
                  <a:gd name="T28" fmla="*/ 225 w 702"/>
                  <a:gd name="T29" fmla="*/ 341 h 341"/>
                  <a:gd name="T30" fmla="*/ 155 w 702"/>
                  <a:gd name="T31" fmla="*/ 341 h 341"/>
                  <a:gd name="T32" fmla="*/ 155 w 702"/>
                  <a:gd name="T33" fmla="*/ 275 h 341"/>
                  <a:gd name="T34" fmla="*/ 0 w 702"/>
                  <a:gd name="T35" fmla="*/ 275 h 341"/>
                  <a:gd name="T36" fmla="*/ 0 w 702"/>
                  <a:gd name="T37" fmla="*/ 185 h 3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702" h="341">
                    <a:moveTo>
                      <a:pt x="0" y="185"/>
                    </a:moveTo>
                    <a:lnTo>
                      <a:pt x="155" y="185"/>
                    </a:lnTo>
                    <a:lnTo>
                      <a:pt x="155" y="0"/>
                    </a:lnTo>
                    <a:lnTo>
                      <a:pt x="225" y="0"/>
                    </a:lnTo>
                    <a:lnTo>
                      <a:pt x="225" y="185"/>
                    </a:lnTo>
                    <a:lnTo>
                      <a:pt x="522" y="185"/>
                    </a:lnTo>
                    <a:cubicBezTo>
                      <a:pt x="567" y="185"/>
                      <a:pt x="596" y="179"/>
                      <a:pt x="608" y="167"/>
                    </a:cubicBezTo>
                    <a:cubicBezTo>
                      <a:pt x="621" y="155"/>
                      <a:pt x="627" y="130"/>
                      <a:pt x="627" y="92"/>
                    </a:cubicBezTo>
                    <a:lnTo>
                      <a:pt x="627" y="0"/>
                    </a:lnTo>
                    <a:lnTo>
                      <a:pt x="702" y="0"/>
                    </a:lnTo>
                    <a:lnTo>
                      <a:pt x="702" y="92"/>
                    </a:lnTo>
                    <a:cubicBezTo>
                      <a:pt x="702" y="162"/>
                      <a:pt x="689" y="210"/>
                      <a:pt x="663" y="236"/>
                    </a:cubicBezTo>
                    <a:cubicBezTo>
                      <a:pt x="637" y="262"/>
                      <a:pt x="590" y="275"/>
                      <a:pt x="522" y="275"/>
                    </a:cubicBezTo>
                    <a:lnTo>
                      <a:pt x="225" y="275"/>
                    </a:lnTo>
                    <a:lnTo>
                      <a:pt x="225" y="341"/>
                    </a:lnTo>
                    <a:lnTo>
                      <a:pt x="155" y="341"/>
                    </a:lnTo>
                    <a:lnTo>
                      <a:pt x="155" y="275"/>
                    </a:lnTo>
                    <a:lnTo>
                      <a:pt x="0" y="275"/>
                    </a:lnTo>
                    <a:lnTo>
                      <a:pt x="0" y="185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3" name="Rectangle 111 2">
                <a:extLst>
                  <a:ext uri="{FF2B5EF4-FFF2-40B4-BE49-F238E27FC236}">
                    <a16:creationId xmlns:a16="http://schemas.microsoft.com/office/drawing/2014/main" id="{802D2DD6-87FC-5A0C-8F41-7558879FE3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65790" y="430117"/>
                <a:ext cx="9221" cy="7904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4" name="Freeform 112">
                <a:extLst>
                  <a:ext uri="{FF2B5EF4-FFF2-40B4-BE49-F238E27FC236}">
                    <a16:creationId xmlns:a16="http://schemas.microsoft.com/office/drawing/2014/main" id="{40CAA0DA-FD8C-77AE-D3E9-B17D7E1437A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18367" y="374790"/>
                <a:ext cx="66524" cy="17125"/>
              </a:xfrm>
              <a:custGeom>
                <a:avLst/>
                <a:gdLst>
                  <a:gd name="T0" fmla="*/ 0 w 890"/>
                  <a:gd name="T1" fmla="*/ 0 h 224"/>
                  <a:gd name="T2" fmla="*/ 223 w 890"/>
                  <a:gd name="T3" fmla="*/ 97 h 224"/>
                  <a:gd name="T4" fmla="*/ 445 w 890"/>
                  <a:gd name="T5" fmla="*/ 129 h 224"/>
                  <a:gd name="T6" fmla="*/ 668 w 890"/>
                  <a:gd name="T7" fmla="*/ 97 h 224"/>
                  <a:gd name="T8" fmla="*/ 890 w 890"/>
                  <a:gd name="T9" fmla="*/ 0 h 224"/>
                  <a:gd name="T10" fmla="*/ 890 w 890"/>
                  <a:gd name="T11" fmla="*/ 78 h 224"/>
                  <a:gd name="T12" fmla="*/ 665 w 890"/>
                  <a:gd name="T13" fmla="*/ 188 h 224"/>
                  <a:gd name="T14" fmla="*/ 445 w 890"/>
                  <a:gd name="T15" fmla="*/ 224 h 224"/>
                  <a:gd name="T16" fmla="*/ 226 w 890"/>
                  <a:gd name="T17" fmla="*/ 188 h 224"/>
                  <a:gd name="T18" fmla="*/ 0 w 890"/>
                  <a:gd name="T19" fmla="*/ 78 h 224"/>
                  <a:gd name="T20" fmla="*/ 0 w 890"/>
                  <a:gd name="T21" fmla="*/ 0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0"/>
                    </a:moveTo>
                    <a:cubicBezTo>
                      <a:pt x="76" y="44"/>
                      <a:pt x="150" y="76"/>
                      <a:pt x="223" y="97"/>
                    </a:cubicBezTo>
                    <a:cubicBezTo>
                      <a:pt x="296" y="119"/>
                      <a:pt x="370" y="129"/>
                      <a:pt x="445" y="129"/>
                    </a:cubicBezTo>
                    <a:cubicBezTo>
                      <a:pt x="521" y="129"/>
                      <a:pt x="595" y="119"/>
                      <a:pt x="668" y="97"/>
                    </a:cubicBezTo>
                    <a:cubicBezTo>
                      <a:pt x="742" y="76"/>
                      <a:pt x="815" y="44"/>
                      <a:pt x="890" y="0"/>
                    </a:cubicBezTo>
                    <a:lnTo>
                      <a:pt x="890" y="78"/>
                    </a:lnTo>
                    <a:cubicBezTo>
                      <a:pt x="813" y="127"/>
                      <a:pt x="739" y="164"/>
                      <a:pt x="665" y="188"/>
                    </a:cubicBezTo>
                    <a:cubicBezTo>
                      <a:pt x="591" y="212"/>
                      <a:pt x="518" y="224"/>
                      <a:pt x="445" y="224"/>
                    </a:cubicBezTo>
                    <a:cubicBezTo>
                      <a:pt x="373" y="224"/>
                      <a:pt x="300" y="212"/>
                      <a:pt x="226" y="188"/>
                    </a:cubicBezTo>
                    <a:cubicBezTo>
                      <a:pt x="152" y="164"/>
                      <a:pt x="77" y="128"/>
                      <a:pt x="0" y="78"/>
                    </a:cubicBez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5" name="Freeform 113">
                <a:extLst>
                  <a:ext uri="{FF2B5EF4-FFF2-40B4-BE49-F238E27FC236}">
                    <a16:creationId xmlns:a16="http://schemas.microsoft.com/office/drawing/2014/main" id="{3B5EC28D-FB4B-2DCC-F1BB-905FB3B1059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33516" y="254916"/>
                <a:ext cx="41495" cy="59937"/>
              </a:xfrm>
              <a:custGeom>
                <a:avLst/>
                <a:gdLst>
                  <a:gd name="T0" fmla="*/ 118 w 560"/>
                  <a:gd name="T1" fmla="*/ 369 h 798"/>
                  <a:gd name="T2" fmla="*/ 29 w 560"/>
                  <a:gd name="T3" fmla="*/ 289 h 798"/>
                  <a:gd name="T4" fmla="*/ 0 w 560"/>
                  <a:gd name="T5" fmla="*/ 178 h 798"/>
                  <a:gd name="T6" fmla="*/ 60 w 560"/>
                  <a:gd name="T7" fmla="*/ 47 h 798"/>
                  <a:gd name="T8" fmla="*/ 230 w 560"/>
                  <a:gd name="T9" fmla="*/ 0 h 798"/>
                  <a:gd name="T10" fmla="*/ 560 w 560"/>
                  <a:gd name="T11" fmla="*/ 0 h 798"/>
                  <a:gd name="T12" fmla="*/ 560 w 560"/>
                  <a:gd name="T13" fmla="*/ 90 h 798"/>
                  <a:gd name="T14" fmla="*/ 233 w 560"/>
                  <a:gd name="T15" fmla="*/ 90 h 798"/>
                  <a:gd name="T16" fmla="*/ 116 w 560"/>
                  <a:gd name="T17" fmla="*/ 118 h 798"/>
                  <a:gd name="T18" fmla="*/ 78 w 560"/>
                  <a:gd name="T19" fmla="*/ 203 h 798"/>
                  <a:gd name="T20" fmla="*/ 125 w 560"/>
                  <a:gd name="T21" fmla="*/ 314 h 798"/>
                  <a:gd name="T22" fmla="*/ 251 w 560"/>
                  <a:gd name="T23" fmla="*/ 354 h 798"/>
                  <a:gd name="T24" fmla="*/ 560 w 560"/>
                  <a:gd name="T25" fmla="*/ 354 h 798"/>
                  <a:gd name="T26" fmla="*/ 560 w 560"/>
                  <a:gd name="T27" fmla="*/ 444 h 798"/>
                  <a:gd name="T28" fmla="*/ 233 w 560"/>
                  <a:gd name="T29" fmla="*/ 444 h 798"/>
                  <a:gd name="T30" fmla="*/ 116 w 560"/>
                  <a:gd name="T31" fmla="*/ 472 h 798"/>
                  <a:gd name="T32" fmla="*/ 78 w 560"/>
                  <a:gd name="T33" fmla="*/ 558 h 798"/>
                  <a:gd name="T34" fmla="*/ 125 w 560"/>
                  <a:gd name="T35" fmla="*/ 668 h 798"/>
                  <a:gd name="T36" fmla="*/ 251 w 560"/>
                  <a:gd name="T37" fmla="*/ 708 h 798"/>
                  <a:gd name="T38" fmla="*/ 560 w 560"/>
                  <a:gd name="T39" fmla="*/ 708 h 798"/>
                  <a:gd name="T40" fmla="*/ 560 w 560"/>
                  <a:gd name="T41" fmla="*/ 798 h 798"/>
                  <a:gd name="T42" fmla="*/ 13 w 560"/>
                  <a:gd name="T43" fmla="*/ 798 h 798"/>
                  <a:gd name="T44" fmla="*/ 13 w 560"/>
                  <a:gd name="T45" fmla="*/ 708 h 798"/>
                  <a:gd name="T46" fmla="*/ 98 w 560"/>
                  <a:gd name="T47" fmla="*/ 708 h 798"/>
                  <a:gd name="T48" fmla="*/ 24 w 560"/>
                  <a:gd name="T49" fmla="*/ 634 h 798"/>
                  <a:gd name="T50" fmla="*/ 0 w 560"/>
                  <a:gd name="T51" fmla="*/ 532 h 798"/>
                  <a:gd name="T52" fmla="*/ 30 w 560"/>
                  <a:gd name="T53" fmla="*/ 431 h 798"/>
                  <a:gd name="T54" fmla="*/ 118 w 560"/>
                  <a:gd name="T55" fmla="*/ 369 h 7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560" h="798">
                    <a:moveTo>
                      <a:pt x="118" y="369"/>
                    </a:moveTo>
                    <a:cubicBezTo>
                      <a:pt x="78" y="347"/>
                      <a:pt x="49" y="320"/>
                      <a:pt x="29" y="289"/>
                    </a:cubicBezTo>
                    <a:cubicBezTo>
                      <a:pt x="10" y="258"/>
                      <a:pt x="0" y="221"/>
                      <a:pt x="0" y="178"/>
                    </a:cubicBezTo>
                    <a:cubicBezTo>
                      <a:pt x="0" y="122"/>
                      <a:pt x="20" y="78"/>
                      <a:pt x="60" y="47"/>
                    </a:cubicBezTo>
                    <a:cubicBezTo>
                      <a:pt x="100" y="16"/>
                      <a:pt x="157" y="0"/>
                      <a:pt x="230" y="0"/>
                    </a:cubicBezTo>
                    <a:lnTo>
                      <a:pt x="560" y="0"/>
                    </a:lnTo>
                    <a:lnTo>
                      <a:pt x="560" y="90"/>
                    </a:lnTo>
                    <a:lnTo>
                      <a:pt x="233" y="90"/>
                    </a:lnTo>
                    <a:cubicBezTo>
                      <a:pt x="181" y="90"/>
                      <a:pt x="142" y="100"/>
                      <a:pt x="116" y="118"/>
                    </a:cubicBezTo>
                    <a:cubicBezTo>
                      <a:pt x="91" y="137"/>
                      <a:pt x="78" y="165"/>
                      <a:pt x="78" y="203"/>
                    </a:cubicBezTo>
                    <a:cubicBezTo>
                      <a:pt x="78" y="250"/>
                      <a:pt x="94" y="287"/>
                      <a:pt x="125" y="314"/>
                    </a:cubicBezTo>
                    <a:cubicBezTo>
                      <a:pt x="156" y="341"/>
                      <a:pt x="198" y="354"/>
                      <a:pt x="251" y="354"/>
                    </a:cubicBezTo>
                    <a:lnTo>
                      <a:pt x="560" y="354"/>
                    </a:lnTo>
                    <a:lnTo>
                      <a:pt x="560" y="444"/>
                    </a:lnTo>
                    <a:lnTo>
                      <a:pt x="233" y="444"/>
                    </a:lnTo>
                    <a:cubicBezTo>
                      <a:pt x="181" y="444"/>
                      <a:pt x="142" y="454"/>
                      <a:pt x="116" y="472"/>
                    </a:cubicBezTo>
                    <a:cubicBezTo>
                      <a:pt x="91" y="491"/>
                      <a:pt x="78" y="520"/>
                      <a:pt x="78" y="558"/>
                    </a:cubicBezTo>
                    <a:cubicBezTo>
                      <a:pt x="78" y="604"/>
                      <a:pt x="94" y="641"/>
                      <a:pt x="125" y="668"/>
                    </a:cubicBezTo>
                    <a:cubicBezTo>
                      <a:pt x="156" y="695"/>
                      <a:pt x="198" y="708"/>
                      <a:pt x="251" y="708"/>
                    </a:cubicBezTo>
                    <a:lnTo>
                      <a:pt x="560" y="708"/>
                    </a:lnTo>
                    <a:lnTo>
                      <a:pt x="560" y="798"/>
                    </a:lnTo>
                    <a:lnTo>
                      <a:pt x="13" y="798"/>
                    </a:lnTo>
                    <a:lnTo>
                      <a:pt x="13" y="708"/>
                    </a:lnTo>
                    <a:lnTo>
                      <a:pt x="98" y="708"/>
                    </a:lnTo>
                    <a:cubicBezTo>
                      <a:pt x="65" y="688"/>
                      <a:pt x="40" y="663"/>
                      <a:pt x="24" y="634"/>
                    </a:cubicBezTo>
                    <a:cubicBezTo>
                      <a:pt x="8" y="606"/>
                      <a:pt x="0" y="572"/>
                      <a:pt x="0" y="532"/>
                    </a:cubicBezTo>
                    <a:cubicBezTo>
                      <a:pt x="0" y="492"/>
                      <a:pt x="10" y="459"/>
                      <a:pt x="30" y="431"/>
                    </a:cubicBezTo>
                    <a:cubicBezTo>
                      <a:pt x="50" y="403"/>
                      <a:pt x="80" y="383"/>
                      <a:pt x="118" y="36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6" name="Freeform 114">
                <a:extLst>
                  <a:ext uri="{FF2B5EF4-FFF2-40B4-BE49-F238E27FC236}">
                    <a16:creationId xmlns:a16="http://schemas.microsoft.com/office/drawing/2014/main" id="{59DE073D-119A-E980-56DB-AD961978D76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18367" y="225935"/>
                <a:ext cx="66524" cy="16466"/>
              </a:xfrm>
              <a:custGeom>
                <a:avLst/>
                <a:gdLst>
                  <a:gd name="T0" fmla="*/ 0 w 890"/>
                  <a:gd name="T1" fmla="*/ 224 h 224"/>
                  <a:gd name="T2" fmla="*/ 0 w 890"/>
                  <a:gd name="T3" fmla="*/ 146 h 224"/>
                  <a:gd name="T4" fmla="*/ 226 w 890"/>
                  <a:gd name="T5" fmla="*/ 37 h 224"/>
                  <a:gd name="T6" fmla="*/ 445 w 890"/>
                  <a:gd name="T7" fmla="*/ 0 h 224"/>
                  <a:gd name="T8" fmla="*/ 665 w 890"/>
                  <a:gd name="T9" fmla="*/ 37 h 224"/>
                  <a:gd name="T10" fmla="*/ 890 w 890"/>
                  <a:gd name="T11" fmla="*/ 146 h 224"/>
                  <a:gd name="T12" fmla="*/ 890 w 890"/>
                  <a:gd name="T13" fmla="*/ 224 h 224"/>
                  <a:gd name="T14" fmla="*/ 668 w 890"/>
                  <a:gd name="T15" fmla="*/ 127 h 224"/>
                  <a:gd name="T16" fmla="*/ 445 w 890"/>
                  <a:gd name="T17" fmla="*/ 95 h 224"/>
                  <a:gd name="T18" fmla="*/ 223 w 890"/>
                  <a:gd name="T19" fmla="*/ 127 h 224"/>
                  <a:gd name="T20" fmla="*/ 0 w 890"/>
                  <a:gd name="T21" fmla="*/ 224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224"/>
                    </a:moveTo>
                    <a:lnTo>
                      <a:pt x="0" y="146"/>
                    </a:lnTo>
                    <a:cubicBezTo>
                      <a:pt x="77" y="98"/>
                      <a:pt x="152" y="61"/>
                      <a:pt x="226" y="37"/>
                    </a:cubicBezTo>
                    <a:cubicBezTo>
                      <a:pt x="300" y="13"/>
                      <a:pt x="373" y="0"/>
                      <a:pt x="445" y="0"/>
                    </a:cubicBezTo>
                    <a:cubicBezTo>
                      <a:pt x="518" y="0"/>
                      <a:pt x="591" y="13"/>
                      <a:pt x="665" y="37"/>
                    </a:cubicBezTo>
                    <a:cubicBezTo>
                      <a:pt x="739" y="61"/>
                      <a:pt x="813" y="98"/>
                      <a:pt x="890" y="146"/>
                    </a:cubicBezTo>
                    <a:lnTo>
                      <a:pt x="890" y="224"/>
                    </a:lnTo>
                    <a:cubicBezTo>
                      <a:pt x="815" y="181"/>
                      <a:pt x="742" y="149"/>
                      <a:pt x="668" y="127"/>
                    </a:cubicBezTo>
                    <a:cubicBezTo>
                      <a:pt x="595" y="106"/>
                      <a:pt x="521" y="95"/>
                      <a:pt x="445" y="95"/>
                    </a:cubicBezTo>
                    <a:cubicBezTo>
                      <a:pt x="370" y="95"/>
                      <a:pt x="296" y="106"/>
                      <a:pt x="223" y="127"/>
                    </a:cubicBezTo>
                    <a:cubicBezTo>
                      <a:pt x="150" y="149"/>
                      <a:pt x="76" y="181"/>
                      <a:pt x="0" y="224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7" name="Freeform 115">
                <a:extLst>
                  <a:ext uri="{FF2B5EF4-FFF2-40B4-BE49-F238E27FC236}">
                    <a16:creationId xmlns:a16="http://schemas.microsoft.com/office/drawing/2014/main" id="{4BCBD1EB-91EE-20A9-CF42-53EC7715BA6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34175" y="323416"/>
                <a:ext cx="56644" cy="39519"/>
              </a:xfrm>
              <a:custGeom>
                <a:avLst/>
                <a:gdLst>
                  <a:gd name="T0" fmla="*/ 754 w 754"/>
                  <a:gd name="T1" fmla="*/ 527 h 527"/>
                  <a:gd name="T2" fmla="*/ 0 w 754"/>
                  <a:gd name="T3" fmla="*/ 527 h 527"/>
                  <a:gd name="T4" fmla="*/ 0 w 754"/>
                  <a:gd name="T5" fmla="*/ 437 h 527"/>
                  <a:gd name="T6" fmla="*/ 340 w 754"/>
                  <a:gd name="T7" fmla="*/ 437 h 527"/>
                  <a:gd name="T8" fmla="*/ 447 w 754"/>
                  <a:gd name="T9" fmla="*/ 404 h 527"/>
                  <a:gd name="T10" fmla="*/ 483 w 754"/>
                  <a:gd name="T11" fmla="*/ 304 h 527"/>
                  <a:gd name="T12" fmla="*/ 442 w 754"/>
                  <a:gd name="T13" fmla="*/ 196 h 527"/>
                  <a:gd name="T14" fmla="*/ 319 w 754"/>
                  <a:gd name="T15" fmla="*/ 159 h 527"/>
                  <a:gd name="T16" fmla="*/ 0 w 754"/>
                  <a:gd name="T17" fmla="*/ 159 h 527"/>
                  <a:gd name="T18" fmla="*/ 0 w 754"/>
                  <a:gd name="T19" fmla="*/ 69 h 527"/>
                  <a:gd name="T20" fmla="*/ 421 w 754"/>
                  <a:gd name="T21" fmla="*/ 69 h 527"/>
                  <a:gd name="T22" fmla="*/ 464 w 754"/>
                  <a:gd name="T23" fmla="*/ 61 h 527"/>
                  <a:gd name="T24" fmla="*/ 478 w 754"/>
                  <a:gd name="T25" fmla="*/ 34 h 527"/>
                  <a:gd name="T26" fmla="*/ 476 w 754"/>
                  <a:gd name="T27" fmla="*/ 22 h 527"/>
                  <a:gd name="T28" fmla="*/ 467 w 754"/>
                  <a:gd name="T29" fmla="*/ 0 h 527"/>
                  <a:gd name="T30" fmla="*/ 539 w 754"/>
                  <a:gd name="T31" fmla="*/ 0 h 527"/>
                  <a:gd name="T32" fmla="*/ 554 w 754"/>
                  <a:gd name="T33" fmla="*/ 38 h 527"/>
                  <a:gd name="T34" fmla="*/ 560 w 754"/>
                  <a:gd name="T35" fmla="*/ 73 h 527"/>
                  <a:gd name="T36" fmla="*/ 542 w 754"/>
                  <a:gd name="T37" fmla="*/ 127 h 527"/>
                  <a:gd name="T38" fmla="*/ 484 w 754"/>
                  <a:gd name="T39" fmla="*/ 154 h 527"/>
                  <a:gd name="T40" fmla="*/ 542 w 754"/>
                  <a:gd name="T41" fmla="*/ 214 h 527"/>
                  <a:gd name="T42" fmla="*/ 560 w 754"/>
                  <a:gd name="T43" fmla="*/ 297 h 527"/>
                  <a:gd name="T44" fmla="*/ 542 w 754"/>
                  <a:gd name="T45" fmla="*/ 382 h 527"/>
                  <a:gd name="T46" fmla="*/ 485 w 754"/>
                  <a:gd name="T47" fmla="*/ 437 h 527"/>
                  <a:gd name="T48" fmla="*/ 754 w 754"/>
                  <a:gd name="T49" fmla="*/ 437 h 527"/>
                  <a:gd name="T50" fmla="*/ 754 w 754"/>
                  <a:gd name="T51" fmla="*/ 527 h 5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</a:cxnLst>
                <a:rect l="0" t="0" r="r" b="b"/>
                <a:pathLst>
                  <a:path w="754" h="527">
                    <a:moveTo>
                      <a:pt x="754" y="527"/>
                    </a:moveTo>
                    <a:lnTo>
                      <a:pt x="0" y="527"/>
                    </a:lnTo>
                    <a:lnTo>
                      <a:pt x="0" y="437"/>
                    </a:lnTo>
                    <a:lnTo>
                      <a:pt x="340" y="437"/>
                    </a:lnTo>
                    <a:cubicBezTo>
                      <a:pt x="388" y="437"/>
                      <a:pt x="423" y="426"/>
                      <a:pt x="447" y="404"/>
                    </a:cubicBezTo>
                    <a:cubicBezTo>
                      <a:pt x="471" y="382"/>
                      <a:pt x="483" y="348"/>
                      <a:pt x="483" y="304"/>
                    </a:cubicBezTo>
                    <a:cubicBezTo>
                      <a:pt x="483" y="256"/>
                      <a:pt x="470" y="220"/>
                      <a:pt x="442" y="196"/>
                    </a:cubicBezTo>
                    <a:cubicBezTo>
                      <a:pt x="415" y="172"/>
                      <a:pt x="374" y="159"/>
                      <a:pt x="319" y="159"/>
                    </a:cubicBezTo>
                    <a:lnTo>
                      <a:pt x="0" y="159"/>
                    </a:lnTo>
                    <a:lnTo>
                      <a:pt x="0" y="69"/>
                    </a:lnTo>
                    <a:lnTo>
                      <a:pt x="421" y="69"/>
                    </a:lnTo>
                    <a:cubicBezTo>
                      <a:pt x="441" y="69"/>
                      <a:pt x="455" y="67"/>
                      <a:pt x="464" y="61"/>
                    </a:cubicBezTo>
                    <a:cubicBezTo>
                      <a:pt x="474" y="55"/>
                      <a:pt x="478" y="46"/>
                      <a:pt x="478" y="34"/>
                    </a:cubicBezTo>
                    <a:cubicBezTo>
                      <a:pt x="478" y="31"/>
                      <a:pt x="478" y="27"/>
                      <a:pt x="476" y="22"/>
                    </a:cubicBezTo>
                    <a:cubicBezTo>
                      <a:pt x="474" y="17"/>
                      <a:pt x="471" y="10"/>
                      <a:pt x="467" y="0"/>
                    </a:cubicBezTo>
                    <a:lnTo>
                      <a:pt x="539" y="0"/>
                    </a:lnTo>
                    <a:cubicBezTo>
                      <a:pt x="546" y="14"/>
                      <a:pt x="550" y="26"/>
                      <a:pt x="554" y="38"/>
                    </a:cubicBezTo>
                    <a:cubicBezTo>
                      <a:pt x="558" y="50"/>
                      <a:pt x="560" y="62"/>
                      <a:pt x="560" y="73"/>
                    </a:cubicBezTo>
                    <a:cubicBezTo>
                      <a:pt x="560" y="96"/>
                      <a:pt x="554" y="114"/>
                      <a:pt x="542" y="127"/>
                    </a:cubicBezTo>
                    <a:cubicBezTo>
                      <a:pt x="530" y="141"/>
                      <a:pt x="510" y="150"/>
                      <a:pt x="484" y="154"/>
                    </a:cubicBezTo>
                    <a:cubicBezTo>
                      <a:pt x="510" y="170"/>
                      <a:pt x="530" y="190"/>
                      <a:pt x="542" y="214"/>
                    </a:cubicBezTo>
                    <a:cubicBezTo>
                      <a:pt x="554" y="238"/>
                      <a:pt x="560" y="265"/>
                      <a:pt x="560" y="297"/>
                    </a:cubicBezTo>
                    <a:cubicBezTo>
                      <a:pt x="560" y="331"/>
                      <a:pt x="554" y="359"/>
                      <a:pt x="542" y="382"/>
                    </a:cubicBezTo>
                    <a:cubicBezTo>
                      <a:pt x="530" y="406"/>
                      <a:pt x="511" y="424"/>
                      <a:pt x="485" y="437"/>
                    </a:cubicBezTo>
                    <a:lnTo>
                      <a:pt x="754" y="437"/>
                    </a:lnTo>
                    <a:lnTo>
                      <a:pt x="754" y="527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pic>
            <p:nvPicPr>
              <p:cNvPr id="1198" name="Picture 116">
                <a:extLst>
                  <a:ext uri="{FF2B5EF4-FFF2-40B4-BE49-F238E27FC236}">
                    <a16:creationId xmlns:a16="http://schemas.microsoft.com/office/drawing/2014/main" id="{4404E0C5-6EC0-B924-21F4-C3CF88B8254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24640" y="84984"/>
                <a:ext cx="912232" cy="8536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199" name="Freeform 117">
                <a:extLst>
                  <a:ext uri="{FF2B5EF4-FFF2-40B4-BE49-F238E27FC236}">
                    <a16:creationId xmlns:a16="http://schemas.microsoft.com/office/drawing/2014/main" id="{33721050-8AB3-24A6-135F-3887CA46BE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829250" y="96840"/>
                <a:ext cx="904328" cy="827925"/>
              </a:xfrm>
              <a:custGeom>
                <a:avLst/>
                <a:gdLst>
                  <a:gd name="T0" fmla="*/ 0 w 12085"/>
                  <a:gd name="T1" fmla="*/ 11055 h 11055"/>
                  <a:gd name="T2" fmla="*/ 345 w 12085"/>
                  <a:gd name="T3" fmla="*/ 10938 h 11055"/>
                  <a:gd name="T4" fmla="*/ 691 w 12085"/>
                  <a:gd name="T5" fmla="*/ 10819 h 11055"/>
                  <a:gd name="T6" fmla="*/ 1036 w 12085"/>
                  <a:gd name="T7" fmla="*/ 10667 h 11055"/>
                  <a:gd name="T8" fmla="*/ 1381 w 12085"/>
                  <a:gd name="T9" fmla="*/ 10445 h 11055"/>
                  <a:gd name="T10" fmla="*/ 1726 w 12085"/>
                  <a:gd name="T11" fmla="*/ 10178 h 11055"/>
                  <a:gd name="T12" fmla="*/ 2072 w 12085"/>
                  <a:gd name="T13" fmla="*/ 9863 h 11055"/>
                  <a:gd name="T14" fmla="*/ 2417 w 12085"/>
                  <a:gd name="T15" fmla="*/ 9510 h 11055"/>
                  <a:gd name="T16" fmla="*/ 2762 w 12085"/>
                  <a:gd name="T17" fmla="*/ 9164 h 11055"/>
                  <a:gd name="T18" fmla="*/ 3108 w 12085"/>
                  <a:gd name="T19" fmla="*/ 8789 h 11055"/>
                  <a:gd name="T20" fmla="*/ 3453 w 12085"/>
                  <a:gd name="T21" fmla="*/ 8384 h 11055"/>
                  <a:gd name="T22" fmla="*/ 3798 w 12085"/>
                  <a:gd name="T23" fmla="*/ 7978 h 11055"/>
                  <a:gd name="T24" fmla="*/ 4143 w 12085"/>
                  <a:gd name="T25" fmla="*/ 7564 h 11055"/>
                  <a:gd name="T26" fmla="*/ 4489 w 12085"/>
                  <a:gd name="T27" fmla="*/ 7171 h 11055"/>
                  <a:gd name="T28" fmla="*/ 4834 w 12085"/>
                  <a:gd name="T29" fmla="*/ 6806 h 11055"/>
                  <a:gd name="T30" fmla="*/ 5179 w 12085"/>
                  <a:gd name="T31" fmla="*/ 6450 h 11055"/>
                  <a:gd name="T32" fmla="*/ 5524 w 12085"/>
                  <a:gd name="T33" fmla="*/ 6125 h 11055"/>
                  <a:gd name="T34" fmla="*/ 5870 w 12085"/>
                  <a:gd name="T35" fmla="*/ 5746 h 11055"/>
                  <a:gd name="T36" fmla="*/ 6215 w 12085"/>
                  <a:gd name="T37" fmla="*/ 5377 h 11055"/>
                  <a:gd name="T38" fmla="*/ 6560 w 12085"/>
                  <a:gd name="T39" fmla="*/ 4995 h 11055"/>
                  <a:gd name="T40" fmla="*/ 6906 w 12085"/>
                  <a:gd name="T41" fmla="*/ 4592 h 11055"/>
                  <a:gd name="T42" fmla="*/ 7251 w 12085"/>
                  <a:gd name="T43" fmla="*/ 4220 h 11055"/>
                  <a:gd name="T44" fmla="*/ 7596 w 12085"/>
                  <a:gd name="T45" fmla="*/ 3851 h 11055"/>
                  <a:gd name="T46" fmla="*/ 7941 w 12085"/>
                  <a:gd name="T47" fmla="*/ 3465 h 11055"/>
                  <a:gd name="T48" fmla="*/ 8287 w 12085"/>
                  <a:gd name="T49" fmla="*/ 3121 h 11055"/>
                  <a:gd name="T50" fmla="*/ 8632 w 12085"/>
                  <a:gd name="T51" fmla="*/ 2763 h 11055"/>
                  <a:gd name="T52" fmla="*/ 8977 w 12085"/>
                  <a:gd name="T53" fmla="*/ 2376 h 11055"/>
                  <a:gd name="T54" fmla="*/ 9323 w 12085"/>
                  <a:gd name="T55" fmla="*/ 1965 h 11055"/>
                  <a:gd name="T56" fmla="*/ 9668 w 12085"/>
                  <a:gd name="T57" fmla="*/ 1584 h 11055"/>
                  <a:gd name="T58" fmla="*/ 10013 w 12085"/>
                  <a:gd name="T59" fmla="*/ 1236 h 11055"/>
                  <a:gd name="T60" fmla="*/ 10358 w 12085"/>
                  <a:gd name="T61" fmla="*/ 935 h 11055"/>
                  <a:gd name="T62" fmla="*/ 10704 w 12085"/>
                  <a:gd name="T63" fmla="*/ 668 h 11055"/>
                  <a:gd name="T64" fmla="*/ 11049 w 12085"/>
                  <a:gd name="T65" fmla="*/ 449 h 11055"/>
                  <a:gd name="T66" fmla="*/ 11394 w 12085"/>
                  <a:gd name="T67" fmla="*/ 257 h 11055"/>
                  <a:gd name="T68" fmla="*/ 11739 w 12085"/>
                  <a:gd name="T69" fmla="*/ 112 h 11055"/>
                  <a:gd name="T70" fmla="*/ 12085 w 12085"/>
                  <a:gd name="T71" fmla="*/ 0 h 110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</a:cxnLst>
                <a:rect l="0" t="0" r="r" b="b"/>
                <a:pathLst>
                  <a:path w="12085" h="11055">
                    <a:moveTo>
                      <a:pt x="0" y="11055"/>
                    </a:moveTo>
                    <a:lnTo>
                      <a:pt x="345" y="10938"/>
                    </a:lnTo>
                    <a:lnTo>
                      <a:pt x="691" y="10819"/>
                    </a:lnTo>
                    <a:lnTo>
                      <a:pt x="1036" y="10667"/>
                    </a:lnTo>
                    <a:lnTo>
                      <a:pt x="1381" y="10445"/>
                    </a:lnTo>
                    <a:lnTo>
                      <a:pt x="1726" y="10178"/>
                    </a:lnTo>
                    <a:lnTo>
                      <a:pt x="2072" y="9863"/>
                    </a:lnTo>
                    <a:lnTo>
                      <a:pt x="2417" y="9510"/>
                    </a:lnTo>
                    <a:lnTo>
                      <a:pt x="2762" y="9164"/>
                    </a:lnTo>
                    <a:lnTo>
                      <a:pt x="3108" y="8789"/>
                    </a:lnTo>
                    <a:lnTo>
                      <a:pt x="3453" y="8384"/>
                    </a:lnTo>
                    <a:lnTo>
                      <a:pt x="3798" y="7978"/>
                    </a:lnTo>
                    <a:lnTo>
                      <a:pt x="4143" y="7564"/>
                    </a:lnTo>
                    <a:lnTo>
                      <a:pt x="4489" y="7171"/>
                    </a:lnTo>
                    <a:lnTo>
                      <a:pt x="4834" y="6806"/>
                    </a:lnTo>
                    <a:lnTo>
                      <a:pt x="5179" y="6450"/>
                    </a:lnTo>
                    <a:lnTo>
                      <a:pt x="5524" y="6125"/>
                    </a:lnTo>
                    <a:lnTo>
                      <a:pt x="5870" y="5746"/>
                    </a:lnTo>
                    <a:lnTo>
                      <a:pt x="6215" y="5377"/>
                    </a:lnTo>
                    <a:lnTo>
                      <a:pt x="6560" y="4995"/>
                    </a:lnTo>
                    <a:lnTo>
                      <a:pt x="6906" y="4592"/>
                    </a:lnTo>
                    <a:lnTo>
                      <a:pt x="7251" y="4220"/>
                    </a:lnTo>
                    <a:lnTo>
                      <a:pt x="7596" y="3851"/>
                    </a:lnTo>
                    <a:lnTo>
                      <a:pt x="7941" y="3465"/>
                    </a:lnTo>
                    <a:lnTo>
                      <a:pt x="8287" y="3121"/>
                    </a:lnTo>
                    <a:lnTo>
                      <a:pt x="8632" y="2763"/>
                    </a:lnTo>
                    <a:lnTo>
                      <a:pt x="8977" y="2376"/>
                    </a:lnTo>
                    <a:lnTo>
                      <a:pt x="9323" y="1965"/>
                    </a:lnTo>
                    <a:lnTo>
                      <a:pt x="9668" y="1584"/>
                    </a:lnTo>
                    <a:lnTo>
                      <a:pt x="10013" y="1236"/>
                    </a:lnTo>
                    <a:lnTo>
                      <a:pt x="10358" y="935"/>
                    </a:lnTo>
                    <a:lnTo>
                      <a:pt x="10704" y="668"/>
                    </a:lnTo>
                    <a:lnTo>
                      <a:pt x="11049" y="449"/>
                    </a:lnTo>
                    <a:lnTo>
                      <a:pt x="11394" y="257"/>
                    </a:lnTo>
                    <a:lnTo>
                      <a:pt x="11739" y="112"/>
                    </a:lnTo>
                    <a:lnTo>
                      <a:pt x="12085" y="0"/>
                    </a:lnTo>
                  </a:path>
                </a:pathLst>
              </a:custGeom>
              <a:noFill/>
              <a:ln w="6350" cap="rnd">
                <a:solidFill>
                  <a:srgbClr val="4C72B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200" name="Freeform 118">
                <a:extLst>
                  <a:ext uri="{FF2B5EF4-FFF2-40B4-BE49-F238E27FC236}">
                    <a16:creationId xmlns:a16="http://schemas.microsoft.com/office/drawing/2014/main" id="{26621823-602F-4E77-1888-00FDF445AF4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827275" y="54028"/>
                <a:ext cx="909598" cy="910915"/>
              </a:xfrm>
              <a:custGeom>
                <a:avLst/>
                <a:gdLst>
                  <a:gd name="T0" fmla="*/ 0 w 1381"/>
                  <a:gd name="T1" fmla="*/ 1375 h 1383"/>
                  <a:gd name="T2" fmla="*/ 72 w 1381"/>
                  <a:gd name="T3" fmla="*/ 1302 h 1383"/>
                  <a:gd name="T4" fmla="*/ 122 w 1381"/>
                  <a:gd name="T5" fmla="*/ 1268 h 1383"/>
                  <a:gd name="T6" fmla="*/ 135 w 1381"/>
                  <a:gd name="T7" fmla="*/ 1255 h 1383"/>
                  <a:gd name="T8" fmla="*/ 156 w 1381"/>
                  <a:gd name="T9" fmla="*/ 1218 h 1383"/>
                  <a:gd name="T10" fmla="*/ 204 w 1381"/>
                  <a:gd name="T11" fmla="*/ 1186 h 1383"/>
                  <a:gd name="T12" fmla="*/ 170 w 1381"/>
                  <a:gd name="T13" fmla="*/ 1204 h 1383"/>
                  <a:gd name="T14" fmla="*/ 250 w 1381"/>
                  <a:gd name="T15" fmla="*/ 1140 h 1383"/>
                  <a:gd name="T16" fmla="*/ 221 w 1381"/>
                  <a:gd name="T17" fmla="*/ 1170 h 1383"/>
                  <a:gd name="T18" fmla="*/ 285 w 1381"/>
                  <a:gd name="T19" fmla="*/ 1089 h 1383"/>
                  <a:gd name="T20" fmla="*/ 306 w 1381"/>
                  <a:gd name="T21" fmla="*/ 1084 h 1383"/>
                  <a:gd name="T22" fmla="*/ 314 w 1381"/>
                  <a:gd name="T23" fmla="*/ 1061 h 1383"/>
                  <a:gd name="T24" fmla="*/ 361 w 1381"/>
                  <a:gd name="T25" fmla="*/ 1029 h 1383"/>
                  <a:gd name="T26" fmla="*/ 340 w 1381"/>
                  <a:gd name="T27" fmla="*/ 1034 h 1383"/>
                  <a:gd name="T28" fmla="*/ 421 w 1381"/>
                  <a:gd name="T29" fmla="*/ 969 h 1383"/>
                  <a:gd name="T30" fmla="*/ 391 w 1381"/>
                  <a:gd name="T31" fmla="*/ 999 h 1383"/>
                  <a:gd name="T32" fmla="*/ 455 w 1381"/>
                  <a:gd name="T33" fmla="*/ 918 h 1383"/>
                  <a:gd name="T34" fmla="*/ 476 w 1381"/>
                  <a:gd name="T35" fmla="*/ 914 h 1383"/>
                  <a:gd name="T36" fmla="*/ 471 w 1381"/>
                  <a:gd name="T37" fmla="*/ 903 h 1383"/>
                  <a:gd name="T38" fmla="*/ 549 w 1381"/>
                  <a:gd name="T39" fmla="*/ 841 h 1383"/>
                  <a:gd name="T40" fmla="*/ 561 w 1381"/>
                  <a:gd name="T41" fmla="*/ 828 h 1383"/>
                  <a:gd name="T42" fmla="*/ 561 w 1381"/>
                  <a:gd name="T43" fmla="*/ 828 h 1383"/>
                  <a:gd name="T44" fmla="*/ 596 w 1381"/>
                  <a:gd name="T45" fmla="*/ 778 h 1383"/>
                  <a:gd name="T46" fmla="*/ 676 w 1381"/>
                  <a:gd name="T47" fmla="*/ 714 h 1383"/>
                  <a:gd name="T48" fmla="*/ 647 w 1381"/>
                  <a:gd name="T49" fmla="*/ 743 h 1383"/>
                  <a:gd name="T50" fmla="*/ 711 w 1381"/>
                  <a:gd name="T51" fmla="*/ 663 h 1383"/>
                  <a:gd name="T52" fmla="*/ 732 w 1381"/>
                  <a:gd name="T53" fmla="*/ 658 h 1383"/>
                  <a:gd name="T54" fmla="*/ 745 w 1381"/>
                  <a:gd name="T55" fmla="*/ 628 h 1383"/>
                  <a:gd name="T56" fmla="*/ 792 w 1381"/>
                  <a:gd name="T57" fmla="*/ 597 h 1383"/>
                  <a:gd name="T58" fmla="*/ 767 w 1381"/>
                  <a:gd name="T59" fmla="*/ 607 h 1383"/>
                  <a:gd name="T60" fmla="*/ 847 w 1381"/>
                  <a:gd name="T61" fmla="*/ 543 h 1383"/>
                  <a:gd name="T62" fmla="*/ 817 w 1381"/>
                  <a:gd name="T63" fmla="*/ 573 h 1383"/>
                  <a:gd name="T64" fmla="*/ 882 w 1381"/>
                  <a:gd name="T65" fmla="*/ 492 h 1383"/>
                  <a:gd name="T66" fmla="*/ 902 w 1381"/>
                  <a:gd name="T67" fmla="*/ 487 h 1383"/>
                  <a:gd name="T68" fmla="*/ 903 w 1381"/>
                  <a:gd name="T69" fmla="*/ 471 h 1383"/>
                  <a:gd name="T70" fmla="*/ 950 w 1381"/>
                  <a:gd name="T71" fmla="*/ 440 h 1383"/>
                  <a:gd name="T72" fmla="*/ 937 w 1381"/>
                  <a:gd name="T73" fmla="*/ 437 h 1383"/>
                  <a:gd name="T74" fmla="*/ 1017 w 1381"/>
                  <a:gd name="T75" fmla="*/ 372 h 1383"/>
                  <a:gd name="T76" fmla="*/ 988 w 1381"/>
                  <a:gd name="T77" fmla="*/ 402 h 1383"/>
                  <a:gd name="T78" fmla="*/ 1022 w 1381"/>
                  <a:gd name="T79" fmla="*/ 351 h 1383"/>
                  <a:gd name="T80" fmla="*/ 1095 w 1381"/>
                  <a:gd name="T81" fmla="*/ 279 h 1383"/>
                  <a:gd name="T82" fmla="*/ 1145 w 1381"/>
                  <a:gd name="T83" fmla="*/ 244 h 1383"/>
                  <a:gd name="T84" fmla="*/ 1158 w 1381"/>
                  <a:gd name="T85" fmla="*/ 232 h 1383"/>
                  <a:gd name="T86" fmla="*/ 1177 w 1381"/>
                  <a:gd name="T87" fmla="*/ 196 h 1383"/>
                  <a:gd name="T88" fmla="*/ 1224 w 1381"/>
                  <a:gd name="T89" fmla="*/ 165 h 1383"/>
                  <a:gd name="T90" fmla="*/ 1192 w 1381"/>
                  <a:gd name="T91" fmla="*/ 181 h 1383"/>
                  <a:gd name="T92" fmla="*/ 1273 w 1381"/>
                  <a:gd name="T93" fmla="*/ 116 h 1383"/>
                  <a:gd name="T94" fmla="*/ 1243 w 1381"/>
                  <a:gd name="T95" fmla="*/ 146 h 1383"/>
                  <a:gd name="T96" fmla="*/ 1307 w 1381"/>
                  <a:gd name="T97" fmla="*/ 66 h 1383"/>
                  <a:gd name="T98" fmla="*/ 1328 w 1381"/>
                  <a:gd name="T99" fmla="*/ 61 h 1383"/>
                  <a:gd name="T100" fmla="*/ 1334 w 1381"/>
                  <a:gd name="T101" fmla="*/ 39 h 1383"/>
                  <a:gd name="T102" fmla="*/ 1381 w 1381"/>
                  <a:gd name="T103" fmla="*/ 8 h 13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</a:cxnLst>
                <a:rect l="0" t="0" r="r" b="b"/>
                <a:pathLst>
                  <a:path w="1381" h="1383">
                    <a:moveTo>
                      <a:pt x="8" y="1383"/>
                    </a:moveTo>
                    <a:lnTo>
                      <a:pt x="37" y="1353"/>
                    </a:lnTo>
                    <a:lnTo>
                      <a:pt x="29" y="1345"/>
                    </a:lnTo>
                    <a:lnTo>
                      <a:pt x="0" y="1375"/>
                    </a:lnTo>
                    <a:lnTo>
                      <a:pt x="8" y="1383"/>
                    </a:lnTo>
                    <a:close/>
                    <a:moveTo>
                      <a:pt x="50" y="1340"/>
                    </a:moveTo>
                    <a:lnTo>
                      <a:pt x="80" y="1310"/>
                    </a:lnTo>
                    <a:lnTo>
                      <a:pt x="72" y="1302"/>
                    </a:lnTo>
                    <a:lnTo>
                      <a:pt x="42" y="1332"/>
                    </a:lnTo>
                    <a:lnTo>
                      <a:pt x="50" y="1340"/>
                    </a:lnTo>
                    <a:close/>
                    <a:moveTo>
                      <a:pt x="93" y="1297"/>
                    </a:moveTo>
                    <a:lnTo>
                      <a:pt x="122" y="1268"/>
                    </a:lnTo>
                    <a:lnTo>
                      <a:pt x="115" y="1259"/>
                    </a:lnTo>
                    <a:lnTo>
                      <a:pt x="85" y="1289"/>
                    </a:lnTo>
                    <a:lnTo>
                      <a:pt x="93" y="1297"/>
                    </a:lnTo>
                    <a:close/>
                    <a:moveTo>
                      <a:pt x="135" y="1255"/>
                    </a:moveTo>
                    <a:lnTo>
                      <a:pt x="165" y="1226"/>
                    </a:lnTo>
                    <a:lnTo>
                      <a:pt x="165" y="1225"/>
                    </a:lnTo>
                    <a:lnTo>
                      <a:pt x="157" y="1217"/>
                    </a:lnTo>
                    <a:lnTo>
                      <a:pt x="156" y="1218"/>
                    </a:lnTo>
                    <a:lnTo>
                      <a:pt x="127" y="1247"/>
                    </a:lnTo>
                    <a:lnTo>
                      <a:pt x="135" y="1255"/>
                    </a:lnTo>
                    <a:close/>
                    <a:moveTo>
                      <a:pt x="178" y="1212"/>
                    </a:moveTo>
                    <a:lnTo>
                      <a:pt x="204" y="1186"/>
                    </a:lnTo>
                    <a:lnTo>
                      <a:pt x="208" y="1182"/>
                    </a:lnTo>
                    <a:lnTo>
                      <a:pt x="200" y="1174"/>
                    </a:lnTo>
                    <a:lnTo>
                      <a:pt x="196" y="1178"/>
                    </a:lnTo>
                    <a:lnTo>
                      <a:pt x="170" y="1204"/>
                    </a:lnTo>
                    <a:lnTo>
                      <a:pt x="178" y="1212"/>
                    </a:lnTo>
                    <a:close/>
                    <a:moveTo>
                      <a:pt x="221" y="1170"/>
                    </a:moveTo>
                    <a:lnTo>
                      <a:pt x="243" y="1147"/>
                    </a:lnTo>
                    <a:lnTo>
                      <a:pt x="250" y="1140"/>
                    </a:lnTo>
                    <a:lnTo>
                      <a:pt x="242" y="1132"/>
                    </a:lnTo>
                    <a:lnTo>
                      <a:pt x="235" y="1139"/>
                    </a:lnTo>
                    <a:lnTo>
                      <a:pt x="212" y="1161"/>
                    </a:lnTo>
                    <a:lnTo>
                      <a:pt x="221" y="1170"/>
                    </a:lnTo>
                    <a:close/>
                    <a:moveTo>
                      <a:pt x="263" y="1127"/>
                    </a:moveTo>
                    <a:lnTo>
                      <a:pt x="282" y="1108"/>
                    </a:lnTo>
                    <a:lnTo>
                      <a:pt x="293" y="1097"/>
                    </a:lnTo>
                    <a:lnTo>
                      <a:pt x="285" y="1089"/>
                    </a:lnTo>
                    <a:lnTo>
                      <a:pt x="274" y="1100"/>
                    </a:lnTo>
                    <a:lnTo>
                      <a:pt x="255" y="1119"/>
                    </a:lnTo>
                    <a:lnTo>
                      <a:pt x="263" y="1127"/>
                    </a:lnTo>
                    <a:close/>
                    <a:moveTo>
                      <a:pt x="306" y="1084"/>
                    </a:moveTo>
                    <a:lnTo>
                      <a:pt x="321" y="1068"/>
                    </a:lnTo>
                    <a:lnTo>
                      <a:pt x="336" y="1055"/>
                    </a:lnTo>
                    <a:lnTo>
                      <a:pt x="327" y="1046"/>
                    </a:lnTo>
                    <a:lnTo>
                      <a:pt x="314" y="1061"/>
                    </a:lnTo>
                    <a:lnTo>
                      <a:pt x="298" y="1076"/>
                    </a:lnTo>
                    <a:lnTo>
                      <a:pt x="306" y="1084"/>
                    </a:lnTo>
                    <a:close/>
                    <a:moveTo>
                      <a:pt x="348" y="1042"/>
                    </a:moveTo>
                    <a:lnTo>
                      <a:pt x="361" y="1029"/>
                    </a:lnTo>
                    <a:lnTo>
                      <a:pt x="378" y="1012"/>
                    </a:lnTo>
                    <a:lnTo>
                      <a:pt x="370" y="1004"/>
                    </a:lnTo>
                    <a:lnTo>
                      <a:pt x="353" y="1021"/>
                    </a:lnTo>
                    <a:lnTo>
                      <a:pt x="340" y="1034"/>
                    </a:lnTo>
                    <a:lnTo>
                      <a:pt x="348" y="1042"/>
                    </a:lnTo>
                    <a:close/>
                    <a:moveTo>
                      <a:pt x="391" y="999"/>
                    </a:moveTo>
                    <a:lnTo>
                      <a:pt x="400" y="990"/>
                    </a:lnTo>
                    <a:lnTo>
                      <a:pt x="421" y="969"/>
                    </a:lnTo>
                    <a:lnTo>
                      <a:pt x="413" y="961"/>
                    </a:lnTo>
                    <a:lnTo>
                      <a:pt x="392" y="982"/>
                    </a:lnTo>
                    <a:lnTo>
                      <a:pt x="383" y="991"/>
                    </a:lnTo>
                    <a:lnTo>
                      <a:pt x="391" y="999"/>
                    </a:lnTo>
                    <a:close/>
                    <a:moveTo>
                      <a:pt x="434" y="956"/>
                    </a:moveTo>
                    <a:lnTo>
                      <a:pt x="439" y="950"/>
                    </a:lnTo>
                    <a:lnTo>
                      <a:pt x="463" y="927"/>
                    </a:lnTo>
                    <a:lnTo>
                      <a:pt x="455" y="918"/>
                    </a:lnTo>
                    <a:lnTo>
                      <a:pt x="431" y="943"/>
                    </a:lnTo>
                    <a:lnTo>
                      <a:pt x="425" y="948"/>
                    </a:lnTo>
                    <a:lnTo>
                      <a:pt x="434" y="956"/>
                    </a:lnTo>
                    <a:close/>
                    <a:moveTo>
                      <a:pt x="476" y="914"/>
                    </a:moveTo>
                    <a:lnTo>
                      <a:pt x="479" y="911"/>
                    </a:lnTo>
                    <a:lnTo>
                      <a:pt x="506" y="884"/>
                    </a:lnTo>
                    <a:lnTo>
                      <a:pt x="498" y="876"/>
                    </a:lnTo>
                    <a:lnTo>
                      <a:pt x="471" y="903"/>
                    </a:lnTo>
                    <a:lnTo>
                      <a:pt x="468" y="906"/>
                    </a:lnTo>
                    <a:lnTo>
                      <a:pt x="476" y="914"/>
                    </a:lnTo>
                    <a:close/>
                    <a:moveTo>
                      <a:pt x="519" y="871"/>
                    </a:moveTo>
                    <a:lnTo>
                      <a:pt x="549" y="841"/>
                    </a:lnTo>
                    <a:lnTo>
                      <a:pt x="540" y="833"/>
                    </a:lnTo>
                    <a:lnTo>
                      <a:pt x="511" y="863"/>
                    </a:lnTo>
                    <a:lnTo>
                      <a:pt x="519" y="871"/>
                    </a:lnTo>
                    <a:close/>
                    <a:moveTo>
                      <a:pt x="561" y="828"/>
                    </a:moveTo>
                    <a:lnTo>
                      <a:pt x="591" y="799"/>
                    </a:lnTo>
                    <a:lnTo>
                      <a:pt x="583" y="791"/>
                    </a:lnTo>
                    <a:lnTo>
                      <a:pt x="553" y="820"/>
                    </a:lnTo>
                    <a:lnTo>
                      <a:pt x="561" y="828"/>
                    </a:lnTo>
                    <a:close/>
                    <a:moveTo>
                      <a:pt x="604" y="786"/>
                    </a:moveTo>
                    <a:lnTo>
                      <a:pt x="634" y="756"/>
                    </a:lnTo>
                    <a:lnTo>
                      <a:pt x="626" y="748"/>
                    </a:lnTo>
                    <a:lnTo>
                      <a:pt x="596" y="778"/>
                    </a:lnTo>
                    <a:lnTo>
                      <a:pt x="604" y="786"/>
                    </a:lnTo>
                    <a:close/>
                    <a:moveTo>
                      <a:pt x="647" y="743"/>
                    </a:moveTo>
                    <a:lnTo>
                      <a:pt x="675" y="715"/>
                    </a:lnTo>
                    <a:lnTo>
                      <a:pt x="676" y="714"/>
                    </a:lnTo>
                    <a:lnTo>
                      <a:pt x="668" y="705"/>
                    </a:lnTo>
                    <a:lnTo>
                      <a:pt x="667" y="707"/>
                    </a:lnTo>
                    <a:lnTo>
                      <a:pt x="639" y="735"/>
                    </a:lnTo>
                    <a:lnTo>
                      <a:pt x="647" y="743"/>
                    </a:lnTo>
                    <a:close/>
                    <a:moveTo>
                      <a:pt x="689" y="700"/>
                    </a:moveTo>
                    <a:lnTo>
                      <a:pt x="714" y="676"/>
                    </a:lnTo>
                    <a:lnTo>
                      <a:pt x="719" y="671"/>
                    </a:lnTo>
                    <a:lnTo>
                      <a:pt x="711" y="663"/>
                    </a:lnTo>
                    <a:lnTo>
                      <a:pt x="706" y="668"/>
                    </a:lnTo>
                    <a:lnTo>
                      <a:pt x="681" y="693"/>
                    </a:lnTo>
                    <a:lnTo>
                      <a:pt x="689" y="700"/>
                    </a:lnTo>
                    <a:close/>
                    <a:moveTo>
                      <a:pt x="732" y="658"/>
                    </a:moveTo>
                    <a:lnTo>
                      <a:pt x="753" y="636"/>
                    </a:lnTo>
                    <a:lnTo>
                      <a:pt x="762" y="628"/>
                    </a:lnTo>
                    <a:lnTo>
                      <a:pt x="753" y="620"/>
                    </a:lnTo>
                    <a:lnTo>
                      <a:pt x="745" y="628"/>
                    </a:lnTo>
                    <a:lnTo>
                      <a:pt x="724" y="650"/>
                    </a:lnTo>
                    <a:lnTo>
                      <a:pt x="732" y="658"/>
                    </a:lnTo>
                    <a:close/>
                    <a:moveTo>
                      <a:pt x="774" y="615"/>
                    </a:moveTo>
                    <a:lnTo>
                      <a:pt x="792" y="597"/>
                    </a:lnTo>
                    <a:lnTo>
                      <a:pt x="804" y="585"/>
                    </a:lnTo>
                    <a:lnTo>
                      <a:pt x="796" y="578"/>
                    </a:lnTo>
                    <a:lnTo>
                      <a:pt x="785" y="589"/>
                    </a:lnTo>
                    <a:lnTo>
                      <a:pt x="767" y="607"/>
                    </a:lnTo>
                    <a:lnTo>
                      <a:pt x="774" y="615"/>
                    </a:lnTo>
                    <a:close/>
                    <a:moveTo>
                      <a:pt x="817" y="573"/>
                    </a:moveTo>
                    <a:lnTo>
                      <a:pt x="832" y="558"/>
                    </a:lnTo>
                    <a:lnTo>
                      <a:pt x="847" y="543"/>
                    </a:lnTo>
                    <a:lnTo>
                      <a:pt x="839" y="535"/>
                    </a:lnTo>
                    <a:lnTo>
                      <a:pt x="824" y="550"/>
                    </a:lnTo>
                    <a:lnTo>
                      <a:pt x="809" y="565"/>
                    </a:lnTo>
                    <a:lnTo>
                      <a:pt x="817" y="573"/>
                    </a:lnTo>
                    <a:close/>
                    <a:moveTo>
                      <a:pt x="860" y="530"/>
                    </a:moveTo>
                    <a:lnTo>
                      <a:pt x="871" y="519"/>
                    </a:lnTo>
                    <a:lnTo>
                      <a:pt x="889" y="500"/>
                    </a:lnTo>
                    <a:lnTo>
                      <a:pt x="882" y="492"/>
                    </a:lnTo>
                    <a:lnTo>
                      <a:pt x="863" y="510"/>
                    </a:lnTo>
                    <a:lnTo>
                      <a:pt x="852" y="522"/>
                    </a:lnTo>
                    <a:lnTo>
                      <a:pt x="860" y="530"/>
                    </a:lnTo>
                    <a:close/>
                    <a:moveTo>
                      <a:pt x="902" y="487"/>
                    </a:moveTo>
                    <a:lnTo>
                      <a:pt x="910" y="479"/>
                    </a:lnTo>
                    <a:lnTo>
                      <a:pt x="932" y="457"/>
                    </a:lnTo>
                    <a:lnTo>
                      <a:pt x="924" y="450"/>
                    </a:lnTo>
                    <a:lnTo>
                      <a:pt x="903" y="471"/>
                    </a:lnTo>
                    <a:lnTo>
                      <a:pt x="894" y="479"/>
                    </a:lnTo>
                    <a:lnTo>
                      <a:pt x="902" y="487"/>
                    </a:lnTo>
                    <a:close/>
                    <a:moveTo>
                      <a:pt x="945" y="445"/>
                    </a:moveTo>
                    <a:lnTo>
                      <a:pt x="950" y="440"/>
                    </a:lnTo>
                    <a:lnTo>
                      <a:pt x="975" y="415"/>
                    </a:lnTo>
                    <a:lnTo>
                      <a:pt x="967" y="407"/>
                    </a:lnTo>
                    <a:lnTo>
                      <a:pt x="942" y="432"/>
                    </a:lnTo>
                    <a:lnTo>
                      <a:pt x="937" y="437"/>
                    </a:lnTo>
                    <a:lnTo>
                      <a:pt x="945" y="445"/>
                    </a:lnTo>
                    <a:close/>
                    <a:moveTo>
                      <a:pt x="988" y="402"/>
                    </a:moveTo>
                    <a:lnTo>
                      <a:pt x="989" y="401"/>
                    </a:lnTo>
                    <a:lnTo>
                      <a:pt x="1017" y="372"/>
                    </a:lnTo>
                    <a:lnTo>
                      <a:pt x="1009" y="364"/>
                    </a:lnTo>
                    <a:lnTo>
                      <a:pt x="981" y="392"/>
                    </a:lnTo>
                    <a:lnTo>
                      <a:pt x="980" y="394"/>
                    </a:lnTo>
                    <a:lnTo>
                      <a:pt x="988" y="402"/>
                    </a:lnTo>
                    <a:close/>
                    <a:moveTo>
                      <a:pt x="1030" y="359"/>
                    </a:moveTo>
                    <a:lnTo>
                      <a:pt x="1060" y="330"/>
                    </a:lnTo>
                    <a:lnTo>
                      <a:pt x="1052" y="322"/>
                    </a:lnTo>
                    <a:lnTo>
                      <a:pt x="1022" y="351"/>
                    </a:lnTo>
                    <a:lnTo>
                      <a:pt x="1030" y="359"/>
                    </a:lnTo>
                    <a:close/>
                    <a:moveTo>
                      <a:pt x="1073" y="317"/>
                    </a:moveTo>
                    <a:lnTo>
                      <a:pt x="1102" y="287"/>
                    </a:lnTo>
                    <a:lnTo>
                      <a:pt x="1095" y="279"/>
                    </a:lnTo>
                    <a:lnTo>
                      <a:pt x="1065" y="309"/>
                    </a:lnTo>
                    <a:lnTo>
                      <a:pt x="1073" y="317"/>
                    </a:lnTo>
                    <a:close/>
                    <a:moveTo>
                      <a:pt x="1115" y="274"/>
                    </a:moveTo>
                    <a:lnTo>
                      <a:pt x="1145" y="244"/>
                    </a:lnTo>
                    <a:lnTo>
                      <a:pt x="1137" y="236"/>
                    </a:lnTo>
                    <a:lnTo>
                      <a:pt x="1107" y="266"/>
                    </a:lnTo>
                    <a:lnTo>
                      <a:pt x="1115" y="274"/>
                    </a:lnTo>
                    <a:close/>
                    <a:moveTo>
                      <a:pt x="1158" y="232"/>
                    </a:moveTo>
                    <a:lnTo>
                      <a:pt x="1185" y="204"/>
                    </a:lnTo>
                    <a:lnTo>
                      <a:pt x="1188" y="202"/>
                    </a:lnTo>
                    <a:lnTo>
                      <a:pt x="1180" y="194"/>
                    </a:lnTo>
                    <a:lnTo>
                      <a:pt x="1177" y="196"/>
                    </a:lnTo>
                    <a:lnTo>
                      <a:pt x="1150" y="223"/>
                    </a:lnTo>
                    <a:lnTo>
                      <a:pt x="1158" y="232"/>
                    </a:lnTo>
                    <a:close/>
                    <a:moveTo>
                      <a:pt x="1201" y="189"/>
                    </a:moveTo>
                    <a:lnTo>
                      <a:pt x="1224" y="165"/>
                    </a:lnTo>
                    <a:lnTo>
                      <a:pt x="1230" y="159"/>
                    </a:lnTo>
                    <a:lnTo>
                      <a:pt x="1222" y="151"/>
                    </a:lnTo>
                    <a:lnTo>
                      <a:pt x="1216" y="157"/>
                    </a:lnTo>
                    <a:lnTo>
                      <a:pt x="1192" y="181"/>
                    </a:lnTo>
                    <a:lnTo>
                      <a:pt x="1201" y="189"/>
                    </a:lnTo>
                    <a:close/>
                    <a:moveTo>
                      <a:pt x="1243" y="146"/>
                    </a:moveTo>
                    <a:lnTo>
                      <a:pt x="1264" y="126"/>
                    </a:lnTo>
                    <a:lnTo>
                      <a:pt x="1273" y="116"/>
                    </a:lnTo>
                    <a:lnTo>
                      <a:pt x="1265" y="108"/>
                    </a:lnTo>
                    <a:lnTo>
                      <a:pt x="1256" y="118"/>
                    </a:lnTo>
                    <a:lnTo>
                      <a:pt x="1235" y="138"/>
                    </a:lnTo>
                    <a:lnTo>
                      <a:pt x="1243" y="146"/>
                    </a:lnTo>
                    <a:close/>
                    <a:moveTo>
                      <a:pt x="1286" y="104"/>
                    </a:moveTo>
                    <a:lnTo>
                      <a:pt x="1303" y="86"/>
                    </a:lnTo>
                    <a:lnTo>
                      <a:pt x="1316" y="74"/>
                    </a:lnTo>
                    <a:lnTo>
                      <a:pt x="1307" y="66"/>
                    </a:lnTo>
                    <a:lnTo>
                      <a:pt x="1295" y="78"/>
                    </a:lnTo>
                    <a:lnTo>
                      <a:pt x="1278" y="96"/>
                    </a:lnTo>
                    <a:lnTo>
                      <a:pt x="1286" y="104"/>
                    </a:lnTo>
                    <a:close/>
                    <a:moveTo>
                      <a:pt x="1328" y="61"/>
                    </a:moveTo>
                    <a:lnTo>
                      <a:pt x="1342" y="47"/>
                    </a:lnTo>
                    <a:lnTo>
                      <a:pt x="1358" y="31"/>
                    </a:lnTo>
                    <a:lnTo>
                      <a:pt x="1350" y="23"/>
                    </a:lnTo>
                    <a:lnTo>
                      <a:pt x="1334" y="39"/>
                    </a:lnTo>
                    <a:lnTo>
                      <a:pt x="1320" y="53"/>
                    </a:lnTo>
                    <a:lnTo>
                      <a:pt x="1328" y="61"/>
                    </a:lnTo>
                    <a:close/>
                    <a:moveTo>
                      <a:pt x="1371" y="18"/>
                    </a:moveTo>
                    <a:lnTo>
                      <a:pt x="1381" y="8"/>
                    </a:lnTo>
                    <a:lnTo>
                      <a:pt x="1374" y="0"/>
                    </a:lnTo>
                    <a:lnTo>
                      <a:pt x="1363" y="10"/>
                    </a:lnTo>
                    <a:lnTo>
                      <a:pt x="1371" y="18"/>
                    </a:lnTo>
                    <a:close/>
                  </a:path>
                </a:pathLst>
              </a:custGeom>
              <a:solidFill>
                <a:srgbClr val="C44E52"/>
              </a:solidFill>
              <a:ln w="9525" cap="flat">
                <a:noFill/>
                <a:prstDash val="solid"/>
                <a:bevel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9525" cap="flat">
                    <a:solidFill>
                      <a:srgbClr val="C44E52"/>
                    </a:solidFill>
                    <a:prstDash val="solid"/>
                    <a:bevel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1" name="Line 119">
                <a:extLst>
                  <a:ext uri="{FF2B5EF4-FFF2-40B4-BE49-F238E27FC236}">
                    <a16:creationId xmlns:a16="http://schemas.microsoft.com/office/drawing/2014/main" id="{65609D08-CABA-B520-5784-FBF262662C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783804" y="11215"/>
                <a:ext cx="0" cy="995222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4" name="Line 122">
                <a:extLst>
                  <a:ext uri="{FF2B5EF4-FFF2-40B4-BE49-F238E27FC236}">
                    <a16:creationId xmlns:a16="http://schemas.microsoft.com/office/drawing/2014/main" id="{3F2DECAF-8934-D029-34D1-313DDA6A40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83804" y="11215"/>
                <a:ext cx="994563" cy="0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pic>
            <p:nvPicPr>
              <p:cNvPr id="1205" name="Picture 123">
                <a:extLst>
                  <a:ext uri="{FF2B5EF4-FFF2-40B4-BE49-F238E27FC236}">
                    <a16:creationId xmlns:a16="http://schemas.microsoft.com/office/drawing/2014/main" id="{C52F0240-D9C4-3360-1817-3D5D3269219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17395" y="44806"/>
                <a:ext cx="559854" cy="24962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206" name="Freeform 124">
                <a:extLst>
                  <a:ext uri="{FF2B5EF4-FFF2-40B4-BE49-F238E27FC236}">
                    <a16:creationId xmlns:a16="http://schemas.microsoft.com/office/drawing/2014/main" id="{C9C33649-15C2-B83E-5A7F-81D33B7E095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851645" y="109354"/>
                <a:ext cx="149514" cy="0"/>
              </a:xfrm>
              <a:custGeom>
                <a:avLst/>
                <a:gdLst>
                  <a:gd name="T0" fmla="*/ 0 w 2000"/>
                  <a:gd name="T1" fmla="*/ 1000 w 2000"/>
                  <a:gd name="T2" fmla="*/ 2000 w 20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2000">
                    <a:moveTo>
                      <a:pt x="0" y="0"/>
                    </a:moveTo>
                    <a:lnTo>
                      <a:pt x="1000" y="0"/>
                    </a:lnTo>
                    <a:lnTo>
                      <a:pt x="2000" y="0"/>
                    </a:lnTo>
                  </a:path>
                </a:pathLst>
              </a:custGeom>
              <a:noFill/>
              <a:ln w="6350" cap="rnd">
                <a:solidFill>
                  <a:srgbClr val="4C72B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207" name="Freeform 125">
                <a:extLst>
                  <a:ext uri="{FF2B5EF4-FFF2-40B4-BE49-F238E27FC236}">
                    <a16:creationId xmlns:a16="http://schemas.microsoft.com/office/drawing/2014/main" id="{06D785E1-4B7A-3FB3-48F1-A186D306BF5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60437" y="81032"/>
                <a:ext cx="46106" cy="54668"/>
              </a:xfrm>
              <a:custGeom>
                <a:avLst/>
                <a:gdLst>
                  <a:gd name="T0" fmla="*/ 0 w 616"/>
                  <a:gd name="T1" fmla="*/ 0 h 729"/>
                  <a:gd name="T2" fmla="*/ 616 w 616"/>
                  <a:gd name="T3" fmla="*/ 0 h 729"/>
                  <a:gd name="T4" fmla="*/ 616 w 616"/>
                  <a:gd name="T5" fmla="*/ 83 h 729"/>
                  <a:gd name="T6" fmla="*/ 357 w 616"/>
                  <a:gd name="T7" fmla="*/ 83 h 729"/>
                  <a:gd name="T8" fmla="*/ 357 w 616"/>
                  <a:gd name="T9" fmla="*/ 729 h 729"/>
                  <a:gd name="T10" fmla="*/ 258 w 616"/>
                  <a:gd name="T11" fmla="*/ 729 h 729"/>
                  <a:gd name="T12" fmla="*/ 258 w 616"/>
                  <a:gd name="T13" fmla="*/ 83 h 729"/>
                  <a:gd name="T14" fmla="*/ 0 w 616"/>
                  <a:gd name="T15" fmla="*/ 83 h 729"/>
                  <a:gd name="T16" fmla="*/ 0 w 616"/>
                  <a:gd name="T17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616" h="729">
                    <a:moveTo>
                      <a:pt x="0" y="0"/>
                    </a:moveTo>
                    <a:lnTo>
                      <a:pt x="616" y="0"/>
                    </a:lnTo>
                    <a:lnTo>
                      <a:pt x="616" y="83"/>
                    </a:lnTo>
                    <a:lnTo>
                      <a:pt x="357" y="83"/>
                    </a:lnTo>
                    <a:lnTo>
                      <a:pt x="357" y="729"/>
                    </a:lnTo>
                    <a:lnTo>
                      <a:pt x="258" y="729"/>
                    </a:lnTo>
                    <a:lnTo>
                      <a:pt x="258" y="83"/>
                    </a:lnTo>
                    <a:lnTo>
                      <a:pt x="0" y="8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8" name="Freeform 126">
                <a:extLst>
                  <a:ext uri="{FF2B5EF4-FFF2-40B4-BE49-F238E27FC236}">
                    <a16:creationId xmlns:a16="http://schemas.microsoft.com/office/drawing/2014/main" id="{68A7ADC4-E32A-6AE3-2E80-A6361C03391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113788" y="81032"/>
                <a:ext cx="35567" cy="54668"/>
              </a:xfrm>
              <a:custGeom>
                <a:avLst/>
                <a:gdLst>
                  <a:gd name="T0" fmla="*/ 99 w 471"/>
                  <a:gd name="T1" fmla="*/ 81 h 729"/>
                  <a:gd name="T2" fmla="*/ 99 w 471"/>
                  <a:gd name="T3" fmla="*/ 355 h 729"/>
                  <a:gd name="T4" fmla="*/ 223 w 471"/>
                  <a:gd name="T5" fmla="*/ 355 h 729"/>
                  <a:gd name="T6" fmla="*/ 329 w 471"/>
                  <a:gd name="T7" fmla="*/ 320 h 729"/>
                  <a:gd name="T8" fmla="*/ 367 w 471"/>
                  <a:gd name="T9" fmla="*/ 218 h 729"/>
                  <a:gd name="T10" fmla="*/ 329 w 471"/>
                  <a:gd name="T11" fmla="*/ 117 h 729"/>
                  <a:gd name="T12" fmla="*/ 223 w 471"/>
                  <a:gd name="T13" fmla="*/ 81 h 729"/>
                  <a:gd name="T14" fmla="*/ 99 w 471"/>
                  <a:gd name="T15" fmla="*/ 81 h 729"/>
                  <a:gd name="T16" fmla="*/ 0 w 471"/>
                  <a:gd name="T17" fmla="*/ 0 h 729"/>
                  <a:gd name="T18" fmla="*/ 223 w 471"/>
                  <a:gd name="T19" fmla="*/ 0 h 729"/>
                  <a:gd name="T20" fmla="*/ 408 w 471"/>
                  <a:gd name="T21" fmla="*/ 56 h 729"/>
                  <a:gd name="T22" fmla="*/ 471 w 471"/>
                  <a:gd name="T23" fmla="*/ 218 h 729"/>
                  <a:gd name="T24" fmla="*/ 408 w 471"/>
                  <a:gd name="T25" fmla="*/ 381 h 729"/>
                  <a:gd name="T26" fmla="*/ 223 w 471"/>
                  <a:gd name="T27" fmla="*/ 436 h 729"/>
                  <a:gd name="T28" fmla="*/ 99 w 471"/>
                  <a:gd name="T29" fmla="*/ 436 h 729"/>
                  <a:gd name="T30" fmla="*/ 99 w 471"/>
                  <a:gd name="T31" fmla="*/ 729 h 729"/>
                  <a:gd name="T32" fmla="*/ 0 w 471"/>
                  <a:gd name="T33" fmla="*/ 729 h 729"/>
                  <a:gd name="T34" fmla="*/ 0 w 471"/>
                  <a:gd name="T35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71" h="729">
                    <a:moveTo>
                      <a:pt x="99" y="81"/>
                    </a:moveTo>
                    <a:lnTo>
                      <a:pt x="99" y="355"/>
                    </a:lnTo>
                    <a:lnTo>
                      <a:pt x="223" y="355"/>
                    </a:lnTo>
                    <a:cubicBezTo>
                      <a:pt x="269" y="355"/>
                      <a:pt x="304" y="344"/>
                      <a:pt x="329" y="320"/>
                    </a:cubicBezTo>
                    <a:cubicBezTo>
                      <a:pt x="354" y="296"/>
                      <a:pt x="367" y="262"/>
                      <a:pt x="367" y="218"/>
                    </a:cubicBezTo>
                    <a:cubicBezTo>
                      <a:pt x="367" y="174"/>
                      <a:pt x="354" y="141"/>
                      <a:pt x="329" y="117"/>
                    </a:cubicBezTo>
                    <a:cubicBezTo>
                      <a:pt x="304" y="93"/>
                      <a:pt x="269" y="81"/>
                      <a:pt x="223" y="81"/>
                    </a:cubicBezTo>
                    <a:lnTo>
                      <a:pt x="99" y="81"/>
                    </a:lnTo>
                    <a:close/>
                    <a:moveTo>
                      <a:pt x="0" y="0"/>
                    </a:moveTo>
                    <a:lnTo>
                      <a:pt x="223" y="0"/>
                    </a:lnTo>
                    <a:cubicBezTo>
                      <a:pt x="304" y="0"/>
                      <a:pt x="366" y="19"/>
                      <a:pt x="408" y="56"/>
                    </a:cubicBezTo>
                    <a:cubicBezTo>
                      <a:pt x="450" y="93"/>
                      <a:pt x="471" y="147"/>
                      <a:pt x="471" y="218"/>
                    </a:cubicBezTo>
                    <a:cubicBezTo>
                      <a:pt x="471" y="290"/>
                      <a:pt x="450" y="345"/>
                      <a:pt x="408" y="381"/>
                    </a:cubicBezTo>
                    <a:cubicBezTo>
                      <a:pt x="366" y="418"/>
                      <a:pt x="304" y="436"/>
                      <a:pt x="223" y="436"/>
                    </a:cubicBezTo>
                    <a:lnTo>
                      <a:pt x="99" y="436"/>
                    </a:lnTo>
                    <a:lnTo>
                      <a:pt x="99" y="729"/>
                    </a:lnTo>
                    <a:lnTo>
                      <a:pt x="0" y="729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9" name="Freeform 127">
                <a:extLst>
                  <a:ext uri="{FF2B5EF4-FFF2-40B4-BE49-F238E27FC236}">
                    <a16:creationId xmlns:a16="http://schemas.microsoft.com/office/drawing/2014/main" id="{94967A42-A7F1-674D-20C0-67ACC96DF30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851645" y="215397"/>
                <a:ext cx="146879" cy="7200"/>
              </a:xfrm>
              <a:custGeom>
                <a:avLst/>
                <a:gdLst>
                  <a:gd name="T0" fmla="*/ 0 w 223"/>
                  <a:gd name="T1" fmla="*/ 12 h 12"/>
                  <a:gd name="T2" fmla="*/ 42 w 223"/>
                  <a:gd name="T3" fmla="*/ 12 h 12"/>
                  <a:gd name="T4" fmla="*/ 42 w 223"/>
                  <a:gd name="T5" fmla="*/ 0 h 12"/>
                  <a:gd name="T6" fmla="*/ 0 w 223"/>
                  <a:gd name="T7" fmla="*/ 0 h 12"/>
                  <a:gd name="T8" fmla="*/ 0 w 223"/>
                  <a:gd name="T9" fmla="*/ 12 h 12"/>
                  <a:gd name="T10" fmla="*/ 60 w 223"/>
                  <a:gd name="T11" fmla="*/ 12 h 12"/>
                  <a:gd name="T12" fmla="*/ 102 w 223"/>
                  <a:gd name="T13" fmla="*/ 12 h 12"/>
                  <a:gd name="T14" fmla="*/ 102 w 223"/>
                  <a:gd name="T15" fmla="*/ 0 h 12"/>
                  <a:gd name="T16" fmla="*/ 60 w 223"/>
                  <a:gd name="T17" fmla="*/ 0 h 12"/>
                  <a:gd name="T18" fmla="*/ 60 w 223"/>
                  <a:gd name="T19" fmla="*/ 12 h 12"/>
                  <a:gd name="T20" fmla="*/ 121 w 223"/>
                  <a:gd name="T21" fmla="*/ 12 h 12"/>
                  <a:gd name="T22" fmla="*/ 163 w 223"/>
                  <a:gd name="T23" fmla="*/ 12 h 12"/>
                  <a:gd name="T24" fmla="*/ 163 w 223"/>
                  <a:gd name="T25" fmla="*/ 0 h 12"/>
                  <a:gd name="T26" fmla="*/ 121 w 223"/>
                  <a:gd name="T27" fmla="*/ 0 h 12"/>
                  <a:gd name="T28" fmla="*/ 121 w 223"/>
                  <a:gd name="T29" fmla="*/ 12 h 12"/>
                  <a:gd name="T30" fmla="*/ 181 w 223"/>
                  <a:gd name="T31" fmla="*/ 12 h 12"/>
                  <a:gd name="T32" fmla="*/ 223 w 223"/>
                  <a:gd name="T33" fmla="*/ 12 h 12"/>
                  <a:gd name="T34" fmla="*/ 223 w 223"/>
                  <a:gd name="T35" fmla="*/ 0 h 12"/>
                  <a:gd name="T36" fmla="*/ 181 w 223"/>
                  <a:gd name="T37" fmla="*/ 0 h 12"/>
                  <a:gd name="T38" fmla="*/ 181 w 223"/>
                  <a:gd name="T39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223" h="12">
                    <a:moveTo>
                      <a:pt x="0" y="12"/>
                    </a:moveTo>
                    <a:lnTo>
                      <a:pt x="42" y="12"/>
                    </a:lnTo>
                    <a:lnTo>
                      <a:pt x="42" y="0"/>
                    </a:lnTo>
                    <a:lnTo>
                      <a:pt x="0" y="0"/>
                    </a:lnTo>
                    <a:lnTo>
                      <a:pt x="0" y="12"/>
                    </a:lnTo>
                    <a:close/>
                    <a:moveTo>
                      <a:pt x="60" y="12"/>
                    </a:moveTo>
                    <a:lnTo>
                      <a:pt x="102" y="12"/>
                    </a:lnTo>
                    <a:lnTo>
                      <a:pt x="102" y="0"/>
                    </a:lnTo>
                    <a:lnTo>
                      <a:pt x="60" y="0"/>
                    </a:lnTo>
                    <a:lnTo>
                      <a:pt x="60" y="12"/>
                    </a:lnTo>
                    <a:close/>
                    <a:moveTo>
                      <a:pt x="121" y="12"/>
                    </a:moveTo>
                    <a:lnTo>
                      <a:pt x="163" y="12"/>
                    </a:lnTo>
                    <a:lnTo>
                      <a:pt x="163" y="0"/>
                    </a:lnTo>
                    <a:lnTo>
                      <a:pt x="121" y="0"/>
                    </a:lnTo>
                    <a:lnTo>
                      <a:pt x="121" y="12"/>
                    </a:lnTo>
                    <a:close/>
                    <a:moveTo>
                      <a:pt x="181" y="12"/>
                    </a:moveTo>
                    <a:lnTo>
                      <a:pt x="223" y="12"/>
                    </a:lnTo>
                    <a:lnTo>
                      <a:pt x="223" y="0"/>
                    </a:lnTo>
                    <a:lnTo>
                      <a:pt x="181" y="0"/>
                    </a:lnTo>
                    <a:lnTo>
                      <a:pt x="181" y="12"/>
                    </a:lnTo>
                    <a:close/>
                  </a:path>
                </a:pathLst>
              </a:custGeom>
              <a:solidFill>
                <a:srgbClr val="C44E52"/>
              </a:solidFill>
              <a:ln w="9525" cap="flat">
                <a:noFill/>
                <a:prstDash val="solid"/>
                <a:bevel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9525" cap="flat">
                    <a:solidFill>
                      <a:srgbClr val="C44E52"/>
                    </a:solidFill>
                    <a:prstDash val="solid"/>
                    <a:bevel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0" name="Freeform 128">
                <a:extLst>
                  <a:ext uri="{FF2B5EF4-FFF2-40B4-BE49-F238E27FC236}">
                    <a16:creationId xmlns:a16="http://schemas.microsoft.com/office/drawing/2014/main" id="{BB92001C-870A-BDB6-9E48-75F19689ACE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065048" y="203541"/>
                <a:ext cx="37543" cy="42813"/>
              </a:xfrm>
              <a:custGeom>
                <a:avLst/>
                <a:gdLst>
                  <a:gd name="T0" fmla="*/ 251 w 502"/>
                  <a:gd name="T1" fmla="*/ 76 h 573"/>
                  <a:gd name="T2" fmla="*/ 137 w 502"/>
                  <a:gd name="T3" fmla="*/ 133 h 573"/>
                  <a:gd name="T4" fmla="*/ 95 w 502"/>
                  <a:gd name="T5" fmla="*/ 287 h 573"/>
                  <a:gd name="T6" fmla="*/ 136 w 502"/>
                  <a:gd name="T7" fmla="*/ 442 h 573"/>
                  <a:gd name="T8" fmla="*/ 251 w 502"/>
                  <a:gd name="T9" fmla="*/ 498 h 573"/>
                  <a:gd name="T10" fmla="*/ 365 w 502"/>
                  <a:gd name="T11" fmla="*/ 442 h 573"/>
                  <a:gd name="T12" fmla="*/ 407 w 502"/>
                  <a:gd name="T13" fmla="*/ 287 h 573"/>
                  <a:gd name="T14" fmla="*/ 365 w 502"/>
                  <a:gd name="T15" fmla="*/ 133 h 573"/>
                  <a:gd name="T16" fmla="*/ 251 w 502"/>
                  <a:gd name="T17" fmla="*/ 76 h 573"/>
                  <a:gd name="T18" fmla="*/ 251 w 502"/>
                  <a:gd name="T19" fmla="*/ 0 h 573"/>
                  <a:gd name="T20" fmla="*/ 435 w 502"/>
                  <a:gd name="T21" fmla="*/ 76 h 573"/>
                  <a:gd name="T22" fmla="*/ 502 w 502"/>
                  <a:gd name="T23" fmla="*/ 287 h 573"/>
                  <a:gd name="T24" fmla="*/ 435 w 502"/>
                  <a:gd name="T25" fmla="*/ 497 h 573"/>
                  <a:gd name="T26" fmla="*/ 251 w 502"/>
                  <a:gd name="T27" fmla="*/ 573 h 573"/>
                  <a:gd name="T28" fmla="*/ 66 w 502"/>
                  <a:gd name="T29" fmla="*/ 497 h 573"/>
                  <a:gd name="T30" fmla="*/ 0 w 502"/>
                  <a:gd name="T31" fmla="*/ 287 h 573"/>
                  <a:gd name="T32" fmla="*/ 66 w 502"/>
                  <a:gd name="T33" fmla="*/ 76 h 573"/>
                  <a:gd name="T34" fmla="*/ 251 w 502"/>
                  <a:gd name="T35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2" h="573">
                    <a:moveTo>
                      <a:pt x="251" y="76"/>
                    </a:moveTo>
                    <a:cubicBezTo>
                      <a:pt x="203" y="76"/>
                      <a:pt x="165" y="95"/>
                      <a:pt x="137" y="133"/>
                    </a:cubicBezTo>
                    <a:cubicBezTo>
                      <a:pt x="109" y="171"/>
                      <a:pt x="95" y="222"/>
                      <a:pt x="95" y="287"/>
                    </a:cubicBezTo>
                    <a:cubicBezTo>
                      <a:pt x="95" y="353"/>
                      <a:pt x="108" y="404"/>
                      <a:pt x="136" y="442"/>
                    </a:cubicBezTo>
                    <a:cubicBezTo>
                      <a:pt x="164" y="480"/>
                      <a:pt x="202" y="498"/>
                      <a:pt x="251" y="498"/>
                    </a:cubicBezTo>
                    <a:cubicBezTo>
                      <a:pt x="299" y="498"/>
                      <a:pt x="337" y="480"/>
                      <a:pt x="365" y="442"/>
                    </a:cubicBezTo>
                    <a:cubicBezTo>
                      <a:pt x="393" y="404"/>
                      <a:pt x="407" y="353"/>
                      <a:pt x="407" y="287"/>
                    </a:cubicBezTo>
                    <a:cubicBezTo>
                      <a:pt x="407" y="223"/>
                      <a:pt x="393" y="171"/>
                      <a:pt x="365" y="133"/>
                    </a:cubicBezTo>
                    <a:cubicBezTo>
                      <a:pt x="337" y="95"/>
                      <a:pt x="299" y="76"/>
                      <a:pt x="251" y="76"/>
                    </a:cubicBezTo>
                    <a:close/>
                    <a:moveTo>
                      <a:pt x="251" y="0"/>
                    </a:moveTo>
                    <a:cubicBezTo>
                      <a:pt x="329" y="0"/>
                      <a:pt x="390" y="26"/>
                      <a:pt x="435" y="76"/>
                    </a:cubicBezTo>
                    <a:cubicBezTo>
                      <a:pt x="479" y="127"/>
                      <a:pt x="502" y="197"/>
                      <a:pt x="502" y="287"/>
                    </a:cubicBezTo>
                    <a:cubicBezTo>
                      <a:pt x="502" y="377"/>
                      <a:pt x="479" y="447"/>
                      <a:pt x="435" y="497"/>
                    </a:cubicBezTo>
                    <a:cubicBezTo>
                      <a:pt x="390" y="548"/>
                      <a:pt x="329" y="573"/>
                      <a:pt x="251" y="573"/>
                    </a:cubicBezTo>
                    <a:cubicBezTo>
                      <a:pt x="172" y="573"/>
                      <a:pt x="110" y="548"/>
                      <a:pt x="66" y="497"/>
                    </a:cubicBezTo>
                    <a:cubicBezTo>
                      <a:pt x="22" y="447"/>
                      <a:pt x="0" y="377"/>
                      <a:pt x="0" y="287"/>
                    </a:cubicBezTo>
                    <a:cubicBezTo>
                      <a:pt x="0" y="197"/>
                      <a:pt x="22" y="127"/>
                      <a:pt x="66" y="76"/>
                    </a:cubicBezTo>
                    <a:cubicBezTo>
                      <a:pt x="110" y="26"/>
                      <a:pt x="172" y="0"/>
                      <a:pt x="251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1" name="Freeform 129">
                <a:extLst>
                  <a:ext uri="{FF2B5EF4-FFF2-40B4-BE49-F238E27FC236}">
                    <a16:creationId xmlns:a16="http://schemas.microsoft.com/office/drawing/2014/main" id="{21899450-A346-3A98-142F-F39FD59431D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113129" y="203541"/>
                <a:ext cx="36884" cy="57303"/>
              </a:xfrm>
              <a:custGeom>
                <a:avLst/>
                <a:gdLst>
                  <a:gd name="T0" fmla="*/ 90 w 489"/>
                  <a:gd name="T1" fmla="*/ 478 h 767"/>
                  <a:gd name="T2" fmla="*/ 90 w 489"/>
                  <a:gd name="T3" fmla="*/ 767 h 767"/>
                  <a:gd name="T4" fmla="*/ 0 w 489"/>
                  <a:gd name="T5" fmla="*/ 767 h 767"/>
                  <a:gd name="T6" fmla="*/ 0 w 489"/>
                  <a:gd name="T7" fmla="*/ 13 h 767"/>
                  <a:gd name="T8" fmla="*/ 90 w 489"/>
                  <a:gd name="T9" fmla="*/ 13 h 767"/>
                  <a:gd name="T10" fmla="*/ 90 w 489"/>
                  <a:gd name="T11" fmla="*/ 96 h 767"/>
                  <a:gd name="T12" fmla="*/ 161 w 489"/>
                  <a:gd name="T13" fmla="*/ 24 h 767"/>
                  <a:gd name="T14" fmla="*/ 265 w 489"/>
                  <a:gd name="T15" fmla="*/ 0 h 767"/>
                  <a:gd name="T16" fmla="*/ 427 w 489"/>
                  <a:gd name="T17" fmla="*/ 79 h 767"/>
                  <a:gd name="T18" fmla="*/ 489 w 489"/>
                  <a:gd name="T19" fmla="*/ 287 h 767"/>
                  <a:gd name="T20" fmla="*/ 427 w 489"/>
                  <a:gd name="T21" fmla="*/ 495 h 767"/>
                  <a:gd name="T22" fmla="*/ 265 w 489"/>
                  <a:gd name="T23" fmla="*/ 573 h 767"/>
                  <a:gd name="T24" fmla="*/ 161 w 489"/>
                  <a:gd name="T25" fmla="*/ 550 h 767"/>
                  <a:gd name="T26" fmla="*/ 90 w 489"/>
                  <a:gd name="T27" fmla="*/ 478 h 767"/>
                  <a:gd name="T28" fmla="*/ 396 w 489"/>
                  <a:gd name="T29" fmla="*/ 287 h 767"/>
                  <a:gd name="T30" fmla="*/ 355 w 489"/>
                  <a:gd name="T31" fmla="*/ 132 h 767"/>
                  <a:gd name="T32" fmla="*/ 243 w 489"/>
                  <a:gd name="T33" fmla="*/ 75 h 767"/>
                  <a:gd name="T34" fmla="*/ 131 w 489"/>
                  <a:gd name="T35" fmla="*/ 132 h 767"/>
                  <a:gd name="T36" fmla="*/ 90 w 489"/>
                  <a:gd name="T37" fmla="*/ 287 h 767"/>
                  <a:gd name="T38" fmla="*/ 131 w 489"/>
                  <a:gd name="T39" fmla="*/ 443 h 767"/>
                  <a:gd name="T40" fmla="*/ 243 w 489"/>
                  <a:gd name="T41" fmla="*/ 499 h 767"/>
                  <a:gd name="T42" fmla="*/ 355 w 489"/>
                  <a:gd name="T43" fmla="*/ 443 h 767"/>
                  <a:gd name="T44" fmla="*/ 396 w 489"/>
                  <a:gd name="T45" fmla="*/ 287 h 7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89" h="767">
                    <a:moveTo>
                      <a:pt x="90" y="478"/>
                    </a:moveTo>
                    <a:lnTo>
                      <a:pt x="90" y="767"/>
                    </a:lnTo>
                    <a:lnTo>
                      <a:pt x="0" y="767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6"/>
                    </a:lnTo>
                    <a:cubicBezTo>
                      <a:pt x="108" y="64"/>
                      <a:pt x="132" y="40"/>
                      <a:pt x="161" y="24"/>
                    </a:cubicBezTo>
                    <a:cubicBezTo>
                      <a:pt x="190" y="8"/>
                      <a:pt x="225" y="0"/>
                      <a:pt x="265" y="0"/>
                    </a:cubicBezTo>
                    <a:cubicBezTo>
                      <a:pt x="331" y="0"/>
                      <a:pt x="385" y="27"/>
                      <a:pt x="427" y="79"/>
                    </a:cubicBezTo>
                    <a:cubicBezTo>
                      <a:pt x="468" y="132"/>
                      <a:pt x="489" y="201"/>
                      <a:pt x="489" y="287"/>
                    </a:cubicBezTo>
                    <a:cubicBezTo>
                      <a:pt x="489" y="373"/>
                      <a:pt x="468" y="443"/>
                      <a:pt x="427" y="495"/>
                    </a:cubicBezTo>
                    <a:cubicBezTo>
                      <a:pt x="385" y="547"/>
                      <a:pt x="331" y="573"/>
                      <a:pt x="265" y="573"/>
                    </a:cubicBezTo>
                    <a:cubicBezTo>
                      <a:pt x="225" y="573"/>
                      <a:pt x="190" y="565"/>
                      <a:pt x="161" y="550"/>
                    </a:cubicBezTo>
                    <a:cubicBezTo>
                      <a:pt x="132" y="535"/>
                      <a:pt x="108" y="511"/>
                      <a:pt x="90" y="478"/>
                    </a:cubicBezTo>
                    <a:close/>
                    <a:moveTo>
                      <a:pt x="396" y="287"/>
                    </a:moveTo>
                    <a:cubicBezTo>
                      <a:pt x="396" y="221"/>
                      <a:pt x="382" y="170"/>
                      <a:pt x="355" y="132"/>
                    </a:cubicBezTo>
                    <a:cubicBezTo>
                      <a:pt x="327" y="94"/>
                      <a:pt x="290" y="75"/>
                      <a:pt x="243" y="75"/>
                    </a:cubicBezTo>
                    <a:cubicBezTo>
                      <a:pt x="195" y="75"/>
                      <a:pt x="158" y="94"/>
                      <a:pt x="131" y="132"/>
                    </a:cubicBezTo>
                    <a:cubicBezTo>
                      <a:pt x="103" y="170"/>
                      <a:pt x="90" y="221"/>
                      <a:pt x="90" y="287"/>
                    </a:cubicBezTo>
                    <a:cubicBezTo>
                      <a:pt x="90" y="353"/>
                      <a:pt x="103" y="405"/>
                      <a:pt x="131" y="443"/>
                    </a:cubicBezTo>
                    <a:cubicBezTo>
                      <a:pt x="158" y="481"/>
                      <a:pt x="195" y="499"/>
                      <a:pt x="243" y="499"/>
                    </a:cubicBezTo>
                    <a:cubicBezTo>
                      <a:pt x="290" y="499"/>
                      <a:pt x="327" y="481"/>
                      <a:pt x="355" y="443"/>
                    </a:cubicBezTo>
                    <a:cubicBezTo>
                      <a:pt x="382" y="405"/>
                      <a:pt x="396" y="353"/>
                      <a:pt x="396" y="28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2" name="Freeform 130">
                <a:extLst>
                  <a:ext uri="{FF2B5EF4-FFF2-40B4-BE49-F238E27FC236}">
                    <a16:creationId xmlns:a16="http://schemas.microsoft.com/office/drawing/2014/main" id="{ECC72FB1-17B2-4235-D1F0-E15CEF3EB05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55941" y="193003"/>
                <a:ext cx="25688" cy="52692"/>
              </a:xfrm>
              <a:custGeom>
                <a:avLst/>
                <a:gdLst>
                  <a:gd name="T0" fmla="*/ 156 w 341"/>
                  <a:gd name="T1" fmla="*/ 0 h 702"/>
                  <a:gd name="T2" fmla="*/ 156 w 341"/>
                  <a:gd name="T3" fmla="*/ 155 h 702"/>
                  <a:gd name="T4" fmla="*/ 341 w 341"/>
                  <a:gd name="T5" fmla="*/ 155 h 702"/>
                  <a:gd name="T6" fmla="*/ 341 w 341"/>
                  <a:gd name="T7" fmla="*/ 225 h 702"/>
                  <a:gd name="T8" fmla="*/ 156 w 341"/>
                  <a:gd name="T9" fmla="*/ 225 h 702"/>
                  <a:gd name="T10" fmla="*/ 156 w 341"/>
                  <a:gd name="T11" fmla="*/ 522 h 702"/>
                  <a:gd name="T12" fmla="*/ 174 w 341"/>
                  <a:gd name="T13" fmla="*/ 608 h 702"/>
                  <a:gd name="T14" fmla="*/ 249 w 341"/>
                  <a:gd name="T15" fmla="*/ 627 h 702"/>
                  <a:gd name="T16" fmla="*/ 341 w 341"/>
                  <a:gd name="T17" fmla="*/ 627 h 702"/>
                  <a:gd name="T18" fmla="*/ 341 w 341"/>
                  <a:gd name="T19" fmla="*/ 702 h 702"/>
                  <a:gd name="T20" fmla="*/ 249 w 341"/>
                  <a:gd name="T21" fmla="*/ 702 h 702"/>
                  <a:gd name="T22" fmla="*/ 105 w 341"/>
                  <a:gd name="T23" fmla="*/ 663 h 702"/>
                  <a:gd name="T24" fmla="*/ 66 w 341"/>
                  <a:gd name="T25" fmla="*/ 522 h 702"/>
                  <a:gd name="T26" fmla="*/ 66 w 341"/>
                  <a:gd name="T27" fmla="*/ 225 h 702"/>
                  <a:gd name="T28" fmla="*/ 0 w 341"/>
                  <a:gd name="T29" fmla="*/ 225 h 702"/>
                  <a:gd name="T30" fmla="*/ 0 w 341"/>
                  <a:gd name="T31" fmla="*/ 155 h 702"/>
                  <a:gd name="T32" fmla="*/ 66 w 341"/>
                  <a:gd name="T33" fmla="*/ 155 h 702"/>
                  <a:gd name="T34" fmla="*/ 66 w 341"/>
                  <a:gd name="T35" fmla="*/ 0 h 702"/>
                  <a:gd name="T36" fmla="*/ 156 w 341"/>
                  <a:gd name="T37" fmla="*/ 0 h 7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341" h="702">
                    <a:moveTo>
                      <a:pt x="156" y="0"/>
                    </a:moveTo>
                    <a:lnTo>
                      <a:pt x="156" y="155"/>
                    </a:lnTo>
                    <a:lnTo>
                      <a:pt x="341" y="155"/>
                    </a:lnTo>
                    <a:lnTo>
                      <a:pt x="341" y="225"/>
                    </a:lnTo>
                    <a:lnTo>
                      <a:pt x="156" y="225"/>
                    </a:lnTo>
                    <a:lnTo>
                      <a:pt x="156" y="522"/>
                    </a:lnTo>
                    <a:cubicBezTo>
                      <a:pt x="156" y="567"/>
                      <a:pt x="162" y="596"/>
                      <a:pt x="174" y="608"/>
                    </a:cubicBezTo>
                    <a:cubicBezTo>
                      <a:pt x="186" y="621"/>
                      <a:pt x="211" y="627"/>
                      <a:pt x="249" y="627"/>
                    </a:cubicBezTo>
                    <a:lnTo>
                      <a:pt x="341" y="627"/>
                    </a:lnTo>
                    <a:lnTo>
                      <a:pt x="341" y="702"/>
                    </a:lnTo>
                    <a:lnTo>
                      <a:pt x="249" y="702"/>
                    </a:lnTo>
                    <a:cubicBezTo>
                      <a:pt x="179" y="702"/>
                      <a:pt x="131" y="689"/>
                      <a:pt x="105" y="663"/>
                    </a:cubicBezTo>
                    <a:cubicBezTo>
                      <a:pt x="79" y="637"/>
                      <a:pt x="66" y="590"/>
                      <a:pt x="66" y="522"/>
                    </a:cubicBezTo>
                    <a:lnTo>
                      <a:pt x="66" y="225"/>
                    </a:lnTo>
                    <a:lnTo>
                      <a:pt x="0" y="225"/>
                    </a:lnTo>
                    <a:lnTo>
                      <a:pt x="0" y="155"/>
                    </a:lnTo>
                    <a:lnTo>
                      <a:pt x="66" y="155"/>
                    </a:lnTo>
                    <a:lnTo>
                      <a:pt x="66" y="0"/>
                    </a:lnTo>
                    <a:lnTo>
                      <a:pt x="156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3" name="Freeform 131">
                <a:extLst>
                  <a:ext uri="{FF2B5EF4-FFF2-40B4-BE49-F238E27FC236}">
                    <a16:creationId xmlns:a16="http://schemas.microsoft.com/office/drawing/2014/main" id="{4DAD01CA-F462-EE97-DF19-BC58BAE1405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190191" y="188392"/>
                <a:ext cx="7245" cy="57303"/>
              </a:xfrm>
              <a:custGeom>
                <a:avLst/>
                <a:gdLst>
                  <a:gd name="T0" fmla="*/ 0 w 90"/>
                  <a:gd name="T1" fmla="*/ 213 h 760"/>
                  <a:gd name="T2" fmla="*/ 90 w 90"/>
                  <a:gd name="T3" fmla="*/ 213 h 760"/>
                  <a:gd name="T4" fmla="*/ 90 w 90"/>
                  <a:gd name="T5" fmla="*/ 760 h 760"/>
                  <a:gd name="T6" fmla="*/ 0 w 90"/>
                  <a:gd name="T7" fmla="*/ 760 h 760"/>
                  <a:gd name="T8" fmla="*/ 0 w 90"/>
                  <a:gd name="T9" fmla="*/ 213 h 760"/>
                  <a:gd name="T10" fmla="*/ 0 w 90"/>
                  <a:gd name="T11" fmla="*/ 0 h 760"/>
                  <a:gd name="T12" fmla="*/ 90 w 90"/>
                  <a:gd name="T13" fmla="*/ 0 h 760"/>
                  <a:gd name="T14" fmla="*/ 90 w 90"/>
                  <a:gd name="T15" fmla="*/ 114 h 760"/>
                  <a:gd name="T16" fmla="*/ 0 w 90"/>
                  <a:gd name="T17" fmla="*/ 114 h 760"/>
                  <a:gd name="T18" fmla="*/ 0 w 90"/>
                  <a:gd name="T19" fmla="*/ 0 h 7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90" h="760">
                    <a:moveTo>
                      <a:pt x="0" y="213"/>
                    </a:moveTo>
                    <a:lnTo>
                      <a:pt x="90" y="213"/>
                    </a:lnTo>
                    <a:lnTo>
                      <a:pt x="90" y="760"/>
                    </a:lnTo>
                    <a:lnTo>
                      <a:pt x="0" y="760"/>
                    </a:lnTo>
                    <a:lnTo>
                      <a:pt x="0" y="213"/>
                    </a:lnTo>
                    <a:close/>
                    <a:moveTo>
                      <a:pt x="0" y="0"/>
                    </a:moveTo>
                    <a:lnTo>
                      <a:pt x="90" y="0"/>
                    </a:lnTo>
                    <a:lnTo>
                      <a:pt x="90" y="114"/>
                    </a:lnTo>
                    <a:lnTo>
                      <a:pt x="0" y="11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4" name="Freeform 132">
                <a:extLst>
                  <a:ext uri="{FF2B5EF4-FFF2-40B4-BE49-F238E27FC236}">
                    <a16:creationId xmlns:a16="http://schemas.microsoft.com/office/drawing/2014/main" id="{1F9E8FA6-3A68-9580-0C34-AC904D49BF8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11268" y="203541"/>
                <a:ext cx="59279" cy="42154"/>
              </a:xfrm>
              <a:custGeom>
                <a:avLst/>
                <a:gdLst>
                  <a:gd name="T0" fmla="*/ 429 w 798"/>
                  <a:gd name="T1" fmla="*/ 118 h 560"/>
                  <a:gd name="T2" fmla="*/ 509 w 798"/>
                  <a:gd name="T3" fmla="*/ 29 h 560"/>
                  <a:gd name="T4" fmla="*/ 620 w 798"/>
                  <a:gd name="T5" fmla="*/ 0 h 560"/>
                  <a:gd name="T6" fmla="*/ 751 w 798"/>
                  <a:gd name="T7" fmla="*/ 60 h 560"/>
                  <a:gd name="T8" fmla="*/ 798 w 798"/>
                  <a:gd name="T9" fmla="*/ 230 h 560"/>
                  <a:gd name="T10" fmla="*/ 798 w 798"/>
                  <a:gd name="T11" fmla="*/ 560 h 560"/>
                  <a:gd name="T12" fmla="*/ 708 w 798"/>
                  <a:gd name="T13" fmla="*/ 560 h 560"/>
                  <a:gd name="T14" fmla="*/ 708 w 798"/>
                  <a:gd name="T15" fmla="*/ 233 h 560"/>
                  <a:gd name="T16" fmla="*/ 680 w 798"/>
                  <a:gd name="T17" fmla="*/ 116 h 560"/>
                  <a:gd name="T18" fmla="*/ 595 w 798"/>
                  <a:gd name="T19" fmla="*/ 78 h 560"/>
                  <a:gd name="T20" fmla="*/ 484 w 798"/>
                  <a:gd name="T21" fmla="*/ 125 h 560"/>
                  <a:gd name="T22" fmla="*/ 444 w 798"/>
                  <a:gd name="T23" fmla="*/ 251 h 560"/>
                  <a:gd name="T24" fmla="*/ 444 w 798"/>
                  <a:gd name="T25" fmla="*/ 560 h 560"/>
                  <a:gd name="T26" fmla="*/ 354 w 798"/>
                  <a:gd name="T27" fmla="*/ 560 h 560"/>
                  <a:gd name="T28" fmla="*/ 354 w 798"/>
                  <a:gd name="T29" fmla="*/ 233 h 560"/>
                  <a:gd name="T30" fmla="*/ 326 w 798"/>
                  <a:gd name="T31" fmla="*/ 116 h 560"/>
                  <a:gd name="T32" fmla="*/ 240 w 798"/>
                  <a:gd name="T33" fmla="*/ 78 h 560"/>
                  <a:gd name="T34" fmla="*/ 130 w 798"/>
                  <a:gd name="T35" fmla="*/ 125 h 560"/>
                  <a:gd name="T36" fmla="*/ 90 w 798"/>
                  <a:gd name="T37" fmla="*/ 251 h 560"/>
                  <a:gd name="T38" fmla="*/ 90 w 798"/>
                  <a:gd name="T39" fmla="*/ 560 h 560"/>
                  <a:gd name="T40" fmla="*/ 0 w 798"/>
                  <a:gd name="T41" fmla="*/ 560 h 560"/>
                  <a:gd name="T42" fmla="*/ 0 w 798"/>
                  <a:gd name="T43" fmla="*/ 13 h 560"/>
                  <a:gd name="T44" fmla="*/ 90 w 798"/>
                  <a:gd name="T45" fmla="*/ 13 h 560"/>
                  <a:gd name="T46" fmla="*/ 90 w 798"/>
                  <a:gd name="T47" fmla="*/ 98 h 560"/>
                  <a:gd name="T48" fmla="*/ 164 w 798"/>
                  <a:gd name="T49" fmla="*/ 24 h 560"/>
                  <a:gd name="T50" fmla="*/ 266 w 798"/>
                  <a:gd name="T51" fmla="*/ 0 h 560"/>
                  <a:gd name="T52" fmla="*/ 367 w 798"/>
                  <a:gd name="T53" fmla="*/ 30 h 560"/>
                  <a:gd name="T54" fmla="*/ 429 w 798"/>
                  <a:gd name="T55" fmla="*/ 118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798" h="560">
                    <a:moveTo>
                      <a:pt x="429" y="118"/>
                    </a:moveTo>
                    <a:cubicBezTo>
                      <a:pt x="451" y="78"/>
                      <a:pt x="478" y="49"/>
                      <a:pt x="509" y="29"/>
                    </a:cubicBezTo>
                    <a:cubicBezTo>
                      <a:pt x="540" y="10"/>
                      <a:pt x="577" y="0"/>
                      <a:pt x="620" y="0"/>
                    </a:cubicBezTo>
                    <a:cubicBezTo>
                      <a:pt x="676" y="0"/>
                      <a:pt x="720" y="20"/>
                      <a:pt x="751" y="60"/>
                    </a:cubicBezTo>
                    <a:cubicBezTo>
                      <a:pt x="782" y="100"/>
                      <a:pt x="798" y="157"/>
                      <a:pt x="798" y="230"/>
                    </a:cubicBezTo>
                    <a:lnTo>
                      <a:pt x="798" y="560"/>
                    </a:lnTo>
                    <a:lnTo>
                      <a:pt x="708" y="560"/>
                    </a:lnTo>
                    <a:lnTo>
                      <a:pt x="708" y="233"/>
                    </a:lnTo>
                    <a:cubicBezTo>
                      <a:pt x="708" y="181"/>
                      <a:pt x="698" y="142"/>
                      <a:pt x="680" y="116"/>
                    </a:cubicBezTo>
                    <a:cubicBezTo>
                      <a:pt x="661" y="91"/>
                      <a:pt x="633" y="78"/>
                      <a:pt x="595" y="78"/>
                    </a:cubicBezTo>
                    <a:cubicBezTo>
                      <a:pt x="548" y="78"/>
                      <a:pt x="511" y="94"/>
                      <a:pt x="484" y="125"/>
                    </a:cubicBezTo>
                    <a:cubicBezTo>
                      <a:pt x="457" y="156"/>
                      <a:pt x="444" y="198"/>
                      <a:pt x="444" y="251"/>
                    </a:cubicBezTo>
                    <a:lnTo>
                      <a:pt x="444" y="560"/>
                    </a:lnTo>
                    <a:lnTo>
                      <a:pt x="354" y="560"/>
                    </a:lnTo>
                    <a:lnTo>
                      <a:pt x="354" y="233"/>
                    </a:lnTo>
                    <a:cubicBezTo>
                      <a:pt x="354" y="181"/>
                      <a:pt x="344" y="142"/>
                      <a:pt x="326" y="116"/>
                    </a:cubicBezTo>
                    <a:cubicBezTo>
                      <a:pt x="307" y="91"/>
                      <a:pt x="278" y="78"/>
                      <a:pt x="240" y="78"/>
                    </a:cubicBezTo>
                    <a:cubicBezTo>
                      <a:pt x="194" y="78"/>
                      <a:pt x="157" y="94"/>
                      <a:pt x="130" y="125"/>
                    </a:cubicBezTo>
                    <a:cubicBezTo>
                      <a:pt x="103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0" y="65"/>
                      <a:pt x="135" y="40"/>
                      <a:pt x="164" y="24"/>
                    </a:cubicBezTo>
                    <a:cubicBezTo>
                      <a:pt x="192" y="8"/>
                      <a:pt x="226" y="0"/>
                      <a:pt x="266" y="0"/>
                    </a:cubicBezTo>
                    <a:cubicBezTo>
                      <a:pt x="306" y="0"/>
                      <a:pt x="339" y="10"/>
                      <a:pt x="367" y="30"/>
                    </a:cubicBezTo>
                    <a:cubicBezTo>
                      <a:pt x="395" y="50"/>
                      <a:pt x="415" y="80"/>
                      <a:pt x="429" y="11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5" name="Freeform 133">
                <a:extLst>
                  <a:ext uri="{FF2B5EF4-FFF2-40B4-BE49-F238E27FC236}">
                    <a16:creationId xmlns:a16="http://schemas.microsoft.com/office/drawing/2014/main" id="{D2ABA09A-9313-2AB0-D1FD-ECE98571F35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281744" y="203541"/>
                <a:ext cx="34250" cy="42813"/>
              </a:xfrm>
              <a:custGeom>
                <a:avLst/>
                <a:gdLst>
                  <a:gd name="T0" fmla="*/ 283 w 462"/>
                  <a:gd name="T1" fmla="*/ 285 h 573"/>
                  <a:gd name="T2" fmla="*/ 132 w 462"/>
                  <a:gd name="T3" fmla="*/ 310 h 573"/>
                  <a:gd name="T4" fmla="*/ 90 w 462"/>
                  <a:gd name="T5" fmla="*/ 395 h 573"/>
                  <a:gd name="T6" fmla="*/ 121 w 462"/>
                  <a:gd name="T7" fmla="*/ 471 h 573"/>
                  <a:gd name="T8" fmla="*/ 207 w 462"/>
                  <a:gd name="T9" fmla="*/ 499 h 573"/>
                  <a:gd name="T10" fmla="*/ 327 w 462"/>
                  <a:gd name="T11" fmla="*/ 446 h 573"/>
                  <a:gd name="T12" fmla="*/ 372 w 462"/>
                  <a:gd name="T13" fmla="*/ 305 h 573"/>
                  <a:gd name="T14" fmla="*/ 372 w 462"/>
                  <a:gd name="T15" fmla="*/ 285 h 573"/>
                  <a:gd name="T16" fmla="*/ 283 w 462"/>
                  <a:gd name="T17" fmla="*/ 285 h 573"/>
                  <a:gd name="T18" fmla="*/ 462 w 462"/>
                  <a:gd name="T19" fmla="*/ 248 h 573"/>
                  <a:gd name="T20" fmla="*/ 462 w 462"/>
                  <a:gd name="T21" fmla="*/ 560 h 573"/>
                  <a:gd name="T22" fmla="*/ 372 w 462"/>
                  <a:gd name="T23" fmla="*/ 560 h 573"/>
                  <a:gd name="T24" fmla="*/ 372 w 462"/>
                  <a:gd name="T25" fmla="*/ 477 h 573"/>
                  <a:gd name="T26" fmla="*/ 295 w 462"/>
                  <a:gd name="T27" fmla="*/ 550 h 573"/>
                  <a:gd name="T28" fmla="*/ 183 w 462"/>
                  <a:gd name="T29" fmla="*/ 573 h 573"/>
                  <a:gd name="T30" fmla="*/ 49 w 462"/>
                  <a:gd name="T31" fmla="*/ 527 h 573"/>
                  <a:gd name="T32" fmla="*/ 0 w 462"/>
                  <a:gd name="T33" fmla="*/ 401 h 573"/>
                  <a:gd name="T34" fmla="*/ 62 w 462"/>
                  <a:gd name="T35" fmla="*/ 262 h 573"/>
                  <a:gd name="T36" fmla="*/ 246 w 462"/>
                  <a:gd name="T37" fmla="*/ 215 h 573"/>
                  <a:gd name="T38" fmla="*/ 372 w 462"/>
                  <a:gd name="T39" fmla="*/ 215 h 573"/>
                  <a:gd name="T40" fmla="*/ 372 w 462"/>
                  <a:gd name="T41" fmla="*/ 206 h 573"/>
                  <a:gd name="T42" fmla="*/ 331 w 462"/>
                  <a:gd name="T43" fmla="*/ 110 h 573"/>
                  <a:gd name="T44" fmla="*/ 217 w 462"/>
                  <a:gd name="T45" fmla="*/ 76 h 573"/>
                  <a:gd name="T46" fmla="*/ 125 w 462"/>
                  <a:gd name="T47" fmla="*/ 88 h 573"/>
                  <a:gd name="T48" fmla="*/ 40 w 462"/>
                  <a:gd name="T49" fmla="*/ 121 h 573"/>
                  <a:gd name="T50" fmla="*/ 40 w 462"/>
                  <a:gd name="T51" fmla="*/ 38 h 573"/>
                  <a:gd name="T52" fmla="*/ 135 w 462"/>
                  <a:gd name="T53" fmla="*/ 10 h 573"/>
                  <a:gd name="T54" fmla="*/ 226 w 462"/>
                  <a:gd name="T55" fmla="*/ 0 h 573"/>
                  <a:gd name="T56" fmla="*/ 403 w 462"/>
                  <a:gd name="T57" fmla="*/ 62 h 573"/>
                  <a:gd name="T58" fmla="*/ 462 w 462"/>
                  <a:gd name="T59" fmla="*/ 24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462" h="573">
                    <a:moveTo>
                      <a:pt x="283" y="285"/>
                    </a:moveTo>
                    <a:cubicBezTo>
                      <a:pt x="210" y="285"/>
                      <a:pt x="160" y="294"/>
                      <a:pt x="132" y="310"/>
                    </a:cubicBezTo>
                    <a:cubicBezTo>
                      <a:pt x="104" y="327"/>
                      <a:pt x="90" y="355"/>
                      <a:pt x="90" y="395"/>
                    </a:cubicBezTo>
                    <a:cubicBezTo>
                      <a:pt x="90" y="427"/>
                      <a:pt x="100" y="453"/>
                      <a:pt x="121" y="471"/>
                    </a:cubicBezTo>
                    <a:cubicBezTo>
                      <a:pt x="142" y="490"/>
                      <a:pt x="171" y="499"/>
                      <a:pt x="207" y="499"/>
                    </a:cubicBezTo>
                    <a:cubicBezTo>
                      <a:pt x="257" y="499"/>
                      <a:pt x="297" y="482"/>
                      <a:pt x="327" y="446"/>
                    </a:cubicBezTo>
                    <a:cubicBezTo>
                      <a:pt x="357" y="411"/>
                      <a:pt x="372" y="364"/>
                      <a:pt x="372" y="305"/>
                    </a:cubicBezTo>
                    <a:lnTo>
                      <a:pt x="372" y="285"/>
                    </a:lnTo>
                    <a:lnTo>
                      <a:pt x="283" y="285"/>
                    </a:lnTo>
                    <a:close/>
                    <a:moveTo>
                      <a:pt x="462" y="248"/>
                    </a:moveTo>
                    <a:lnTo>
                      <a:pt x="462" y="560"/>
                    </a:lnTo>
                    <a:lnTo>
                      <a:pt x="372" y="560"/>
                    </a:lnTo>
                    <a:lnTo>
                      <a:pt x="372" y="477"/>
                    </a:lnTo>
                    <a:cubicBezTo>
                      <a:pt x="351" y="511"/>
                      <a:pt x="325" y="535"/>
                      <a:pt x="295" y="550"/>
                    </a:cubicBezTo>
                    <a:cubicBezTo>
                      <a:pt x="265" y="565"/>
                      <a:pt x="227" y="573"/>
                      <a:pt x="183" y="573"/>
                    </a:cubicBezTo>
                    <a:cubicBezTo>
                      <a:pt x="127" y="573"/>
                      <a:pt x="82" y="558"/>
                      <a:pt x="49" y="527"/>
                    </a:cubicBezTo>
                    <a:cubicBezTo>
                      <a:pt x="16" y="496"/>
                      <a:pt x="0" y="454"/>
                      <a:pt x="0" y="401"/>
                    </a:cubicBezTo>
                    <a:cubicBezTo>
                      <a:pt x="0" y="340"/>
                      <a:pt x="20" y="294"/>
                      <a:pt x="62" y="262"/>
                    </a:cubicBezTo>
                    <a:cubicBezTo>
                      <a:pt x="103" y="231"/>
                      <a:pt x="164" y="215"/>
                      <a:pt x="246" y="215"/>
                    </a:cubicBezTo>
                    <a:lnTo>
                      <a:pt x="372" y="215"/>
                    </a:lnTo>
                    <a:lnTo>
                      <a:pt x="372" y="206"/>
                    </a:lnTo>
                    <a:cubicBezTo>
                      <a:pt x="372" y="165"/>
                      <a:pt x="358" y="133"/>
                      <a:pt x="331" y="110"/>
                    </a:cubicBezTo>
                    <a:cubicBezTo>
                      <a:pt x="304" y="88"/>
                      <a:pt x="266" y="76"/>
                      <a:pt x="217" y="76"/>
                    </a:cubicBezTo>
                    <a:cubicBezTo>
                      <a:pt x="185" y="76"/>
                      <a:pt x="155" y="80"/>
                      <a:pt x="125" y="88"/>
                    </a:cubicBezTo>
                    <a:cubicBezTo>
                      <a:pt x="95" y="96"/>
                      <a:pt x="67" y="107"/>
                      <a:pt x="40" y="121"/>
                    </a:cubicBezTo>
                    <a:lnTo>
                      <a:pt x="40" y="38"/>
                    </a:lnTo>
                    <a:cubicBezTo>
                      <a:pt x="72" y="26"/>
                      <a:pt x="104" y="16"/>
                      <a:pt x="135" y="10"/>
                    </a:cubicBezTo>
                    <a:cubicBezTo>
                      <a:pt x="166" y="4"/>
                      <a:pt x="196" y="0"/>
                      <a:pt x="226" y="0"/>
                    </a:cubicBezTo>
                    <a:cubicBezTo>
                      <a:pt x="305" y="0"/>
                      <a:pt x="364" y="21"/>
                      <a:pt x="403" y="62"/>
                    </a:cubicBezTo>
                    <a:cubicBezTo>
                      <a:pt x="442" y="103"/>
                      <a:pt x="462" y="165"/>
                      <a:pt x="462" y="24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6" name="Rectangle 134">
                <a:extLst>
                  <a:ext uri="{FF2B5EF4-FFF2-40B4-BE49-F238E27FC236}">
                    <a16:creationId xmlns:a16="http://schemas.microsoft.com/office/drawing/2014/main" id="{067B12A1-87DA-9FAE-D833-B5E8978C64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29825" y="188392"/>
                <a:ext cx="6587" cy="57303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5442840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12.0332"/>
  <p:tag name="ORIGINALWIDTH" val="32.20842"/>
  <p:tag name="OUTPUTTYPE" val="SVG"/>
  <p:tag name="IGUANATEXVERSION" val="159"/>
  <p:tag name="LATEXADDIN" val="\documentclass{article}&#10;\usepackage{amsmath}&#10;\pagestyle{empty}&#10;\begin{document}&#10;&#10;$\ell_{\text{F}}(f,\hat{f})$&#10;&#10;\end{document}"/>
  <p:tag name="IGUANATEXSIZE" val="20"/>
  <p:tag name="IGUANATEXCURSOR" val="97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9.27101"/>
  <p:tag name="ORIGINALWIDTH" val="5.326387"/>
  <p:tag name="EMFCHILD" val="True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1.568266"/>
  <p:tag name="ORIGINALWIDTH" val="2.849164"/>
  <p:tag name="LATEXADDIN" val="\documentclass{article}&#10;\usepackage{amsmath}&#10;\pagestyle{empty}&#10;\begin{document}&#10;&#10;$\hat{f}$&#10;&#10;\end{document}"/>
  <p:tag name="IGUANATEXSIZE" val="20"/>
  <p:tag name="IGUANATEXCURSOR" val="82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  <p:tag name="EMFCHILD" val="True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9.27101"/>
  <p:tag name="ORIGINALWIDTH" val="5.326387"/>
  <p:tag name="EMFCHILD" val="True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6.963447"/>
  <p:tag name="ORIGINALWIDTH" val="3.855512"/>
  <p:tag name="LATEXADDIN" val="\documentclass{article}&#10;\usepackage{amsmath,bm}&#10;\pagestyle{empty}&#10;\begin{document}&#10;&#10;$\ell_{\text{S}}(\bm{p},\hat{\bm{p}})$&#10;&#10;\end{document}"/>
  <p:tag name="IGUANATEXSIZE" val="20"/>
  <p:tag name="IGUANATEXCURSOR" val="46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  <p:tag name="EMFCHILD" val="True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4.915247"/>
  <p:tag name="ORIGINALWIDTH" val="3.416919"/>
  <p:tag name="EMFCHILD" val="True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9.712744"/>
  <p:tag name="ORIGINALWIDTH" val="2.310714"/>
  <p:tag name="EMFCHILD" val="True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6.274231"/>
  <p:tag name="ORIGINALWIDTH" val="5.9869"/>
  <p:tag name="EMFCHILD" val="True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2.903777"/>
  <p:tag name="ORIGINALWIDTH" val="1.16562"/>
  <p:tag name="EMFCHILD" val="True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1.495099"/>
  <p:tag name="ORIGINALWIDTH" val="2.659644"/>
  <p:tag name="EMFCHILD" val="True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6.274231"/>
  <p:tag name="ORIGINALWIDTH" val="5.9869"/>
  <p:tag name="EMFCHILD" val="True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11.84708"/>
  <p:tag name="ORIGINALWIDTH" val="5.81959"/>
  <p:tag name="OUTPUTTYPE" val="SVG"/>
  <p:tag name="IGUANATEXVERSION" val="159"/>
  <p:tag name="LATEXADDIN" val="\documentclass{article}&#10;\usepackage{amsmath}&#10;\pagestyle{empty}&#10;\begin{document}&#10;&#10;$\hat{f}$&#10;&#10;\end{document}"/>
  <p:tag name="IGUANATEXSIZE" val="20"/>
  <p:tag name="IGUANATEXCURSOR" val="82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9.712744"/>
  <p:tag name="ORIGINALWIDTH" val="2.310714"/>
  <p:tag name="EMFCHILD" val="True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1.568266"/>
  <p:tag name="ORIGINALWIDTH" val="2.849164"/>
  <p:tag name="LATEXADDIN" val="\documentclass{article}&#10;\usepackage{amsmath}&#10;\pagestyle{empty}&#10;\begin{document}&#10;&#10;$\hat{f}$&#10;&#10;\end{document}"/>
  <p:tag name="IGUANATEXSIZE" val="20"/>
  <p:tag name="IGUANATEXCURSOR" val="82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  <p:tag name="EMFCHILD" val="True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9.27101"/>
  <p:tag name="ORIGINALWIDTH" val="5.326387"/>
  <p:tag name="EMFCHILD" val="True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7.14279"/>
  <p:tag name="ORIGINALWIDTH" val="3.855504"/>
  <p:tag name="LATEXADDIN" val="\documentclass{article}&#10;\usepackage{amsmath}&#10;\pagestyle{empty}&#10;\begin{document}&#10;&#10;$\ell_{\text{F}}(f,\hat{f})$&#10;&#10;\end{document}"/>
  <p:tag name="IGUANATEXSIZE" val="20"/>
  <p:tag name="IGUANATEXCURSOR" val="97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  <p:tag name="EMFCHILD" val="True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4.734853"/>
  <p:tag name="ORIGINALWIDTH" val="4.365394"/>
  <p:tag name="EMFCHILD" val="True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9.962312"/>
  <p:tag name="ORIGINALWIDTH" val="2.31071"/>
  <p:tag name="EMFCHILD" val="True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9.065681"/>
  <p:tag name="ORIGINALWIDTH" val="4.970349"/>
  <p:tag name="EMFCHILD" val="True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2.978323"/>
  <p:tag name="ORIGINALWIDTH" val="1.165618"/>
  <p:tag name="EMFCHILD" val="True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1.533993"/>
  <p:tag name="ORIGINALWIDTH" val="2.659639"/>
  <p:tag name="EMFCHILD" val="True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9.065681"/>
  <p:tag name="ORIGINALWIDTH" val="4.970349"/>
  <p:tag name="EMFCHILD" val="True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9.712744"/>
  <p:tag name="ORIGINALWIDTH" val="32.09505"/>
  <p:tag name="OUTPUTTYPE" val="SVG"/>
  <p:tag name="IGUANATEXVERSION" val="159"/>
  <p:tag name="LATEXADDIN" val="\documentclass{article}&#10;\usepackage{amsmath,bm}&#10;\pagestyle{empty}&#10;\begin{document}&#10;&#10;$\ell_{\text{S}}(\bm{p},\hat{\bm{p}})$&#10;&#10;\end{document}"/>
  <p:tag name="IGUANATEXSIZE" val="20"/>
  <p:tag name="IGUANATEXCURSOR" val="46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9.962312"/>
  <p:tag name="ORIGINALWIDTH" val="2.31071"/>
  <p:tag name="EMFCHILD" val="True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11.84708"/>
  <p:tag name="ORIGINALWIDTH" val="5.81959"/>
  <p:tag name="OUTPUTTYPE" val="SVG"/>
  <p:tag name="IGUANATEXVERSION" val="159"/>
  <p:tag name="LATEXADDIN" val="\documentclass{article}&#10;\usepackage{amsmath}&#10;\pagestyle{empty}&#10;\begin{document}&#10;&#10;$\hat{f}$&#10;&#10;\end{document}"/>
  <p:tag name="IGUANATEXSIZE" val="20"/>
  <p:tag name="IGUANATEXCURSOR" val="82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11.84708"/>
  <p:tag name="ORIGINALWIDTH" val="5.81959"/>
  <p:tag name="OUTPUTTYPE" val="SVG"/>
  <p:tag name="IGUANATEXVERSION" val="159"/>
  <p:tag name="LATEXADDIN" val="\documentclass{article}&#10;\usepackage{amsmath}&#10;\pagestyle{empty}&#10;\begin{document}&#10;&#10;$\hat{f}$&#10;&#10;\end{document}"/>
  <p:tag name="IGUANATEXSIZE" val="20"/>
  <p:tag name="IGUANATEXCURSOR" val="82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11.84708"/>
  <p:tag name="ORIGINALWIDTH" val="5.81959"/>
  <p:tag name="OUTPUTTYPE" val="SVG"/>
  <p:tag name="IGUANATEXVERSION" val="159"/>
  <p:tag name="LATEXADDIN" val="\documentclass{article}&#10;\usepackage{amsmath}&#10;\pagestyle{empty}&#10;\begin{document}&#10;&#10;$\hat{f}$&#10;&#10;\end{document}"/>
  <p:tag name="IGUANATEXSIZE" val="20"/>
  <p:tag name="IGUANATEXCURSOR" val="82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1.568266"/>
  <p:tag name="ORIGINALWIDTH" val="2.849164"/>
  <p:tag name="LATEXADDIN" val="\documentclass{article}&#10;\usepackage{amsmath}&#10;\pagestyle{empty}&#10;\begin{document}&#10;&#10;$\hat{f}$&#10;&#10;\end{document}"/>
  <p:tag name="IGUANATEXSIZE" val="20"/>
  <p:tag name="IGUANATEXCURSOR" val="82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  <p:tag name="EMFCHILD" val="True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9.27101"/>
  <p:tag name="ORIGINALWIDTH" val="5.326387"/>
  <p:tag name="EMFCHILD" val="True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RIGINALHEIGHT" val="1.568266"/>
  <p:tag name="ORIGINALWIDTH" val="2.849164"/>
  <p:tag name="LATEXADDIN" val="\documentclass{article}&#10;\usepackage{amsmath}&#10;\pagestyle{empty}&#10;\begin{document}&#10;&#10;$\hat{f}$&#10;&#10;\end{document}"/>
  <p:tag name="IGUANATEXSIZE" val="20"/>
  <p:tag name="IGUANATEXCURSOR" val="82"/>
  <p:tag name="TRANSPARENCY" val="True"/>
  <p:tag name="LATEXENGINEID" val="0"/>
  <p:tag name="TEMPFOLDER" val="C:\Users\elias\Downloads\Temp\"/>
  <p:tag name="LATEXFORMHEIGHT" val="320"/>
  <p:tag name="LATEXFORMWIDTH" val="385"/>
  <p:tag name="LATEXFORMWRAP" val="True"/>
  <p:tag name="BITMAPVECTOR" val="1"/>
  <p:tag name="EMFCHILD" val="True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063</TotalTime>
  <Words>68</Words>
  <Application>Microsoft Office PowerPoint</Application>
  <PresentationFormat>Custom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 Math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as Nehme</dc:creator>
  <cp:lastModifiedBy>Elias Nehme</cp:lastModifiedBy>
  <cp:revision>53</cp:revision>
  <dcterms:created xsi:type="dcterms:W3CDTF">2023-03-26T19:04:44Z</dcterms:created>
  <dcterms:modified xsi:type="dcterms:W3CDTF">2024-04-02T14:22:09Z</dcterms:modified>
</cp:coreProperties>
</file>